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3" r:id="rId2"/>
  </p:sldIdLst>
  <p:sldSz cx="9144000" cy="10801350"/>
  <p:notesSz cx="6662738" cy="9926638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FF2C"/>
  </p:clrMru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Geen stijl, gee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Geen stijl, tabel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76" autoAdjust="0"/>
    <p:restoredTop sz="98649" autoAdjust="0"/>
  </p:normalViewPr>
  <p:slideViewPr>
    <p:cSldViewPr>
      <p:cViewPr>
        <p:scale>
          <a:sx n="86" d="100"/>
          <a:sy n="86" d="100"/>
        </p:scale>
        <p:origin x="-1590" y="1644"/>
      </p:cViewPr>
      <p:guideLst>
        <p:guide orient="horz" pos="3402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73177B-EF86-4E5D-9618-8CEDE6C29829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1755775" y="744538"/>
            <a:ext cx="31527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l-NL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29238" cy="44672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7663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773488" y="9428163"/>
            <a:ext cx="2887662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95E214-DD95-4E51-BAED-BA5174A07053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3355424"/>
            <a:ext cx="7772400" cy="2315289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2" y="6120765"/>
            <a:ext cx="6400800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432559"/>
            <a:ext cx="2057400" cy="9216151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432559"/>
            <a:ext cx="6019800" cy="9216151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940868"/>
            <a:ext cx="7772400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4578075"/>
            <a:ext cx="7772400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2520316"/>
            <a:ext cx="4038600" cy="712839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2417805"/>
            <a:ext cx="4040188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3425430"/>
            <a:ext cx="4040188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30" y="2417805"/>
            <a:ext cx="404177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30" y="3425430"/>
            <a:ext cx="404177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5" y="430055"/>
            <a:ext cx="3008313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2" y="430058"/>
            <a:ext cx="5111750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5" y="2260283"/>
            <a:ext cx="3008313" cy="738842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560945"/>
            <a:ext cx="5486400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965121"/>
            <a:ext cx="5486400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8453557"/>
            <a:ext cx="5486400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57202" y="432556"/>
            <a:ext cx="8229600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2" y="2520316"/>
            <a:ext cx="8229600" cy="712839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7EA69-F530-47DE-852A-F284379A2B2E}" type="datetimeFigureOut">
              <a:rPr lang="nl-NL" smtClean="0"/>
              <a:pPr/>
              <a:t>12-11-2015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10011256"/>
            <a:ext cx="2895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2" y="10011256"/>
            <a:ext cx="2133600" cy="5750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5C0B61-2407-4770-9DB8-203424BEAAA7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ep 103"/>
          <p:cNvGrpSpPr/>
          <p:nvPr/>
        </p:nvGrpSpPr>
        <p:grpSpPr>
          <a:xfrm>
            <a:off x="578565" y="432124"/>
            <a:ext cx="6369699" cy="6940200"/>
            <a:chOff x="578565" y="636858"/>
            <a:chExt cx="5939671" cy="6735465"/>
          </a:xfrm>
        </p:grpSpPr>
        <p:grpSp>
          <p:nvGrpSpPr>
            <p:cNvPr id="40" name="Groep 39"/>
            <p:cNvGrpSpPr/>
            <p:nvPr/>
          </p:nvGrpSpPr>
          <p:grpSpPr>
            <a:xfrm>
              <a:off x="1911734" y="894708"/>
              <a:ext cx="1163039" cy="1191023"/>
              <a:chOff x="930275" y="2182813"/>
              <a:chExt cx="2074863" cy="1992312"/>
            </a:xfrm>
          </p:grpSpPr>
          <p:sp>
            <p:nvSpPr>
              <p:cNvPr id="58375" name="Freeform 7"/>
              <p:cNvSpPr>
                <a:spLocks/>
              </p:cNvSpPr>
              <p:nvPr/>
            </p:nvSpPr>
            <p:spPr bwMode="auto">
              <a:xfrm>
                <a:off x="930275" y="2846388"/>
                <a:ext cx="2074863" cy="1328737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25"/>
                  </a:cxn>
                  <a:cxn ang="0">
                    <a:pos x="92" y="837"/>
                  </a:cxn>
                  <a:cxn ang="0">
                    <a:pos x="117" y="814"/>
                  </a:cxn>
                  <a:cxn ang="0">
                    <a:pos x="143" y="825"/>
                  </a:cxn>
                  <a:cxn ang="0">
                    <a:pos x="168" y="825"/>
                  </a:cxn>
                  <a:cxn ang="0">
                    <a:pos x="194" y="790"/>
                  </a:cxn>
                  <a:cxn ang="0">
                    <a:pos x="219" y="779"/>
                  </a:cxn>
                  <a:cxn ang="0">
                    <a:pos x="245" y="709"/>
                  </a:cxn>
                  <a:cxn ang="0">
                    <a:pos x="270" y="709"/>
                  </a:cxn>
                  <a:cxn ang="0">
                    <a:pos x="296" y="663"/>
                  </a:cxn>
                  <a:cxn ang="0">
                    <a:pos x="321" y="686"/>
                  </a:cxn>
                  <a:cxn ang="0">
                    <a:pos x="347" y="593"/>
                  </a:cxn>
                  <a:cxn ang="0">
                    <a:pos x="372" y="477"/>
                  </a:cxn>
                  <a:cxn ang="0">
                    <a:pos x="398" y="477"/>
                  </a:cxn>
                  <a:cxn ang="0">
                    <a:pos x="424" y="268"/>
                  </a:cxn>
                  <a:cxn ang="0">
                    <a:pos x="449" y="326"/>
                  </a:cxn>
                  <a:cxn ang="0">
                    <a:pos x="475" y="93"/>
                  </a:cxn>
                  <a:cxn ang="0">
                    <a:pos x="500" y="326"/>
                  </a:cxn>
                  <a:cxn ang="0">
                    <a:pos x="526" y="256"/>
                  </a:cxn>
                  <a:cxn ang="0">
                    <a:pos x="551" y="151"/>
                  </a:cxn>
                  <a:cxn ang="0">
                    <a:pos x="577" y="291"/>
                  </a:cxn>
                  <a:cxn ang="0">
                    <a:pos x="602" y="291"/>
                  </a:cxn>
                  <a:cxn ang="0">
                    <a:pos x="628" y="116"/>
                  </a:cxn>
                  <a:cxn ang="0">
                    <a:pos x="653" y="244"/>
                  </a:cxn>
                  <a:cxn ang="0">
                    <a:pos x="679" y="198"/>
                  </a:cxn>
                  <a:cxn ang="0">
                    <a:pos x="704" y="268"/>
                  </a:cxn>
                  <a:cxn ang="0">
                    <a:pos x="730" y="256"/>
                  </a:cxn>
                  <a:cxn ang="0">
                    <a:pos x="755" y="233"/>
                  </a:cxn>
                  <a:cxn ang="0">
                    <a:pos x="781" y="337"/>
                  </a:cxn>
                  <a:cxn ang="0">
                    <a:pos x="807" y="372"/>
                  </a:cxn>
                  <a:cxn ang="0">
                    <a:pos x="832" y="256"/>
                  </a:cxn>
                  <a:cxn ang="0">
                    <a:pos x="858" y="244"/>
                  </a:cxn>
                  <a:cxn ang="0">
                    <a:pos x="883" y="337"/>
                  </a:cxn>
                  <a:cxn ang="0">
                    <a:pos x="909" y="221"/>
                  </a:cxn>
                  <a:cxn ang="0">
                    <a:pos x="934" y="488"/>
                  </a:cxn>
                  <a:cxn ang="0">
                    <a:pos x="960" y="175"/>
                  </a:cxn>
                  <a:cxn ang="0">
                    <a:pos x="985" y="361"/>
                  </a:cxn>
                  <a:cxn ang="0">
                    <a:pos x="1011" y="291"/>
                  </a:cxn>
                  <a:cxn ang="0">
                    <a:pos x="1036" y="93"/>
                  </a:cxn>
                  <a:cxn ang="0">
                    <a:pos x="1062" y="221"/>
                  </a:cxn>
                  <a:cxn ang="0">
                    <a:pos x="1087" y="337"/>
                  </a:cxn>
                  <a:cxn ang="0">
                    <a:pos x="1113" y="535"/>
                  </a:cxn>
                  <a:cxn ang="0">
                    <a:pos x="1139" y="558"/>
                  </a:cxn>
                  <a:cxn ang="0">
                    <a:pos x="1164" y="732"/>
                  </a:cxn>
                  <a:cxn ang="0">
                    <a:pos x="1189" y="814"/>
                  </a:cxn>
                  <a:cxn ang="0">
                    <a:pos x="1215" y="814"/>
                  </a:cxn>
                  <a:cxn ang="0">
                    <a:pos x="1240" y="825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4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25"/>
                    </a:lnTo>
                    <a:lnTo>
                      <a:pt x="71" y="837"/>
                    </a:lnTo>
                    <a:lnTo>
                      <a:pt x="76" y="825"/>
                    </a:lnTo>
                    <a:lnTo>
                      <a:pt x="82" y="837"/>
                    </a:lnTo>
                    <a:lnTo>
                      <a:pt x="87" y="837"/>
                    </a:lnTo>
                    <a:lnTo>
                      <a:pt x="92" y="837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14"/>
                    </a:lnTo>
                    <a:lnTo>
                      <a:pt x="117" y="814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14"/>
                    </a:lnTo>
                    <a:lnTo>
                      <a:pt x="158" y="814"/>
                    </a:lnTo>
                    <a:lnTo>
                      <a:pt x="163" y="825"/>
                    </a:lnTo>
                    <a:lnTo>
                      <a:pt x="168" y="825"/>
                    </a:lnTo>
                    <a:lnTo>
                      <a:pt x="173" y="802"/>
                    </a:lnTo>
                    <a:lnTo>
                      <a:pt x="179" y="825"/>
                    </a:lnTo>
                    <a:lnTo>
                      <a:pt x="184" y="802"/>
                    </a:lnTo>
                    <a:lnTo>
                      <a:pt x="189" y="802"/>
                    </a:lnTo>
                    <a:lnTo>
                      <a:pt x="194" y="790"/>
                    </a:lnTo>
                    <a:lnTo>
                      <a:pt x="199" y="779"/>
                    </a:lnTo>
                    <a:lnTo>
                      <a:pt x="204" y="825"/>
                    </a:lnTo>
                    <a:lnTo>
                      <a:pt x="209" y="744"/>
                    </a:lnTo>
                    <a:lnTo>
                      <a:pt x="214" y="779"/>
                    </a:lnTo>
                    <a:lnTo>
                      <a:pt x="219" y="779"/>
                    </a:lnTo>
                    <a:lnTo>
                      <a:pt x="224" y="802"/>
                    </a:lnTo>
                    <a:lnTo>
                      <a:pt x="230" y="802"/>
                    </a:lnTo>
                    <a:lnTo>
                      <a:pt x="235" y="721"/>
                    </a:lnTo>
                    <a:lnTo>
                      <a:pt x="240" y="709"/>
                    </a:lnTo>
                    <a:lnTo>
                      <a:pt x="245" y="709"/>
                    </a:lnTo>
                    <a:lnTo>
                      <a:pt x="250" y="779"/>
                    </a:lnTo>
                    <a:lnTo>
                      <a:pt x="255" y="605"/>
                    </a:lnTo>
                    <a:lnTo>
                      <a:pt x="260" y="767"/>
                    </a:lnTo>
                    <a:lnTo>
                      <a:pt x="265" y="674"/>
                    </a:lnTo>
                    <a:lnTo>
                      <a:pt x="270" y="709"/>
                    </a:lnTo>
                    <a:lnTo>
                      <a:pt x="275" y="744"/>
                    </a:lnTo>
                    <a:lnTo>
                      <a:pt x="281" y="721"/>
                    </a:lnTo>
                    <a:lnTo>
                      <a:pt x="286" y="732"/>
                    </a:lnTo>
                    <a:lnTo>
                      <a:pt x="291" y="732"/>
                    </a:lnTo>
                    <a:lnTo>
                      <a:pt x="296" y="663"/>
                    </a:lnTo>
                    <a:lnTo>
                      <a:pt x="301" y="628"/>
                    </a:lnTo>
                    <a:lnTo>
                      <a:pt x="306" y="639"/>
                    </a:lnTo>
                    <a:lnTo>
                      <a:pt x="311" y="558"/>
                    </a:lnTo>
                    <a:lnTo>
                      <a:pt x="316" y="558"/>
                    </a:lnTo>
                    <a:lnTo>
                      <a:pt x="321" y="686"/>
                    </a:lnTo>
                    <a:lnTo>
                      <a:pt x="327" y="523"/>
                    </a:lnTo>
                    <a:lnTo>
                      <a:pt x="332" y="732"/>
                    </a:lnTo>
                    <a:lnTo>
                      <a:pt x="337" y="593"/>
                    </a:lnTo>
                    <a:lnTo>
                      <a:pt x="342" y="628"/>
                    </a:lnTo>
                    <a:lnTo>
                      <a:pt x="347" y="593"/>
                    </a:lnTo>
                    <a:lnTo>
                      <a:pt x="352" y="488"/>
                    </a:lnTo>
                    <a:lnTo>
                      <a:pt x="357" y="488"/>
                    </a:lnTo>
                    <a:lnTo>
                      <a:pt x="362" y="442"/>
                    </a:lnTo>
                    <a:lnTo>
                      <a:pt x="367" y="535"/>
                    </a:lnTo>
                    <a:lnTo>
                      <a:pt x="372" y="477"/>
                    </a:lnTo>
                    <a:lnTo>
                      <a:pt x="378" y="430"/>
                    </a:lnTo>
                    <a:lnTo>
                      <a:pt x="383" y="407"/>
                    </a:lnTo>
                    <a:lnTo>
                      <a:pt x="388" y="361"/>
                    </a:lnTo>
                    <a:lnTo>
                      <a:pt x="393" y="500"/>
                    </a:lnTo>
                    <a:lnTo>
                      <a:pt x="398" y="477"/>
                    </a:lnTo>
                    <a:lnTo>
                      <a:pt x="403" y="361"/>
                    </a:lnTo>
                    <a:lnTo>
                      <a:pt x="408" y="233"/>
                    </a:lnTo>
                    <a:lnTo>
                      <a:pt x="413" y="384"/>
                    </a:lnTo>
                    <a:lnTo>
                      <a:pt x="419" y="209"/>
                    </a:lnTo>
                    <a:lnTo>
                      <a:pt x="424" y="268"/>
                    </a:lnTo>
                    <a:lnTo>
                      <a:pt x="429" y="198"/>
                    </a:lnTo>
                    <a:lnTo>
                      <a:pt x="434" y="186"/>
                    </a:lnTo>
                    <a:lnTo>
                      <a:pt x="439" y="175"/>
                    </a:lnTo>
                    <a:lnTo>
                      <a:pt x="444" y="175"/>
                    </a:lnTo>
                    <a:lnTo>
                      <a:pt x="449" y="326"/>
                    </a:lnTo>
                    <a:lnTo>
                      <a:pt x="454" y="291"/>
                    </a:lnTo>
                    <a:lnTo>
                      <a:pt x="459" y="291"/>
                    </a:lnTo>
                    <a:lnTo>
                      <a:pt x="464" y="384"/>
                    </a:lnTo>
                    <a:lnTo>
                      <a:pt x="470" y="58"/>
                    </a:lnTo>
                    <a:lnTo>
                      <a:pt x="475" y="93"/>
                    </a:lnTo>
                    <a:lnTo>
                      <a:pt x="480" y="175"/>
                    </a:lnTo>
                    <a:lnTo>
                      <a:pt x="485" y="326"/>
                    </a:lnTo>
                    <a:lnTo>
                      <a:pt x="490" y="70"/>
                    </a:lnTo>
                    <a:lnTo>
                      <a:pt x="495" y="140"/>
                    </a:lnTo>
                    <a:lnTo>
                      <a:pt x="500" y="326"/>
                    </a:lnTo>
                    <a:lnTo>
                      <a:pt x="505" y="244"/>
                    </a:lnTo>
                    <a:lnTo>
                      <a:pt x="510" y="326"/>
                    </a:lnTo>
                    <a:lnTo>
                      <a:pt x="515" y="302"/>
                    </a:lnTo>
                    <a:lnTo>
                      <a:pt x="521" y="198"/>
                    </a:lnTo>
                    <a:lnTo>
                      <a:pt x="526" y="256"/>
                    </a:lnTo>
                    <a:lnTo>
                      <a:pt x="531" y="233"/>
                    </a:lnTo>
                    <a:lnTo>
                      <a:pt x="536" y="395"/>
                    </a:lnTo>
                    <a:lnTo>
                      <a:pt x="541" y="256"/>
                    </a:lnTo>
                    <a:lnTo>
                      <a:pt x="546" y="244"/>
                    </a:lnTo>
                    <a:lnTo>
                      <a:pt x="551" y="151"/>
                    </a:lnTo>
                    <a:lnTo>
                      <a:pt x="556" y="209"/>
                    </a:lnTo>
                    <a:lnTo>
                      <a:pt x="561" y="198"/>
                    </a:lnTo>
                    <a:lnTo>
                      <a:pt x="567" y="163"/>
                    </a:lnTo>
                    <a:lnTo>
                      <a:pt x="572" y="256"/>
                    </a:lnTo>
                    <a:lnTo>
                      <a:pt x="577" y="291"/>
                    </a:lnTo>
                    <a:lnTo>
                      <a:pt x="582" y="256"/>
                    </a:lnTo>
                    <a:lnTo>
                      <a:pt x="587" y="186"/>
                    </a:lnTo>
                    <a:lnTo>
                      <a:pt x="592" y="82"/>
                    </a:lnTo>
                    <a:lnTo>
                      <a:pt x="597" y="233"/>
                    </a:lnTo>
                    <a:lnTo>
                      <a:pt x="602" y="291"/>
                    </a:lnTo>
                    <a:lnTo>
                      <a:pt x="607" y="58"/>
                    </a:lnTo>
                    <a:lnTo>
                      <a:pt x="612" y="291"/>
                    </a:lnTo>
                    <a:lnTo>
                      <a:pt x="618" y="244"/>
                    </a:lnTo>
                    <a:lnTo>
                      <a:pt x="623" y="244"/>
                    </a:lnTo>
                    <a:lnTo>
                      <a:pt x="628" y="116"/>
                    </a:lnTo>
                    <a:lnTo>
                      <a:pt x="633" y="47"/>
                    </a:lnTo>
                    <a:lnTo>
                      <a:pt x="638" y="140"/>
                    </a:lnTo>
                    <a:lnTo>
                      <a:pt x="643" y="163"/>
                    </a:lnTo>
                    <a:lnTo>
                      <a:pt x="648" y="221"/>
                    </a:lnTo>
                    <a:lnTo>
                      <a:pt x="653" y="244"/>
                    </a:lnTo>
                    <a:lnTo>
                      <a:pt x="659" y="24"/>
                    </a:lnTo>
                    <a:lnTo>
                      <a:pt x="664" y="326"/>
                    </a:lnTo>
                    <a:lnTo>
                      <a:pt x="669" y="151"/>
                    </a:lnTo>
                    <a:lnTo>
                      <a:pt x="674" y="337"/>
                    </a:lnTo>
                    <a:lnTo>
                      <a:pt x="679" y="198"/>
                    </a:lnTo>
                    <a:lnTo>
                      <a:pt x="684" y="326"/>
                    </a:lnTo>
                    <a:lnTo>
                      <a:pt x="689" y="151"/>
                    </a:lnTo>
                    <a:lnTo>
                      <a:pt x="694" y="256"/>
                    </a:lnTo>
                    <a:lnTo>
                      <a:pt x="699" y="244"/>
                    </a:lnTo>
                    <a:lnTo>
                      <a:pt x="704" y="268"/>
                    </a:lnTo>
                    <a:lnTo>
                      <a:pt x="710" y="349"/>
                    </a:lnTo>
                    <a:lnTo>
                      <a:pt x="715" y="163"/>
                    </a:lnTo>
                    <a:lnTo>
                      <a:pt x="720" y="442"/>
                    </a:lnTo>
                    <a:lnTo>
                      <a:pt x="725" y="209"/>
                    </a:lnTo>
                    <a:lnTo>
                      <a:pt x="730" y="256"/>
                    </a:lnTo>
                    <a:lnTo>
                      <a:pt x="735" y="326"/>
                    </a:lnTo>
                    <a:lnTo>
                      <a:pt x="740" y="198"/>
                    </a:lnTo>
                    <a:lnTo>
                      <a:pt x="745" y="372"/>
                    </a:lnTo>
                    <a:lnTo>
                      <a:pt x="750" y="221"/>
                    </a:lnTo>
                    <a:lnTo>
                      <a:pt x="755" y="233"/>
                    </a:lnTo>
                    <a:lnTo>
                      <a:pt x="761" y="279"/>
                    </a:lnTo>
                    <a:lnTo>
                      <a:pt x="766" y="407"/>
                    </a:lnTo>
                    <a:lnTo>
                      <a:pt x="771" y="163"/>
                    </a:lnTo>
                    <a:lnTo>
                      <a:pt x="776" y="337"/>
                    </a:lnTo>
                    <a:lnTo>
                      <a:pt x="781" y="337"/>
                    </a:lnTo>
                    <a:lnTo>
                      <a:pt x="786" y="384"/>
                    </a:lnTo>
                    <a:lnTo>
                      <a:pt x="791" y="291"/>
                    </a:lnTo>
                    <a:lnTo>
                      <a:pt x="796" y="279"/>
                    </a:lnTo>
                    <a:lnTo>
                      <a:pt x="801" y="279"/>
                    </a:lnTo>
                    <a:lnTo>
                      <a:pt x="807" y="372"/>
                    </a:lnTo>
                    <a:lnTo>
                      <a:pt x="812" y="314"/>
                    </a:lnTo>
                    <a:lnTo>
                      <a:pt x="817" y="244"/>
                    </a:lnTo>
                    <a:lnTo>
                      <a:pt x="822" y="279"/>
                    </a:lnTo>
                    <a:lnTo>
                      <a:pt x="827" y="302"/>
                    </a:lnTo>
                    <a:lnTo>
                      <a:pt x="832" y="256"/>
                    </a:lnTo>
                    <a:lnTo>
                      <a:pt x="837" y="442"/>
                    </a:lnTo>
                    <a:lnTo>
                      <a:pt x="842" y="233"/>
                    </a:lnTo>
                    <a:lnTo>
                      <a:pt x="847" y="337"/>
                    </a:lnTo>
                    <a:lnTo>
                      <a:pt x="852" y="337"/>
                    </a:lnTo>
                    <a:lnTo>
                      <a:pt x="858" y="244"/>
                    </a:lnTo>
                    <a:lnTo>
                      <a:pt x="863" y="314"/>
                    </a:lnTo>
                    <a:lnTo>
                      <a:pt x="868" y="361"/>
                    </a:lnTo>
                    <a:lnTo>
                      <a:pt x="873" y="349"/>
                    </a:lnTo>
                    <a:lnTo>
                      <a:pt x="878" y="314"/>
                    </a:lnTo>
                    <a:lnTo>
                      <a:pt x="883" y="337"/>
                    </a:lnTo>
                    <a:lnTo>
                      <a:pt x="888" y="349"/>
                    </a:lnTo>
                    <a:lnTo>
                      <a:pt x="893" y="268"/>
                    </a:lnTo>
                    <a:lnTo>
                      <a:pt x="899" y="477"/>
                    </a:lnTo>
                    <a:lnTo>
                      <a:pt x="904" y="361"/>
                    </a:lnTo>
                    <a:lnTo>
                      <a:pt x="909" y="221"/>
                    </a:lnTo>
                    <a:lnTo>
                      <a:pt x="914" y="221"/>
                    </a:lnTo>
                    <a:lnTo>
                      <a:pt x="919" y="175"/>
                    </a:lnTo>
                    <a:lnTo>
                      <a:pt x="924" y="233"/>
                    </a:lnTo>
                    <a:lnTo>
                      <a:pt x="929" y="209"/>
                    </a:lnTo>
                    <a:lnTo>
                      <a:pt x="934" y="488"/>
                    </a:lnTo>
                    <a:lnTo>
                      <a:pt x="939" y="314"/>
                    </a:lnTo>
                    <a:lnTo>
                      <a:pt x="944" y="151"/>
                    </a:lnTo>
                    <a:lnTo>
                      <a:pt x="950" y="291"/>
                    </a:lnTo>
                    <a:lnTo>
                      <a:pt x="955" y="233"/>
                    </a:lnTo>
                    <a:lnTo>
                      <a:pt x="960" y="175"/>
                    </a:lnTo>
                    <a:lnTo>
                      <a:pt x="965" y="163"/>
                    </a:lnTo>
                    <a:lnTo>
                      <a:pt x="970" y="116"/>
                    </a:lnTo>
                    <a:lnTo>
                      <a:pt x="975" y="198"/>
                    </a:lnTo>
                    <a:lnTo>
                      <a:pt x="980" y="209"/>
                    </a:lnTo>
                    <a:lnTo>
                      <a:pt x="985" y="361"/>
                    </a:lnTo>
                    <a:lnTo>
                      <a:pt x="990" y="105"/>
                    </a:lnTo>
                    <a:lnTo>
                      <a:pt x="995" y="93"/>
                    </a:lnTo>
                    <a:lnTo>
                      <a:pt x="1000" y="0"/>
                    </a:lnTo>
                    <a:lnTo>
                      <a:pt x="1006" y="186"/>
                    </a:lnTo>
                    <a:lnTo>
                      <a:pt x="1011" y="291"/>
                    </a:lnTo>
                    <a:lnTo>
                      <a:pt x="1016" y="244"/>
                    </a:lnTo>
                    <a:lnTo>
                      <a:pt x="1021" y="35"/>
                    </a:lnTo>
                    <a:lnTo>
                      <a:pt x="1026" y="186"/>
                    </a:lnTo>
                    <a:lnTo>
                      <a:pt x="1031" y="279"/>
                    </a:lnTo>
                    <a:lnTo>
                      <a:pt x="1036" y="93"/>
                    </a:lnTo>
                    <a:lnTo>
                      <a:pt x="1041" y="198"/>
                    </a:lnTo>
                    <a:lnTo>
                      <a:pt x="1047" y="175"/>
                    </a:lnTo>
                    <a:lnTo>
                      <a:pt x="1052" y="233"/>
                    </a:lnTo>
                    <a:lnTo>
                      <a:pt x="1057" y="58"/>
                    </a:lnTo>
                    <a:lnTo>
                      <a:pt x="1062" y="221"/>
                    </a:lnTo>
                    <a:lnTo>
                      <a:pt x="1067" y="279"/>
                    </a:lnTo>
                    <a:lnTo>
                      <a:pt x="1072" y="384"/>
                    </a:lnTo>
                    <a:lnTo>
                      <a:pt x="1077" y="326"/>
                    </a:lnTo>
                    <a:lnTo>
                      <a:pt x="1082" y="268"/>
                    </a:lnTo>
                    <a:lnTo>
                      <a:pt x="1087" y="337"/>
                    </a:lnTo>
                    <a:lnTo>
                      <a:pt x="1092" y="291"/>
                    </a:lnTo>
                    <a:lnTo>
                      <a:pt x="1098" y="488"/>
                    </a:lnTo>
                    <a:lnTo>
                      <a:pt x="1103" y="477"/>
                    </a:lnTo>
                    <a:lnTo>
                      <a:pt x="1108" y="488"/>
                    </a:lnTo>
                    <a:lnTo>
                      <a:pt x="1113" y="535"/>
                    </a:lnTo>
                    <a:lnTo>
                      <a:pt x="1118" y="546"/>
                    </a:lnTo>
                    <a:lnTo>
                      <a:pt x="1123" y="500"/>
                    </a:lnTo>
                    <a:lnTo>
                      <a:pt x="1128" y="546"/>
                    </a:lnTo>
                    <a:lnTo>
                      <a:pt x="1133" y="674"/>
                    </a:lnTo>
                    <a:lnTo>
                      <a:pt x="1139" y="558"/>
                    </a:lnTo>
                    <a:lnTo>
                      <a:pt x="1144" y="593"/>
                    </a:lnTo>
                    <a:lnTo>
                      <a:pt x="1149" y="721"/>
                    </a:lnTo>
                    <a:lnTo>
                      <a:pt x="1154" y="709"/>
                    </a:lnTo>
                    <a:lnTo>
                      <a:pt x="1159" y="709"/>
                    </a:lnTo>
                    <a:lnTo>
                      <a:pt x="1164" y="732"/>
                    </a:lnTo>
                    <a:lnTo>
                      <a:pt x="1169" y="756"/>
                    </a:lnTo>
                    <a:lnTo>
                      <a:pt x="1174" y="779"/>
                    </a:lnTo>
                    <a:lnTo>
                      <a:pt x="1179" y="802"/>
                    </a:lnTo>
                    <a:lnTo>
                      <a:pt x="1184" y="779"/>
                    </a:lnTo>
                    <a:lnTo>
                      <a:pt x="1189" y="814"/>
                    </a:lnTo>
                    <a:lnTo>
                      <a:pt x="1195" y="814"/>
                    </a:lnTo>
                    <a:lnTo>
                      <a:pt x="1200" y="814"/>
                    </a:lnTo>
                    <a:lnTo>
                      <a:pt x="1205" y="837"/>
                    </a:lnTo>
                    <a:lnTo>
                      <a:pt x="1210" y="814"/>
                    </a:lnTo>
                    <a:lnTo>
                      <a:pt x="1215" y="814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25"/>
                    </a:lnTo>
                    <a:lnTo>
                      <a:pt x="1240" y="825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376" name="Freeform 8"/>
              <p:cNvSpPr>
                <a:spLocks/>
              </p:cNvSpPr>
              <p:nvPr/>
            </p:nvSpPr>
            <p:spPr bwMode="auto">
              <a:xfrm>
                <a:off x="930275" y="2846388"/>
                <a:ext cx="2074863" cy="1328737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25"/>
                  </a:cxn>
                  <a:cxn ang="0">
                    <a:pos x="92" y="837"/>
                  </a:cxn>
                  <a:cxn ang="0">
                    <a:pos x="117" y="814"/>
                  </a:cxn>
                  <a:cxn ang="0">
                    <a:pos x="143" y="825"/>
                  </a:cxn>
                  <a:cxn ang="0">
                    <a:pos x="168" y="825"/>
                  </a:cxn>
                  <a:cxn ang="0">
                    <a:pos x="194" y="790"/>
                  </a:cxn>
                  <a:cxn ang="0">
                    <a:pos x="219" y="779"/>
                  </a:cxn>
                  <a:cxn ang="0">
                    <a:pos x="245" y="709"/>
                  </a:cxn>
                  <a:cxn ang="0">
                    <a:pos x="270" y="709"/>
                  </a:cxn>
                  <a:cxn ang="0">
                    <a:pos x="296" y="663"/>
                  </a:cxn>
                  <a:cxn ang="0">
                    <a:pos x="321" y="686"/>
                  </a:cxn>
                  <a:cxn ang="0">
                    <a:pos x="347" y="593"/>
                  </a:cxn>
                  <a:cxn ang="0">
                    <a:pos x="372" y="477"/>
                  </a:cxn>
                  <a:cxn ang="0">
                    <a:pos x="398" y="477"/>
                  </a:cxn>
                  <a:cxn ang="0">
                    <a:pos x="424" y="268"/>
                  </a:cxn>
                  <a:cxn ang="0">
                    <a:pos x="449" y="326"/>
                  </a:cxn>
                  <a:cxn ang="0">
                    <a:pos x="475" y="93"/>
                  </a:cxn>
                  <a:cxn ang="0">
                    <a:pos x="500" y="326"/>
                  </a:cxn>
                  <a:cxn ang="0">
                    <a:pos x="526" y="256"/>
                  </a:cxn>
                  <a:cxn ang="0">
                    <a:pos x="551" y="151"/>
                  </a:cxn>
                  <a:cxn ang="0">
                    <a:pos x="577" y="291"/>
                  </a:cxn>
                  <a:cxn ang="0">
                    <a:pos x="602" y="291"/>
                  </a:cxn>
                  <a:cxn ang="0">
                    <a:pos x="628" y="116"/>
                  </a:cxn>
                  <a:cxn ang="0">
                    <a:pos x="653" y="244"/>
                  </a:cxn>
                  <a:cxn ang="0">
                    <a:pos x="679" y="198"/>
                  </a:cxn>
                  <a:cxn ang="0">
                    <a:pos x="704" y="268"/>
                  </a:cxn>
                  <a:cxn ang="0">
                    <a:pos x="730" y="256"/>
                  </a:cxn>
                  <a:cxn ang="0">
                    <a:pos x="755" y="233"/>
                  </a:cxn>
                  <a:cxn ang="0">
                    <a:pos x="781" y="337"/>
                  </a:cxn>
                  <a:cxn ang="0">
                    <a:pos x="807" y="372"/>
                  </a:cxn>
                  <a:cxn ang="0">
                    <a:pos x="832" y="256"/>
                  </a:cxn>
                  <a:cxn ang="0">
                    <a:pos x="858" y="244"/>
                  </a:cxn>
                  <a:cxn ang="0">
                    <a:pos x="883" y="337"/>
                  </a:cxn>
                  <a:cxn ang="0">
                    <a:pos x="909" y="221"/>
                  </a:cxn>
                  <a:cxn ang="0">
                    <a:pos x="934" y="488"/>
                  </a:cxn>
                  <a:cxn ang="0">
                    <a:pos x="960" y="175"/>
                  </a:cxn>
                  <a:cxn ang="0">
                    <a:pos x="985" y="361"/>
                  </a:cxn>
                  <a:cxn ang="0">
                    <a:pos x="1011" y="291"/>
                  </a:cxn>
                  <a:cxn ang="0">
                    <a:pos x="1036" y="93"/>
                  </a:cxn>
                  <a:cxn ang="0">
                    <a:pos x="1062" y="221"/>
                  </a:cxn>
                  <a:cxn ang="0">
                    <a:pos x="1087" y="337"/>
                  </a:cxn>
                  <a:cxn ang="0">
                    <a:pos x="1113" y="535"/>
                  </a:cxn>
                  <a:cxn ang="0">
                    <a:pos x="1139" y="558"/>
                  </a:cxn>
                  <a:cxn ang="0">
                    <a:pos x="1164" y="732"/>
                  </a:cxn>
                  <a:cxn ang="0">
                    <a:pos x="1189" y="814"/>
                  </a:cxn>
                  <a:cxn ang="0">
                    <a:pos x="1215" y="814"/>
                  </a:cxn>
                  <a:cxn ang="0">
                    <a:pos x="1240" y="825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4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25"/>
                    </a:lnTo>
                    <a:lnTo>
                      <a:pt x="71" y="837"/>
                    </a:lnTo>
                    <a:lnTo>
                      <a:pt x="76" y="825"/>
                    </a:lnTo>
                    <a:lnTo>
                      <a:pt x="82" y="837"/>
                    </a:lnTo>
                    <a:lnTo>
                      <a:pt x="87" y="837"/>
                    </a:lnTo>
                    <a:lnTo>
                      <a:pt x="92" y="837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14"/>
                    </a:lnTo>
                    <a:lnTo>
                      <a:pt x="117" y="814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14"/>
                    </a:lnTo>
                    <a:lnTo>
                      <a:pt x="158" y="814"/>
                    </a:lnTo>
                    <a:lnTo>
                      <a:pt x="163" y="825"/>
                    </a:lnTo>
                    <a:lnTo>
                      <a:pt x="168" y="825"/>
                    </a:lnTo>
                    <a:lnTo>
                      <a:pt x="173" y="802"/>
                    </a:lnTo>
                    <a:lnTo>
                      <a:pt x="179" y="825"/>
                    </a:lnTo>
                    <a:lnTo>
                      <a:pt x="184" y="802"/>
                    </a:lnTo>
                    <a:lnTo>
                      <a:pt x="189" y="802"/>
                    </a:lnTo>
                    <a:lnTo>
                      <a:pt x="194" y="790"/>
                    </a:lnTo>
                    <a:lnTo>
                      <a:pt x="199" y="779"/>
                    </a:lnTo>
                    <a:lnTo>
                      <a:pt x="204" y="825"/>
                    </a:lnTo>
                    <a:lnTo>
                      <a:pt x="209" y="744"/>
                    </a:lnTo>
                    <a:lnTo>
                      <a:pt x="214" y="779"/>
                    </a:lnTo>
                    <a:lnTo>
                      <a:pt x="219" y="779"/>
                    </a:lnTo>
                    <a:lnTo>
                      <a:pt x="224" y="802"/>
                    </a:lnTo>
                    <a:lnTo>
                      <a:pt x="230" y="802"/>
                    </a:lnTo>
                    <a:lnTo>
                      <a:pt x="235" y="721"/>
                    </a:lnTo>
                    <a:lnTo>
                      <a:pt x="240" y="709"/>
                    </a:lnTo>
                    <a:lnTo>
                      <a:pt x="245" y="709"/>
                    </a:lnTo>
                    <a:lnTo>
                      <a:pt x="250" y="779"/>
                    </a:lnTo>
                    <a:lnTo>
                      <a:pt x="255" y="605"/>
                    </a:lnTo>
                    <a:lnTo>
                      <a:pt x="260" y="767"/>
                    </a:lnTo>
                    <a:lnTo>
                      <a:pt x="265" y="674"/>
                    </a:lnTo>
                    <a:lnTo>
                      <a:pt x="270" y="709"/>
                    </a:lnTo>
                    <a:lnTo>
                      <a:pt x="275" y="744"/>
                    </a:lnTo>
                    <a:lnTo>
                      <a:pt x="281" y="721"/>
                    </a:lnTo>
                    <a:lnTo>
                      <a:pt x="286" y="732"/>
                    </a:lnTo>
                    <a:lnTo>
                      <a:pt x="291" y="732"/>
                    </a:lnTo>
                    <a:lnTo>
                      <a:pt x="296" y="663"/>
                    </a:lnTo>
                    <a:lnTo>
                      <a:pt x="301" y="628"/>
                    </a:lnTo>
                    <a:lnTo>
                      <a:pt x="306" y="639"/>
                    </a:lnTo>
                    <a:lnTo>
                      <a:pt x="311" y="558"/>
                    </a:lnTo>
                    <a:lnTo>
                      <a:pt x="316" y="558"/>
                    </a:lnTo>
                    <a:lnTo>
                      <a:pt x="321" y="686"/>
                    </a:lnTo>
                    <a:lnTo>
                      <a:pt x="327" y="523"/>
                    </a:lnTo>
                    <a:lnTo>
                      <a:pt x="332" y="732"/>
                    </a:lnTo>
                    <a:lnTo>
                      <a:pt x="337" y="593"/>
                    </a:lnTo>
                    <a:lnTo>
                      <a:pt x="342" y="628"/>
                    </a:lnTo>
                    <a:lnTo>
                      <a:pt x="347" y="593"/>
                    </a:lnTo>
                    <a:lnTo>
                      <a:pt x="352" y="488"/>
                    </a:lnTo>
                    <a:lnTo>
                      <a:pt x="357" y="488"/>
                    </a:lnTo>
                    <a:lnTo>
                      <a:pt x="362" y="442"/>
                    </a:lnTo>
                    <a:lnTo>
                      <a:pt x="367" y="535"/>
                    </a:lnTo>
                    <a:lnTo>
                      <a:pt x="372" y="477"/>
                    </a:lnTo>
                    <a:lnTo>
                      <a:pt x="378" y="430"/>
                    </a:lnTo>
                    <a:lnTo>
                      <a:pt x="383" y="407"/>
                    </a:lnTo>
                    <a:lnTo>
                      <a:pt x="388" y="361"/>
                    </a:lnTo>
                    <a:lnTo>
                      <a:pt x="393" y="500"/>
                    </a:lnTo>
                    <a:lnTo>
                      <a:pt x="398" y="477"/>
                    </a:lnTo>
                    <a:lnTo>
                      <a:pt x="403" y="361"/>
                    </a:lnTo>
                    <a:lnTo>
                      <a:pt x="408" y="233"/>
                    </a:lnTo>
                    <a:lnTo>
                      <a:pt x="413" y="384"/>
                    </a:lnTo>
                    <a:lnTo>
                      <a:pt x="419" y="209"/>
                    </a:lnTo>
                    <a:lnTo>
                      <a:pt x="424" y="268"/>
                    </a:lnTo>
                    <a:lnTo>
                      <a:pt x="429" y="198"/>
                    </a:lnTo>
                    <a:lnTo>
                      <a:pt x="434" y="186"/>
                    </a:lnTo>
                    <a:lnTo>
                      <a:pt x="439" y="175"/>
                    </a:lnTo>
                    <a:lnTo>
                      <a:pt x="444" y="175"/>
                    </a:lnTo>
                    <a:lnTo>
                      <a:pt x="449" y="326"/>
                    </a:lnTo>
                    <a:lnTo>
                      <a:pt x="454" y="291"/>
                    </a:lnTo>
                    <a:lnTo>
                      <a:pt x="459" y="291"/>
                    </a:lnTo>
                    <a:lnTo>
                      <a:pt x="464" y="384"/>
                    </a:lnTo>
                    <a:lnTo>
                      <a:pt x="470" y="58"/>
                    </a:lnTo>
                    <a:lnTo>
                      <a:pt x="475" y="93"/>
                    </a:lnTo>
                    <a:lnTo>
                      <a:pt x="480" y="175"/>
                    </a:lnTo>
                    <a:lnTo>
                      <a:pt x="485" y="326"/>
                    </a:lnTo>
                    <a:lnTo>
                      <a:pt x="490" y="70"/>
                    </a:lnTo>
                    <a:lnTo>
                      <a:pt x="495" y="140"/>
                    </a:lnTo>
                    <a:lnTo>
                      <a:pt x="500" y="326"/>
                    </a:lnTo>
                    <a:lnTo>
                      <a:pt x="505" y="244"/>
                    </a:lnTo>
                    <a:lnTo>
                      <a:pt x="510" y="326"/>
                    </a:lnTo>
                    <a:lnTo>
                      <a:pt x="515" y="302"/>
                    </a:lnTo>
                    <a:lnTo>
                      <a:pt x="521" y="198"/>
                    </a:lnTo>
                    <a:lnTo>
                      <a:pt x="526" y="256"/>
                    </a:lnTo>
                    <a:lnTo>
                      <a:pt x="531" y="233"/>
                    </a:lnTo>
                    <a:lnTo>
                      <a:pt x="536" y="395"/>
                    </a:lnTo>
                    <a:lnTo>
                      <a:pt x="541" y="256"/>
                    </a:lnTo>
                    <a:lnTo>
                      <a:pt x="546" y="244"/>
                    </a:lnTo>
                    <a:lnTo>
                      <a:pt x="551" y="151"/>
                    </a:lnTo>
                    <a:lnTo>
                      <a:pt x="556" y="209"/>
                    </a:lnTo>
                    <a:lnTo>
                      <a:pt x="561" y="198"/>
                    </a:lnTo>
                    <a:lnTo>
                      <a:pt x="567" y="163"/>
                    </a:lnTo>
                    <a:lnTo>
                      <a:pt x="572" y="256"/>
                    </a:lnTo>
                    <a:lnTo>
                      <a:pt x="577" y="291"/>
                    </a:lnTo>
                    <a:lnTo>
                      <a:pt x="582" y="256"/>
                    </a:lnTo>
                    <a:lnTo>
                      <a:pt x="587" y="186"/>
                    </a:lnTo>
                    <a:lnTo>
                      <a:pt x="592" y="82"/>
                    </a:lnTo>
                    <a:lnTo>
                      <a:pt x="597" y="233"/>
                    </a:lnTo>
                    <a:lnTo>
                      <a:pt x="602" y="291"/>
                    </a:lnTo>
                    <a:lnTo>
                      <a:pt x="607" y="58"/>
                    </a:lnTo>
                    <a:lnTo>
                      <a:pt x="612" y="291"/>
                    </a:lnTo>
                    <a:lnTo>
                      <a:pt x="618" y="244"/>
                    </a:lnTo>
                    <a:lnTo>
                      <a:pt x="623" y="244"/>
                    </a:lnTo>
                    <a:lnTo>
                      <a:pt x="628" y="116"/>
                    </a:lnTo>
                    <a:lnTo>
                      <a:pt x="633" y="47"/>
                    </a:lnTo>
                    <a:lnTo>
                      <a:pt x="638" y="140"/>
                    </a:lnTo>
                    <a:lnTo>
                      <a:pt x="643" y="163"/>
                    </a:lnTo>
                    <a:lnTo>
                      <a:pt x="648" y="221"/>
                    </a:lnTo>
                    <a:lnTo>
                      <a:pt x="653" y="244"/>
                    </a:lnTo>
                    <a:lnTo>
                      <a:pt x="659" y="24"/>
                    </a:lnTo>
                    <a:lnTo>
                      <a:pt x="664" y="326"/>
                    </a:lnTo>
                    <a:lnTo>
                      <a:pt x="669" y="151"/>
                    </a:lnTo>
                    <a:lnTo>
                      <a:pt x="674" y="337"/>
                    </a:lnTo>
                    <a:lnTo>
                      <a:pt x="679" y="198"/>
                    </a:lnTo>
                    <a:lnTo>
                      <a:pt x="684" y="326"/>
                    </a:lnTo>
                    <a:lnTo>
                      <a:pt x="689" y="151"/>
                    </a:lnTo>
                    <a:lnTo>
                      <a:pt x="694" y="256"/>
                    </a:lnTo>
                    <a:lnTo>
                      <a:pt x="699" y="244"/>
                    </a:lnTo>
                    <a:lnTo>
                      <a:pt x="704" y="268"/>
                    </a:lnTo>
                    <a:lnTo>
                      <a:pt x="710" y="349"/>
                    </a:lnTo>
                    <a:lnTo>
                      <a:pt x="715" y="163"/>
                    </a:lnTo>
                    <a:lnTo>
                      <a:pt x="720" y="442"/>
                    </a:lnTo>
                    <a:lnTo>
                      <a:pt x="725" y="209"/>
                    </a:lnTo>
                    <a:lnTo>
                      <a:pt x="730" y="256"/>
                    </a:lnTo>
                    <a:lnTo>
                      <a:pt x="735" y="326"/>
                    </a:lnTo>
                    <a:lnTo>
                      <a:pt x="740" y="198"/>
                    </a:lnTo>
                    <a:lnTo>
                      <a:pt x="745" y="372"/>
                    </a:lnTo>
                    <a:lnTo>
                      <a:pt x="750" y="221"/>
                    </a:lnTo>
                    <a:lnTo>
                      <a:pt x="755" y="233"/>
                    </a:lnTo>
                    <a:lnTo>
                      <a:pt x="761" y="279"/>
                    </a:lnTo>
                    <a:lnTo>
                      <a:pt x="766" y="407"/>
                    </a:lnTo>
                    <a:lnTo>
                      <a:pt x="771" y="163"/>
                    </a:lnTo>
                    <a:lnTo>
                      <a:pt x="776" y="337"/>
                    </a:lnTo>
                    <a:lnTo>
                      <a:pt x="781" y="337"/>
                    </a:lnTo>
                    <a:lnTo>
                      <a:pt x="786" y="384"/>
                    </a:lnTo>
                    <a:lnTo>
                      <a:pt x="791" y="291"/>
                    </a:lnTo>
                    <a:lnTo>
                      <a:pt x="796" y="279"/>
                    </a:lnTo>
                    <a:lnTo>
                      <a:pt x="801" y="279"/>
                    </a:lnTo>
                    <a:lnTo>
                      <a:pt x="807" y="372"/>
                    </a:lnTo>
                    <a:lnTo>
                      <a:pt x="812" y="314"/>
                    </a:lnTo>
                    <a:lnTo>
                      <a:pt x="817" y="244"/>
                    </a:lnTo>
                    <a:lnTo>
                      <a:pt x="822" y="279"/>
                    </a:lnTo>
                    <a:lnTo>
                      <a:pt x="827" y="302"/>
                    </a:lnTo>
                    <a:lnTo>
                      <a:pt x="832" y="256"/>
                    </a:lnTo>
                    <a:lnTo>
                      <a:pt x="837" y="442"/>
                    </a:lnTo>
                    <a:lnTo>
                      <a:pt x="842" y="233"/>
                    </a:lnTo>
                    <a:lnTo>
                      <a:pt x="847" y="337"/>
                    </a:lnTo>
                    <a:lnTo>
                      <a:pt x="852" y="337"/>
                    </a:lnTo>
                    <a:lnTo>
                      <a:pt x="858" y="244"/>
                    </a:lnTo>
                    <a:lnTo>
                      <a:pt x="863" y="314"/>
                    </a:lnTo>
                    <a:lnTo>
                      <a:pt x="868" y="361"/>
                    </a:lnTo>
                    <a:lnTo>
                      <a:pt x="873" y="349"/>
                    </a:lnTo>
                    <a:lnTo>
                      <a:pt x="878" y="314"/>
                    </a:lnTo>
                    <a:lnTo>
                      <a:pt x="883" y="337"/>
                    </a:lnTo>
                    <a:lnTo>
                      <a:pt x="888" y="349"/>
                    </a:lnTo>
                    <a:lnTo>
                      <a:pt x="893" y="268"/>
                    </a:lnTo>
                    <a:lnTo>
                      <a:pt x="899" y="477"/>
                    </a:lnTo>
                    <a:lnTo>
                      <a:pt x="904" y="361"/>
                    </a:lnTo>
                    <a:lnTo>
                      <a:pt x="909" y="221"/>
                    </a:lnTo>
                    <a:lnTo>
                      <a:pt x="914" y="221"/>
                    </a:lnTo>
                    <a:lnTo>
                      <a:pt x="919" y="175"/>
                    </a:lnTo>
                    <a:lnTo>
                      <a:pt x="924" y="233"/>
                    </a:lnTo>
                    <a:lnTo>
                      <a:pt x="929" y="209"/>
                    </a:lnTo>
                    <a:lnTo>
                      <a:pt x="934" y="488"/>
                    </a:lnTo>
                    <a:lnTo>
                      <a:pt x="939" y="314"/>
                    </a:lnTo>
                    <a:lnTo>
                      <a:pt x="944" y="151"/>
                    </a:lnTo>
                    <a:lnTo>
                      <a:pt x="950" y="291"/>
                    </a:lnTo>
                    <a:lnTo>
                      <a:pt x="955" y="233"/>
                    </a:lnTo>
                    <a:lnTo>
                      <a:pt x="960" y="175"/>
                    </a:lnTo>
                    <a:lnTo>
                      <a:pt x="965" y="163"/>
                    </a:lnTo>
                    <a:lnTo>
                      <a:pt x="970" y="116"/>
                    </a:lnTo>
                    <a:lnTo>
                      <a:pt x="975" y="198"/>
                    </a:lnTo>
                    <a:lnTo>
                      <a:pt x="980" y="209"/>
                    </a:lnTo>
                    <a:lnTo>
                      <a:pt x="985" y="361"/>
                    </a:lnTo>
                    <a:lnTo>
                      <a:pt x="990" y="105"/>
                    </a:lnTo>
                    <a:lnTo>
                      <a:pt x="995" y="93"/>
                    </a:lnTo>
                    <a:lnTo>
                      <a:pt x="1000" y="0"/>
                    </a:lnTo>
                    <a:lnTo>
                      <a:pt x="1006" y="186"/>
                    </a:lnTo>
                    <a:lnTo>
                      <a:pt x="1011" y="291"/>
                    </a:lnTo>
                    <a:lnTo>
                      <a:pt x="1016" y="244"/>
                    </a:lnTo>
                    <a:lnTo>
                      <a:pt x="1021" y="35"/>
                    </a:lnTo>
                    <a:lnTo>
                      <a:pt x="1026" y="186"/>
                    </a:lnTo>
                    <a:lnTo>
                      <a:pt x="1031" y="279"/>
                    </a:lnTo>
                    <a:lnTo>
                      <a:pt x="1036" y="93"/>
                    </a:lnTo>
                    <a:lnTo>
                      <a:pt x="1041" y="198"/>
                    </a:lnTo>
                    <a:lnTo>
                      <a:pt x="1047" y="175"/>
                    </a:lnTo>
                    <a:lnTo>
                      <a:pt x="1052" y="233"/>
                    </a:lnTo>
                    <a:lnTo>
                      <a:pt x="1057" y="58"/>
                    </a:lnTo>
                    <a:lnTo>
                      <a:pt x="1062" y="221"/>
                    </a:lnTo>
                    <a:lnTo>
                      <a:pt x="1067" y="279"/>
                    </a:lnTo>
                    <a:lnTo>
                      <a:pt x="1072" y="384"/>
                    </a:lnTo>
                    <a:lnTo>
                      <a:pt x="1077" y="326"/>
                    </a:lnTo>
                    <a:lnTo>
                      <a:pt x="1082" y="268"/>
                    </a:lnTo>
                    <a:lnTo>
                      <a:pt x="1087" y="337"/>
                    </a:lnTo>
                    <a:lnTo>
                      <a:pt x="1092" y="291"/>
                    </a:lnTo>
                    <a:lnTo>
                      <a:pt x="1098" y="488"/>
                    </a:lnTo>
                    <a:lnTo>
                      <a:pt x="1103" y="477"/>
                    </a:lnTo>
                    <a:lnTo>
                      <a:pt x="1108" y="488"/>
                    </a:lnTo>
                    <a:lnTo>
                      <a:pt x="1113" y="535"/>
                    </a:lnTo>
                    <a:lnTo>
                      <a:pt x="1118" y="546"/>
                    </a:lnTo>
                    <a:lnTo>
                      <a:pt x="1123" y="500"/>
                    </a:lnTo>
                    <a:lnTo>
                      <a:pt x="1128" y="546"/>
                    </a:lnTo>
                    <a:lnTo>
                      <a:pt x="1133" y="674"/>
                    </a:lnTo>
                    <a:lnTo>
                      <a:pt x="1139" y="558"/>
                    </a:lnTo>
                    <a:lnTo>
                      <a:pt x="1144" y="593"/>
                    </a:lnTo>
                    <a:lnTo>
                      <a:pt x="1149" y="721"/>
                    </a:lnTo>
                    <a:lnTo>
                      <a:pt x="1154" y="709"/>
                    </a:lnTo>
                    <a:lnTo>
                      <a:pt x="1159" y="709"/>
                    </a:lnTo>
                    <a:lnTo>
                      <a:pt x="1164" y="732"/>
                    </a:lnTo>
                    <a:lnTo>
                      <a:pt x="1169" y="756"/>
                    </a:lnTo>
                    <a:lnTo>
                      <a:pt x="1174" y="779"/>
                    </a:lnTo>
                    <a:lnTo>
                      <a:pt x="1179" y="802"/>
                    </a:lnTo>
                    <a:lnTo>
                      <a:pt x="1184" y="779"/>
                    </a:lnTo>
                    <a:lnTo>
                      <a:pt x="1189" y="814"/>
                    </a:lnTo>
                    <a:lnTo>
                      <a:pt x="1195" y="814"/>
                    </a:lnTo>
                    <a:lnTo>
                      <a:pt x="1200" y="814"/>
                    </a:lnTo>
                    <a:lnTo>
                      <a:pt x="1205" y="837"/>
                    </a:lnTo>
                    <a:lnTo>
                      <a:pt x="1210" y="814"/>
                    </a:lnTo>
                    <a:lnTo>
                      <a:pt x="1215" y="814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25"/>
                    </a:lnTo>
                    <a:lnTo>
                      <a:pt x="1240" y="825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379" name="Freeform 11"/>
              <p:cNvSpPr>
                <a:spLocks/>
              </p:cNvSpPr>
              <p:nvPr/>
            </p:nvSpPr>
            <p:spPr bwMode="auto">
              <a:xfrm flipV="1">
                <a:off x="1082109" y="2557693"/>
                <a:ext cx="1037205" cy="63477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99"/>
                  </a:cxn>
                  <a:cxn ang="0">
                    <a:pos x="2822" y="2399"/>
                  </a:cxn>
                  <a:cxn ang="0">
                    <a:pos x="2822" y="0"/>
                  </a:cxn>
                </a:cxnLst>
                <a:rect l="0" t="0" r="r" b="b"/>
                <a:pathLst>
                  <a:path w="2822" h="2399">
                    <a:moveTo>
                      <a:pt x="0" y="0"/>
                    </a:moveTo>
                    <a:lnTo>
                      <a:pt x="0" y="2399"/>
                    </a:lnTo>
                    <a:lnTo>
                      <a:pt x="2822" y="2399"/>
                    </a:lnTo>
                    <a:lnTo>
                      <a:pt x="2822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381" name="Rectangle 13"/>
              <p:cNvSpPr>
                <a:spLocks noChangeArrowheads="1"/>
              </p:cNvSpPr>
              <p:nvPr/>
            </p:nvSpPr>
            <p:spPr bwMode="auto">
              <a:xfrm>
                <a:off x="930275" y="2182813"/>
                <a:ext cx="2074863" cy="19923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41" name="Groep 40"/>
            <p:cNvGrpSpPr/>
            <p:nvPr/>
          </p:nvGrpSpPr>
          <p:grpSpPr>
            <a:xfrm>
              <a:off x="1893165" y="2528127"/>
              <a:ext cx="1163039" cy="1191023"/>
              <a:chOff x="930275" y="2182813"/>
              <a:chExt cx="2074863" cy="1992312"/>
            </a:xfrm>
          </p:grpSpPr>
          <p:sp>
            <p:nvSpPr>
              <p:cNvPr id="42" name="Freeform 7"/>
              <p:cNvSpPr>
                <a:spLocks/>
              </p:cNvSpPr>
              <p:nvPr/>
            </p:nvSpPr>
            <p:spPr bwMode="auto">
              <a:xfrm>
                <a:off x="930275" y="2846388"/>
                <a:ext cx="2074863" cy="1328737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25"/>
                  </a:cxn>
                  <a:cxn ang="0">
                    <a:pos x="92" y="837"/>
                  </a:cxn>
                  <a:cxn ang="0">
                    <a:pos x="117" y="814"/>
                  </a:cxn>
                  <a:cxn ang="0">
                    <a:pos x="143" y="825"/>
                  </a:cxn>
                  <a:cxn ang="0">
                    <a:pos x="168" y="825"/>
                  </a:cxn>
                  <a:cxn ang="0">
                    <a:pos x="194" y="790"/>
                  </a:cxn>
                  <a:cxn ang="0">
                    <a:pos x="219" y="779"/>
                  </a:cxn>
                  <a:cxn ang="0">
                    <a:pos x="245" y="709"/>
                  </a:cxn>
                  <a:cxn ang="0">
                    <a:pos x="270" y="709"/>
                  </a:cxn>
                  <a:cxn ang="0">
                    <a:pos x="296" y="663"/>
                  </a:cxn>
                  <a:cxn ang="0">
                    <a:pos x="321" y="686"/>
                  </a:cxn>
                  <a:cxn ang="0">
                    <a:pos x="347" y="593"/>
                  </a:cxn>
                  <a:cxn ang="0">
                    <a:pos x="372" y="477"/>
                  </a:cxn>
                  <a:cxn ang="0">
                    <a:pos x="398" y="477"/>
                  </a:cxn>
                  <a:cxn ang="0">
                    <a:pos x="424" y="268"/>
                  </a:cxn>
                  <a:cxn ang="0">
                    <a:pos x="449" y="326"/>
                  </a:cxn>
                  <a:cxn ang="0">
                    <a:pos x="475" y="93"/>
                  </a:cxn>
                  <a:cxn ang="0">
                    <a:pos x="500" y="326"/>
                  </a:cxn>
                  <a:cxn ang="0">
                    <a:pos x="526" y="256"/>
                  </a:cxn>
                  <a:cxn ang="0">
                    <a:pos x="551" y="151"/>
                  </a:cxn>
                  <a:cxn ang="0">
                    <a:pos x="577" y="291"/>
                  </a:cxn>
                  <a:cxn ang="0">
                    <a:pos x="602" y="291"/>
                  </a:cxn>
                  <a:cxn ang="0">
                    <a:pos x="628" y="116"/>
                  </a:cxn>
                  <a:cxn ang="0">
                    <a:pos x="653" y="244"/>
                  </a:cxn>
                  <a:cxn ang="0">
                    <a:pos x="679" y="198"/>
                  </a:cxn>
                  <a:cxn ang="0">
                    <a:pos x="704" y="268"/>
                  </a:cxn>
                  <a:cxn ang="0">
                    <a:pos x="730" y="256"/>
                  </a:cxn>
                  <a:cxn ang="0">
                    <a:pos x="755" y="233"/>
                  </a:cxn>
                  <a:cxn ang="0">
                    <a:pos x="781" y="337"/>
                  </a:cxn>
                  <a:cxn ang="0">
                    <a:pos x="807" y="372"/>
                  </a:cxn>
                  <a:cxn ang="0">
                    <a:pos x="832" y="256"/>
                  </a:cxn>
                  <a:cxn ang="0">
                    <a:pos x="858" y="244"/>
                  </a:cxn>
                  <a:cxn ang="0">
                    <a:pos x="883" y="337"/>
                  </a:cxn>
                  <a:cxn ang="0">
                    <a:pos x="909" y="221"/>
                  </a:cxn>
                  <a:cxn ang="0">
                    <a:pos x="934" y="488"/>
                  </a:cxn>
                  <a:cxn ang="0">
                    <a:pos x="960" y="175"/>
                  </a:cxn>
                  <a:cxn ang="0">
                    <a:pos x="985" y="361"/>
                  </a:cxn>
                  <a:cxn ang="0">
                    <a:pos x="1011" y="291"/>
                  </a:cxn>
                  <a:cxn ang="0">
                    <a:pos x="1036" y="93"/>
                  </a:cxn>
                  <a:cxn ang="0">
                    <a:pos x="1062" y="221"/>
                  </a:cxn>
                  <a:cxn ang="0">
                    <a:pos x="1087" y="337"/>
                  </a:cxn>
                  <a:cxn ang="0">
                    <a:pos x="1113" y="535"/>
                  </a:cxn>
                  <a:cxn ang="0">
                    <a:pos x="1139" y="558"/>
                  </a:cxn>
                  <a:cxn ang="0">
                    <a:pos x="1164" y="732"/>
                  </a:cxn>
                  <a:cxn ang="0">
                    <a:pos x="1189" y="814"/>
                  </a:cxn>
                  <a:cxn ang="0">
                    <a:pos x="1215" y="814"/>
                  </a:cxn>
                  <a:cxn ang="0">
                    <a:pos x="1240" y="825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4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25"/>
                    </a:lnTo>
                    <a:lnTo>
                      <a:pt x="71" y="837"/>
                    </a:lnTo>
                    <a:lnTo>
                      <a:pt x="76" y="825"/>
                    </a:lnTo>
                    <a:lnTo>
                      <a:pt x="82" y="837"/>
                    </a:lnTo>
                    <a:lnTo>
                      <a:pt x="87" y="837"/>
                    </a:lnTo>
                    <a:lnTo>
                      <a:pt x="92" y="837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14"/>
                    </a:lnTo>
                    <a:lnTo>
                      <a:pt x="117" y="814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14"/>
                    </a:lnTo>
                    <a:lnTo>
                      <a:pt x="158" y="814"/>
                    </a:lnTo>
                    <a:lnTo>
                      <a:pt x="163" y="825"/>
                    </a:lnTo>
                    <a:lnTo>
                      <a:pt x="168" y="825"/>
                    </a:lnTo>
                    <a:lnTo>
                      <a:pt x="173" y="802"/>
                    </a:lnTo>
                    <a:lnTo>
                      <a:pt x="179" y="825"/>
                    </a:lnTo>
                    <a:lnTo>
                      <a:pt x="184" y="802"/>
                    </a:lnTo>
                    <a:lnTo>
                      <a:pt x="189" y="802"/>
                    </a:lnTo>
                    <a:lnTo>
                      <a:pt x="194" y="790"/>
                    </a:lnTo>
                    <a:lnTo>
                      <a:pt x="199" y="779"/>
                    </a:lnTo>
                    <a:lnTo>
                      <a:pt x="204" y="825"/>
                    </a:lnTo>
                    <a:lnTo>
                      <a:pt x="209" y="744"/>
                    </a:lnTo>
                    <a:lnTo>
                      <a:pt x="214" y="779"/>
                    </a:lnTo>
                    <a:lnTo>
                      <a:pt x="219" y="779"/>
                    </a:lnTo>
                    <a:lnTo>
                      <a:pt x="224" y="802"/>
                    </a:lnTo>
                    <a:lnTo>
                      <a:pt x="230" y="802"/>
                    </a:lnTo>
                    <a:lnTo>
                      <a:pt x="235" y="721"/>
                    </a:lnTo>
                    <a:lnTo>
                      <a:pt x="240" y="709"/>
                    </a:lnTo>
                    <a:lnTo>
                      <a:pt x="245" y="709"/>
                    </a:lnTo>
                    <a:lnTo>
                      <a:pt x="250" y="779"/>
                    </a:lnTo>
                    <a:lnTo>
                      <a:pt x="255" y="605"/>
                    </a:lnTo>
                    <a:lnTo>
                      <a:pt x="260" y="767"/>
                    </a:lnTo>
                    <a:lnTo>
                      <a:pt x="265" y="674"/>
                    </a:lnTo>
                    <a:lnTo>
                      <a:pt x="270" y="709"/>
                    </a:lnTo>
                    <a:lnTo>
                      <a:pt x="275" y="744"/>
                    </a:lnTo>
                    <a:lnTo>
                      <a:pt x="281" y="721"/>
                    </a:lnTo>
                    <a:lnTo>
                      <a:pt x="286" y="732"/>
                    </a:lnTo>
                    <a:lnTo>
                      <a:pt x="291" y="732"/>
                    </a:lnTo>
                    <a:lnTo>
                      <a:pt x="296" y="663"/>
                    </a:lnTo>
                    <a:lnTo>
                      <a:pt x="301" y="628"/>
                    </a:lnTo>
                    <a:lnTo>
                      <a:pt x="306" y="639"/>
                    </a:lnTo>
                    <a:lnTo>
                      <a:pt x="311" y="558"/>
                    </a:lnTo>
                    <a:lnTo>
                      <a:pt x="316" y="558"/>
                    </a:lnTo>
                    <a:lnTo>
                      <a:pt x="321" y="686"/>
                    </a:lnTo>
                    <a:lnTo>
                      <a:pt x="327" y="523"/>
                    </a:lnTo>
                    <a:lnTo>
                      <a:pt x="332" y="732"/>
                    </a:lnTo>
                    <a:lnTo>
                      <a:pt x="337" y="593"/>
                    </a:lnTo>
                    <a:lnTo>
                      <a:pt x="342" y="628"/>
                    </a:lnTo>
                    <a:lnTo>
                      <a:pt x="347" y="593"/>
                    </a:lnTo>
                    <a:lnTo>
                      <a:pt x="352" y="488"/>
                    </a:lnTo>
                    <a:lnTo>
                      <a:pt x="357" y="488"/>
                    </a:lnTo>
                    <a:lnTo>
                      <a:pt x="362" y="442"/>
                    </a:lnTo>
                    <a:lnTo>
                      <a:pt x="367" y="535"/>
                    </a:lnTo>
                    <a:lnTo>
                      <a:pt x="372" y="477"/>
                    </a:lnTo>
                    <a:lnTo>
                      <a:pt x="378" y="430"/>
                    </a:lnTo>
                    <a:lnTo>
                      <a:pt x="383" y="407"/>
                    </a:lnTo>
                    <a:lnTo>
                      <a:pt x="388" y="361"/>
                    </a:lnTo>
                    <a:lnTo>
                      <a:pt x="393" y="500"/>
                    </a:lnTo>
                    <a:lnTo>
                      <a:pt x="398" y="477"/>
                    </a:lnTo>
                    <a:lnTo>
                      <a:pt x="403" y="361"/>
                    </a:lnTo>
                    <a:lnTo>
                      <a:pt x="408" y="233"/>
                    </a:lnTo>
                    <a:lnTo>
                      <a:pt x="413" y="384"/>
                    </a:lnTo>
                    <a:lnTo>
                      <a:pt x="419" y="209"/>
                    </a:lnTo>
                    <a:lnTo>
                      <a:pt x="424" y="268"/>
                    </a:lnTo>
                    <a:lnTo>
                      <a:pt x="429" y="198"/>
                    </a:lnTo>
                    <a:lnTo>
                      <a:pt x="434" y="186"/>
                    </a:lnTo>
                    <a:lnTo>
                      <a:pt x="439" y="175"/>
                    </a:lnTo>
                    <a:lnTo>
                      <a:pt x="444" y="175"/>
                    </a:lnTo>
                    <a:lnTo>
                      <a:pt x="449" y="326"/>
                    </a:lnTo>
                    <a:lnTo>
                      <a:pt x="454" y="291"/>
                    </a:lnTo>
                    <a:lnTo>
                      <a:pt x="459" y="291"/>
                    </a:lnTo>
                    <a:lnTo>
                      <a:pt x="464" y="384"/>
                    </a:lnTo>
                    <a:lnTo>
                      <a:pt x="470" y="58"/>
                    </a:lnTo>
                    <a:lnTo>
                      <a:pt x="475" y="93"/>
                    </a:lnTo>
                    <a:lnTo>
                      <a:pt x="480" y="175"/>
                    </a:lnTo>
                    <a:lnTo>
                      <a:pt x="485" y="326"/>
                    </a:lnTo>
                    <a:lnTo>
                      <a:pt x="490" y="70"/>
                    </a:lnTo>
                    <a:lnTo>
                      <a:pt x="495" y="140"/>
                    </a:lnTo>
                    <a:lnTo>
                      <a:pt x="500" y="326"/>
                    </a:lnTo>
                    <a:lnTo>
                      <a:pt x="505" y="244"/>
                    </a:lnTo>
                    <a:lnTo>
                      <a:pt x="510" y="326"/>
                    </a:lnTo>
                    <a:lnTo>
                      <a:pt x="515" y="302"/>
                    </a:lnTo>
                    <a:lnTo>
                      <a:pt x="521" y="198"/>
                    </a:lnTo>
                    <a:lnTo>
                      <a:pt x="526" y="256"/>
                    </a:lnTo>
                    <a:lnTo>
                      <a:pt x="531" y="233"/>
                    </a:lnTo>
                    <a:lnTo>
                      <a:pt x="536" y="395"/>
                    </a:lnTo>
                    <a:lnTo>
                      <a:pt x="541" y="256"/>
                    </a:lnTo>
                    <a:lnTo>
                      <a:pt x="546" y="244"/>
                    </a:lnTo>
                    <a:lnTo>
                      <a:pt x="551" y="151"/>
                    </a:lnTo>
                    <a:lnTo>
                      <a:pt x="556" y="209"/>
                    </a:lnTo>
                    <a:lnTo>
                      <a:pt x="561" y="198"/>
                    </a:lnTo>
                    <a:lnTo>
                      <a:pt x="567" y="163"/>
                    </a:lnTo>
                    <a:lnTo>
                      <a:pt x="572" y="256"/>
                    </a:lnTo>
                    <a:lnTo>
                      <a:pt x="577" y="291"/>
                    </a:lnTo>
                    <a:lnTo>
                      <a:pt x="582" y="256"/>
                    </a:lnTo>
                    <a:lnTo>
                      <a:pt x="587" y="186"/>
                    </a:lnTo>
                    <a:lnTo>
                      <a:pt x="592" y="82"/>
                    </a:lnTo>
                    <a:lnTo>
                      <a:pt x="597" y="233"/>
                    </a:lnTo>
                    <a:lnTo>
                      <a:pt x="602" y="291"/>
                    </a:lnTo>
                    <a:lnTo>
                      <a:pt x="607" y="58"/>
                    </a:lnTo>
                    <a:lnTo>
                      <a:pt x="612" y="291"/>
                    </a:lnTo>
                    <a:lnTo>
                      <a:pt x="618" y="244"/>
                    </a:lnTo>
                    <a:lnTo>
                      <a:pt x="623" y="244"/>
                    </a:lnTo>
                    <a:lnTo>
                      <a:pt x="628" y="116"/>
                    </a:lnTo>
                    <a:lnTo>
                      <a:pt x="633" y="47"/>
                    </a:lnTo>
                    <a:lnTo>
                      <a:pt x="638" y="140"/>
                    </a:lnTo>
                    <a:lnTo>
                      <a:pt x="643" y="163"/>
                    </a:lnTo>
                    <a:lnTo>
                      <a:pt x="648" y="221"/>
                    </a:lnTo>
                    <a:lnTo>
                      <a:pt x="653" y="244"/>
                    </a:lnTo>
                    <a:lnTo>
                      <a:pt x="659" y="24"/>
                    </a:lnTo>
                    <a:lnTo>
                      <a:pt x="664" y="326"/>
                    </a:lnTo>
                    <a:lnTo>
                      <a:pt x="669" y="151"/>
                    </a:lnTo>
                    <a:lnTo>
                      <a:pt x="674" y="337"/>
                    </a:lnTo>
                    <a:lnTo>
                      <a:pt x="679" y="198"/>
                    </a:lnTo>
                    <a:lnTo>
                      <a:pt x="684" y="326"/>
                    </a:lnTo>
                    <a:lnTo>
                      <a:pt x="689" y="151"/>
                    </a:lnTo>
                    <a:lnTo>
                      <a:pt x="694" y="256"/>
                    </a:lnTo>
                    <a:lnTo>
                      <a:pt x="699" y="244"/>
                    </a:lnTo>
                    <a:lnTo>
                      <a:pt x="704" y="268"/>
                    </a:lnTo>
                    <a:lnTo>
                      <a:pt x="710" y="349"/>
                    </a:lnTo>
                    <a:lnTo>
                      <a:pt x="715" y="163"/>
                    </a:lnTo>
                    <a:lnTo>
                      <a:pt x="720" y="442"/>
                    </a:lnTo>
                    <a:lnTo>
                      <a:pt x="725" y="209"/>
                    </a:lnTo>
                    <a:lnTo>
                      <a:pt x="730" y="256"/>
                    </a:lnTo>
                    <a:lnTo>
                      <a:pt x="735" y="326"/>
                    </a:lnTo>
                    <a:lnTo>
                      <a:pt x="740" y="198"/>
                    </a:lnTo>
                    <a:lnTo>
                      <a:pt x="745" y="372"/>
                    </a:lnTo>
                    <a:lnTo>
                      <a:pt x="750" y="221"/>
                    </a:lnTo>
                    <a:lnTo>
                      <a:pt x="755" y="233"/>
                    </a:lnTo>
                    <a:lnTo>
                      <a:pt x="761" y="279"/>
                    </a:lnTo>
                    <a:lnTo>
                      <a:pt x="766" y="407"/>
                    </a:lnTo>
                    <a:lnTo>
                      <a:pt x="771" y="163"/>
                    </a:lnTo>
                    <a:lnTo>
                      <a:pt x="776" y="337"/>
                    </a:lnTo>
                    <a:lnTo>
                      <a:pt x="781" y="337"/>
                    </a:lnTo>
                    <a:lnTo>
                      <a:pt x="786" y="384"/>
                    </a:lnTo>
                    <a:lnTo>
                      <a:pt x="791" y="291"/>
                    </a:lnTo>
                    <a:lnTo>
                      <a:pt x="796" y="279"/>
                    </a:lnTo>
                    <a:lnTo>
                      <a:pt x="801" y="279"/>
                    </a:lnTo>
                    <a:lnTo>
                      <a:pt x="807" y="372"/>
                    </a:lnTo>
                    <a:lnTo>
                      <a:pt x="812" y="314"/>
                    </a:lnTo>
                    <a:lnTo>
                      <a:pt x="817" y="244"/>
                    </a:lnTo>
                    <a:lnTo>
                      <a:pt x="822" y="279"/>
                    </a:lnTo>
                    <a:lnTo>
                      <a:pt x="827" y="302"/>
                    </a:lnTo>
                    <a:lnTo>
                      <a:pt x="832" y="256"/>
                    </a:lnTo>
                    <a:lnTo>
                      <a:pt x="837" y="442"/>
                    </a:lnTo>
                    <a:lnTo>
                      <a:pt x="842" y="233"/>
                    </a:lnTo>
                    <a:lnTo>
                      <a:pt x="847" y="337"/>
                    </a:lnTo>
                    <a:lnTo>
                      <a:pt x="852" y="337"/>
                    </a:lnTo>
                    <a:lnTo>
                      <a:pt x="858" y="244"/>
                    </a:lnTo>
                    <a:lnTo>
                      <a:pt x="863" y="314"/>
                    </a:lnTo>
                    <a:lnTo>
                      <a:pt x="868" y="361"/>
                    </a:lnTo>
                    <a:lnTo>
                      <a:pt x="873" y="349"/>
                    </a:lnTo>
                    <a:lnTo>
                      <a:pt x="878" y="314"/>
                    </a:lnTo>
                    <a:lnTo>
                      <a:pt x="883" y="337"/>
                    </a:lnTo>
                    <a:lnTo>
                      <a:pt x="888" y="349"/>
                    </a:lnTo>
                    <a:lnTo>
                      <a:pt x="893" y="268"/>
                    </a:lnTo>
                    <a:lnTo>
                      <a:pt x="899" y="477"/>
                    </a:lnTo>
                    <a:lnTo>
                      <a:pt x="904" y="361"/>
                    </a:lnTo>
                    <a:lnTo>
                      <a:pt x="909" y="221"/>
                    </a:lnTo>
                    <a:lnTo>
                      <a:pt x="914" y="221"/>
                    </a:lnTo>
                    <a:lnTo>
                      <a:pt x="919" y="175"/>
                    </a:lnTo>
                    <a:lnTo>
                      <a:pt x="924" y="233"/>
                    </a:lnTo>
                    <a:lnTo>
                      <a:pt x="929" y="209"/>
                    </a:lnTo>
                    <a:lnTo>
                      <a:pt x="934" y="488"/>
                    </a:lnTo>
                    <a:lnTo>
                      <a:pt x="939" y="314"/>
                    </a:lnTo>
                    <a:lnTo>
                      <a:pt x="944" y="151"/>
                    </a:lnTo>
                    <a:lnTo>
                      <a:pt x="950" y="291"/>
                    </a:lnTo>
                    <a:lnTo>
                      <a:pt x="955" y="233"/>
                    </a:lnTo>
                    <a:lnTo>
                      <a:pt x="960" y="175"/>
                    </a:lnTo>
                    <a:lnTo>
                      <a:pt x="965" y="163"/>
                    </a:lnTo>
                    <a:lnTo>
                      <a:pt x="970" y="116"/>
                    </a:lnTo>
                    <a:lnTo>
                      <a:pt x="975" y="198"/>
                    </a:lnTo>
                    <a:lnTo>
                      <a:pt x="980" y="209"/>
                    </a:lnTo>
                    <a:lnTo>
                      <a:pt x="985" y="361"/>
                    </a:lnTo>
                    <a:lnTo>
                      <a:pt x="990" y="105"/>
                    </a:lnTo>
                    <a:lnTo>
                      <a:pt x="995" y="93"/>
                    </a:lnTo>
                    <a:lnTo>
                      <a:pt x="1000" y="0"/>
                    </a:lnTo>
                    <a:lnTo>
                      <a:pt x="1006" y="186"/>
                    </a:lnTo>
                    <a:lnTo>
                      <a:pt x="1011" y="291"/>
                    </a:lnTo>
                    <a:lnTo>
                      <a:pt x="1016" y="244"/>
                    </a:lnTo>
                    <a:lnTo>
                      <a:pt x="1021" y="35"/>
                    </a:lnTo>
                    <a:lnTo>
                      <a:pt x="1026" y="186"/>
                    </a:lnTo>
                    <a:lnTo>
                      <a:pt x="1031" y="279"/>
                    </a:lnTo>
                    <a:lnTo>
                      <a:pt x="1036" y="93"/>
                    </a:lnTo>
                    <a:lnTo>
                      <a:pt x="1041" y="198"/>
                    </a:lnTo>
                    <a:lnTo>
                      <a:pt x="1047" y="175"/>
                    </a:lnTo>
                    <a:lnTo>
                      <a:pt x="1052" y="233"/>
                    </a:lnTo>
                    <a:lnTo>
                      <a:pt x="1057" y="58"/>
                    </a:lnTo>
                    <a:lnTo>
                      <a:pt x="1062" y="221"/>
                    </a:lnTo>
                    <a:lnTo>
                      <a:pt x="1067" y="279"/>
                    </a:lnTo>
                    <a:lnTo>
                      <a:pt x="1072" y="384"/>
                    </a:lnTo>
                    <a:lnTo>
                      <a:pt x="1077" y="326"/>
                    </a:lnTo>
                    <a:lnTo>
                      <a:pt x="1082" y="268"/>
                    </a:lnTo>
                    <a:lnTo>
                      <a:pt x="1087" y="337"/>
                    </a:lnTo>
                    <a:lnTo>
                      <a:pt x="1092" y="291"/>
                    </a:lnTo>
                    <a:lnTo>
                      <a:pt x="1098" y="488"/>
                    </a:lnTo>
                    <a:lnTo>
                      <a:pt x="1103" y="477"/>
                    </a:lnTo>
                    <a:lnTo>
                      <a:pt x="1108" y="488"/>
                    </a:lnTo>
                    <a:lnTo>
                      <a:pt x="1113" y="535"/>
                    </a:lnTo>
                    <a:lnTo>
                      <a:pt x="1118" y="546"/>
                    </a:lnTo>
                    <a:lnTo>
                      <a:pt x="1123" y="500"/>
                    </a:lnTo>
                    <a:lnTo>
                      <a:pt x="1128" y="546"/>
                    </a:lnTo>
                    <a:lnTo>
                      <a:pt x="1133" y="674"/>
                    </a:lnTo>
                    <a:lnTo>
                      <a:pt x="1139" y="558"/>
                    </a:lnTo>
                    <a:lnTo>
                      <a:pt x="1144" y="593"/>
                    </a:lnTo>
                    <a:lnTo>
                      <a:pt x="1149" y="721"/>
                    </a:lnTo>
                    <a:lnTo>
                      <a:pt x="1154" y="709"/>
                    </a:lnTo>
                    <a:lnTo>
                      <a:pt x="1159" y="709"/>
                    </a:lnTo>
                    <a:lnTo>
                      <a:pt x="1164" y="732"/>
                    </a:lnTo>
                    <a:lnTo>
                      <a:pt x="1169" y="756"/>
                    </a:lnTo>
                    <a:lnTo>
                      <a:pt x="1174" y="779"/>
                    </a:lnTo>
                    <a:lnTo>
                      <a:pt x="1179" y="802"/>
                    </a:lnTo>
                    <a:lnTo>
                      <a:pt x="1184" y="779"/>
                    </a:lnTo>
                    <a:lnTo>
                      <a:pt x="1189" y="814"/>
                    </a:lnTo>
                    <a:lnTo>
                      <a:pt x="1195" y="814"/>
                    </a:lnTo>
                    <a:lnTo>
                      <a:pt x="1200" y="814"/>
                    </a:lnTo>
                    <a:lnTo>
                      <a:pt x="1205" y="837"/>
                    </a:lnTo>
                    <a:lnTo>
                      <a:pt x="1210" y="814"/>
                    </a:lnTo>
                    <a:lnTo>
                      <a:pt x="1215" y="814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25"/>
                    </a:lnTo>
                    <a:lnTo>
                      <a:pt x="1240" y="825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3" name="Freeform 8"/>
              <p:cNvSpPr>
                <a:spLocks/>
              </p:cNvSpPr>
              <p:nvPr/>
            </p:nvSpPr>
            <p:spPr bwMode="auto">
              <a:xfrm>
                <a:off x="930275" y="2846388"/>
                <a:ext cx="2074863" cy="1328737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25"/>
                  </a:cxn>
                  <a:cxn ang="0">
                    <a:pos x="92" y="837"/>
                  </a:cxn>
                  <a:cxn ang="0">
                    <a:pos x="117" y="814"/>
                  </a:cxn>
                  <a:cxn ang="0">
                    <a:pos x="143" y="825"/>
                  </a:cxn>
                  <a:cxn ang="0">
                    <a:pos x="168" y="825"/>
                  </a:cxn>
                  <a:cxn ang="0">
                    <a:pos x="194" y="790"/>
                  </a:cxn>
                  <a:cxn ang="0">
                    <a:pos x="219" y="779"/>
                  </a:cxn>
                  <a:cxn ang="0">
                    <a:pos x="245" y="709"/>
                  </a:cxn>
                  <a:cxn ang="0">
                    <a:pos x="270" y="709"/>
                  </a:cxn>
                  <a:cxn ang="0">
                    <a:pos x="296" y="663"/>
                  </a:cxn>
                  <a:cxn ang="0">
                    <a:pos x="321" y="686"/>
                  </a:cxn>
                  <a:cxn ang="0">
                    <a:pos x="347" y="593"/>
                  </a:cxn>
                  <a:cxn ang="0">
                    <a:pos x="372" y="477"/>
                  </a:cxn>
                  <a:cxn ang="0">
                    <a:pos x="398" y="477"/>
                  </a:cxn>
                  <a:cxn ang="0">
                    <a:pos x="424" y="268"/>
                  </a:cxn>
                  <a:cxn ang="0">
                    <a:pos x="449" y="326"/>
                  </a:cxn>
                  <a:cxn ang="0">
                    <a:pos x="475" y="93"/>
                  </a:cxn>
                  <a:cxn ang="0">
                    <a:pos x="500" y="326"/>
                  </a:cxn>
                  <a:cxn ang="0">
                    <a:pos x="526" y="256"/>
                  </a:cxn>
                  <a:cxn ang="0">
                    <a:pos x="551" y="151"/>
                  </a:cxn>
                  <a:cxn ang="0">
                    <a:pos x="577" y="291"/>
                  </a:cxn>
                  <a:cxn ang="0">
                    <a:pos x="602" y="291"/>
                  </a:cxn>
                  <a:cxn ang="0">
                    <a:pos x="628" y="116"/>
                  </a:cxn>
                  <a:cxn ang="0">
                    <a:pos x="653" y="244"/>
                  </a:cxn>
                  <a:cxn ang="0">
                    <a:pos x="679" y="198"/>
                  </a:cxn>
                  <a:cxn ang="0">
                    <a:pos x="704" y="268"/>
                  </a:cxn>
                  <a:cxn ang="0">
                    <a:pos x="730" y="256"/>
                  </a:cxn>
                  <a:cxn ang="0">
                    <a:pos x="755" y="233"/>
                  </a:cxn>
                  <a:cxn ang="0">
                    <a:pos x="781" y="337"/>
                  </a:cxn>
                  <a:cxn ang="0">
                    <a:pos x="807" y="372"/>
                  </a:cxn>
                  <a:cxn ang="0">
                    <a:pos x="832" y="256"/>
                  </a:cxn>
                  <a:cxn ang="0">
                    <a:pos x="858" y="244"/>
                  </a:cxn>
                  <a:cxn ang="0">
                    <a:pos x="883" y="337"/>
                  </a:cxn>
                  <a:cxn ang="0">
                    <a:pos x="909" y="221"/>
                  </a:cxn>
                  <a:cxn ang="0">
                    <a:pos x="934" y="488"/>
                  </a:cxn>
                  <a:cxn ang="0">
                    <a:pos x="960" y="175"/>
                  </a:cxn>
                  <a:cxn ang="0">
                    <a:pos x="985" y="361"/>
                  </a:cxn>
                  <a:cxn ang="0">
                    <a:pos x="1011" y="291"/>
                  </a:cxn>
                  <a:cxn ang="0">
                    <a:pos x="1036" y="93"/>
                  </a:cxn>
                  <a:cxn ang="0">
                    <a:pos x="1062" y="221"/>
                  </a:cxn>
                  <a:cxn ang="0">
                    <a:pos x="1087" y="337"/>
                  </a:cxn>
                  <a:cxn ang="0">
                    <a:pos x="1113" y="535"/>
                  </a:cxn>
                  <a:cxn ang="0">
                    <a:pos x="1139" y="558"/>
                  </a:cxn>
                  <a:cxn ang="0">
                    <a:pos x="1164" y="732"/>
                  </a:cxn>
                  <a:cxn ang="0">
                    <a:pos x="1189" y="814"/>
                  </a:cxn>
                  <a:cxn ang="0">
                    <a:pos x="1215" y="814"/>
                  </a:cxn>
                  <a:cxn ang="0">
                    <a:pos x="1240" y="825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4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25"/>
                    </a:lnTo>
                    <a:lnTo>
                      <a:pt x="71" y="837"/>
                    </a:lnTo>
                    <a:lnTo>
                      <a:pt x="76" y="825"/>
                    </a:lnTo>
                    <a:lnTo>
                      <a:pt x="82" y="837"/>
                    </a:lnTo>
                    <a:lnTo>
                      <a:pt x="87" y="837"/>
                    </a:lnTo>
                    <a:lnTo>
                      <a:pt x="92" y="837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14"/>
                    </a:lnTo>
                    <a:lnTo>
                      <a:pt x="117" y="814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14"/>
                    </a:lnTo>
                    <a:lnTo>
                      <a:pt x="158" y="814"/>
                    </a:lnTo>
                    <a:lnTo>
                      <a:pt x="163" y="825"/>
                    </a:lnTo>
                    <a:lnTo>
                      <a:pt x="168" y="825"/>
                    </a:lnTo>
                    <a:lnTo>
                      <a:pt x="173" y="802"/>
                    </a:lnTo>
                    <a:lnTo>
                      <a:pt x="179" y="825"/>
                    </a:lnTo>
                    <a:lnTo>
                      <a:pt x="184" y="802"/>
                    </a:lnTo>
                    <a:lnTo>
                      <a:pt x="189" y="802"/>
                    </a:lnTo>
                    <a:lnTo>
                      <a:pt x="194" y="790"/>
                    </a:lnTo>
                    <a:lnTo>
                      <a:pt x="199" y="779"/>
                    </a:lnTo>
                    <a:lnTo>
                      <a:pt x="204" y="825"/>
                    </a:lnTo>
                    <a:lnTo>
                      <a:pt x="209" y="744"/>
                    </a:lnTo>
                    <a:lnTo>
                      <a:pt x="214" y="779"/>
                    </a:lnTo>
                    <a:lnTo>
                      <a:pt x="219" y="779"/>
                    </a:lnTo>
                    <a:lnTo>
                      <a:pt x="224" y="802"/>
                    </a:lnTo>
                    <a:lnTo>
                      <a:pt x="230" y="802"/>
                    </a:lnTo>
                    <a:lnTo>
                      <a:pt x="235" y="721"/>
                    </a:lnTo>
                    <a:lnTo>
                      <a:pt x="240" y="709"/>
                    </a:lnTo>
                    <a:lnTo>
                      <a:pt x="245" y="709"/>
                    </a:lnTo>
                    <a:lnTo>
                      <a:pt x="250" y="779"/>
                    </a:lnTo>
                    <a:lnTo>
                      <a:pt x="255" y="605"/>
                    </a:lnTo>
                    <a:lnTo>
                      <a:pt x="260" y="767"/>
                    </a:lnTo>
                    <a:lnTo>
                      <a:pt x="265" y="674"/>
                    </a:lnTo>
                    <a:lnTo>
                      <a:pt x="270" y="709"/>
                    </a:lnTo>
                    <a:lnTo>
                      <a:pt x="275" y="744"/>
                    </a:lnTo>
                    <a:lnTo>
                      <a:pt x="281" y="721"/>
                    </a:lnTo>
                    <a:lnTo>
                      <a:pt x="286" y="732"/>
                    </a:lnTo>
                    <a:lnTo>
                      <a:pt x="291" y="732"/>
                    </a:lnTo>
                    <a:lnTo>
                      <a:pt x="296" y="663"/>
                    </a:lnTo>
                    <a:lnTo>
                      <a:pt x="301" y="628"/>
                    </a:lnTo>
                    <a:lnTo>
                      <a:pt x="306" y="639"/>
                    </a:lnTo>
                    <a:lnTo>
                      <a:pt x="311" y="558"/>
                    </a:lnTo>
                    <a:lnTo>
                      <a:pt x="316" y="558"/>
                    </a:lnTo>
                    <a:lnTo>
                      <a:pt x="321" y="686"/>
                    </a:lnTo>
                    <a:lnTo>
                      <a:pt x="327" y="523"/>
                    </a:lnTo>
                    <a:lnTo>
                      <a:pt x="332" y="732"/>
                    </a:lnTo>
                    <a:lnTo>
                      <a:pt x="337" y="593"/>
                    </a:lnTo>
                    <a:lnTo>
                      <a:pt x="342" y="628"/>
                    </a:lnTo>
                    <a:lnTo>
                      <a:pt x="347" y="593"/>
                    </a:lnTo>
                    <a:lnTo>
                      <a:pt x="352" y="488"/>
                    </a:lnTo>
                    <a:lnTo>
                      <a:pt x="357" y="488"/>
                    </a:lnTo>
                    <a:lnTo>
                      <a:pt x="362" y="442"/>
                    </a:lnTo>
                    <a:lnTo>
                      <a:pt x="367" y="535"/>
                    </a:lnTo>
                    <a:lnTo>
                      <a:pt x="372" y="477"/>
                    </a:lnTo>
                    <a:lnTo>
                      <a:pt x="378" y="430"/>
                    </a:lnTo>
                    <a:lnTo>
                      <a:pt x="383" y="407"/>
                    </a:lnTo>
                    <a:lnTo>
                      <a:pt x="388" y="361"/>
                    </a:lnTo>
                    <a:lnTo>
                      <a:pt x="393" y="500"/>
                    </a:lnTo>
                    <a:lnTo>
                      <a:pt x="398" y="477"/>
                    </a:lnTo>
                    <a:lnTo>
                      <a:pt x="403" y="361"/>
                    </a:lnTo>
                    <a:lnTo>
                      <a:pt x="408" y="233"/>
                    </a:lnTo>
                    <a:lnTo>
                      <a:pt x="413" y="384"/>
                    </a:lnTo>
                    <a:lnTo>
                      <a:pt x="419" y="209"/>
                    </a:lnTo>
                    <a:lnTo>
                      <a:pt x="424" y="268"/>
                    </a:lnTo>
                    <a:lnTo>
                      <a:pt x="429" y="198"/>
                    </a:lnTo>
                    <a:lnTo>
                      <a:pt x="434" y="186"/>
                    </a:lnTo>
                    <a:lnTo>
                      <a:pt x="439" y="175"/>
                    </a:lnTo>
                    <a:lnTo>
                      <a:pt x="444" y="175"/>
                    </a:lnTo>
                    <a:lnTo>
                      <a:pt x="449" y="326"/>
                    </a:lnTo>
                    <a:lnTo>
                      <a:pt x="454" y="291"/>
                    </a:lnTo>
                    <a:lnTo>
                      <a:pt x="459" y="291"/>
                    </a:lnTo>
                    <a:lnTo>
                      <a:pt x="464" y="384"/>
                    </a:lnTo>
                    <a:lnTo>
                      <a:pt x="470" y="58"/>
                    </a:lnTo>
                    <a:lnTo>
                      <a:pt x="475" y="93"/>
                    </a:lnTo>
                    <a:lnTo>
                      <a:pt x="480" y="175"/>
                    </a:lnTo>
                    <a:lnTo>
                      <a:pt x="485" y="326"/>
                    </a:lnTo>
                    <a:lnTo>
                      <a:pt x="490" y="70"/>
                    </a:lnTo>
                    <a:lnTo>
                      <a:pt x="495" y="140"/>
                    </a:lnTo>
                    <a:lnTo>
                      <a:pt x="500" y="326"/>
                    </a:lnTo>
                    <a:lnTo>
                      <a:pt x="505" y="244"/>
                    </a:lnTo>
                    <a:lnTo>
                      <a:pt x="510" y="326"/>
                    </a:lnTo>
                    <a:lnTo>
                      <a:pt x="515" y="302"/>
                    </a:lnTo>
                    <a:lnTo>
                      <a:pt x="521" y="198"/>
                    </a:lnTo>
                    <a:lnTo>
                      <a:pt x="526" y="256"/>
                    </a:lnTo>
                    <a:lnTo>
                      <a:pt x="531" y="233"/>
                    </a:lnTo>
                    <a:lnTo>
                      <a:pt x="536" y="395"/>
                    </a:lnTo>
                    <a:lnTo>
                      <a:pt x="541" y="256"/>
                    </a:lnTo>
                    <a:lnTo>
                      <a:pt x="546" y="244"/>
                    </a:lnTo>
                    <a:lnTo>
                      <a:pt x="551" y="151"/>
                    </a:lnTo>
                    <a:lnTo>
                      <a:pt x="556" y="209"/>
                    </a:lnTo>
                    <a:lnTo>
                      <a:pt x="561" y="198"/>
                    </a:lnTo>
                    <a:lnTo>
                      <a:pt x="567" y="163"/>
                    </a:lnTo>
                    <a:lnTo>
                      <a:pt x="572" y="256"/>
                    </a:lnTo>
                    <a:lnTo>
                      <a:pt x="577" y="291"/>
                    </a:lnTo>
                    <a:lnTo>
                      <a:pt x="582" y="256"/>
                    </a:lnTo>
                    <a:lnTo>
                      <a:pt x="587" y="186"/>
                    </a:lnTo>
                    <a:lnTo>
                      <a:pt x="592" y="82"/>
                    </a:lnTo>
                    <a:lnTo>
                      <a:pt x="597" y="233"/>
                    </a:lnTo>
                    <a:lnTo>
                      <a:pt x="602" y="291"/>
                    </a:lnTo>
                    <a:lnTo>
                      <a:pt x="607" y="58"/>
                    </a:lnTo>
                    <a:lnTo>
                      <a:pt x="612" y="291"/>
                    </a:lnTo>
                    <a:lnTo>
                      <a:pt x="618" y="244"/>
                    </a:lnTo>
                    <a:lnTo>
                      <a:pt x="623" y="244"/>
                    </a:lnTo>
                    <a:lnTo>
                      <a:pt x="628" y="116"/>
                    </a:lnTo>
                    <a:lnTo>
                      <a:pt x="633" y="47"/>
                    </a:lnTo>
                    <a:lnTo>
                      <a:pt x="638" y="140"/>
                    </a:lnTo>
                    <a:lnTo>
                      <a:pt x="643" y="163"/>
                    </a:lnTo>
                    <a:lnTo>
                      <a:pt x="648" y="221"/>
                    </a:lnTo>
                    <a:lnTo>
                      <a:pt x="653" y="244"/>
                    </a:lnTo>
                    <a:lnTo>
                      <a:pt x="659" y="24"/>
                    </a:lnTo>
                    <a:lnTo>
                      <a:pt x="664" y="326"/>
                    </a:lnTo>
                    <a:lnTo>
                      <a:pt x="669" y="151"/>
                    </a:lnTo>
                    <a:lnTo>
                      <a:pt x="674" y="337"/>
                    </a:lnTo>
                    <a:lnTo>
                      <a:pt x="679" y="198"/>
                    </a:lnTo>
                    <a:lnTo>
                      <a:pt x="684" y="326"/>
                    </a:lnTo>
                    <a:lnTo>
                      <a:pt x="689" y="151"/>
                    </a:lnTo>
                    <a:lnTo>
                      <a:pt x="694" y="256"/>
                    </a:lnTo>
                    <a:lnTo>
                      <a:pt x="699" y="244"/>
                    </a:lnTo>
                    <a:lnTo>
                      <a:pt x="704" y="268"/>
                    </a:lnTo>
                    <a:lnTo>
                      <a:pt x="710" y="349"/>
                    </a:lnTo>
                    <a:lnTo>
                      <a:pt x="715" y="163"/>
                    </a:lnTo>
                    <a:lnTo>
                      <a:pt x="720" y="442"/>
                    </a:lnTo>
                    <a:lnTo>
                      <a:pt x="725" y="209"/>
                    </a:lnTo>
                    <a:lnTo>
                      <a:pt x="730" y="256"/>
                    </a:lnTo>
                    <a:lnTo>
                      <a:pt x="735" y="326"/>
                    </a:lnTo>
                    <a:lnTo>
                      <a:pt x="740" y="198"/>
                    </a:lnTo>
                    <a:lnTo>
                      <a:pt x="745" y="372"/>
                    </a:lnTo>
                    <a:lnTo>
                      <a:pt x="750" y="221"/>
                    </a:lnTo>
                    <a:lnTo>
                      <a:pt x="755" y="233"/>
                    </a:lnTo>
                    <a:lnTo>
                      <a:pt x="761" y="279"/>
                    </a:lnTo>
                    <a:lnTo>
                      <a:pt x="766" y="407"/>
                    </a:lnTo>
                    <a:lnTo>
                      <a:pt x="771" y="163"/>
                    </a:lnTo>
                    <a:lnTo>
                      <a:pt x="776" y="337"/>
                    </a:lnTo>
                    <a:lnTo>
                      <a:pt x="781" y="337"/>
                    </a:lnTo>
                    <a:lnTo>
                      <a:pt x="786" y="384"/>
                    </a:lnTo>
                    <a:lnTo>
                      <a:pt x="791" y="291"/>
                    </a:lnTo>
                    <a:lnTo>
                      <a:pt x="796" y="279"/>
                    </a:lnTo>
                    <a:lnTo>
                      <a:pt x="801" y="279"/>
                    </a:lnTo>
                    <a:lnTo>
                      <a:pt x="807" y="372"/>
                    </a:lnTo>
                    <a:lnTo>
                      <a:pt x="812" y="314"/>
                    </a:lnTo>
                    <a:lnTo>
                      <a:pt x="817" y="244"/>
                    </a:lnTo>
                    <a:lnTo>
                      <a:pt x="822" y="279"/>
                    </a:lnTo>
                    <a:lnTo>
                      <a:pt x="827" y="302"/>
                    </a:lnTo>
                    <a:lnTo>
                      <a:pt x="832" y="256"/>
                    </a:lnTo>
                    <a:lnTo>
                      <a:pt x="837" y="442"/>
                    </a:lnTo>
                    <a:lnTo>
                      <a:pt x="842" y="233"/>
                    </a:lnTo>
                    <a:lnTo>
                      <a:pt x="847" y="337"/>
                    </a:lnTo>
                    <a:lnTo>
                      <a:pt x="852" y="337"/>
                    </a:lnTo>
                    <a:lnTo>
                      <a:pt x="858" y="244"/>
                    </a:lnTo>
                    <a:lnTo>
                      <a:pt x="863" y="314"/>
                    </a:lnTo>
                    <a:lnTo>
                      <a:pt x="868" y="361"/>
                    </a:lnTo>
                    <a:lnTo>
                      <a:pt x="873" y="349"/>
                    </a:lnTo>
                    <a:lnTo>
                      <a:pt x="878" y="314"/>
                    </a:lnTo>
                    <a:lnTo>
                      <a:pt x="883" y="337"/>
                    </a:lnTo>
                    <a:lnTo>
                      <a:pt x="888" y="349"/>
                    </a:lnTo>
                    <a:lnTo>
                      <a:pt x="893" y="268"/>
                    </a:lnTo>
                    <a:lnTo>
                      <a:pt x="899" y="477"/>
                    </a:lnTo>
                    <a:lnTo>
                      <a:pt x="904" y="361"/>
                    </a:lnTo>
                    <a:lnTo>
                      <a:pt x="909" y="221"/>
                    </a:lnTo>
                    <a:lnTo>
                      <a:pt x="914" y="221"/>
                    </a:lnTo>
                    <a:lnTo>
                      <a:pt x="919" y="175"/>
                    </a:lnTo>
                    <a:lnTo>
                      <a:pt x="924" y="233"/>
                    </a:lnTo>
                    <a:lnTo>
                      <a:pt x="929" y="209"/>
                    </a:lnTo>
                    <a:lnTo>
                      <a:pt x="934" y="488"/>
                    </a:lnTo>
                    <a:lnTo>
                      <a:pt x="939" y="314"/>
                    </a:lnTo>
                    <a:lnTo>
                      <a:pt x="944" y="151"/>
                    </a:lnTo>
                    <a:lnTo>
                      <a:pt x="950" y="291"/>
                    </a:lnTo>
                    <a:lnTo>
                      <a:pt x="955" y="233"/>
                    </a:lnTo>
                    <a:lnTo>
                      <a:pt x="960" y="175"/>
                    </a:lnTo>
                    <a:lnTo>
                      <a:pt x="965" y="163"/>
                    </a:lnTo>
                    <a:lnTo>
                      <a:pt x="970" y="116"/>
                    </a:lnTo>
                    <a:lnTo>
                      <a:pt x="975" y="198"/>
                    </a:lnTo>
                    <a:lnTo>
                      <a:pt x="980" y="209"/>
                    </a:lnTo>
                    <a:lnTo>
                      <a:pt x="985" y="361"/>
                    </a:lnTo>
                    <a:lnTo>
                      <a:pt x="990" y="105"/>
                    </a:lnTo>
                    <a:lnTo>
                      <a:pt x="995" y="93"/>
                    </a:lnTo>
                    <a:lnTo>
                      <a:pt x="1000" y="0"/>
                    </a:lnTo>
                    <a:lnTo>
                      <a:pt x="1006" y="186"/>
                    </a:lnTo>
                    <a:lnTo>
                      <a:pt x="1011" y="291"/>
                    </a:lnTo>
                    <a:lnTo>
                      <a:pt x="1016" y="244"/>
                    </a:lnTo>
                    <a:lnTo>
                      <a:pt x="1021" y="35"/>
                    </a:lnTo>
                    <a:lnTo>
                      <a:pt x="1026" y="186"/>
                    </a:lnTo>
                    <a:lnTo>
                      <a:pt x="1031" y="279"/>
                    </a:lnTo>
                    <a:lnTo>
                      <a:pt x="1036" y="93"/>
                    </a:lnTo>
                    <a:lnTo>
                      <a:pt x="1041" y="198"/>
                    </a:lnTo>
                    <a:lnTo>
                      <a:pt x="1047" y="175"/>
                    </a:lnTo>
                    <a:lnTo>
                      <a:pt x="1052" y="233"/>
                    </a:lnTo>
                    <a:lnTo>
                      <a:pt x="1057" y="58"/>
                    </a:lnTo>
                    <a:lnTo>
                      <a:pt x="1062" y="221"/>
                    </a:lnTo>
                    <a:lnTo>
                      <a:pt x="1067" y="279"/>
                    </a:lnTo>
                    <a:lnTo>
                      <a:pt x="1072" y="384"/>
                    </a:lnTo>
                    <a:lnTo>
                      <a:pt x="1077" y="326"/>
                    </a:lnTo>
                    <a:lnTo>
                      <a:pt x="1082" y="268"/>
                    </a:lnTo>
                    <a:lnTo>
                      <a:pt x="1087" y="337"/>
                    </a:lnTo>
                    <a:lnTo>
                      <a:pt x="1092" y="291"/>
                    </a:lnTo>
                    <a:lnTo>
                      <a:pt x="1098" y="488"/>
                    </a:lnTo>
                    <a:lnTo>
                      <a:pt x="1103" y="477"/>
                    </a:lnTo>
                    <a:lnTo>
                      <a:pt x="1108" y="488"/>
                    </a:lnTo>
                    <a:lnTo>
                      <a:pt x="1113" y="535"/>
                    </a:lnTo>
                    <a:lnTo>
                      <a:pt x="1118" y="546"/>
                    </a:lnTo>
                    <a:lnTo>
                      <a:pt x="1123" y="500"/>
                    </a:lnTo>
                    <a:lnTo>
                      <a:pt x="1128" y="546"/>
                    </a:lnTo>
                    <a:lnTo>
                      <a:pt x="1133" y="674"/>
                    </a:lnTo>
                    <a:lnTo>
                      <a:pt x="1139" y="558"/>
                    </a:lnTo>
                    <a:lnTo>
                      <a:pt x="1144" y="593"/>
                    </a:lnTo>
                    <a:lnTo>
                      <a:pt x="1149" y="721"/>
                    </a:lnTo>
                    <a:lnTo>
                      <a:pt x="1154" y="709"/>
                    </a:lnTo>
                    <a:lnTo>
                      <a:pt x="1159" y="709"/>
                    </a:lnTo>
                    <a:lnTo>
                      <a:pt x="1164" y="732"/>
                    </a:lnTo>
                    <a:lnTo>
                      <a:pt x="1169" y="756"/>
                    </a:lnTo>
                    <a:lnTo>
                      <a:pt x="1174" y="779"/>
                    </a:lnTo>
                    <a:lnTo>
                      <a:pt x="1179" y="802"/>
                    </a:lnTo>
                    <a:lnTo>
                      <a:pt x="1184" y="779"/>
                    </a:lnTo>
                    <a:lnTo>
                      <a:pt x="1189" y="814"/>
                    </a:lnTo>
                    <a:lnTo>
                      <a:pt x="1195" y="814"/>
                    </a:lnTo>
                    <a:lnTo>
                      <a:pt x="1200" y="814"/>
                    </a:lnTo>
                    <a:lnTo>
                      <a:pt x="1205" y="837"/>
                    </a:lnTo>
                    <a:lnTo>
                      <a:pt x="1210" y="814"/>
                    </a:lnTo>
                    <a:lnTo>
                      <a:pt x="1215" y="814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25"/>
                    </a:lnTo>
                    <a:lnTo>
                      <a:pt x="1240" y="825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4" name="Freeform 9"/>
              <p:cNvSpPr>
                <a:spLocks/>
              </p:cNvSpPr>
              <p:nvPr/>
            </p:nvSpPr>
            <p:spPr bwMode="auto">
              <a:xfrm flipV="1">
                <a:off x="2147888" y="2543335"/>
                <a:ext cx="781050" cy="6381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63"/>
                  </a:cxn>
                  <a:cxn ang="0">
                    <a:pos x="2893" y="2363"/>
                  </a:cxn>
                  <a:cxn ang="0">
                    <a:pos x="2893" y="0"/>
                  </a:cxn>
                </a:cxnLst>
                <a:rect l="0" t="0" r="r" b="b"/>
                <a:pathLst>
                  <a:path w="2893" h="2363">
                    <a:moveTo>
                      <a:pt x="0" y="0"/>
                    </a:moveTo>
                    <a:lnTo>
                      <a:pt x="0" y="2363"/>
                    </a:lnTo>
                    <a:lnTo>
                      <a:pt x="2893" y="2363"/>
                    </a:lnTo>
                    <a:lnTo>
                      <a:pt x="2893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46" name="Rectangle 13"/>
              <p:cNvSpPr>
                <a:spLocks noChangeArrowheads="1"/>
              </p:cNvSpPr>
              <p:nvPr/>
            </p:nvSpPr>
            <p:spPr bwMode="auto">
              <a:xfrm>
                <a:off x="930275" y="2182813"/>
                <a:ext cx="2074863" cy="19923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79" name="Groep 78"/>
            <p:cNvGrpSpPr/>
            <p:nvPr/>
          </p:nvGrpSpPr>
          <p:grpSpPr>
            <a:xfrm>
              <a:off x="3653080" y="894708"/>
              <a:ext cx="1163039" cy="1191023"/>
              <a:chOff x="3594100" y="1462088"/>
              <a:chExt cx="2301875" cy="2297112"/>
            </a:xfrm>
          </p:grpSpPr>
          <p:sp>
            <p:nvSpPr>
              <p:cNvPr id="58412" name="Freeform 44"/>
              <p:cNvSpPr>
                <a:spLocks/>
              </p:cNvSpPr>
              <p:nvPr/>
            </p:nvSpPr>
            <p:spPr bwMode="auto">
              <a:xfrm>
                <a:off x="3594100" y="2220913"/>
                <a:ext cx="2301875" cy="1538287"/>
              </a:xfrm>
              <a:custGeom>
                <a:avLst/>
                <a:gdLst/>
                <a:ahLst/>
                <a:cxnLst>
                  <a:cxn ang="0">
                    <a:pos x="17" y="969"/>
                  </a:cxn>
                  <a:cxn ang="0">
                    <a:pos x="45" y="969"/>
                  </a:cxn>
                  <a:cxn ang="0">
                    <a:pos x="73" y="969"/>
                  </a:cxn>
                  <a:cxn ang="0">
                    <a:pos x="102" y="969"/>
                  </a:cxn>
                  <a:cxn ang="0">
                    <a:pos x="130" y="969"/>
                  </a:cxn>
                  <a:cxn ang="0">
                    <a:pos x="158" y="969"/>
                  </a:cxn>
                  <a:cxn ang="0">
                    <a:pos x="187" y="969"/>
                  </a:cxn>
                  <a:cxn ang="0">
                    <a:pos x="215" y="969"/>
                  </a:cxn>
                  <a:cxn ang="0">
                    <a:pos x="243" y="969"/>
                  </a:cxn>
                  <a:cxn ang="0">
                    <a:pos x="272" y="956"/>
                  </a:cxn>
                  <a:cxn ang="0">
                    <a:pos x="300" y="942"/>
                  </a:cxn>
                  <a:cxn ang="0">
                    <a:pos x="328" y="956"/>
                  </a:cxn>
                  <a:cxn ang="0">
                    <a:pos x="357" y="903"/>
                  </a:cxn>
                  <a:cxn ang="0">
                    <a:pos x="385" y="823"/>
                  </a:cxn>
                  <a:cxn ang="0">
                    <a:pos x="413" y="810"/>
                  </a:cxn>
                  <a:cxn ang="0">
                    <a:pos x="441" y="836"/>
                  </a:cxn>
                  <a:cxn ang="0">
                    <a:pos x="470" y="557"/>
                  </a:cxn>
                  <a:cxn ang="0">
                    <a:pos x="498" y="531"/>
                  </a:cxn>
                  <a:cxn ang="0">
                    <a:pos x="527" y="438"/>
                  </a:cxn>
                  <a:cxn ang="0">
                    <a:pos x="555" y="226"/>
                  </a:cxn>
                  <a:cxn ang="0">
                    <a:pos x="583" y="0"/>
                  </a:cxn>
                  <a:cxn ang="0">
                    <a:pos x="612" y="358"/>
                  </a:cxn>
                  <a:cxn ang="0">
                    <a:pos x="640" y="544"/>
                  </a:cxn>
                  <a:cxn ang="0">
                    <a:pos x="668" y="584"/>
                  </a:cxn>
                  <a:cxn ang="0">
                    <a:pos x="696" y="557"/>
                  </a:cxn>
                  <a:cxn ang="0">
                    <a:pos x="725" y="664"/>
                  </a:cxn>
                  <a:cxn ang="0">
                    <a:pos x="753" y="624"/>
                  </a:cxn>
                  <a:cxn ang="0">
                    <a:pos x="782" y="597"/>
                  </a:cxn>
                  <a:cxn ang="0">
                    <a:pos x="810" y="398"/>
                  </a:cxn>
                  <a:cxn ang="0">
                    <a:pos x="838" y="478"/>
                  </a:cxn>
                  <a:cxn ang="0">
                    <a:pos x="867" y="557"/>
                  </a:cxn>
                  <a:cxn ang="0">
                    <a:pos x="895" y="597"/>
                  </a:cxn>
                  <a:cxn ang="0">
                    <a:pos x="923" y="544"/>
                  </a:cxn>
                  <a:cxn ang="0">
                    <a:pos x="951" y="385"/>
                  </a:cxn>
                  <a:cxn ang="0">
                    <a:pos x="980" y="531"/>
                  </a:cxn>
                  <a:cxn ang="0">
                    <a:pos x="1008" y="624"/>
                  </a:cxn>
                  <a:cxn ang="0">
                    <a:pos x="1036" y="624"/>
                  </a:cxn>
                  <a:cxn ang="0">
                    <a:pos x="1065" y="810"/>
                  </a:cxn>
                  <a:cxn ang="0">
                    <a:pos x="1093" y="916"/>
                  </a:cxn>
                  <a:cxn ang="0">
                    <a:pos x="1122" y="956"/>
                  </a:cxn>
                  <a:cxn ang="0">
                    <a:pos x="1150" y="969"/>
                  </a:cxn>
                  <a:cxn ang="0">
                    <a:pos x="1178" y="969"/>
                  </a:cxn>
                  <a:cxn ang="0">
                    <a:pos x="1206" y="969"/>
                  </a:cxn>
                  <a:cxn ang="0">
                    <a:pos x="1235" y="969"/>
                  </a:cxn>
                  <a:cxn ang="0">
                    <a:pos x="1263" y="969"/>
                  </a:cxn>
                  <a:cxn ang="0">
                    <a:pos x="1291" y="969"/>
                  </a:cxn>
                  <a:cxn ang="0">
                    <a:pos x="1320" y="969"/>
                  </a:cxn>
                  <a:cxn ang="0">
                    <a:pos x="1348" y="969"/>
                  </a:cxn>
                  <a:cxn ang="0">
                    <a:pos x="1376" y="969"/>
                  </a:cxn>
                  <a:cxn ang="0">
                    <a:pos x="1405" y="969"/>
                  </a:cxn>
                  <a:cxn ang="0">
                    <a:pos x="1433" y="969"/>
                  </a:cxn>
                </a:cxnLst>
                <a:rect l="0" t="0" r="r" b="b"/>
                <a:pathLst>
                  <a:path w="1450" h="969">
                    <a:moveTo>
                      <a:pt x="0" y="969"/>
                    </a:moveTo>
                    <a:lnTo>
                      <a:pt x="0" y="969"/>
                    </a:lnTo>
                    <a:lnTo>
                      <a:pt x="5" y="969"/>
                    </a:lnTo>
                    <a:lnTo>
                      <a:pt x="11" y="969"/>
                    </a:lnTo>
                    <a:lnTo>
                      <a:pt x="17" y="969"/>
                    </a:lnTo>
                    <a:lnTo>
                      <a:pt x="22" y="969"/>
                    </a:lnTo>
                    <a:lnTo>
                      <a:pt x="28" y="969"/>
                    </a:lnTo>
                    <a:lnTo>
                      <a:pt x="34" y="969"/>
                    </a:lnTo>
                    <a:lnTo>
                      <a:pt x="39" y="969"/>
                    </a:lnTo>
                    <a:lnTo>
                      <a:pt x="45" y="969"/>
                    </a:lnTo>
                    <a:lnTo>
                      <a:pt x="51" y="969"/>
                    </a:lnTo>
                    <a:lnTo>
                      <a:pt x="56" y="969"/>
                    </a:lnTo>
                    <a:lnTo>
                      <a:pt x="62" y="969"/>
                    </a:lnTo>
                    <a:lnTo>
                      <a:pt x="68" y="969"/>
                    </a:lnTo>
                    <a:lnTo>
                      <a:pt x="73" y="969"/>
                    </a:lnTo>
                    <a:lnTo>
                      <a:pt x="79" y="969"/>
                    </a:lnTo>
                    <a:lnTo>
                      <a:pt x="85" y="969"/>
                    </a:lnTo>
                    <a:lnTo>
                      <a:pt x="90" y="969"/>
                    </a:lnTo>
                    <a:lnTo>
                      <a:pt x="96" y="969"/>
                    </a:lnTo>
                    <a:lnTo>
                      <a:pt x="102" y="969"/>
                    </a:lnTo>
                    <a:lnTo>
                      <a:pt x="107" y="969"/>
                    </a:lnTo>
                    <a:lnTo>
                      <a:pt x="113" y="969"/>
                    </a:lnTo>
                    <a:lnTo>
                      <a:pt x="119" y="969"/>
                    </a:lnTo>
                    <a:lnTo>
                      <a:pt x="124" y="969"/>
                    </a:lnTo>
                    <a:lnTo>
                      <a:pt x="130" y="969"/>
                    </a:lnTo>
                    <a:lnTo>
                      <a:pt x="136" y="969"/>
                    </a:lnTo>
                    <a:lnTo>
                      <a:pt x="141" y="969"/>
                    </a:lnTo>
                    <a:lnTo>
                      <a:pt x="147" y="969"/>
                    </a:lnTo>
                    <a:lnTo>
                      <a:pt x="153" y="969"/>
                    </a:lnTo>
                    <a:lnTo>
                      <a:pt x="158" y="969"/>
                    </a:lnTo>
                    <a:lnTo>
                      <a:pt x="164" y="969"/>
                    </a:lnTo>
                    <a:lnTo>
                      <a:pt x="170" y="969"/>
                    </a:lnTo>
                    <a:lnTo>
                      <a:pt x="175" y="969"/>
                    </a:lnTo>
                    <a:lnTo>
                      <a:pt x="181" y="969"/>
                    </a:lnTo>
                    <a:lnTo>
                      <a:pt x="187" y="969"/>
                    </a:lnTo>
                    <a:lnTo>
                      <a:pt x="192" y="969"/>
                    </a:lnTo>
                    <a:lnTo>
                      <a:pt x="198" y="969"/>
                    </a:lnTo>
                    <a:lnTo>
                      <a:pt x="204" y="969"/>
                    </a:lnTo>
                    <a:lnTo>
                      <a:pt x="209" y="969"/>
                    </a:lnTo>
                    <a:lnTo>
                      <a:pt x="215" y="969"/>
                    </a:lnTo>
                    <a:lnTo>
                      <a:pt x="221" y="969"/>
                    </a:lnTo>
                    <a:lnTo>
                      <a:pt x="226" y="969"/>
                    </a:lnTo>
                    <a:lnTo>
                      <a:pt x="232" y="969"/>
                    </a:lnTo>
                    <a:lnTo>
                      <a:pt x="238" y="969"/>
                    </a:lnTo>
                    <a:lnTo>
                      <a:pt x="243" y="969"/>
                    </a:lnTo>
                    <a:lnTo>
                      <a:pt x="249" y="969"/>
                    </a:lnTo>
                    <a:lnTo>
                      <a:pt x="255" y="956"/>
                    </a:lnTo>
                    <a:lnTo>
                      <a:pt x="260" y="956"/>
                    </a:lnTo>
                    <a:lnTo>
                      <a:pt x="266" y="956"/>
                    </a:lnTo>
                    <a:lnTo>
                      <a:pt x="272" y="956"/>
                    </a:lnTo>
                    <a:lnTo>
                      <a:pt x="277" y="969"/>
                    </a:lnTo>
                    <a:lnTo>
                      <a:pt x="283" y="969"/>
                    </a:lnTo>
                    <a:lnTo>
                      <a:pt x="289" y="969"/>
                    </a:lnTo>
                    <a:lnTo>
                      <a:pt x="294" y="969"/>
                    </a:lnTo>
                    <a:lnTo>
                      <a:pt x="300" y="942"/>
                    </a:lnTo>
                    <a:lnTo>
                      <a:pt x="306" y="942"/>
                    </a:lnTo>
                    <a:lnTo>
                      <a:pt x="311" y="969"/>
                    </a:lnTo>
                    <a:lnTo>
                      <a:pt x="317" y="929"/>
                    </a:lnTo>
                    <a:lnTo>
                      <a:pt x="323" y="916"/>
                    </a:lnTo>
                    <a:lnTo>
                      <a:pt x="328" y="956"/>
                    </a:lnTo>
                    <a:lnTo>
                      <a:pt x="334" y="903"/>
                    </a:lnTo>
                    <a:lnTo>
                      <a:pt x="340" y="916"/>
                    </a:lnTo>
                    <a:lnTo>
                      <a:pt x="345" y="916"/>
                    </a:lnTo>
                    <a:lnTo>
                      <a:pt x="351" y="903"/>
                    </a:lnTo>
                    <a:lnTo>
                      <a:pt x="357" y="903"/>
                    </a:lnTo>
                    <a:lnTo>
                      <a:pt x="362" y="836"/>
                    </a:lnTo>
                    <a:lnTo>
                      <a:pt x="368" y="889"/>
                    </a:lnTo>
                    <a:lnTo>
                      <a:pt x="374" y="903"/>
                    </a:lnTo>
                    <a:lnTo>
                      <a:pt x="379" y="876"/>
                    </a:lnTo>
                    <a:lnTo>
                      <a:pt x="385" y="823"/>
                    </a:lnTo>
                    <a:lnTo>
                      <a:pt x="391" y="823"/>
                    </a:lnTo>
                    <a:lnTo>
                      <a:pt x="396" y="823"/>
                    </a:lnTo>
                    <a:lnTo>
                      <a:pt x="402" y="783"/>
                    </a:lnTo>
                    <a:lnTo>
                      <a:pt x="408" y="863"/>
                    </a:lnTo>
                    <a:lnTo>
                      <a:pt x="413" y="810"/>
                    </a:lnTo>
                    <a:lnTo>
                      <a:pt x="419" y="796"/>
                    </a:lnTo>
                    <a:lnTo>
                      <a:pt x="425" y="836"/>
                    </a:lnTo>
                    <a:lnTo>
                      <a:pt x="430" y="757"/>
                    </a:lnTo>
                    <a:lnTo>
                      <a:pt x="436" y="690"/>
                    </a:lnTo>
                    <a:lnTo>
                      <a:pt x="441" y="836"/>
                    </a:lnTo>
                    <a:lnTo>
                      <a:pt x="447" y="717"/>
                    </a:lnTo>
                    <a:lnTo>
                      <a:pt x="453" y="730"/>
                    </a:lnTo>
                    <a:lnTo>
                      <a:pt x="458" y="677"/>
                    </a:lnTo>
                    <a:lnTo>
                      <a:pt x="464" y="690"/>
                    </a:lnTo>
                    <a:lnTo>
                      <a:pt x="470" y="557"/>
                    </a:lnTo>
                    <a:lnTo>
                      <a:pt x="476" y="518"/>
                    </a:lnTo>
                    <a:lnTo>
                      <a:pt x="481" y="504"/>
                    </a:lnTo>
                    <a:lnTo>
                      <a:pt x="487" y="557"/>
                    </a:lnTo>
                    <a:lnTo>
                      <a:pt x="493" y="571"/>
                    </a:lnTo>
                    <a:lnTo>
                      <a:pt x="498" y="531"/>
                    </a:lnTo>
                    <a:lnTo>
                      <a:pt x="504" y="504"/>
                    </a:lnTo>
                    <a:lnTo>
                      <a:pt x="510" y="451"/>
                    </a:lnTo>
                    <a:lnTo>
                      <a:pt x="515" y="491"/>
                    </a:lnTo>
                    <a:lnTo>
                      <a:pt x="521" y="305"/>
                    </a:lnTo>
                    <a:lnTo>
                      <a:pt x="527" y="438"/>
                    </a:lnTo>
                    <a:lnTo>
                      <a:pt x="532" y="464"/>
                    </a:lnTo>
                    <a:lnTo>
                      <a:pt x="538" y="106"/>
                    </a:lnTo>
                    <a:lnTo>
                      <a:pt x="544" y="212"/>
                    </a:lnTo>
                    <a:lnTo>
                      <a:pt x="549" y="265"/>
                    </a:lnTo>
                    <a:lnTo>
                      <a:pt x="555" y="226"/>
                    </a:lnTo>
                    <a:lnTo>
                      <a:pt x="561" y="279"/>
                    </a:lnTo>
                    <a:lnTo>
                      <a:pt x="566" y="119"/>
                    </a:lnTo>
                    <a:lnTo>
                      <a:pt x="572" y="146"/>
                    </a:lnTo>
                    <a:lnTo>
                      <a:pt x="578" y="265"/>
                    </a:lnTo>
                    <a:lnTo>
                      <a:pt x="583" y="0"/>
                    </a:lnTo>
                    <a:lnTo>
                      <a:pt x="589" y="265"/>
                    </a:lnTo>
                    <a:lnTo>
                      <a:pt x="595" y="411"/>
                    </a:lnTo>
                    <a:lnTo>
                      <a:pt x="600" y="199"/>
                    </a:lnTo>
                    <a:lnTo>
                      <a:pt x="606" y="398"/>
                    </a:lnTo>
                    <a:lnTo>
                      <a:pt x="612" y="358"/>
                    </a:lnTo>
                    <a:lnTo>
                      <a:pt x="617" y="398"/>
                    </a:lnTo>
                    <a:lnTo>
                      <a:pt x="623" y="345"/>
                    </a:lnTo>
                    <a:lnTo>
                      <a:pt x="629" y="292"/>
                    </a:lnTo>
                    <a:lnTo>
                      <a:pt x="634" y="464"/>
                    </a:lnTo>
                    <a:lnTo>
                      <a:pt x="640" y="544"/>
                    </a:lnTo>
                    <a:lnTo>
                      <a:pt x="646" y="464"/>
                    </a:lnTo>
                    <a:lnTo>
                      <a:pt x="651" y="425"/>
                    </a:lnTo>
                    <a:lnTo>
                      <a:pt x="657" y="544"/>
                    </a:lnTo>
                    <a:lnTo>
                      <a:pt x="663" y="637"/>
                    </a:lnTo>
                    <a:lnTo>
                      <a:pt x="668" y="584"/>
                    </a:lnTo>
                    <a:lnTo>
                      <a:pt x="674" y="491"/>
                    </a:lnTo>
                    <a:lnTo>
                      <a:pt x="680" y="703"/>
                    </a:lnTo>
                    <a:lnTo>
                      <a:pt x="685" y="597"/>
                    </a:lnTo>
                    <a:lnTo>
                      <a:pt x="691" y="571"/>
                    </a:lnTo>
                    <a:lnTo>
                      <a:pt x="696" y="557"/>
                    </a:lnTo>
                    <a:lnTo>
                      <a:pt x="702" y="637"/>
                    </a:lnTo>
                    <a:lnTo>
                      <a:pt x="708" y="650"/>
                    </a:lnTo>
                    <a:lnTo>
                      <a:pt x="713" y="610"/>
                    </a:lnTo>
                    <a:lnTo>
                      <a:pt x="719" y="584"/>
                    </a:lnTo>
                    <a:lnTo>
                      <a:pt x="725" y="664"/>
                    </a:lnTo>
                    <a:lnTo>
                      <a:pt x="730" y="557"/>
                    </a:lnTo>
                    <a:lnTo>
                      <a:pt x="736" y="584"/>
                    </a:lnTo>
                    <a:lnTo>
                      <a:pt x="742" y="544"/>
                    </a:lnTo>
                    <a:lnTo>
                      <a:pt x="747" y="571"/>
                    </a:lnTo>
                    <a:lnTo>
                      <a:pt x="753" y="624"/>
                    </a:lnTo>
                    <a:lnTo>
                      <a:pt x="759" y="690"/>
                    </a:lnTo>
                    <a:lnTo>
                      <a:pt x="764" y="398"/>
                    </a:lnTo>
                    <a:lnTo>
                      <a:pt x="770" y="584"/>
                    </a:lnTo>
                    <a:lnTo>
                      <a:pt x="776" y="411"/>
                    </a:lnTo>
                    <a:lnTo>
                      <a:pt x="782" y="597"/>
                    </a:lnTo>
                    <a:lnTo>
                      <a:pt x="787" y="385"/>
                    </a:lnTo>
                    <a:lnTo>
                      <a:pt x="793" y="518"/>
                    </a:lnTo>
                    <a:lnTo>
                      <a:pt x="799" y="624"/>
                    </a:lnTo>
                    <a:lnTo>
                      <a:pt x="804" y="544"/>
                    </a:lnTo>
                    <a:lnTo>
                      <a:pt x="810" y="398"/>
                    </a:lnTo>
                    <a:lnTo>
                      <a:pt x="816" y="584"/>
                    </a:lnTo>
                    <a:lnTo>
                      <a:pt x="821" y="664"/>
                    </a:lnTo>
                    <a:lnTo>
                      <a:pt x="827" y="610"/>
                    </a:lnTo>
                    <a:lnTo>
                      <a:pt x="833" y="491"/>
                    </a:lnTo>
                    <a:lnTo>
                      <a:pt x="838" y="478"/>
                    </a:lnTo>
                    <a:lnTo>
                      <a:pt x="844" y="597"/>
                    </a:lnTo>
                    <a:lnTo>
                      <a:pt x="850" y="518"/>
                    </a:lnTo>
                    <a:lnTo>
                      <a:pt x="855" y="597"/>
                    </a:lnTo>
                    <a:lnTo>
                      <a:pt x="861" y="597"/>
                    </a:lnTo>
                    <a:lnTo>
                      <a:pt x="867" y="557"/>
                    </a:lnTo>
                    <a:lnTo>
                      <a:pt x="872" y="610"/>
                    </a:lnTo>
                    <a:lnTo>
                      <a:pt x="878" y="491"/>
                    </a:lnTo>
                    <a:lnTo>
                      <a:pt x="884" y="478"/>
                    </a:lnTo>
                    <a:lnTo>
                      <a:pt x="889" y="531"/>
                    </a:lnTo>
                    <a:lnTo>
                      <a:pt x="895" y="597"/>
                    </a:lnTo>
                    <a:lnTo>
                      <a:pt x="901" y="531"/>
                    </a:lnTo>
                    <a:lnTo>
                      <a:pt x="906" y="491"/>
                    </a:lnTo>
                    <a:lnTo>
                      <a:pt x="912" y="438"/>
                    </a:lnTo>
                    <a:lnTo>
                      <a:pt x="918" y="345"/>
                    </a:lnTo>
                    <a:lnTo>
                      <a:pt x="923" y="544"/>
                    </a:lnTo>
                    <a:lnTo>
                      <a:pt x="929" y="478"/>
                    </a:lnTo>
                    <a:lnTo>
                      <a:pt x="935" y="478"/>
                    </a:lnTo>
                    <a:lnTo>
                      <a:pt x="940" y="584"/>
                    </a:lnTo>
                    <a:lnTo>
                      <a:pt x="946" y="557"/>
                    </a:lnTo>
                    <a:lnTo>
                      <a:pt x="951" y="385"/>
                    </a:lnTo>
                    <a:lnTo>
                      <a:pt x="957" y="584"/>
                    </a:lnTo>
                    <a:lnTo>
                      <a:pt x="963" y="398"/>
                    </a:lnTo>
                    <a:lnTo>
                      <a:pt x="968" y="531"/>
                    </a:lnTo>
                    <a:lnTo>
                      <a:pt x="974" y="504"/>
                    </a:lnTo>
                    <a:lnTo>
                      <a:pt x="980" y="531"/>
                    </a:lnTo>
                    <a:lnTo>
                      <a:pt x="985" y="491"/>
                    </a:lnTo>
                    <a:lnTo>
                      <a:pt x="991" y="531"/>
                    </a:lnTo>
                    <a:lnTo>
                      <a:pt x="997" y="504"/>
                    </a:lnTo>
                    <a:lnTo>
                      <a:pt x="1002" y="358"/>
                    </a:lnTo>
                    <a:lnTo>
                      <a:pt x="1008" y="624"/>
                    </a:lnTo>
                    <a:lnTo>
                      <a:pt x="1014" y="478"/>
                    </a:lnTo>
                    <a:lnTo>
                      <a:pt x="1019" y="677"/>
                    </a:lnTo>
                    <a:lnTo>
                      <a:pt x="1025" y="531"/>
                    </a:lnTo>
                    <a:lnTo>
                      <a:pt x="1031" y="664"/>
                    </a:lnTo>
                    <a:lnTo>
                      <a:pt x="1036" y="624"/>
                    </a:lnTo>
                    <a:lnTo>
                      <a:pt x="1042" y="624"/>
                    </a:lnTo>
                    <a:lnTo>
                      <a:pt x="1048" y="677"/>
                    </a:lnTo>
                    <a:lnTo>
                      <a:pt x="1053" y="783"/>
                    </a:lnTo>
                    <a:lnTo>
                      <a:pt x="1059" y="677"/>
                    </a:lnTo>
                    <a:lnTo>
                      <a:pt x="1065" y="810"/>
                    </a:lnTo>
                    <a:lnTo>
                      <a:pt x="1070" y="836"/>
                    </a:lnTo>
                    <a:lnTo>
                      <a:pt x="1076" y="876"/>
                    </a:lnTo>
                    <a:lnTo>
                      <a:pt x="1082" y="810"/>
                    </a:lnTo>
                    <a:lnTo>
                      <a:pt x="1088" y="863"/>
                    </a:lnTo>
                    <a:lnTo>
                      <a:pt x="1093" y="916"/>
                    </a:lnTo>
                    <a:lnTo>
                      <a:pt x="1099" y="863"/>
                    </a:lnTo>
                    <a:lnTo>
                      <a:pt x="1105" y="903"/>
                    </a:lnTo>
                    <a:lnTo>
                      <a:pt x="1110" y="916"/>
                    </a:lnTo>
                    <a:lnTo>
                      <a:pt x="1116" y="916"/>
                    </a:lnTo>
                    <a:lnTo>
                      <a:pt x="1122" y="956"/>
                    </a:lnTo>
                    <a:lnTo>
                      <a:pt x="1127" y="969"/>
                    </a:lnTo>
                    <a:lnTo>
                      <a:pt x="1133" y="942"/>
                    </a:lnTo>
                    <a:lnTo>
                      <a:pt x="1139" y="942"/>
                    </a:lnTo>
                    <a:lnTo>
                      <a:pt x="1144" y="942"/>
                    </a:lnTo>
                    <a:lnTo>
                      <a:pt x="1150" y="969"/>
                    </a:lnTo>
                    <a:lnTo>
                      <a:pt x="1156" y="956"/>
                    </a:lnTo>
                    <a:lnTo>
                      <a:pt x="1161" y="969"/>
                    </a:lnTo>
                    <a:lnTo>
                      <a:pt x="1167" y="969"/>
                    </a:lnTo>
                    <a:lnTo>
                      <a:pt x="1173" y="969"/>
                    </a:lnTo>
                    <a:lnTo>
                      <a:pt x="1178" y="969"/>
                    </a:lnTo>
                    <a:lnTo>
                      <a:pt x="1184" y="969"/>
                    </a:lnTo>
                    <a:lnTo>
                      <a:pt x="1190" y="969"/>
                    </a:lnTo>
                    <a:lnTo>
                      <a:pt x="1195" y="969"/>
                    </a:lnTo>
                    <a:lnTo>
                      <a:pt x="1201" y="969"/>
                    </a:lnTo>
                    <a:lnTo>
                      <a:pt x="1206" y="969"/>
                    </a:lnTo>
                    <a:lnTo>
                      <a:pt x="1212" y="969"/>
                    </a:lnTo>
                    <a:lnTo>
                      <a:pt x="1218" y="969"/>
                    </a:lnTo>
                    <a:lnTo>
                      <a:pt x="1223" y="969"/>
                    </a:lnTo>
                    <a:lnTo>
                      <a:pt x="1229" y="969"/>
                    </a:lnTo>
                    <a:lnTo>
                      <a:pt x="1235" y="969"/>
                    </a:lnTo>
                    <a:lnTo>
                      <a:pt x="1240" y="969"/>
                    </a:lnTo>
                    <a:lnTo>
                      <a:pt x="1246" y="969"/>
                    </a:lnTo>
                    <a:lnTo>
                      <a:pt x="1252" y="969"/>
                    </a:lnTo>
                    <a:lnTo>
                      <a:pt x="1257" y="969"/>
                    </a:lnTo>
                    <a:lnTo>
                      <a:pt x="1263" y="969"/>
                    </a:lnTo>
                    <a:lnTo>
                      <a:pt x="1269" y="969"/>
                    </a:lnTo>
                    <a:lnTo>
                      <a:pt x="1274" y="969"/>
                    </a:lnTo>
                    <a:lnTo>
                      <a:pt x="1280" y="969"/>
                    </a:lnTo>
                    <a:lnTo>
                      <a:pt x="1286" y="969"/>
                    </a:lnTo>
                    <a:lnTo>
                      <a:pt x="1291" y="969"/>
                    </a:lnTo>
                    <a:lnTo>
                      <a:pt x="1297" y="969"/>
                    </a:lnTo>
                    <a:lnTo>
                      <a:pt x="1303" y="969"/>
                    </a:lnTo>
                    <a:lnTo>
                      <a:pt x="1308" y="969"/>
                    </a:lnTo>
                    <a:lnTo>
                      <a:pt x="1314" y="969"/>
                    </a:lnTo>
                    <a:lnTo>
                      <a:pt x="1320" y="969"/>
                    </a:lnTo>
                    <a:lnTo>
                      <a:pt x="1325" y="969"/>
                    </a:lnTo>
                    <a:lnTo>
                      <a:pt x="1331" y="969"/>
                    </a:lnTo>
                    <a:lnTo>
                      <a:pt x="1337" y="969"/>
                    </a:lnTo>
                    <a:lnTo>
                      <a:pt x="1342" y="969"/>
                    </a:lnTo>
                    <a:lnTo>
                      <a:pt x="1348" y="969"/>
                    </a:lnTo>
                    <a:lnTo>
                      <a:pt x="1354" y="969"/>
                    </a:lnTo>
                    <a:lnTo>
                      <a:pt x="1359" y="969"/>
                    </a:lnTo>
                    <a:lnTo>
                      <a:pt x="1365" y="969"/>
                    </a:lnTo>
                    <a:lnTo>
                      <a:pt x="1371" y="969"/>
                    </a:lnTo>
                    <a:lnTo>
                      <a:pt x="1376" y="969"/>
                    </a:lnTo>
                    <a:lnTo>
                      <a:pt x="1382" y="969"/>
                    </a:lnTo>
                    <a:lnTo>
                      <a:pt x="1388" y="969"/>
                    </a:lnTo>
                    <a:lnTo>
                      <a:pt x="1393" y="969"/>
                    </a:lnTo>
                    <a:lnTo>
                      <a:pt x="1399" y="969"/>
                    </a:lnTo>
                    <a:lnTo>
                      <a:pt x="1405" y="969"/>
                    </a:lnTo>
                    <a:lnTo>
                      <a:pt x="1411" y="969"/>
                    </a:lnTo>
                    <a:lnTo>
                      <a:pt x="1416" y="969"/>
                    </a:lnTo>
                    <a:lnTo>
                      <a:pt x="1422" y="969"/>
                    </a:lnTo>
                    <a:lnTo>
                      <a:pt x="1428" y="969"/>
                    </a:lnTo>
                    <a:lnTo>
                      <a:pt x="1433" y="969"/>
                    </a:lnTo>
                    <a:lnTo>
                      <a:pt x="1439" y="969"/>
                    </a:lnTo>
                    <a:lnTo>
                      <a:pt x="1445" y="969"/>
                    </a:lnTo>
                    <a:lnTo>
                      <a:pt x="1450" y="969"/>
                    </a:lnTo>
                    <a:lnTo>
                      <a:pt x="0" y="969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13" name="Freeform 45"/>
              <p:cNvSpPr>
                <a:spLocks/>
              </p:cNvSpPr>
              <p:nvPr/>
            </p:nvSpPr>
            <p:spPr bwMode="auto">
              <a:xfrm>
                <a:off x="3594100" y="2220913"/>
                <a:ext cx="2301875" cy="1538287"/>
              </a:xfrm>
              <a:custGeom>
                <a:avLst/>
                <a:gdLst/>
                <a:ahLst/>
                <a:cxnLst>
                  <a:cxn ang="0">
                    <a:pos x="17" y="969"/>
                  </a:cxn>
                  <a:cxn ang="0">
                    <a:pos x="45" y="969"/>
                  </a:cxn>
                  <a:cxn ang="0">
                    <a:pos x="73" y="969"/>
                  </a:cxn>
                  <a:cxn ang="0">
                    <a:pos x="102" y="969"/>
                  </a:cxn>
                  <a:cxn ang="0">
                    <a:pos x="130" y="969"/>
                  </a:cxn>
                  <a:cxn ang="0">
                    <a:pos x="158" y="969"/>
                  </a:cxn>
                  <a:cxn ang="0">
                    <a:pos x="187" y="969"/>
                  </a:cxn>
                  <a:cxn ang="0">
                    <a:pos x="215" y="969"/>
                  </a:cxn>
                  <a:cxn ang="0">
                    <a:pos x="243" y="969"/>
                  </a:cxn>
                  <a:cxn ang="0">
                    <a:pos x="272" y="956"/>
                  </a:cxn>
                  <a:cxn ang="0">
                    <a:pos x="300" y="942"/>
                  </a:cxn>
                  <a:cxn ang="0">
                    <a:pos x="328" y="956"/>
                  </a:cxn>
                  <a:cxn ang="0">
                    <a:pos x="357" y="903"/>
                  </a:cxn>
                  <a:cxn ang="0">
                    <a:pos x="385" y="823"/>
                  </a:cxn>
                  <a:cxn ang="0">
                    <a:pos x="413" y="810"/>
                  </a:cxn>
                  <a:cxn ang="0">
                    <a:pos x="441" y="836"/>
                  </a:cxn>
                  <a:cxn ang="0">
                    <a:pos x="470" y="557"/>
                  </a:cxn>
                  <a:cxn ang="0">
                    <a:pos x="498" y="531"/>
                  </a:cxn>
                  <a:cxn ang="0">
                    <a:pos x="527" y="438"/>
                  </a:cxn>
                  <a:cxn ang="0">
                    <a:pos x="555" y="226"/>
                  </a:cxn>
                  <a:cxn ang="0">
                    <a:pos x="583" y="0"/>
                  </a:cxn>
                  <a:cxn ang="0">
                    <a:pos x="612" y="358"/>
                  </a:cxn>
                  <a:cxn ang="0">
                    <a:pos x="640" y="544"/>
                  </a:cxn>
                  <a:cxn ang="0">
                    <a:pos x="668" y="584"/>
                  </a:cxn>
                  <a:cxn ang="0">
                    <a:pos x="696" y="557"/>
                  </a:cxn>
                  <a:cxn ang="0">
                    <a:pos x="725" y="664"/>
                  </a:cxn>
                  <a:cxn ang="0">
                    <a:pos x="753" y="624"/>
                  </a:cxn>
                  <a:cxn ang="0">
                    <a:pos x="782" y="597"/>
                  </a:cxn>
                  <a:cxn ang="0">
                    <a:pos x="810" y="398"/>
                  </a:cxn>
                  <a:cxn ang="0">
                    <a:pos x="838" y="478"/>
                  </a:cxn>
                  <a:cxn ang="0">
                    <a:pos x="867" y="557"/>
                  </a:cxn>
                  <a:cxn ang="0">
                    <a:pos x="895" y="597"/>
                  </a:cxn>
                  <a:cxn ang="0">
                    <a:pos x="923" y="544"/>
                  </a:cxn>
                  <a:cxn ang="0">
                    <a:pos x="951" y="385"/>
                  </a:cxn>
                  <a:cxn ang="0">
                    <a:pos x="980" y="531"/>
                  </a:cxn>
                  <a:cxn ang="0">
                    <a:pos x="1008" y="624"/>
                  </a:cxn>
                  <a:cxn ang="0">
                    <a:pos x="1036" y="624"/>
                  </a:cxn>
                  <a:cxn ang="0">
                    <a:pos x="1065" y="810"/>
                  </a:cxn>
                  <a:cxn ang="0">
                    <a:pos x="1093" y="916"/>
                  </a:cxn>
                  <a:cxn ang="0">
                    <a:pos x="1122" y="956"/>
                  </a:cxn>
                  <a:cxn ang="0">
                    <a:pos x="1150" y="969"/>
                  </a:cxn>
                  <a:cxn ang="0">
                    <a:pos x="1178" y="969"/>
                  </a:cxn>
                  <a:cxn ang="0">
                    <a:pos x="1206" y="969"/>
                  </a:cxn>
                  <a:cxn ang="0">
                    <a:pos x="1235" y="969"/>
                  </a:cxn>
                  <a:cxn ang="0">
                    <a:pos x="1263" y="969"/>
                  </a:cxn>
                  <a:cxn ang="0">
                    <a:pos x="1291" y="969"/>
                  </a:cxn>
                  <a:cxn ang="0">
                    <a:pos x="1320" y="969"/>
                  </a:cxn>
                  <a:cxn ang="0">
                    <a:pos x="1348" y="969"/>
                  </a:cxn>
                  <a:cxn ang="0">
                    <a:pos x="1376" y="969"/>
                  </a:cxn>
                  <a:cxn ang="0">
                    <a:pos x="1405" y="969"/>
                  </a:cxn>
                  <a:cxn ang="0">
                    <a:pos x="1433" y="969"/>
                  </a:cxn>
                </a:cxnLst>
                <a:rect l="0" t="0" r="r" b="b"/>
                <a:pathLst>
                  <a:path w="1450" h="969">
                    <a:moveTo>
                      <a:pt x="0" y="969"/>
                    </a:moveTo>
                    <a:lnTo>
                      <a:pt x="0" y="969"/>
                    </a:lnTo>
                    <a:lnTo>
                      <a:pt x="5" y="969"/>
                    </a:lnTo>
                    <a:lnTo>
                      <a:pt x="11" y="969"/>
                    </a:lnTo>
                    <a:lnTo>
                      <a:pt x="17" y="969"/>
                    </a:lnTo>
                    <a:lnTo>
                      <a:pt x="22" y="969"/>
                    </a:lnTo>
                    <a:lnTo>
                      <a:pt x="28" y="969"/>
                    </a:lnTo>
                    <a:lnTo>
                      <a:pt x="34" y="969"/>
                    </a:lnTo>
                    <a:lnTo>
                      <a:pt x="39" y="969"/>
                    </a:lnTo>
                    <a:lnTo>
                      <a:pt x="45" y="969"/>
                    </a:lnTo>
                    <a:lnTo>
                      <a:pt x="51" y="969"/>
                    </a:lnTo>
                    <a:lnTo>
                      <a:pt x="56" y="969"/>
                    </a:lnTo>
                    <a:lnTo>
                      <a:pt x="62" y="969"/>
                    </a:lnTo>
                    <a:lnTo>
                      <a:pt x="68" y="969"/>
                    </a:lnTo>
                    <a:lnTo>
                      <a:pt x="73" y="969"/>
                    </a:lnTo>
                    <a:lnTo>
                      <a:pt x="79" y="969"/>
                    </a:lnTo>
                    <a:lnTo>
                      <a:pt x="85" y="969"/>
                    </a:lnTo>
                    <a:lnTo>
                      <a:pt x="90" y="969"/>
                    </a:lnTo>
                    <a:lnTo>
                      <a:pt x="96" y="969"/>
                    </a:lnTo>
                    <a:lnTo>
                      <a:pt x="102" y="969"/>
                    </a:lnTo>
                    <a:lnTo>
                      <a:pt x="107" y="969"/>
                    </a:lnTo>
                    <a:lnTo>
                      <a:pt x="113" y="969"/>
                    </a:lnTo>
                    <a:lnTo>
                      <a:pt x="119" y="969"/>
                    </a:lnTo>
                    <a:lnTo>
                      <a:pt x="124" y="969"/>
                    </a:lnTo>
                    <a:lnTo>
                      <a:pt x="130" y="969"/>
                    </a:lnTo>
                    <a:lnTo>
                      <a:pt x="136" y="969"/>
                    </a:lnTo>
                    <a:lnTo>
                      <a:pt x="141" y="969"/>
                    </a:lnTo>
                    <a:lnTo>
                      <a:pt x="147" y="969"/>
                    </a:lnTo>
                    <a:lnTo>
                      <a:pt x="153" y="969"/>
                    </a:lnTo>
                    <a:lnTo>
                      <a:pt x="158" y="969"/>
                    </a:lnTo>
                    <a:lnTo>
                      <a:pt x="164" y="969"/>
                    </a:lnTo>
                    <a:lnTo>
                      <a:pt x="170" y="969"/>
                    </a:lnTo>
                    <a:lnTo>
                      <a:pt x="175" y="969"/>
                    </a:lnTo>
                    <a:lnTo>
                      <a:pt x="181" y="969"/>
                    </a:lnTo>
                    <a:lnTo>
                      <a:pt x="187" y="969"/>
                    </a:lnTo>
                    <a:lnTo>
                      <a:pt x="192" y="969"/>
                    </a:lnTo>
                    <a:lnTo>
                      <a:pt x="198" y="969"/>
                    </a:lnTo>
                    <a:lnTo>
                      <a:pt x="204" y="969"/>
                    </a:lnTo>
                    <a:lnTo>
                      <a:pt x="209" y="969"/>
                    </a:lnTo>
                    <a:lnTo>
                      <a:pt x="215" y="969"/>
                    </a:lnTo>
                    <a:lnTo>
                      <a:pt x="221" y="969"/>
                    </a:lnTo>
                    <a:lnTo>
                      <a:pt x="226" y="969"/>
                    </a:lnTo>
                    <a:lnTo>
                      <a:pt x="232" y="969"/>
                    </a:lnTo>
                    <a:lnTo>
                      <a:pt x="238" y="969"/>
                    </a:lnTo>
                    <a:lnTo>
                      <a:pt x="243" y="969"/>
                    </a:lnTo>
                    <a:lnTo>
                      <a:pt x="249" y="969"/>
                    </a:lnTo>
                    <a:lnTo>
                      <a:pt x="255" y="956"/>
                    </a:lnTo>
                    <a:lnTo>
                      <a:pt x="260" y="956"/>
                    </a:lnTo>
                    <a:lnTo>
                      <a:pt x="266" y="956"/>
                    </a:lnTo>
                    <a:lnTo>
                      <a:pt x="272" y="956"/>
                    </a:lnTo>
                    <a:lnTo>
                      <a:pt x="277" y="969"/>
                    </a:lnTo>
                    <a:lnTo>
                      <a:pt x="283" y="969"/>
                    </a:lnTo>
                    <a:lnTo>
                      <a:pt x="289" y="969"/>
                    </a:lnTo>
                    <a:lnTo>
                      <a:pt x="294" y="969"/>
                    </a:lnTo>
                    <a:lnTo>
                      <a:pt x="300" y="942"/>
                    </a:lnTo>
                    <a:lnTo>
                      <a:pt x="306" y="942"/>
                    </a:lnTo>
                    <a:lnTo>
                      <a:pt x="311" y="969"/>
                    </a:lnTo>
                    <a:lnTo>
                      <a:pt x="317" y="929"/>
                    </a:lnTo>
                    <a:lnTo>
                      <a:pt x="323" y="916"/>
                    </a:lnTo>
                    <a:lnTo>
                      <a:pt x="328" y="956"/>
                    </a:lnTo>
                    <a:lnTo>
                      <a:pt x="334" y="903"/>
                    </a:lnTo>
                    <a:lnTo>
                      <a:pt x="340" y="916"/>
                    </a:lnTo>
                    <a:lnTo>
                      <a:pt x="345" y="916"/>
                    </a:lnTo>
                    <a:lnTo>
                      <a:pt x="351" y="903"/>
                    </a:lnTo>
                    <a:lnTo>
                      <a:pt x="357" y="903"/>
                    </a:lnTo>
                    <a:lnTo>
                      <a:pt x="362" y="836"/>
                    </a:lnTo>
                    <a:lnTo>
                      <a:pt x="368" y="889"/>
                    </a:lnTo>
                    <a:lnTo>
                      <a:pt x="374" y="903"/>
                    </a:lnTo>
                    <a:lnTo>
                      <a:pt x="379" y="876"/>
                    </a:lnTo>
                    <a:lnTo>
                      <a:pt x="385" y="823"/>
                    </a:lnTo>
                    <a:lnTo>
                      <a:pt x="391" y="823"/>
                    </a:lnTo>
                    <a:lnTo>
                      <a:pt x="396" y="823"/>
                    </a:lnTo>
                    <a:lnTo>
                      <a:pt x="402" y="783"/>
                    </a:lnTo>
                    <a:lnTo>
                      <a:pt x="408" y="863"/>
                    </a:lnTo>
                    <a:lnTo>
                      <a:pt x="413" y="810"/>
                    </a:lnTo>
                    <a:lnTo>
                      <a:pt x="419" y="796"/>
                    </a:lnTo>
                    <a:lnTo>
                      <a:pt x="425" y="836"/>
                    </a:lnTo>
                    <a:lnTo>
                      <a:pt x="430" y="757"/>
                    </a:lnTo>
                    <a:lnTo>
                      <a:pt x="436" y="690"/>
                    </a:lnTo>
                    <a:lnTo>
                      <a:pt x="441" y="836"/>
                    </a:lnTo>
                    <a:lnTo>
                      <a:pt x="447" y="717"/>
                    </a:lnTo>
                    <a:lnTo>
                      <a:pt x="453" y="730"/>
                    </a:lnTo>
                    <a:lnTo>
                      <a:pt x="458" y="677"/>
                    </a:lnTo>
                    <a:lnTo>
                      <a:pt x="464" y="690"/>
                    </a:lnTo>
                    <a:lnTo>
                      <a:pt x="470" y="557"/>
                    </a:lnTo>
                    <a:lnTo>
                      <a:pt x="476" y="518"/>
                    </a:lnTo>
                    <a:lnTo>
                      <a:pt x="481" y="504"/>
                    </a:lnTo>
                    <a:lnTo>
                      <a:pt x="487" y="557"/>
                    </a:lnTo>
                    <a:lnTo>
                      <a:pt x="493" y="571"/>
                    </a:lnTo>
                    <a:lnTo>
                      <a:pt x="498" y="531"/>
                    </a:lnTo>
                    <a:lnTo>
                      <a:pt x="504" y="504"/>
                    </a:lnTo>
                    <a:lnTo>
                      <a:pt x="510" y="451"/>
                    </a:lnTo>
                    <a:lnTo>
                      <a:pt x="515" y="491"/>
                    </a:lnTo>
                    <a:lnTo>
                      <a:pt x="521" y="305"/>
                    </a:lnTo>
                    <a:lnTo>
                      <a:pt x="527" y="438"/>
                    </a:lnTo>
                    <a:lnTo>
                      <a:pt x="532" y="464"/>
                    </a:lnTo>
                    <a:lnTo>
                      <a:pt x="538" y="106"/>
                    </a:lnTo>
                    <a:lnTo>
                      <a:pt x="544" y="212"/>
                    </a:lnTo>
                    <a:lnTo>
                      <a:pt x="549" y="265"/>
                    </a:lnTo>
                    <a:lnTo>
                      <a:pt x="555" y="226"/>
                    </a:lnTo>
                    <a:lnTo>
                      <a:pt x="561" y="279"/>
                    </a:lnTo>
                    <a:lnTo>
                      <a:pt x="566" y="119"/>
                    </a:lnTo>
                    <a:lnTo>
                      <a:pt x="572" y="146"/>
                    </a:lnTo>
                    <a:lnTo>
                      <a:pt x="578" y="265"/>
                    </a:lnTo>
                    <a:lnTo>
                      <a:pt x="583" y="0"/>
                    </a:lnTo>
                    <a:lnTo>
                      <a:pt x="589" y="265"/>
                    </a:lnTo>
                    <a:lnTo>
                      <a:pt x="595" y="411"/>
                    </a:lnTo>
                    <a:lnTo>
                      <a:pt x="600" y="199"/>
                    </a:lnTo>
                    <a:lnTo>
                      <a:pt x="606" y="398"/>
                    </a:lnTo>
                    <a:lnTo>
                      <a:pt x="612" y="358"/>
                    </a:lnTo>
                    <a:lnTo>
                      <a:pt x="617" y="398"/>
                    </a:lnTo>
                    <a:lnTo>
                      <a:pt x="623" y="345"/>
                    </a:lnTo>
                    <a:lnTo>
                      <a:pt x="629" y="292"/>
                    </a:lnTo>
                    <a:lnTo>
                      <a:pt x="634" y="464"/>
                    </a:lnTo>
                    <a:lnTo>
                      <a:pt x="640" y="544"/>
                    </a:lnTo>
                    <a:lnTo>
                      <a:pt x="646" y="464"/>
                    </a:lnTo>
                    <a:lnTo>
                      <a:pt x="651" y="425"/>
                    </a:lnTo>
                    <a:lnTo>
                      <a:pt x="657" y="544"/>
                    </a:lnTo>
                    <a:lnTo>
                      <a:pt x="663" y="637"/>
                    </a:lnTo>
                    <a:lnTo>
                      <a:pt x="668" y="584"/>
                    </a:lnTo>
                    <a:lnTo>
                      <a:pt x="674" y="491"/>
                    </a:lnTo>
                    <a:lnTo>
                      <a:pt x="680" y="703"/>
                    </a:lnTo>
                    <a:lnTo>
                      <a:pt x="685" y="597"/>
                    </a:lnTo>
                    <a:lnTo>
                      <a:pt x="691" y="571"/>
                    </a:lnTo>
                    <a:lnTo>
                      <a:pt x="696" y="557"/>
                    </a:lnTo>
                    <a:lnTo>
                      <a:pt x="702" y="637"/>
                    </a:lnTo>
                    <a:lnTo>
                      <a:pt x="708" y="650"/>
                    </a:lnTo>
                    <a:lnTo>
                      <a:pt x="713" y="610"/>
                    </a:lnTo>
                    <a:lnTo>
                      <a:pt x="719" y="584"/>
                    </a:lnTo>
                    <a:lnTo>
                      <a:pt x="725" y="664"/>
                    </a:lnTo>
                    <a:lnTo>
                      <a:pt x="730" y="557"/>
                    </a:lnTo>
                    <a:lnTo>
                      <a:pt x="736" y="584"/>
                    </a:lnTo>
                    <a:lnTo>
                      <a:pt x="742" y="544"/>
                    </a:lnTo>
                    <a:lnTo>
                      <a:pt x="747" y="571"/>
                    </a:lnTo>
                    <a:lnTo>
                      <a:pt x="753" y="624"/>
                    </a:lnTo>
                    <a:lnTo>
                      <a:pt x="759" y="690"/>
                    </a:lnTo>
                    <a:lnTo>
                      <a:pt x="764" y="398"/>
                    </a:lnTo>
                    <a:lnTo>
                      <a:pt x="770" y="584"/>
                    </a:lnTo>
                    <a:lnTo>
                      <a:pt x="776" y="411"/>
                    </a:lnTo>
                    <a:lnTo>
                      <a:pt x="782" y="597"/>
                    </a:lnTo>
                    <a:lnTo>
                      <a:pt x="787" y="385"/>
                    </a:lnTo>
                    <a:lnTo>
                      <a:pt x="793" y="518"/>
                    </a:lnTo>
                    <a:lnTo>
                      <a:pt x="799" y="624"/>
                    </a:lnTo>
                    <a:lnTo>
                      <a:pt x="804" y="544"/>
                    </a:lnTo>
                    <a:lnTo>
                      <a:pt x="810" y="398"/>
                    </a:lnTo>
                    <a:lnTo>
                      <a:pt x="816" y="584"/>
                    </a:lnTo>
                    <a:lnTo>
                      <a:pt x="821" y="664"/>
                    </a:lnTo>
                    <a:lnTo>
                      <a:pt x="827" y="610"/>
                    </a:lnTo>
                    <a:lnTo>
                      <a:pt x="833" y="491"/>
                    </a:lnTo>
                    <a:lnTo>
                      <a:pt x="838" y="478"/>
                    </a:lnTo>
                    <a:lnTo>
                      <a:pt x="844" y="597"/>
                    </a:lnTo>
                    <a:lnTo>
                      <a:pt x="850" y="518"/>
                    </a:lnTo>
                    <a:lnTo>
                      <a:pt x="855" y="597"/>
                    </a:lnTo>
                    <a:lnTo>
                      <a:pt x="861" y="597"/>
                    </a:lnTo>
                    <a:lnTo>
                      <a:pt x="867" y="557"/>
                    </a:lnTo>
                    <a:lnTo>
                      <a:pt x="872" y="610"/>
                    </a:lnTo>
                    <a:lnTo>
                      <a:pt x="878" y="491"/>
                    </a:lnTo>
                    <a:lnTo>
                      <a:pt x="884" y="478"/>
                    </a:lnTo>
                    <a:lnTo>
                      <a:pt x="889" y="531"/>
                    </a:lnTo>
                    <a:lnTo>
                      <a:pt x="895" y="597"/>
                    </a:lnTo>
                    <a:lnTo>
                      <a:pt x="901" y="531"/>
                    </a:lnTo>
                    <a:lnTo>
                      <a:pt x="906" y="491"/>
                    </a:lnTo>
                    <a:lnTo>
                      <a:pt x="912" y="438"/>
                    </a:lnTo>
                    <a:lnTo>
                      <a:pt x="918" y="345"/>
                    </a:lnTo>
                    <a:lnTo>
                      <a:pt x="923" y="544"/>
                    </a:lnTo>
                    <a:lnTo>
                      <a:pt x="929" y="478"/>
                    </a:lnTo>
                    <a:lnTo>
                      <a:pt x="935" y="478"/>
                    </a:lnTo>
                    <a:lnTo>
                      <a:pt x="940" y="584"/>
                    </a:lnTo>
                    <a:lnTo>
                      <a:pt x="946" y="557"/>
                    </a:lnTo>
                    <a:lnTo>
                      <a:pt x="951" y="385"/>
                    </a:lnTo>
                    <a:lnTo>
                      <a:pt x="957" y="584"/>
                    </a:lnTo>
                    <a:lnTo>
                      <a:pt x="963" y="398"/>
                    </a:lnTo>
                    <a:lnTo>
                      <a:pt x="968" y="531"/>
                    </a:lnTo>
                    <a:lnTo>
                      <a:pt x="974" y="504"/>
                    </a:lnTo>
                    <a:lnTo>
                      <a:pt x="980" y="531"/>
                    </a:lnTo>
                    <a:lnTo>
                      <a:pt x="985" y="491"/>
                    </a:lnTo>
                    <a:lnTo>
                      <a:pt x="991" y="531"/>
                    </a:lnTo>
                    <a:lnTo>
                      <a:pt x="997" y="504"/>
                    </a:lnTo>
                    <a:lnTo>
                      <a:pt x="1002" y="358"/>
                    </a:lnTo>
                    <a:lnTo>
                      <a:pt x="1008" y="624"/>
                    </a:lnTo>
                    <a:lnTo>
                      <a:pt x="1014" y="478"/>
                    </a:lnTo>
                    <a:lnTo>
                      <a:pt x="1019" y="677"/>
                    </a:lnTo>
                    <a:lnTo>
                      <a:pt x="1025" y="531"/>
                    </a:lnTo>
                    <a:lnTo>
                      <a:pt x="1031" y="664"/>
                    </a:lnTo>
                    <a:lnTo>
                      <a:pt x="1036" y="624"/>
                    </a:lnTo>
                    <a:lnTo>
                      <a:pt x="1042" y="624"/>
                    </a:lnTo>
                    <a:lnTo>
                      <a:pt x="1048" y="677"/>
                    </a:lnTo>
                    <a:lnTo>
                      <a:pt x="1053" y="783"/>
                    </a:lnTo>
                    <a:lnTo>
                      <a:pt x="1059" y="677"/>
                    </a:lnTo>
                    <a:lnTo>
                      <a:pt x="1065" y="810"/>
                    </a:lnTo>
                    <a:lnTo>
                      <a:pt x="1070" y="836"/>
                    </a:lnTo>
                    <a:lnTo>
                      <a:pt x="1076" y="876"/>
                    </a:lnTo>
                    <a:lnTo>
                      <a:pt x="1082" y="810"/>
                    </a:lnTo>
                    <a:lnTo>
                      <a:pt x="1088" y="863"/>
                    </a:lnTo>
                    <a:lnTo>
                      <a:pt x="1093" y="916"/>
                    </a:lnTo>
                    <a:lnTo>
                      <a:pt x="1099" y="863"/>
                    </a:lnTo>
                    <a:lnTo>
                      <a:pt x="1105" y="903"/>
                    </a:lnTo>
                    <a:lnTo>
                      <a:pt x="1110" y="916"/>
                    </a:lnTo>
                    <a:lnTo>
                      <a:pt x="1116" y="916"/>
                    </a:lnTo>
                    <a:lnTo>
                      <a:pt x="1122" y="956"/>
                    </a:lnTo>
                    <a:lnTo>
                      <a:pt x="1127" y="969"/>
                    </a:lnTo>
                    <a:lnTo>
                      <a:pt x="1133" y="942"/>
                    </a:lnTo>
                    <a:lnTo>
                      <a:pt x="1139" y="942"/>
                    </a:lnTo>
                    <a:lnTo>
                      <a:pt x="1144" y="942"/>
                    </a:lnTo>
                    <a:lnTo>
                      <a:pt x="1150" y="969"/>
                    </a:lnTo>
                    <a:lnTo>
                      <a:pt x="1156" y="956"/>
                    </a:lnTo>
                    <a:lnTo>
                      <a:pt x="1161" y="969"/>
                    </a:lnTo>
                    <a:lnTo>
                      <a:pt x="1167" y="969"/>
                    </a:lnTo>
                    <a:lnTo>
                      <a:pt x="1173" y="969"/>
                    </a:lnTo>
                    <a:lnTo>
                      <a:pt x="1178" y="969"/>
                    </a:lnTo>
                    <a:lnTo>
                      <a:pt x="1184" y="969"/>
                    </a:lnTo>
                    <a:lnTo>
                      <a:pt x="1190" y="969"/>
                    </a:lnTo>
                    <a:lnTo>
                      <a:pt x="1195" y="969"/>
                    </a:lnTo>
                    <a:lnTo>
                      <a:pt x="1201" y="969"/>
                    </a:lnTo>
                    <a:lnTo>
                      <a:pt x="1206" y="969"/>
                    </a:lnTo>
                    <a:lnTo>
                      <a:pt x="1212" y="969"/>
                    </a:lnTo>
                    <a:lnTo>
                      <a:pt x="1218" y="969"/>
                    </a:lnTo>
                    <a:lnTo>
                      <a:pt x="1223" y="969"/>
                    </a:lnTo>
                    <a:lnTo>
                      <a:pt x="1229" y="969"/>
                    </a:lnTo>
                    <a:lnTo>
                      <a:pt x="1235" y="969"/>
                    </a:lnTo>
                    <a:lnTo>
                      <a:pt x="1240" y="969"/>
                    </a:lnTo>
                    <a:lnTo>
                      <a:pt x="1246" y="969"/>
                    </a:lnTo>
                    <a:lnTo>
                      <a:pt x="1252" y="969"/>
                    </a:lnTo>
                    <a:lnTo>
                      <a:pt x="1257" y="969"/>
                    </a:lnTo>
                    <a:lnTo>
                      <a:pt x="1263" y="969"/>
                    </a:lnTo>
                    <a:lnTo>
                      <a:pt x="1269" y="969"/>
                    </a:lnTo>
                    <a:lnTo>
                      <a:pt x="1274" y="969"/>
                    </a:lnTo>
                    <a:lnTo>
                      <a:pt x="1280" y="969"/>
                    </a:lnTo>
                    <a:lnTo>
                      <a:pt x="1286" y="969"/>
                    </a:lnTo>
                    <a:lnTo>
                      <a:pt x="1291" y="969"/>
                    </a:lnTo>
                    <a:lnTo>
                      <a:pt x="1297" y="969"/>
                    </a:lnTo>
                    <a:lnTo>
                      <a:pt x="1303" y="969"/>
                    </a:lnTo>
                    <a:lnTo>
                      <a:pt x="1308" y="969"/>
                    </a:lnTo>
                    <a:lnTo>
                      <a:pt x="1314" y="969"/>
                    </a:lnTo>
                    <a:lnTo>
                      <a:pt x="1320" y="969"/>
                    </a:lnTo>
                    <a:lnTo>
                      <a:pt x="1325" y="969"/>
                    </a:lnTo>
                    <a:lnTo>
                      <a:pt x="1331" y="969"/>
                    </a:lnTo>
                    <a:lnTo>
                      <a:pt x="1337" y="969"/>
                    </a:lnTo>
                    <a:lnTo>
                      <a:pt x="1342" y="969"/>
                    </a:lnTo>
                    <a:lnTo>
                      <a:pt x="1348" y="969"/>
                    </a:lnTo>
                    <a:lnTo>
                      <a:pt x="1354" y="969"/>
                    </a:lnTo>
                    <a:lnTo>
                      <a:pt x="1359" y="969"/>
                    </a:lnTo>
                    <a:lnTo>
                      <a:pt x="1365" y="969"/>
                    </a:lnTo>
                    <a:lnTo>
                      <a:pt x="1371" y="969"/>
                    </a:lnTo>
                    <a:lnTo>
                      <a:pt x="1376" y="969"/>
                    </a:lnTo>
                    <a:lnTo>
                      <a:pt x="1382" y="969"/>
                    </a:lnTo>
                    <a:lnTo>
                      <a:pt x="1388" y="969"/>
                    </a:lnTo>
                    <a:lnTo>
                      <a:pt x="1393" y="969"/>
                    </a:lnTo>
                    <a:lnTo>
                      <a:pt x="1399" y="969"/>
                    </a:lnTo>
                    <a:lnTo>
                      <a:pt x="1405" y="969"/>
                    </a:lnTo>
                    <a:lnTo>
                      <a:pt x="1411" y="969"/>
                    </a:lnTo>
                    <a:lnTo>
                      <a:pt x="1416" y="969"/>
                    </a:lnTo>
                    <a:lnTo>
                      <a:pt x="1422" y="969"/>
                    </a:lnTo>
                    <a:lnTo>
                      <a:pt x="1428" y="969"/>
                    </a:lnTo>
                    <a:lnTo>
                      <a:pt x="1433" y="969"/>
                    </a:lnTo>
                    <a:lnTo>
                      <a:pt x="1439" y="969"/>
                    </a:lnTo>
                    <a:lnTo>
                      <a:pt x="1445" y="969"/>
                    </a:lnTo>
                    <a:lnTo>
                      <a:pt x="1450" y="969"/>
                    </a:lnTo>
                    <a:lnTo>
                      <a:pt x="0" y="969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14" name="Rectangle 46"/>
              <p:cNvSpPr>
                <a:spLocks noChangeArrowheads="1"/>
              </p:cNvSpPr>
              <p:nvPr/>
            </p:nvSpPr>
            <p:spPr bwMode="auto">
              <a:xfrm>
                <a:off x="3594100" y="1462088"/>
                <a:ext cx="2301875" cy="22971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113" name="Groep 112"/>
            <p:cNvGrpSpPr/>
            <p:nvPr/>
          </p:nvGrpSpPr>
          <p:grpSpPr>
            <a:xfrm>
              <a:off x="5142035" y="894708"/>
              <a:ext cx="1163039" cy="1191023"/>
              <a:chOff x="5688013" y="1462088"/>
              <a:chExt cx="2368550" cy="2297112"/>
            </a:xfrm>
          </p:grpSpPr>
          <p:sp>
            <p:nvSpPr>
              <p:cNvPr id="58446" name="Freeform 78"/>
              <p:cNvSpPr>
                <a:spLocks/>
              </p:cNvSpPr>
              <p:nvPr/>
            </p:nvSpPr>
            <p:spPr bwMode="auto">
              <a:xfrm>
                <a:off x="5688013" y="2219325"/>
                <a:ext cx="2368550" cy="1539875"/>
              </a:xfrm>
              <a:custGeom>
                <a:avLst/>
                <a:gdLst/>
                <a:ahLst/>
                <a:cxnLst>
                  <a:cxn ang="0">
                    <a:pos x="17" y="970"/>
                  </a:cxn>
                  <a:cxn ang="0">
                    <a:pos x="46" y="970"/>
                  </a:cxn>
                  <a:cxn ang="0">
                    <a:pos x="75" y="970"/>
                  </a:cxn>
                  <a:cxn ang="0">
                    <a:pos x="105" y="970"/>
                  </a:cxn>
                  <a:cxn ang="0">
                    <a:pos x="134" y="970"/>
                  </a:cxn>
                  <a:cxn ang="0">
                    <a:pos x="163" y="970"/>
                  </a:cxn>
                  <a:cxn ang="0">
                    <a:pos x="192" y="970"/>
                  </a:cxn>
                  <a:cxn ang="0">
                    <a:pos x="221" y="970"/>
                  </a:cxn>
                  <a:cxn ang="0">
                    <a:pos x="250" y="970"/>
                  </a:cxn>
                  <a:cxn ang="0">
                    <a:pos x="279" y="970"/>
                  </a:cxn>
                  <a:cxn ang="0">
                    <a:pos x="309" y="970"/>
                  </a:cxn>
                  <a:cxn ang="0">
                    <a:pos x="338" y="955"/>
                  </a:cxn>
                  <a:cxn ang="0">
                    <a:pos x="367" y="955"/>
                  </a:cxn>
                  <a:cxn ang="0">
                    <a:pos x="396" y="970"/>
                  </a:cxn>
                  <a:cxn ang="0">
                    <a:pos x="425" y="939"/>
                  </a:cxn>
                  <a:cxn ang="0">
                    <a:pos x="454" y="877"/>
                  </a:cxn>
                  <a:cxn ang="0">
                    <a:pos x="484" y="893"/>
                  </a:cxn>
                  <a:cxn ang="0">
                    <a:pos x="513" y="847"/>
                  </a:cxn>
                  <a:cxn ang="0">
                    <a:pos x="542" y="785"/>
                  </a:cxn>
                  <a:cxn ang="0">
                    <a:pos x="571" y="831"/>
                  </a:cxn>
                  <a:cxn ang="0">
                    <a:pos x="600" y="724"/>
                  </a:cxn>
                  <a:cxn ang="0">
                    <a:pos x="629" y="754"/>
                  </a:cxn>
                  <a:cxn ang="0">
                    <a:pos x="659" y="647"/>
                  </a:cxn>
                  <a:cxn ang="0">
                    <a:pos x="688" y="724"/>
                  </a:cxn>
                  <a:cxn ang="0">
                    <a:pos x="717" y="678"/>
                  </a:cxn>
                  <a:cxn ang="0">
                    <a:pos x="746" y="708"/>
                  </a:cxn>
                  <a:cxn ang="0">
                    <a:pos x="775" y="570"/>
                  </a:cxn>
                  <a:cxn ang="0">
                    <a:pos x="804" y="554"/>
                  </a:cxn>
                  <a:cxn ang="0">
                    <a:pos x="833" y="631"/>
                  </a:cxn>
                  <a:cxn ang="0">
                    <a:pos x="863" y="308"/>
                  </a:cxn>
                  <a:cxn ang="0">
                    <a:pos x="892" y="139"/>
                  </a:cxn>
                  <a:cxn ang="0">
                    <a:pos x="921" y="246"/>
                  </a:cxn>
                  <a:cxn ang="0">
                    <a:pos x="950" y="77"/>
                  </a:cxn>
                  <a:cxn ang="0">
                    <a:pos x="979" y="123"/>
                  </a:cxn>
                  <a:cxn ang="0">
                    <a:pos x="1008" y="277"/>
                  </a:cxn>
                  <a:cxn ang="0">
                    <a:pos x="1037" y="493"/>
                  </a:cxn>
                  <a:cxn ang="0">
                    <a:pos x="1067" y="339"/>
                  </a:cxn>
                  <a:cxn ang="0">
                    <a:pos x="1096" y="416"/>
                  </a:cxn>
                  <a:cxn ang="0">
                    <a:pos x="1125" y="585"/>
                  </a:cxn>
                  <a:cxn ang="0">
                    <a:pos x="1154" y="724"/>
                  </a:cxn>
                  <a:cxn ang="0">
                    <a:pos x="1183" y="662"/>
                  </a:cxn>
                  <a:cxn ang="0">
                    <a:pos x="1212" y="678"/>
                  </a:cxn>
                  <a:cxn ang="0">
                    <a:pos x="1241" y="708"/>
                  </a:cxn>
                  <a:cxn ang="0">
                    <a:pos x="1271" y="616"/>
                  </a:cxn>
                  <a:cxn ang="0">
                    <a:pos x="1300" y="678"/>
                  </a:cxn>
                  <a:cxn ang="0">
                    <a:pos x="1329" y="816"/>
                  </a:cxn>
                  <a:cxn ang="0">
                    <a:pos x="1358" y="816"/>
                  </a:cxn>
                  <a:cxn ang="0">
                    <a:pos x="1387" y="924"/>
                  </a:cxn>
                  <a:cxn ang="0">
                    <a:pos x="1416" y="955"/>
                  </a:cxn>
                  <a:cxn ang="0">
                    <a:pos x="1445" y="955"/>
                  </a:cxn>
                  <a:cxn ang="0">
                    <a:pos x="1475" y="970"/>
                  </a:cxn>
                </a:cxnLst>
                <a:rect l="0" t="0" r="r" b="b"/>
                <a:pathLst>
                  <a:path w="1492" h="970">
                    <a:moveTo>
                      <a:pt x="0" y="970"/>
                    </a:moveTo>
                    <a:lnTo>
                      <a:pt x="0" y="862"/>
                    </a:lnTo>
                    <a:lnTo>
                      <a:pt x="5" y="970"/>
                    </a:lnTo>
                    <a:lnTo>
                      <a:pt x="11" y="970"/>
                    </a:lnTo>
                    <a:lnTo>
                      <a:pt x="17" y="970"/>
                    </a:lnTo>
                    <a:lnTo>
                      <a:pt x="23" y="970"/>
                    </a:lnTo>
                    <a:lnTo>
                      <a:pt x="29" y="970"/>
                    </a:lnTo>
                    <a:lnTo>
                      <a:pt x="35" y="970"/>
                    </a:lnTo>
                    <a:lnTo>
                      <a:pt x="40" y="970"/>
                    </a:lnTo>
                    <a:lnTo>
                      <a:pt x="46" y="970"/>
                    </a:lnTo>
                    <a:lnTo>
                      <a:pt x="52" y="970"/>
                    </a:lnTo>
                    <a:lnTo>
                      <a:pt x="58" y="970"/>
                    </a:lnTo>
                    <a:lnTo>
                      <a:pt x="64" y="970"/>
                    </a:lnTo>
                    <a:lnTo>
                      <a:pt x="70" y="970"/>
                    </a:lnTo>
                    <a:lnTo>
                      <a:pt x="75" y="970"/>
                    </a:lnTo>
                    <a:lnTo>
                      <a:pt x="81" y="970"/>
                    </a:lnTo>
                    <a:lnTo>
                      <a:pt x="87" y="970"/>
                    </a:lnTo>
                    <a:lnTo>
                      <a:pt x="93" y="970"/>
                    </a:lnTo>
                    <a:lnTo>
                      <a:pt x="99" y="970"/>
                    </a:lnTo>
                    <a:lnTo>
                      <a:pt x="105" y="970"/>
                    </a:lnTo>
                    <a:lnTo>
                      <a:pt x="110" y="970"/>
                    </a:lnTo>
                    <a:lnTo>
                      <a:pt x="116" y="970"/>
                    </a:lnTo>
                    <a:lnTo>
                      <a:pt x="122" y="970"/>
                    </a:lnTo>
                    <a:lnTo>
                      <a:pt x="128" y="970"/>
                    </a:lnTo>
                    <a:lnTo>
                      <a:pt x="134" y="970"/>
                    </a:lnTo>
                    <a:lnTo>
                      <a:pt x="140" y="970"/>
                    </a:lnTo>
                    <a:lnTo>
                      <a:pt x="145" y="970"/>
                    </a:lnTo>
                    <a:lnTo>
                      <a:pt x="151" y="970"/>
                    </a:lnTo>
                    <a:lnTo>
                      <a:pt x="157" y="970"/>
                    </a:lnTo>
                    <a:lnTo>
                      <a:pt x="163" y="970"/>
                    </a:lnTo>
                    <a:lnTo>
                      <a:pt x="169" y="970"/>
                    </a:lnTo>
                    <a:lnTo>
                      <a:pt x="175" y="955"/>
                    </a:lnTo>
                    <a:lnTo>
                      <a:pt x="180" y="970"/>
                    </a:lnTo>
                    <a:lnTo>
                      <a:pt x="186" y="970"/>
                    </a:lnTo>
                    <a:lnTo>
                      <a:pt x="192" y="970"/>
                    </a:lnTo>
                    <a:lnTo>
                      <a:pt x="198" y="970"/>
                    </a:lnTo>
                    <a:lnTo>
                      <a:pt x="204" y="970"/>
                    </a:lnTo>
                    <a:lnTo>
                      <a:pt x="209" y="970"/>
                    </a:lnTo>
                    <a:lnTo>
                      <a:pt x="215" y="955"/>
                    </a:lnTo>
                    <a:lnTo>
                      <a:pt x="221" y="970"/>
                    </a:lnTo>
                    <a:lnTo>
                      <a:pt x="227" y="970"/>
                    </a:lnTo>
                    <a:lnTo>
                      <a:pt x="233" y="970"/>
                    </a:lnTo>
                    <a:lnTo>
                      <a:pt x="239" y="955"/>
                    </a:lnTo>
                    <a:lnTo>
                      <a:pt x="244" y="970"/>
                    </a:lnTo>
                    <a:lnTo>
                      <a:pt x="250" y="970"/>
                    </a:lnTo>
                    <a:lnTo>
                      <a:pt x="256" y="955"/>
                    </a:lnTo>
                    <a:lnTo>
                      <a:pt x="262" y="970"/>
                    </a:lnTo>
                    <a:lnTo>
                      <a:pt x="268" y="955"/>
                    </a:lnTo>
                    <a:lnTo>
                      <a:pt x="274" y="970"/>
                    </a:lnTo>
                    <a:lnTo>
                      <a:pt x="279" y="970"/>
                    </a:lnTo>
                    <a:lnTo>
                      <a:pt x="285" y="970"/>
                    </a:lnTo>
                    <a:lnTo>
                      <a:pt x="291" y="924"/>
                    </a:lnTo>
                    <a:lnTo>
                      <a:pt x="297" y="955"/>
                    </a:lnTo>
                    <a:lnTo>
                      <a:pt x="303" y="970"/>
                    </a:lnTo>
                    <a:lnTo>
                      <a:pt x="309" y="970"/>
                    </a:lnTo>
                    <a:lnTo>
                      <a:pt x="314" y="970"/>
                    </a:lnTo>
                    <a:lnTo>
                      <a:pt x="320" y="970"/>
                    </a:lnTo>
                    <a:lnTo>
                      <a:pt x="326" y="939"/>
                    </a:lnTo>
                    <a:lnTo>
                      <a:pt x="332" y="924"/>
                    </a:lnTo>
                    <a:lnTo>
                      <a:pt x="338" y="955"/>
                    </a:lnTo>
                    <a:lnTo>
                      <a:pt x="344" y="970"/>
                    </a:lnTo>
                    <a:lnTo>
                      <a:pt x="349" y="955"/>
                    </a:lnTo>
                    <a:lnTo>
                      <a:pt x="355" y="970"/>
                    </a:lnTo>
                    <a:lnTo>
                      <a:pt x="361" y="939"/>
                    </a:lnTo>
                    <a:lnTo>
                      <a:pt x="367" y="955"/>
                    </a:lnTo>
                    <a:lnTo>
                      <a:pt x="373" y="970"/>
                    </a:lnTo>
                    <a:lnTo>
                      <a:pt x="379" y="924"/>
                    </a:lnTo>
                    <a:lnTo>
                      <a:pt x="384" y="924"/>
                    </a:lnTo>
                    <a:lnTo>
                      <a:pt x="390" y="939"/>
                    </a:lnTo>
                    <a:lnTo>
                      <a:pt x="396" y="970"/>
                    </a:lnTo>
                    <a:lnTo>
                      <a:pt x="402" y="939"/>
                    </a:lnTo>
                    <a:lnTo>
                      <a:pt x="408" y="939"/>
                    </a:lnTo>
                    <a:lnTo>
                      <a:pt x="414" y="939"/>
                    </a:lnTo>
                    <a:lnTo>
                      <a:pt x="419" y="893"/>
                    </a:lnTo>
                    <a:lnTo>
                      <a:pt x="425" y="939"/>
                    </a:lnTo>
                    <a:lnTo>
                      <a:pt x="431" y="955"/>
                    </a:lnTo>
                    <a:lnTo>
                      <a:pt x="437" y="924"/>
                    </a:lnTo>
                    <a:lnTo>
                      <a:pt x="443" y="955"/>
                    </a:lnTo>
                    <a:lnTo>
                      <a:pt x="449" y="908"/>
                    </a:lnTo>
                    <a:lnTo>
                      <a:pt x="454" y="877"/>
                    </a:lnTo>
                    <a:lnTo>
                      <a:pt x="460" y="877"/>
                    </a:lnTo>
                    <a:lnTo>
                      <a:pt x="466" y="924"/>
                    </a:lnTo>
                    <a:lnTo>
                      <a:pt x="472" y="924"/>
                    </a:lnTo>
                    <a:lnTo>
                      <a:pt x="478" y="939"/>
                    </a:lnTo>
                    <a:lnTo>
                      <a:pt x="484" y="893"/>
                    </a:lnTo>
                    <a:lnTo>
                      <a:pt x="489" y="893"/>
                    </a:lnTo>
                    <a:lnTo>
                      <a:pt x="495" y="939"/>
                    </a:lnTo>
                    <a:lnTo>
                      <a:pt x="501" y="862"/>
                    </a:lnTo>
                    <a:lnTo>
                      <a:pt x="507" y="831"/>
                    </a:lnTo>
                    <a:lnTo>
                      <a:pt x="513" y="847"/>
                    </a:lnTo>
                    <a:lnTo>
                      <a:pt x="519" y="924"/>
                    </a:lnTo>
                    <a:lnTo>
                      <a:pt x="524" y="862"/>
                    </a:lnTo>
                    <a:lnTo>
                      <a:pt x="530" y="893"/>
                    </a:lnTo>
                    <a:lnTo>
                      <a:pt x="536" y="816"/>
                    </a:lnTo>
                    <a:lnTo>
                      <a:pt x="542" y="785"/>
                    </a:lnTo>
                    <a:lnTo>
                      <a:pt x="548" y="831"/>
                    </a:lnTo>
                    <a:lnTo>
                      <a:pt x="554" y="831"/>
                    </a:lnTo>
                    <a:lnTo>
                      <a:pt x="559" y="724"/>
                    </a:lnTo>
                    <a:lnTo>
                      <a:pt x="565" y="816"/>
                    </a:lnTo>
                    <a:lnTo>
                      <a:pt x="571" y="831"/>
                    </a:lnTo>
                    <a:lnTo>
                      <a:pt x="577" y="816"/>
                    </a:lnTo>
                    <a:lnTo>
                      <a:pt x="583" y="785"/>
                    </a:lnTo>
                    <a:lnTo>
                      <a:pt x="589" y="893"/>
                    </a:lnTo>
                    <a:lnTo>
                      <a:pt x="594" y="801"/>
                    </a:lnTo>
                    <a:lnTo>
                      <a:pt x="600" y="724"/>
                    </a:lnTo>
                    <a:lnTo>
                      <a:pt x="606" y="739"/>
                    </a:lnTo>
                    <a:lnTo>
                      <a:pt x="612" y="831"/>
                    </a:lnTo>
                    <a:lnTo>
                      <a:pt x="618" y="739"/>
                    </a:lnTo>
                    <a:lnTo>
                      <a:pt x="624" y="816"/>
                    </a:lnTo>
                    <a:lnTo>
                      <a:pt x="629" y="754"/>
                    </a:lnTo>
                    <a:lnTo>
                      <a:pt x="635" y="693"/>
                    </a:lnTo>
                    <a:lnTo>
                      <a:pt x="641" y="739"/>
                    </a:lnTo>
                    <a:lnTo>
                      <a:pt x="647" y="693"/>
                    </a:lnTo>
                    <a:lnTo>
                      <a:pt x="653" y="647"/>
                    </a:lnTo>
                    <a:lnTo>
                      <a:pt x="659" y="647"/>
                    </a:lnTo>
                    <a:lnTo>
                      <a:pt x="664" y="739"/>
                    </a:lnTo>
                    <a:lnTo>
                      <a:pt x="670" y="754"/>
                    </a:lnTo>
                    <a:lnTo>
                      <a:pt x="676" y="770"/>
                    </a:lnTo>
                    <a:lnTo>
                      <a:pt x="682" y="662"/>
                    </a:lnTo>
                    <a:lnTo>
                      <a:pt x="688" y="724"/>
                    </a:lnTo>
                    <a:lnTo>
                      <a:pt x="694" y="616"/>
                    </a:lnTo>
                    <a:lnTo>
                      <a:pt x="699" y="631"/>
                    </a:lnTo>
                    <a:lnTo>
                      <a:pt x="705" y="739"/>
                    </a:lnTo>
                    <a:lnTo>
                      <a:pt x="711" y="754"/>
                    </a:lnTo>
                    <a:lnTo>
                      <a:pt x="717" y="678"/>
                    </a:lnTo>
                    <a:lnTo>
                      <a:pt x="723" y="708"/>
                    </a:lnTo>
                    <a:lnTo>
                      <a:pt x="729" y="570"/>
                    </a:lnTo>
                    <a:lnTo>
                      <a:pt x="734" y="801"/>
                    </a:lnTo>
                    <a:lnTo>
                      <a:pt x="740" y="600"/>
                    </a:lnTo>
                    <a:lnTo>
                      <a:pt x="746" y="708"/>
                    </a:lnTo>
                    <a:lnTo>
                      <a:pt x="752" y="539"/>
                    </a:lnTo>
                    <a:lnTo>
                      <a:pt x="758" y="539"/>
                    </a:lnTo>
                    <a:lnTo>
                      <a:pt x="763" y="631"/>
                    </a:lnTo>
                    <a:lnTo>
                      <a:pt x="769" y="631"/>
                    </a:lnTo>
                    <a:lnTo>
                      <a:pt x="775" y="570"/>
                    </a:lnTo>
                    <a:lnTo>
                      <a:pt x="781" y="554"/>
                    </a:lnTo>
                    <a:lnTo>
                      <a:pt x="787" y="662"/>
                    </a:lnTo>
                    <a:lnTo>
                      <a:pt x="793" y="431"/>
                    </a:lnTo>
                    <a:lnTo>
                      <a:pt x="798" y="631"/>
                    </a:lnTo>
                    <a:lnTo>
                      <a:pt x="804" y="554"/>
                    </a:lnTo>
                    <a:lnTo>
                      <a:pt x="810" y="416"/>
                    </a:lnTo>
                    <a:lnTo>
                      <a:pt x="816" y="431"/>
                    </a:lnTo>
                    <a:lnTo>
                      <a:pt x="822" y="477"/>
                    </a:lnTo>
                    <a:lnTo>
                      <a:pt x="828" y="293"/>
                    </a:lnTo>
                    <a:lnTo>
                      <a:pt x="833" y="631"/>
                    </a:lnTo>
                    <a:lnTo>
                      <a:pt x="839" y="293"/>
                    </a:lnTo>
                    <a:lnTo>
                      <a:pt x="845" y="493"/>
                    </a:lnTo>
                    <a:lnTo>
                      <a:pt x="851" y="308"/>
                    </a:lnTo>
                    <a:lnTo>
                      <a:pt x="857" y="277"/>
                    </a:lnTo>
                    <a:lnTo>
                      <a:pt x="863" y="308"/>
                    </a:lnTo>
                    <a:lnTo>
                      <a:pt x="868" y="293"/>
                    </a:lnTo>
                    <a:lnTo>
                      <a:pt x="874" y="154"/>
                    </a:lnTo>
                    <a:lnTo>
                      <a:pt x="880" y="185"/>
                    </a:lnTo>
                    <a:lnTo>
                      <a:pt x="886" y="154"/>
                    </a:lnTo>
                    <a:lnTo>
                      <a:pt x="892" y="139"/>
                    </a:lnTo>
                    <a:lnTo>
                      <a:pt x="898" y="216"/>
                    </a:lnTo>
                    <a:lnTo>
                      <a:pt x="903" y="262"/>
                    </a:lnTo>
                    <a:lnTo>
                      <a:pt x="909" y="139"/>
                    </a:lnTo>
                    <a:lnTo>
                      <a:pt x="915" y="246"/>
                    </a:lnTo>
                    <a:lnTo>
                      <a:pt x="921" y="246"/>
                    </a:lnTo>
                    <a:lnTo>
                      <a:pt x="927" y="108"/>
                    </a:lnTo>
                    <a:lnTo>
                      <a:pt x="933" y="0"/>
                    </a:lnTo>
                    <a:lnTo>
                      <a:pt x="938" y="31"/>
                    </a:lnTo>
                    <a:lnTo>
                      <a:pt x="944" y="400"/>
                    </a:lnTo>
                    <a:lnTo>
                      <a:pt x="950" y="77"/>
                    </a:lnTo>
                    <a:lnTo>
                      <a:pt x="956" y="323"/>
                    </a:lnTo>
                    <a:lnTo>
                      <a:pt x="962" y="170"/>
                    </a:lnTo>
                    <a:lnTo>
                      <a:pt x="968" y="16"/>
                    </a:lnTo>
                    <a:lnTo>
                      <a:pt x="973" y="62"/>
                    </a:lnTo>
                    <a:lnTo>
                      <a:pt x="979" y="123"/>
                    </a:lnTo>
                    <a:lnTo>
                      <a:pt x="985" y="77"/>
                    </a:lnTo>
                    <a:lnTo>
                      <a:pt x="991" y="154"/>
                    </a:lnTo>
                    <a:lnTo>
                      <a:pt x="997" y="139"/>
                    </a:lnTo>
                    <a:lnTo>
                      <a:pt x="1002" y="231"/>
                    </a:lnTo>
                    <a:lnTo>
                      <a:pt x="1008" y="277"/>
                    </a:lnTo>
                    <a:lnTo>
                      <a:pt x="1014" y="170"/>
                    </a:lnTo>
                    <a:lnTo>
                      <a:pt x="1020" y="308"/>
                    </a:lnTo>
                    <a:lnTo>
                      <a:pt x="1026" y="323"/>
                    </a:lnTo>
                    <a:lnTo>
                      <a:pt x="1032" y="400"/>
                    </a:lnTo>
                    <a:lnTo>
                      <a:pt x="1037" y="493"/>
                    </a:lnTo>
                    <a:lnTo>
                      <a:pt x="1043" y="231"/>
                    </a:lnTo>
                    <a:lnTo>
                      <a:pt x="1049" y="308"/>
                    </a:lnTo>
                    <a:lnTo>
                      <a:pt x="1055" y="585"/>
                    </a:lnTo>
                    <a:lnTo>
                      <a:pt x="1061" y="323"/>
                    </a:lnTo>
                    <a:lnTo>
                      <a:pt x="1067" y="339"/>
                    </a:lnTo>
                    <a:lnTo>
                      <a:pt x="1072" y="416"/>
                    </a:lnTo>
                    <a:lnTo>
                      <a:pt x="1078" y="246"/>
                    </a:lnTo>
                    <a:lnTo>
                      <a:pt x="1084" y="385"/>
                    </a:lnTo>
                    <a:lnTo>
                      <a:pt x="1090" y="539"/>
                    </a:lnTo>
                    <a:lnTo>
                      <a:pt x="1096" y="416"/>
                    </a:lnTo>
                    <a:lnTo>
                      <a:pt x="1102" y="570"/>
                    </a:lnTo>
                    <a:lnTo>
                      <a:pt x="1107" y="508"/>
                    </a:lnTo>
                    <a:lnTo>
                      <a:pt x="1113" y="554"/>
                    </a:lnTo>
                    <a:lnTo>
                      <a:pt x="1119" y="600"/>
                    </a:lnTo>
                    <a:lnTo>
                      <a:pt x="1125" y="585"/>
                    </a:lnTo>
                    <a:lnTo>
                      <a:pt x="1131" y="554"/>
                    </a:lnTo>
                    <a:lnTo>
                      <a:pt x="1137" y="616"/>
                    </a:lnTo>
                    <a:lnTo>
                      <a:pt x="1142" y="570"/>
                    </a:lnTo>
                    <a:lnTo>
                      <a:pt x="1148" y="554"/>
                    </a:lnTo>
                    <a:lnTo>
                      <a:pt x="1154" y="724"/>
                    </a:lnTo>
                    <a:lnTo>
                      <a:pt x="1160" y="631"/>
                    </a:lnTo>
                    <a:lnTo>
                      <a:pt x="1166" y="708"/>
                    </a:lnTo>
                    <a:lnTo>
                      <a:pt x="1172" y="724"/>
                    </a:lnTo>
                    <a:lnTo>
                      <a:pt x="1177" y="570"/>
                    </a:lnTo>
                    <a:lnTo>
                      <a:pt x="1183" y="662"/>
                    </a:lnTo>
                    <a:lnTo>
                      <a:pt x="1189" y="739"/>
                    </a:lnTo>
                    <a:lnTo>
                      <a:pt x="1195" y="631"/>
                    </a:lnTo>
                    <a:lnTo>
                      <a:pt x="1201" y="708"/>
                    </a:lnTo>
                    <a:lnTo>
                      <a:pt x="1206" y="616"/>
                    </a:lnTo>
                    <a:lnTo>
                      <a:pt x="1212" y="678"/>
                    </a:lnTo>
                    <a:lnTo>
                      <a:pt x="1218" y="600"/>
                    </a:lnTo>
                    <a:lnTo>
                      <a:pt x="1224" y="662"/>
                    </a:lnTo>
                    <a:lnTo>
                      <a:pt x="1230" y="693"/>
                    </a:lnTo>
                    <a:lnTo>
                      <a:pt x="1236" y="662"/>
                    </a:lnTo>
                    <a:lnTo>
                      <a:pt x="1241" y="708"/>
                    </a:lnTo>
                    <a:lnTo>
                      <a:pt x="1247" y="647"/>
                    </a:lnTo>
                    <a:lnTo>
                      <a:pt x="1253" y="616"/>
                    </a:lnTo>
                    <a:lnTo>
                      <a:pt x="1259" y="647"/>
                    </a:lnTo>
                    <a:lnTo>
                      <a:pt x="1265" y="693"/>
                    </a:lnTo>
                    <a:lnTo>
                      <a:pt x="1271" y="616"/>
                    </a:lnTo>
                    <a:lnTo>
                      <a:pt x="1276" y="785"/>
                    </a:lnTo>
                    <a:lnTo>
                      <a:pt x="1282" y="693"/>
                    </a:lnTo>
                    <a:lnTo>
                      <a:pt x="1288" y="739"/>
                    </a:lnTo>
                    <a:lnTo>
                      <a:pt x="1294" y="893"/>
                    </a:lnTo>
                    <a:lnTo>
                      <a:pt x="1300" y="678"/>
                    </a:lnTo>
                    <a:lnTo>
                      <a:pt x="1306" y="739"/>
                    </a:lnTo>
                    <a:lnTo>
                      <a:pt x="1311" y="862"/>
                    </a:lnTo>
                    <a:lnTo>
                      <a:pt x="1317" y="785"/>
                    </a:lnTo>
                    <a:lnTo>
                      <a:pt x="1323" y="816"/>
                    </a:lnTo>
                    <a:lnTo>
                      <a:pt x="1329" y="816"/>
                    </a:lnTo>
                    <a:lnTo>
                      <a:pt x="1335" y="816"/>
                    </a:lnTo>
                    <a:lnTo>
                      <a:pt x="1341" y="754"/>
                    </a:lnTo>
                    <a:lnTo>
                      <a:pt x="1346" y="816"/>
                    </a:lnTo>
                    <a:lnTo>
                      <a:pt x="1352" y="877"/>
                    </a:lnTo>
                    <a:lnTo>
                      <a:pt x="1358" y="816"/>
                    </a:lnTo>
                    <a:lnTo>
                      <a:pt x="1364" y="847"/>
                    </a:lnTo>
                    <a:lnTo>
                      <a:pt x="1370" y="939"/>
                    </a:lnTo>
                    <a:lnTo>
                      <a:pt x="1376" y="908"/>
                    </a:lnTo>
                    <a:lnTo>
                      <a:pt x="1381" y="816"/>
                    </a:lnTo>
                    <a:lnTo>
                      <a:pt x="1387" y="924"/>
                    </a:lnTo>
                    <a:lnTo>
                      <a:pt x="1393" y="908"/>
                    </a:lnTo>
                    <a:lnTo>
                      <a:pt x="1399" y="893"/>
                    </a:lnTo>
                    <a:lnTo>
                      <a:pt x="1405" y="862"/>
                    </a:lnTo>
                    <a:lnTo>
                      <a:pt x="1411" y="939"/>
                    </a:lnTo>
                    <a:lnTo>
                      <a:pt x="1416" y="955"/>
                    </a:lnTo>
                    <a:lnTo>
                      <a:pt x="1422" y="924"/>
                    </a:lnTo>
                    <a:lnTo>
                      <a:pt x="1428" y="877"/>
                    </a:lnTo>
                    <a:lnTo>
                      <a:pt x="1434" y="893"/>
                    </a:lnTo>
                    <a:lnTo>
                      <a:pt x="1440" y="924"/>
                    </a:lnTo>
                    <a:lnTo>
                      <a:pt x="1445" y="955"/>
                    </a:lnTo>
                    <a:lnTo>
                      <a:pt x="1451" y="939"/>
                    </a:lnTo>
                    <a:lnTo>
                      <a:pt x="1457" y="847"/>
                    </a:lnTo>
                    <a:lnTo>
                      <a:pt x="1463" y="724"/>
                    </a:lnTo>
                    <a:lnTo>
                      <a:pt x="1469" y="970"/>
                    </a:lnTo>
                    <a:lnTo>
                      <a:pt x="1475" y="970"/>
                    </a:lnTo>
                    <a:lnTo>
                      <a:pt x="1480" y="970"/>
                    </a:lnTo>
                    <a:lnTo>
                      <a:pt x="1486" y="970"/>
                    </a:lnTo>
                    <a:lnTo>
                      <a:pt x="1492" y="970"/>
                    </a:lnTo>
                    <a:lnTo>
                      <a:pt x="0" y="970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47" name="Freeform 79"/>
              <p:cNvSpPr>
                <a:spLocks/>
              </p:cNvSpPr>
              <p:nvPr/>
            </p:nvSpPr>
            <p:spPr bwMode="auto">
              <a:xfrm>
                <a:off x="5688013" y="2219325"/>
                <a:ext cx="2368550" cy="1539875"/>
              </a:xfrm>
              <a:custGeom>
                <a:avLst/>
                <a:gdLst/>
                <a:ahLst/>
                <a:cxnLst>
                  <a:cxn ang="0">
                    <a:pos x="17" y="970"/>
                  </a:cxn>
                  <a:cxn ang="0">
                    <a:pos x="46" y="970"/>
                  </a:cxn>
                  <a:cxn ang="0">
                    <a:pos x="75" y="970"/>
                  </a:cxn>
                  <a:cxn ang="0">
                    <a:pos x="105" y="970"/>
                  </a:cxn>
                  <a:cxn ang="0">
                    <a:pos x="134" y="970"/>
                  </a:cxn>
                  <a:cxn ang="0">
                    <a:pos x="163" y="970"/>
                  </a:cxn>
                  <a:cxn ang="0">
                    <a:pos x="192" y="970"/>
                  </a:cxn>
                  <a:cxn ang="0">
                    <a:pos x="221" y="970"/>
                  </a:cxn>
                  <a:cxn ang="0">
                    <a:pos x="250" y="970"/>
                  </a:cxn>
                  <a:cxn ang="0">
                    <a:pos x="279" y="970"/>
                  </a:cxn>
                  <a:cxn ang="0">
                    <a:pos x="309" y="970"/>
                  </a:cxn>
                  <a:cxn ang="0">
                    <a:pos x="338" y="955"/>
                  </a:cxn>
                  <a:cxn ang="0">
                    <a:pos x="367" y="955"/>
                  </a:cxn>
                  <a:cxn ang="0">
                    <a:pos x="396" y="970"/>
                  </a:cxn>
                  <a:cxn ang="0">
                    <a:pos x="425" y="939"/>
                  </a:cxn>
                  <a:cxn ang="0">
                    <a:pos x="454" y="877"/>
                  </a:cxn>
                  <a:cxn ang="0">
                    <a:pos x="484" y="893"/>
                  </a:cxn>
                  <a:cxn ang="0">
                    <a:pos x="513" y="847"/>
                  </a:cxn>
                  <a:cxn ang="0">
                    <a:pos x="542" y="785"/>
                  </a:cxn>
                  <a:cxn ang="0">
                    <a:pos x="571" y="831"/>
                  </a:cxn>
                  <a:cxn ang="0">
                    <a:pos x="600" y="724"/>
                  </a:cxn>
                  <a:cxn ang="0">
                    <a:pos x="629" y="754"/>
                  </a:cxn>
                  <a:cxn ang="0">
                    <a:pos x="659" y="647"/>
                  </a:cxn>
                  <a:cxn ang="0">
                    <a:pos x="688" y="724"/>
                  </a:cxn>
                  <a:cxn ang="0">
                    <a:pos x="717" y="678"/>
                  </a:cxn>
                  <a:cxn ang="0">
                    <a:pos x="746" y="708"/>
                  </a:cxn>
                  <a:cxn ang="0">
                    <a:pos x="775" y="570"/>
                  </a:cxn>
                  <a:cxn ang="0">
                    <a:pos x="804" y="554"/>
                  </a:cxn>
                  <a:cxn ang="0">
                    <a:pos x="833" y="631"/>
                  </a:cxn>
                  <a:cxn ang="0">
                    <a:pos x="863" y="308"/>
                  </a:cxn>
                  <a:cxn ang="0">
                    <a:pos x="892" y="139"/>
                  </a:cxn>
                  <a:cxn ang="0">
                    <a:pos x="921" y="246"/>
                  </a:cxn>
                  <a:cxn ang="0">
                    <a:pos x="950" y="77"/>
                  </a:cxn>
                  <a:cxn ang="0">
                    <a:pos x="979" y="123"/>
                  </a:cxn>
                  <a:cxn ang="0">
                    <a:pos x="1008" y="277"/>
                  </a:cxn>
                  <a:cxn ang="0">
                    <a:pos x="1037" y="493"/>
                  </a:cxn>
                  <a:cxn ang="0">
                    <a:pos x="1067" y="339"/>
                  </a:cxn>
                  <a:cxn ang="0">
                    <a:pos x="1096" y="416"/>
                  </a:cxn>
                  <a:cxn ang="0">
                    <a:pos x="1125" y="585"/>
                  </a:cxn>
                  <a:cxn ang="0">
                    <a:pos x="1154" y="724"/>
                  </a:cxn>
                  <a:cxn ang="0">
                    <a:pos x="1183" y="662"/>
                  </a:cxn>
                  <a:cxn ang="0">
                    <a:pos x="1212" y="678"/>
                  </a:cxn>
                  <a:cxn ang="0">
                    <a:pos x="1241" y="708"/>
                  </a:cxn>
                  <a:cxn ang="0">
                    <a:pos x="1271" y="616"/>
                  </a:cxn>
                  <a:cxn ang="0">
                    <a:pos x="1300" y="678"/>
                  </a:cxn>
                  <a:cxn ang="0">
                    <a:pos x="1329" y="816"/>
                  </a:cxn>
                  <a:cxn ang="0">
                    <a:pos x="1358" y="816"/>
                  </a:cxn>
                  <a:cxn ang="0">
                    <a:pos x="1387" y="924"/>
                  </a:cxn>
                  <a:cxn ang="0">
                    <a:pos x="1416" y="955"/>
                  </a:cxn>
                  <a:cxn ang="0">
                    <a:pos x="1445" y="955"/>
                  </a:cxn>
                  <a:cxn ang="0">
                    <a:pos x="1475" y="970"/>
                  </a:cxn>
                </a:cxnLst>
                <a:rect l="0" t="0" r="r" b="b"/>
                <a:pathLst>
                  <a:path w="1492" h="970">
                    <a:moveTo>
                      <a:pt x="0" y="970"/>
                    </a:moveTo>
                    <a:lnTo>
                      <a:pt x="0" y="862"/>
                    </a:lnTo>
                    <a:lnTo>
                      <a:pt x="5" y="970"/>
                    </a:lnTo>
                    <a:lnTo>
                      <a:pt x="11" y="970"/>
                    </a:lnTo>
                    <a:lnTo>
                      <a:pt x="17" y="970"/>
                    </a:lnTo>
                    <a:lnTo>
                      <a:pt x="23" y="970"/>
                    </a:lnTo>
                    <a:lnTo>
                      <a:pt x="29" y="970"/>
                    </a:lnTo>
                    <a:lnTo>
                      <a:pt x="35" y="970"/>
                    </a:lnTo>
                    <a:lnTo>
                      <a:pt x="40" y="970"/>
                    </a:lnTo>
                    <a:lnTo>
                      <a:pt x="46" y="970"/>
                    </a:lnTo>
                    <a:lnTo>
                      <a:pt x="52" y="970"/>
                    </a:lnTo>
                    <a:lnTo>
                      <a:pt x="58" y="970"/>
                    </a:lnTo>
                    <a:lnTo>
                      <a:pt x="64" y="970"/>
                    </a:lnTo>
                    <a:lnTo>
                      <a:pt x="70" y="970"/>
                    </a:lnTo>
                    <a:lnTo>
                      <a:pt x="75" y="970"/>
                    </a:lnTo>
                    <a:lnTo>
                      <a:pt x="81" y="970"/>
                    </a:lnTo>
                    <a:lnTo>
                      <a:pt x="87" y="970"/>
                    </a:lnTo>
                    <a:lnTo>
                      <a:pt x="93" y="970"/>
                    </a:lnTo>
                    <a:lnTo>
                      <a:pt x="99" y="970"/>
                    </a:lnTo>
                    <a:lnTo>
                      <a:pt x="105" y="970"/>
                    </a:lnTo>
                    <a:lnTo>
                      <a:pt x="110" y="970"/>
                    </a:lnTo>
                    <a:lnTo>
                      <a:pt x="116" y="970"/>
                    </a:lnTo>
                    <a:lnTo>
                      <a:pt x="122" y="970"/>
                    </a:lnTo>
                    <a:lnTo>
                      <a:pt x="128" y="970"/>
                    </a:lnTo>
                    <a:lnTo>
                      <a:pt x="134" y="970"/>
                    </a:lnTo>
                    <a:lnTo>
                      <a:pt x="140" y="970"/>
                    </a:lnTo>
                    <a:lnTo>
                      <a:pt x="145" y="970"/>
                    </a:lnTo>
                    <a:lnTo>
                      <a:pt x="151" y="970"/>
                    </a:lnTo>
                    <a:lnTo>
                      <a:pt x="157" y="970"/>
                    </a:lnTo>
                    <a:lnTo>
                      <a:pt x="163" y="970"/>
                    </a:lnTo>
                    <a:lnTo>
                      <a:pt x="169" y="970"/>
                    </a:lnTo>
                    <a:lnTo>
                      <a:pt x="175" y="955"/>
                    </a:lnTo>
                    <a:lnTo>
                      <a:pt x="180" y="970"/>
                    </a:lnTo>
                    <a:lnTo>
                      <a:pt x="186" y="970"/>
                    </a:lnTo>
                    <a:lnTo>
                      <a:pt x="192" y="970"/>
                    </a:lnTo>
                    <a:lnTo>
                      <a:pt x="198" y="970"/>
                    </a:lnTo>
                    <a:lnTo>
                      <a:pt x="204" y="970"/>
                    </a:lnTo>
                    <a:lnTo>
                      <a:pt x="209" y="970"/>
                    </a:lnTo>
                    <a:lnTo>
                      <a:pt x="215" y="955"/>
                    </a:lnTo>
                    <a:lnTo>
                      <a:pt x="221" y="970"/>
                    </a:lnTo>
                    <a:lnTo>
                      <a:pt x="227" y="970"/>
                    </a:lnTo>
                    <a:lnTo>
                      <a:pt x="233" y="970"/>
                    </a:lnTo>
                    <a:lnTo>
                      <a:pt x="239" y="955"/>
                    </a:lnTo>
                    <a:lnTo>
                      <a:pt x="244" y="970"/>
                    </a:lnTo>
                    <a:lnTo>
                      <a:pt x="250" y="970"/>
                    </a:lnTo>
                    <a:lnTo>
                      <a:pt x="256" y="955"/>
                    </a:lnTo>
                    <a:lnTo>
                      <a:pt x="262" y="970"/>
                    </a:lnTo>
                    <a:lnTo>
                      <a:pt x="268" y="955"/>
                    </a:lnTo>
                    <a:lnTo>
                      <a:pt x="274" y="970"/>
                    </a:lnTo>
                    <a:lnTo>
                      <a:pt x="279" y="970"/>
                    </a:lnTo>
                    <a:lnTo>
                      <a:pt x="285" y="970"/>
                    </a:lnTo>
                    <a:lnTo>
                      <a:pt x="291" y="924"/>
                    </a:lnTo>
                    <a:lnTo>
                      <a:pt x="297" y="955"/>
                    </a:lnTo>
                    <a:lnTo>
                      <a:pt x="303" y="970"/>
                    </a:lnTo>
                    <a:lnTo>
                      <a:pt x="309" y="970"/>
                    </a:lnTo>
                    <a:lnTo>
                      <a:pt x="314" y="970"/>
                    </a:lnTo>
                    <a:lnTo>
                      <a:pt x="320" y="970"/>
                    </a:lnTo>
                    <a:lnTo>
                      <a:pt x="326" y="939"/>
                    </a:lnTo>
                    <a:lnTo>
                      <a:pt x="332" y="924"/>
                    </a:lnTo>
                    <a:lnTo>
                      <a:pt x="338" y="955"/>
                    </a:lnTo>
                    <a:lnTo>
                      <a:pt x="344" y="970"/>
                    </a:lnTo>
                    <a:lnTo>
                      <a:pt x="349" y="955"/>
                    </a:lnTo>
                    <a:lnTo>
                      <a:pt x="355" y="970"/>
                    </a:lnTo>
                    <a:lnTo>
                      <a:pt x="361" y="939"/>
                    </a:lnTo>
                    <a:lnTo>
                      <a:pt x="367" y="955"/>
                    </a:lnTo>
                    <a:lnTo>
                      <a:pt x="373" y="970"/>
                    </a:lnTo>
                    <a:lnTo>
                      <a:pt x="379" y="924"/>
                    </a:lnTo>
                    <a:lnTo>
                      <a:pt x="384" y="924"/>
                    </a:lnTo>
                    <a:lnTo>
                      <a:pt x="390" y="939"/>
                    </a:lnTo>
                    <a:lnTo>
                      <a:pt x="396" y="970"/>
                    </a:lnTo>
                    <a:lnTo>
                      <a:pt x="402" y="939"/>
                    </a:lnTo>
                    <a:lnTo>
                      <a:pt x="408" y="939"/>
                    </a:lnTo>
                    <a:lnTo>
                      <a:pt x="414" y="939"/>
                    </a:lnTo>
                    <a:lnTo>
                      <a:pt x="419" y="893"/>
                    </a:lnTo>
                    <a:lnTo>
                      <a:pt x="425" y="939"/>
                    </a:lnTo>
                    <a:lnTo>
                      <a:pt x="431" y="955"/>
                    </a:lnTo>
                    <a:lnTo>
                      <a:pt x="437" y="924"/>
                    </a:lnTo>
                    <a:lnTo>
                      <a:pt x="443" y="955"/>
                    </a:lnTo>
                    <a:lnTo>
                      <a:pt x="449" y="908"/>
                    </a:lnTo>
                    <a:lnTo>
                      <a:pt x="454" y="877"/>
                    </a:lnTo>
                    <a:lnTo>
                      <a:pt x="460" y="877"/>
                    </a:lnTo>
                    <a:lnTo>
                      <a:pt x="466" y="924"/>
                    </a:lnTo>
                    <a:lnTo>
                      <a:pt x="472" y="924"/>
                    </a:lnTo>
                    <a:lnTo>
                      <a:pt x="478" y="939"/>
                    </a:lnTo>
                    <a:lnTo>
                      <a:pt x="484" y="893"/>
                    </a:lnTo>
                    <a:lnTo>
                      <a:pt x="489" y="893"/>
                    </a:lnTo>
                    <a:lnTo>
                      <a:pt x="495" y="939"/>
                    </a:lnTo>
                    <a:lnTo>
                      <a:pt x="501" y="862"/>
                    </a:lnTo>
                    <a:lnTo>
                      <a:pt x="507" y="831"/>
                    </a:lnTo>
                    <a:lnTo>
                      <a:pt x="513" y="847"/>
                    </a:lnTo>
                    <a:lnTo>
                      <a:pt x="519" y="924"/>
                    </a:lnTo>
                    <a:lnTo>
                      <a:pt x="524" y="862"/>
                    </a:lnTo>
                    <a:lnTo>
                      <a:pt x="530" y="893"/>
                    </a:lnTo>
                    <a:lnTo>
                      <a:pt x="536" y="816"/>
                    </a:lnTo>
                    <a:lnTo>
                      <a:pt x="542" y="785"/>
                    </a:lnTo>
                    <a:lnTo>
                      <a:pt x="548" y="831"/>
                    </a:lnTo>
                    <a:lnTo>
                      <a:pt x="554" y="831"/>
                    </a:lnTo>
                    <a:lnTo>
                      <a:pt x="559" y="724"/>
                    </a:lnTo>
                    <a:lnTo>
                      <a:pt x="565" y="816"/>
                    </a:lnTo>
                    <a:lnTo>
                      <a:pt x="571" y="831"/>
                    </a:lnTo>
                    <a:lnTo>
                      <a:pt x="577" y="816"/>
                    </a:lnTo>
                    <a:lnTo>
                      <a:pt x="583" y="785"/>
                    </a:lnTo>
                    <a:lnTo>
                      <a:pt x="589" y="893"/>
                    </a:lnTo>
                    <a:lnTo>
                      <a:pt x="594" y="801"/>
                    </a:lnTo>
                    <a:lnTo>
                      <a:pt x="600" y="724"/>
                    </a:lnTo>
                    <a:lnTo>
                      <a:pt x="606" y="739"/>
                    </a:lnTo>
                    <a:lnTo>
                      <a:pt x="612" y="831"/>
                    </a:lnTo>
                    <a:lnTo>
                      <a:pt x="618" y="739"/>
                    </a:lnTo>
                    <a:lnTo>
                      <a:pt x="624" y="816"/>
                    </a:lnTo>
                    <a:lnTo>
                      <a:pt x="629" y="754"/>
                    </a:lnTo>
                    <a:lnTo>
                      <a:pt x="635" y="693"/>
                    </a:lnTo>
                    <a:lnTo>
                      <a:pt x="641" y="739"/>
                    </a:lnTo>
                    <a:lnTo>
                      <a:pt x="647" y="693"/>
                    </a:lnTo>
                    <a:lnTo>
                      <a:pt x="653" y="647"/>
                    </a:lnTo>
                    <a:lnTo>
                      <a:pt x="659" y="647"/>
                    </a:lnTo>
                    <a:lnTo>
                      <a:pt x="664" y="739"/>
                    </a:lnTo>
                    <a:lnTo>
                      <a:pt x="670" y="754"/>
                    </a:lnTo>
                    <a:lnTo>
                      <a:pt x="676" y="770"/>
                    </a:lnTo>
                    <a:lnTo>
                      <a:pt x="682" y="662"/>
                    </a:lnTo>
                    <a:lnTo>
                      <a:pt x="688" y="724"/>
                    </a:lnTo>
                    <a:lnTo>
                      <a:pt x="694" y="616"/>
                    </a:lnTo>
                    <a:lnTo>
                      <a:pt x="699" y="631"/>
                    </a:lnTo>
                    <a:lnTo>
                      <a:pt x="705" y="739"/>
                    </a:lnTo>
                    <a:lnTo>
                      <a:pt x="711" y="754"/>
                    </a:lnTo>
                    <a:lnTo>
                      <a:pt x="717" y="678"/>
                    </a:lnTo>
                    <a:lnTo>
                      <a:pt x="723" y="708"/>
                    </a:lnTo>
                    <a:lnTo>
                      <a:pt x="729" y="570"/>
                    </a:lnTo>
                    <a:lnTo>
                      <a:pt x="734" y="801"/>
                    </a:lnTo>
                    <a:lnTo>
                      <a:pt x="740" y="600"/>
                    </a:lnTo>
                    <a:lnTo>
                      <a:pt x="746" y="708"/>
                    </a:lnTo>
                    <a:lnTo>
                      <a:pt x="752" y="539"/>
                    </a:lnTo>
                    <a:lnTo>
                      <a:pt x="758" y="539"/>
                    </a:lnTo>
                    <a:lnTo>
                      <a:pt x="763" y="631"/>
                    </a:lnTo>
                    <a:lnTo>
                      <a:pt x="769" y="631"/>
                    </a:lnTo>
                    <a:lnTo>
                      <a:pt x="775" y="570"/>
                    </a:lnTo>
                    <a:lnTo>
                      <a:pt x="781" y="554"/>
                    </a:lnTo>
                    <a:lnTo>
                      <a:pt x="787" y="662"/>
                    </a:lnTo>
                    <a:lnTo>
                      <a:pt x="793" y="431"/>
                    </a:lnTo>
                    <a:lnTo>
                      <a:pt x="798" y="631"/>
                    </a:lnTo>
                    <a:lnTo>
                      <a:pt x="804" y="554"/>
                    </a:lnTo>
                    <a:lnTo>
                      <a:pt x="810" y="416"/>
                    </a:lnTo>
                    <a:lnTo>
                      <a:pt x="816" y="431"/>
                    </a:lnTo>
                    <a:lnTo>
                      <a:pt x="822" y="477"/>
                    </a:lnTo>
                    <a:lnTo>
                      <a:pt x="828" y="293"/>
                    </a:lnTo>
                    <a:lnTo>
                      <a:pt x="833" y="631"/>
                    </a:lnTo>
                    <a:lnTo>
                      <a:pt x="839" y="293"/>
                    </a:lnTo>
                    <a:lnTo>
                      <a:pt x="845" y="493"/>
                    </a:lnTo>
                    <a:lnTo>
                      <a:pt x="851" y="308"/>
                    </a:lnTo>
                    <a:lnTo>
                      <a:pt x="857" y="277"/>
                    </a:lnTo>
                    <a:lnTo>
                      <a:pt x="863" y="308"/>
                    </a:lnTo>
                    <a:lnTo>
                      <a:pt x="868" y="293"/>
                    </a:lnTo>
                    <a:lnTo>
                      <a:pt x="874" y="154"/>
                    </a:lnTo>
                    <a:lnTo>
                      <a:pt x="880" y="185"/>
                    </a:lnTo>
                    <a:lnTo>
                      <a:pt x="886" y="154"/>
                    </a:lnTo>
                    <a:lnTo>
                      <a:pt x="892" y="139"/>
                    </a:lnTo>
                    <a:lnTo>
                      <a:pt x="898" y="216"/>
                    </a:lnTo>
                    <a:lnTo>
                      <a:pt x="903" y="262"/>
                    </a:lnTo>
                    <a:lnTo>
                      <a:pt x="909" y="139"/>
                    </a:lnTo>
                    <a:lnTo>
                      <a:pt x="915" y="246"/>
                    </a:lnTo>
                    <a:lnTo>
                      <a:pt x="921" y="246"/>
                    </a:lnTo>
                    <a:lnTo>
                      <a:pt x="927" y="108"/>
                    </a:lnTo>
                    <a:lnTo>
                      <a:pt x="933" y="0"/>
                    </a:lnTo>
                    <a:lnTo>
                      <a:pt x="938" y="31"/>
                    </a:lnTo>
                    <a:lnTo>
                      <a:pt x="944" y="400"/>
                    </a:lnTo>
                    <a:lnTo>
                      <a:pt x="950" y="77"/>
                    </a:lnTo>
                    <a:lnTo>
                      <a:pt x="956" y="323"/>
                    </a:lnTo>
                    <a:lnTo>
                      <a:pt x="962" y="170"/>
                    </a:lnTo>
                    <a:lnTo>
                      <a:pt x="968" y="16"/>
                    </a:lnTo>
                    <a:lnTo>
                      <a:pt x="973" y="62"/>
                    </a:lnTo>
                    <a:lnTo>
                      <a:pt x="979" y="123"/>
                    </a:lnTo>
                    <a:lnTo>
                      <a:pt x="985" y="77"/>
                    </a:lnTo>
                    <a:lnTo>
                      <a:pt x="991" y="154"/>
                    </a:lnTo>
                    <a:lnTo>
                      <a:pt x="997" y="139"/>
                    </a:lnTo>
                    <a:lnTo>
                      <a:pt x="1002" y="231"/>
                    </a:lnTo>
                    <a:lnTo>
                      <a:pt x="1008" y="277"/>
                    </a:lnTo>
                    <a:lnTo>
                      <a:pt x="1014" y="170"/>
                    </a:lnTo>
                    <a:lnTo>
                      <a:pt x="1020" y="308"/>
                    </a:lnTo>
                    <a:lnTo>
                      <a:pt x="1026" y="323"/>
                    </a:lnTo>
                    <a:lnTo>
                      <a:pt x="1032" y="400"/>
                    </a:lnTo>
                    <a:lnTo>
                      <a:pt x="1037" y="493"/>
                    </a:lnTo>
                    <a:lnTo>
                      <a:pt x="1043" y="231"/>
                    </a:lnTo>
                    <a:lnTo>
                      <a:pt x="1049" y="308"/>
                    </a:lnTo>
                    <a:lnTo>
                      <a:pt x="1055" y="585"/>
                    </a:lnTo>
                    <a:lnTo>
                      <a:pt x="1061" y="323"/>
                    </a:lnTo>
                    <a:lnTo>
                      <a:pt x="1067" y="339"/>
                    </a:lnTo>
                    <a:lnTo>
                      <a:pt x="1072" y="416"/>
                    </a:lnTo>
                    <a:lnTo>
                      <a:pt x="1078" y="246"/>
                    </a:lnTo>
                    <a:lnTo>
                      <a:pt x="1084" y="385"/>
                    </a:lnTo>
                    <a:lnTo>
                      <a:pt x="1090" y="539"/>
                    </a:lnTo>
                    <a:lnTo>
                      <a:pt x="1096" y="416"/>
                    </a:lnTo>
                    <a:lnTo>
                      <a:pt x="1102" y="570"/>
                    </a:lnTo>
                    <a:lnTo>
                      <a:pt x="1107" y="508"/>
                    </a:lnTo>
                    <a:lnTo>
                      <a:pt x="1113" y="554"/>
                    </a:lnTo>
                    <a:lnTo>
                      <a:pt x="1119" y="600"/>
                    </a:lnTo>
                    <a:lnTo>
                      <a:pt x="1125" y="585"/>
                    </a:lnTo>
                    <a:lnTo>
                      <a:pt x="1131" y="554"/>
                    </a:lnTo>
                    <a:lnTo>
                      <a:pt x="1137" y="616"/>
                    </a:lnTo>
                    <a:lnTo>
                      <a:pt x="1142" y="570"/>
                    </a:lnTo>
                    <a:lnTo>
                      <a:pt x="1148" y="554"/>
                    </a:lnTo>
                    <a:lnTo>
                      <a:pt x="1154" y="724"/>
                    </a:lnTo>
                    <a:lnTo>
                      <a:pt x="1160" y="631"/>
                    </a:lnTo>
                    <a:lnTo>
                      <a:pt x="1166" y="708"/>
                    </a:lnTo>
                    <a:lnTo>
                      <a:pt x="1172" y="724"/>
                    </a:lnTo>
                    <a:lnTo>
                      <a:pt x="1177" y="570"/>
                    </a:lnTo>
                    <a:lnTo>
                      <a:pt x="1183" y="662"/>
                    </a:lnTo>
                    <a:lnTo>
                      <a:pt x="1189" y="739"/>
                    </a:lnTo>
                    <a:lnTo>
                      <a:pt x="1195" y="631"/>
                    </a:lnTo>
                    <a:lnTo>
                      <a:pt x="1201" y="708"/>
                    </a:lnTo>
                    <a:lnTo>
                      <a:pt x="1206" y="616"/>
                    </a:lnTo>
                    <a:lnTo>
                      <a:pt x="1212" y="678"/>
                    </a:lnTo>
                    <a:lnTo>
                      <a:pt x="1218" y="600"/>
                    </a:lnTo>
                    <a:lnTo>
                      <a:pt x="1224" y="662"/>
                    </a:lnTo>
                    <a:lnTo>
                      <a:pt x="1230" y="693"/>
                    </a:lnTo>
                    <a:lnTo>
                      <a:pt x="1236" y="662"/>
                    </a:lnTo>
                    <a:lnTo>
                      <a:pt x="1241" y="708"/>
                    </a:lnTo>
                    <a:lnTo>
                      <a:pt x="1247" y="647"/>
                    </a:lnTo>
                    <a:lnTo>
                      <a:pt x="1253" y="616"/>
                    </a:lnTo>
                    <a:lnTo>
                      <a:pt x="1259" y="647"/>
                    </a:lnTo>
                    <a:lnTo>
                      <a:pt x="1265" y="693"/>
                    </a:lnTo>
                    <a:lnTo>
                      <a:pt x="1271" y="616"/>
                    </a:lnTo>
                    <a:lnTo>
                      <a:pt x="1276" y="785"/>
                    </a:lnTo>
                    <a:lnTo>
                      <a:pt x="1282" y="693"/>
                    </a:lnTo>
                    <a:lnTo>
                      <a:pt x="1288" y="739"/>
                    </a:lnTo>
                    <a:lnTo>
                      <a:pt x="1294" y="893"/>
                    </a:lnTo>
                    <a:lnTo>
                      <a:pt x="1300" y="678"/>
                    </a:lnTo>
                    <a:lnTo>
                      <a:pt x="1306" y="739"/>
                    </a:lnTo>
                    <a:lnTo>
                      <a:pt x="1311" y="862"/>
                    </a:lnTo>
                    <a:lnTo>
                      <a:pt x="1317" y="785"/>
                    </a:lnTo>
                    <a:lnTo>
                      <a:pt x="1323" y="816"/>
                    </a:lnTo>
                    <a:lnTo>
                      <a:pt x="1329" y="816"/>
                    </a:lnTo>
                    <a:lnTo>
                      <a:pt x="1335" y="816"/>
                    </a:lnTo>
                    <a:lnTo>
                      <a:pt x="1341" y="754"/>
                    </a:lnTo>
                    <a:lnTo>
                      <a:pt x="1346" y="816"/>
                    </a:lnTo>
                    <a:lnTo>
                      <a:pt x="1352" y="877"/>
                    </a:lnTo>
                    <a:lnTo>
                      <a:pt x="1358" y="816"/>
                    </a:lnTo>
                    <a:lnTo>
                      <a:pt x="1364" y="847"/>
                    </a:lnTo>
                    <a:lnTo>
                      <a:pt x="1370" y="939"/>
                    </a:lnTo>
                    <a:lnTo>
                      <a:pt x="1376" y="908"/>
                    </a:lnTo>
                    <a:lnTo>
                      <a:pt x="1381" y="816"/>
                    </a:lnTo>
                    <a:lnTo>
                      <a:pt x="1387" y="924"/>
                    </a:lnTo>
                    <a:lnTo>
                      <a:pt x="1393" y="908"/>
                    </a:lnTo>
                    <a:lnTo>
                      <a:pt x="1399" y="893"/>
                    </a:lnTo>
                    <a:lnTo>
                      <a:pt x="1405" y="862"/>
                    </a:lnTo>
                    <a:lnTo>
                      <a:pt x="1411" y="939"/>
                    </a:lnTo>
                    <a:lnTo>
                      <a:pt x="1416" y="955"/>
                    </a:lnTo>
                    <a:lnTo>
                      <a:pt x="1422" y="924"/>
                    </a:lnTo>
                    <a:lnTo>
                      <a:pt x="1428" y="877"/>
                    </a:lnTo>
                    <a:lnTo>
                      <a:pt x="1434" y="893"/>
                    </a:lnTo>
                    <a:lnTo>
                      <a:pt x="1440" y="924"/>
                    </a:lnTo>
                    <a:lnTo>
                      <a:pt x="1445" y="955"/>
                    </a:lnTo>
                    <a:lnTo>
                      <a:pt x="1451" y="939"/>
                    </a:lnTo>
                    <a:lnTo>
                      <a:pt x="1457" y="847"/>
                    </a:lnTo>
                    <a:lnTo>
                      <a:pt x="1463" y="724"/>
                    </a:lnTo>
                    <a:lnTo>
                      <a:pt x="1469" y="970"/>
                    </a:lnTo>
                    <a:lnTo>
                      <a:pt x="1475" y="970"/>
                    </a:lnTo>
                    <a:lnTo>
                      <a:pt x="1480" y="970"/>
                    </a:lnTo>
                    <a:lnTo>
                      <a:pt x="1486" y="970"/>
                    </a:lnTo>
                    <a:lnTo>
                      <a:pt x="1492" y="970"/>
                    </a:lnTo>
                    <a:lnTo>
                      <a:pt x="0" y="970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48" name="Rectangle 80"/>
              <p:cNvSpPr>
                <a:spLocks noChangeArrowheads="1"/>
              </p:cNvSpPr>
              <p:nvPr/>
            </p:nvSpPr>
            <p:spPr bwMode="auto">
              <a:xfrm>
                <a:off x="5688013" y="1462088"/>
                <a:ext cx="2368550" cy="22971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sp>
          <p:nvSpPr>
            <p:cNvPr id="115" name="Tekstvak 114"/>
            <p:cNvSpPr txBox="1"/>
            <p:nvPr/>
          </p:nvSpPr>
          <p:spPr>
            <a:xfrm>
              <a:off x="2224590" y="2107462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4/80</a:t>
              </a:r>
              <a:endParaRPr lang="nl-NL" sz="1200" b="1" dirty="0"/>
            </a:p>
          </p:txBody>
        </p:sp>
        <p:cxnSp>
          <p:nvCxnSpPr>
            <p:cNvPr id="117" name="Rechte verbindingslijn met pijl 116"/>
            <p:cNvCxnSpPr/>
            <p:nvPr/>
          </p:nvCxnSpPr>
          <p:spPr>
            <a:xfrm>
              <a:off x="1906662" y="2147251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kstvak 117"/>
            <p:cNvSpPr txBox="1"/>
            <p:nvPr/>
          </p:nvSpPr>
          <p:spPr>
            <a:xfrm>
              <a:off x="4033830" y="2099104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</a:t>
              </a:r>
            </a:p>
          </p:txBody>
        </p:sp>
        <p:cxnSp>
          <p:nvCxnSpPr>
            <p:cNvPr id="119" name="Rechte verbindingslijn met pijl 118"/>
            <p:cNvCxnSpPr/>
            <p:nvPr/>
          </p:nvCxnSpPr>
          <p:spPr>
            <a:xfrm>
              <a:off x="3648736" y="2146750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Rechte verbindingslijn met pijl 120"/>
            <p:cNvCxnSpPr/>
            <p:nvPr/>
          </p:nvCxnSpPr>
          <p:spPr>
            <a:xfrm>
              <a:off x="5128102" y="2147251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kstvak 121"/>
            <p:cNvSpPr txBox="1"/>
            <p:nvPr/>
          </p:nvSpPr>
          <p:spPr>
            <a:xfrm>
              <a:off x="5358945" y="2093456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I/III</a:t>
              </a:r>
            </a:p>
          </p:txBody>
        </p:sp>
        <p:sp>
          <p:nvSpPr>
            <p:cNvPr id="123" name="Tekstvak 122"/>
            <p:cNvSpPr txBox="1"/>
            <p:nvPr/>
          </p:nvSpPr>
          <p:spPr>
            <a:xfrm>
              <a:off x="1698059" y="636858"/>
              <a:ext cx="2456983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</a:t>
              </a:r>
              <a:endParaRPr lang="nl-NL" sz="1200" b="1" dirty="0"/>
            </a:p>
          </p:txBody>
        </p:sp>
        <p:grpSp>
          <p:nvGrpSpPr>
            <p:cNvPr id="162" name="Groep 161"/>
            <p:cNvGrpSpPr/>
            <p:nvPr/>
          </p:nvGrpSpPr>
          <p:grpSpPr>
            <a:xfrm>
              <a:off x="3656753" y="2528127"/>
              <a:ext cx="1163039" cy="1191023"/>
              <a:chOff x="3883025" y="5783263"/>
              <a:chExt cx="2301875" cy="1839912"/>
            </a:xfrm>
          </p:grpSpPr>
          <p:sp>
            <p:nvSpPr>
              <p:cNvPr id="58480" name="Freeform 112"/>
              <p:cNvSpPr>
                <a:spLocks/>
              </p:cNvSpPr>
              <p:nvPr/>
            </p:nvSpPr>
            <p:spPr bwMode="auto">
              <a:xfrm>
                <a:off x="3883025" y="6396038"/>
                <a:ext cx="2301875" cy="1227137"/>
              </a:xfrm>
              <a:custGeom>
                <a:avLst/>
                <a:gdLst/>
                <a:ahLst/>
                <a:cxnLst>
                  <a:cxn ang="0">
                    <a:pos x="17" y="773"/>
                  </a:cxn>
                  <a:cxn ang="0">
                    <a:pos x="45" y="773"/>
                  </a:cxn>
                  <a:cxn ang="0">
                    <a:pos x="73" y="773"/>
                  </a:cxn>
                  <a:cxn ang="0">
                    <a:pos x="102" y="773"/>
                  </a:cxn>
                  <a:cxn ang="0">
                    <a:pos x="130" y="773"/>
                  </a:cxn>
                  <a:cxn ang="0">
                    <a:pos x="158" y="773"/>
                  </a:cxn>
                  <a:cxn ang="0">
                    <a:pos x="187" y="773"/>
                  </a:cxn>
                  <a:cxn ang="0">
                    <a:pos x="215" y="773"/>
                  </a:cxn>
                  <a:cxn ang="0">
                    <a:pos x="243" y="773"/>
                  </a:cxn>
                  <a:cxn ang="0">
                    <a:pos x="272" y="773"/>
                  </a:cxn>
                  <a:cxn ang="0">
                    <a:pos x="300" y="773"/>
                  </a:cxn>
                  <a:cxn ang="0">
                    <a:pos x="328" y="773"/>
                  </a:cxn>
                  <a:cxn ang="0">
                    <a:pos x="357" y="773"/>
                  </a:cxn>
                  <a:cxn ang="0">
                    <a:pos x="385" y="773"/>
                  </a:cxn>
                  <a:cxn ang="0">
                    <a:pos x="413" y="765"/>
                  </a:cxn>
                  <a:cxn ang="0">
                    <a:pos x="441" y="773"/>
                  </a:cxn>
                  <a:cxn ang="0">
                    <a:pos x="470" y="773"/>
                  </a:cxn>
                  <a:cxn ang="0">
                    <a:pos x="498" y="765"/>
                  </a:cxn>
                  <a:cxn ang="0">
                    <a:pos x="527" y="773"/>
                  </a:cxn>
                  <a:cxn ang="0">
                    <a:pos x="555" y="773"/>
                  </a:cxn>
                  <a:cxn ang="0">
                    <a:pos x="583" y="773"/>
                  </a:cxn>
                  <a:cxn ang="0">
                    <a:pos x="612" y="748"/>
                  </a:cxn>
                  <a:cxn ang="0">
                    <a:pos x="640" y="706"/>
                  </a:cxn>
                  <a:cxn ang="0">
                    <a:pos x="668" y="722"/>
                  </a:cxn>
                  <a:cxn ang="0">
                    <a:pos x="696" y="722"/>
                  </a:cxn>
                  <a:cxn ang="0">
                    <a:pos x="725" y="706"/>
                  </a:cxn>
                  <a:cxn ang="0">
                    <a:pos x="753" y="706"/>
                  </a:cxn>
                  <a:cxn ang="0">
                    <a:pos x="782" y="664"/>
                  </a:cxn>
                  <a:cxn ang="0">
                    <a:pos x="810" y="706"/>
                  </a:cxn>
                  <a:cxn ang="0">
                    <a:pos x="838" y="630"/>
                  </a:cxn>
                  <a:cxn ang="0">
                    <a:pos x="867" y="647"/>
                  </a:cxn>
                  <a:cxn ang="0">
                    <a:pos x="895" y="580"/>
                  </a:cxn>
                  <a:cxn ang="0">
                    <a:pos x="923" y="445"/>
                  </a:cxn>
                  <a:cxn ang="0">
                    <a:pos x="951" y="353"/>
                  </a:cxn>
                  <a:cxn ang="0">
                    <a:pos x="980" y="277"/>
                  </a:cxn>
                  <a:cxn ang="0">
                    <a:pos x="1008" y="76"/>
                  </a:cxn>
                  <a:cxn ang="0">
                    <a:pos x="1036" y="118"/>
                  </a:cxn>
                  <a:cxn ang="0">
                    <a:pos x="1065" y="0"/>
                  </a:cxn>
                  <a:cxn ang="0">
                    <a:pos x="1093" y="177"/>
                  </a:cxn>
                  <a:cxn ang="0">
                    <a:pos x="1122" y="420"/>
                  </a:cxn>
                  <a:cxn ang="0">
                    <a:pos x="1150" y="479"/>
                  </a:cxn>
                  <a:cxn ang="0">
                    <a:pos x="1178" y="563"/>
                  </a:cxn>
                  <a:cxn ang="0">
                    <a:pos x="1206" y="647"/>
                  </a:cxn>
                  <a:cxn ang="0">
                    <a:pos x="1235" y="739"/>
                  </a:cxn>
                  <a:cxn ang="0">
                    <a:pos x="1263" y="765"/>
                  </a:cxn>
                  <a:cxn ang="0">
                    <a:pos x="1291" y="773"/>
                  </a:cxn>
                  <a:cxn ang="0">
                    <a:pos x="1320" y="773"/>
                  </a:cxn>
                  <a:cxn ang="0">
                    <a:pos x="1348" y="773"/>
                  </a:cxn>
                  <a:cxn ang="0">
                    <a:pos x="1376" y="773"/>
                  </a:cxn>
                  <a:cxn ang="0">
                    <a:pos x="1405" y="773"/>
                  </a:cxn>
                  <a:cxn ang="0">
                    <a:pos x="1433" y="773"/>
                  </a:cxn>
                </a:cxnLst>
                <a:rect l="0" t="0" r="r" b="b"/>
                <a:pathLst>
                  <a:path w="1450" h="773">
                    <a:moveTo>
                      <a:pt x="0" y="773"/>
                    </a:moveTo>
                    <a:lnTo>
                      <a:pt x="0" y="773"/>
                    </a:lnTo>
                    <a:lnTo>
                      <a:pt x="5" y="773"/>
                    </a:lnTo>
                    <a:lnTo>
                      <a:pt x="11" y="773"/>
                    </a:lnTo>
                    <a:lnTo>
                      <a:pt x="17" y="773"/>
                    </a:lnTo>
                    <a:lnTo>
                      <a:pt x="22" y="773"/>
                    </a:lnTo>
                    <a:lnTo>
                      <a:pt x="28" y="773"/>
                    </a:lnTo>
                    <a:lnTo>
                      <a:pt x="34" y="773"/>
                    </a:lnTo>
                    <a:lnTo>
                      <a:pt x="39" y="773"/>
                    </a:lnTo>
                    <a:lnTo>
                      <a:pt x="45" y="773"/>
                    </a:lnTo>
                    <a:lnTo>
                      <a:pt x="51" y="773"/>
                    </a:lnTo>
                    <a:lnTo>
                      <a:pt x="56" y="773"/>
                    </a:lnTo>
                    <a:lnTo>
                      <a:pt x="62" y="773"/>
                    </a:lnTo>
                    <a:lnTo>
                      <a:pt x="68" y="773"/>
                    </a:lnTo>
                    <a:lnTo>
                      <a:pt x="73" y="773"/>
                    </a:lnTo>
                    <a:lnTo>
                      <a:pt x="79" y="773"/>
                    </a:lnTo>
                    <a:lnTo>
                      <a:pt x="85" y="773"/>
                    </a:lnTo>
                    <a:lnTo>
                      <a:pt x="90" y="773"/>
                    </a:lnTo>
                    <a:lnTo>
                      <a:pt x="96" y="773"/>
                    </a:lnTo>
                    <a:lnTo>
                      <a:pt x="102" y="773"/>
                    </a:lnTo>
                    <a:lnTo>
                      <a:pt x="107" y="773"/>
                    </a:lnTo>
                    <a:lnTo>
                      <a:pt x="113" y="773"/>
                    </a:lnTo>
                    <a:lnTo>
                      <a:pt x="119" y="773"/>
                    </a:lnTo>
                    <a:lnTo>
                      <a:pt x="124" y="773"/>
                    </a:lnTo>
                    <a:lnTo>
                      <a:pt x="130" y="773"/>
                    </a:lnTo>
                    <a:lnTo>
                      <a:pt x="136" y="773"/>
                    </a:lnTo>
                    <a:lnTo>
                      <a:pt x="141" y="773"/>
                    </a:lnTo>
                    <a:lnTo>
                      <a:pt x="147" y="773"/>
                    </a:lnTo>
                    <a:lnTo>
                      <a:pt x="153" y="773"/>
                    </a:lnTo>
                    <a:lnTo>
                      <a:pt x="158" y="773"/>
                    </a:lnTo>
                    <a:lnTo>
                      <a:pt x="164" y="773"/>
                    </a:lnTo>
                    <a:lnTo>
                      <a:pt x="170" y="773"/>
                    </a:lnTo>
                    <a:lnTo>
                      <a:pt x="175" y="773"/>
                    </a:lnTo>
                    <a:lnTo>
                      <a:pt x="181" y="773"/>
                    </a:lnTo>
                    <a:lnTo>
                      <a:pt x="187" y="773"/>
                    </a:lnTo>
                    <a:lnTo>
                      <a:pt x="192" y="773"/>
                    </a:lnTo>
                    <a:lnTo>
                      <a:pt x="198" y="773"/>
                    </a:lnTo>
                    <a:lnTo>
                      <a:pt x="204" y="773"/>
                    </a:lnTo>
                    <a:lnTo>
                      <a:pt x="209" y="773"/>
                    </a:lnTo>
                    <a:lnTo>
                      <a:pt x="215" y="773"/>
                    </a:lnTo>
                    <a:lnTo>
                      <a:pt x="221" y="773"/>
                    </a:lnTo>
                    <a:lnTo>
                      <a:pt x="226" y="773"/>
                    </a:lnTo>
                    <a:lnTo>
                      <a:pt x="232" y="773"/>
                    </a:lnTo>
                    <a:lnTo>
                      <a:pt x="238" y="773"/>
                    </a:lnTo>
                    <a:lnTo>
                      <a:pt x="243" y="773"/>
                    </a:lnTo>
                    <a:lnTo>
                      <a:pt x="249" y="773"/>
                    </a:lnTo>
                    <a:lnTo>
                      <a:pt x="255" y="773"/>
                    </a:lnTo>
                    <a:lnTo>
                      <a:pt x="260" y="773"/>
                    </a:lnTo>
                    <a:lnTo>
                      <a:pt x="266" y="773"/>
                    </a:lnTo>
                    <a:lnTo>
                      <a:pt x="272" y="773"/>
                    </a:lnTo>
                    <a:lnTo>
                      <a:pt x="277" y="773"/>
                    </a:lnTo>
                    <a:lnTo>
                      <a:pt x="283" y="773"/>
                    </a:lnTo>
                    <a:lnTo>
                      <a:pt x="289" y="773"/>
                    </a:lnTo>
                    <a:lnTo>
                      <a:pt x="294" y="773"/>
                    </a:lnTo>
                    <a:lnTo>
                      <a:pt x="300" y="773"/>
                    </a:lnTo>
                    <a:lnTo>
                      <a:pt x="306" y="773"/>
                    </a:lnTo>
                    <a:lnTo>
                      <a:pt x="311" y="773"/>
                    </a:lnTo>
                    <a:lnTo>
                      <a:pt x="317" y="773"/>
                    </a:lnTo>
                    <a:lnTo>
                      <a:pt x="323" y="773"/>
                    </a:lnTo>
                    <a:lnTo>
                      <a:pt x="328" y="773"/>
                    </a:lnTo>
                    <a:lnTo>
                      <a:pt x="334" y="773"/>
                    </a:lnTo>
                    <a:lnTo>
                      <a:pt x="340" y="773"/>
                    </a:lnTo>
                    <a:lnTo>
                      <a:pt x="345" y="773"/>
                    </a:lnTo>
                    <a:lnTo>
                      <a:pt x="351" y="773"/>
                    </a:lnTo>
                    <a:lnTo>
                      <a:pt x="357" y="773"/>
                    </a:lnTo>
                    <a:lnTo>
                      <a:pt x="362" y="773"/>
                    </a:lnTo>
                    <a:lnTo>
                      <a:pt x="368" y="773"/>
                    </a:lnTo>
                    <a:lnTo>
                      <a:pt x="374" y="773"/>
                    </a:lnTo>
                    <a:lnTo>
                      <a:pt x="379" y="773"/>
                    </a:lnTo>
                    <a:lnTo>
                      <a:pt x="385" y="773"/>
                    </a:lnTo>
                    <a:lnTo>
                      <a:pt x="391" y="765"/>
                    </a:lnTo>
                    <a:lnTo>
                      <a:pt x="396" y="773"/>
                    </a:lnTo>
                    <a:lnTo>
                      <a:pt x="402" y="773"/>
                    </a:lnTo>
                    <a:lnTo>
                      <a:pt x="408" y="773"/>
                    </a:lnTo>
                    <a:lnTo>
                      <a:pt x="413" y="765"/>
                    </a:lnTo>
                    <a:lnTo>
                      <a:pt x="419" y="773"/>
                    </a:lnTo>
                    <a:lnTo>
                      <a:pt x="425" y="773"/>
                    </a:lnTo>
                    <a:lnTo>
                      <a:pt x="430" y="773"/>
                    </a:lnTo>
                    <a:lnTo>
                      <a:pt x="436" y="773"/>
                    </a:lnTo>
                    <a:lnTo>
                      <a:pt x="441" y="773"/>
                    </a:lnTo>
                    <a:lnTo>
                      <a:pt x="447" y="773"/>
                    </a:lnTo>
                    <a:lnTo>
                      <a:pt x="453" y="765"/>
                    </a:lnTo>
                    <a:lnTo>
                      <a:pt x="458" y="773"/>
                    </a:lnTo>
                    <a:lnTo>
                      <a:pt x="464" y="773"/>
                    </a:lnTo>
                    <a:lnTo>
                      <a:pt x="470" y="773"/>
                    </a:lnTo>
                    <a:lnTo>
                      <a:pt x="476" y="765"/>
                    </a:lnTo>
                    <a:lnTo>
                      <a:pt x="481" y="773"/>
                    </a:lnTo>
                    <a:lnTo>
                      <a:pt x="487" y="773"/>
                    </a:lnTo>
                    <a:lnTo>
                      <a:pt x="493" y="765"/>
                    </a:lnTo>
                    <a:lnTo>
                      <a:pt x="498" y="765"/>
                    </a:lnTo>
                    <a:lnTo>
                      <a:pt x="504" y="765"/>
                    </a:lnTo>
                    <a:lnTo>
                      <a:pt x="510" y="773"/>
                    </a:lnTo>
                    <a:lnTo>
                      <a:pt x="515" y="773"/>
                    </a:lnTo>
                    <a:lnTo>
                      <a:pt x="521" y="773"/>
                    </a:lnTo>
                    <a:lnTo>
                      <a:pt x="527" y="773"/>
                    </a:lnTo>
                    <a:lnTo>
                      <a:pt x="532" y="773"/>
                    </a:lnTo>
                    <a:lnTo>
                      <a:pt x="538" y="773"/>
                    </a:lnTo>
                    <a:lnTo>
                      <a:pt x="544" y="773"/>
                    </a:lnTo>
                    <a:lnTo>
                      <a:pt x="549" y="765"/>
                    </a:lnTo>
                    <a:lnTo>
                      <a:pt x="555" y="773"/>
                    </a:lnTo>
                    <a:lnTo>
                      <a:pt x="561" y="756"/>
                    </a:lnTo>
                    <a:lnTo>
                      <a:pt x="566" y="756"/>
                    </a:lnTo>
                    <a:lnTo>
                      <a:pt x="572" y="765"/>
                    </a:lnTo>
                    <a:lnTo>
                      <a:pt x="578" y="773"/>
                    </a:lnTo>
                    <a:lnTo>
                      <a:pt x="583" y="773"/>
                    </a:lnTo>
                    <a:lnTo>
                      <a:pt x="589" y="748"/>
                    </a:lnTo>
                    <a:lnTo>
                      <a:pt x="595" y="739"/>
                    </a:lnTo>
                    <a:lnTo>
                      <a:pt x="600" y="756"/>
                    </a:lnTo>
                    <a:lnTo>
                      <a:pt x="606" y="756"/>
                    </a:lnTo>
                    <a:lnTo>
                      <a:pt x="612" y="748"/>
                    </a:lnTo>
                    <a:lnTo>
                      <a:pt x="617" y="765"/>
                    </a:lnTo>
                    <a:lnTo>
                      <a:pt x="623" y="765"/>
                    </a:lnTo>
                    <a:lnTo>
                      <a:pt x="629" y="748"/>
                    </a:lnTo>
                    <a:lnTo>
                      <a:pt x="634" y="765"/>
                    </a:lnTo>
                    <a:lnTo>
                      <a:pt x="640" y="706"/>
                    </a:lnTo>
                    <a:lnTo>
                      <a:pt x="646" y="748"/>
                    </a:lnTo>
                    <a:lnTo>
                      <a:pt x="651" y="756"/>
                    </a:lnTo>
                    <a:lnTo>
                      <a:pt x="657" y="748"/>
                    </a:lnTo>
                    <a:lnTo>
                      <a:pt x="663" y="748"/>
                    </a:lnTo>
                    <a:lnTo>
                      <a:pt x="668" y="722"/>
                    </a:lnTo>
                    <a:lnTo>
                      <a:pt x="674" y="714"/>
                    </a:lnTo>
                    <a:lnTo>
                      <a:pt x="680" y="680"/>
                    </a:lnTo>
                    <a:lnTo>
                      <a:pt x="685" y="714"/>
                    </a:lnTo>
                    <a:lnTo>
                      <a:pt x="691" y="748"/>
                    </a:lnTo>
                    <a:lnTo>
                      <a:pt x="696" y="722"/>
                    </a:lnTo>
                    <a:lnTo>
                      <a:pt x="702" y="672"/>
                    </a:lnTo>
                    <a:lnTo>
                      <a:pt x="708" y="722"/>
                    </a:lnTo>
                    <a:lnTo>
                      <a:pt x="713" y="706"/>
                    </a:lnTo>
                    <a:lnTo>
                      <a:pt x="719" y="697"/>
                    </a:lnTo>
                    <a:lnTo>
                      <a:pt x="725" y="706"/>
                    </a:lnTo>
                    <a:lnTo>
                      <a:pt x="730" y="655"/>
                    </a:lnTo>
                    <a:lnTo>
                      <a:pt x="736" y="697"/>
                    </a:lnTo>
                    <a:lnTo>
                      <a:pt x="742" y="697"/>
                    </a:lnTo>
                    <a:lnTo>
                      <a:pt x="747" y="689"/>
                    </a:lnTo>
                    <a:lnTo>
                      <a:pt x="753" y="706"/>
                    </a:lnTo>
                    <a:lnTo>
                      <a:pt x="759" y="672"/>
                    </a:lnTo>
                    <a:lnTo>
                      <a:pt x="764" y="647"/>
                    </a:lnTo>
                    <a:lnTo>
                      <a:pt x="770" y="706"/>
                    </a:lnTo>
                    <a:lnTo>
                      <a:pt x="776" y="639"/>
                    </a:lnTo>
                    <a:lnTo>
                      <a:pt x="782" y="664"/>
                    </a:lnTo>
                    <a:lnTo>
                      <a:pt x="787" y="664"/>
                    </a:lnTo>
                    <a:lnTo>
                      <a:pt x="793" y="639"/>
                    </a:lnTo>
                    <a:lnTo>
                      <a:pt x="799" y="714"/>
                    </a:lnTo>
                    <a:lnTo>
                      <a:pt x="804" y="714"/>
                    </a:lnTo>
                    <a:lnTo>
                      <a:pt x="810" y="706"/>
                    </a:lnTo>
                    <a:lnTo>
                      <a:pt x="816" y="655"/>
                    </a:lnTo>
                    <a:lnTo>
                      <a:pt x="821" y="647"/>
                    </a:lnTo>
                    <a:lnTo>
                      <a:pt x="827" y="622"/>
                    </a:lnTo>
                    <a:lnTo>
                      <a:pt x="833" y="605"/>
                    </a:lnTo>
                    <a:lnTo>
                      <a:pt x="838" y="630"/>
                    </a:lnTo>
                    <a:lnTo>
                      <a:pt x="844" y="597"/>
                    </a:lnTo>
                    <a:lnTo>
                      <a:pt x="850" y="622"/>
                    </a:lnTo>
                    <a:lnTo>
                      <a:pt x="855" y="597"/>
                    </a:lnTo>
                    <a:lnTo>
                      <a:pt x="861" y="613"/>
                    </a:lnTo>
                    <a:lnTo>
                      <a:pt x="867" y="647"/>
                    </a:lnTo>
                    <a:lnTo>
                      <a:pt x="872" y="597"/>
                    </a:lnTo>
                    <a:lnTo>
                      <a:pt x="878" y="555"/>
                    </a:lnTo>
                    <a:lnTo>
                      <a:pt x="884" y="563"/>
                    </a:lnTo>
                    <a:lnTo>
                      <a:pt x="889" y="538"/>
                    </a:lnTo>
                    <a:lnTo>
                      <a:pt x="895" y="580"/>
                    </a:lnTo>
                    <a:lnTo>
                      <a:pt x="901" y="571"/>
                    </a:lnTo>
                    <a:lnTo>
                      <a:pt x="906" y="471"/>
                    </a:lnTo>
                    <a:lnTo>
                      <a:pt x="912" y="521"/>
                    </a:lnTo>
                    <a:lnTo>
                      <a:pt x="918" y="504"/>
                    </a:lnTo>
                    <a:lnTo>
                      <a:pt x="923" y="445"/>
                    </a:lnTo>
                    <a:lnTo>
                      <a:pt x="929" y="403"/>
                    </a:lnTo>
                    <a:lnTo>
                      <a:pt x="935" y="395"/>
                    </a:lnTo>
                    <a:lnTo>
                      <a:pt x="940" y="361"/>
                    </a:lnTo>
                    <a:lnTo>
                      <a:pt x="946" y="378"/>
                    </a:lnTo>
                    <a:lnTo>
                      <a:pt x="951" y="353"/>
                    </a:lnTo>
                    <a:lnTo>
                      <a:pt x="957" y="328"/>
                    </a:lnTo>
                    <a:lnTo>
                      <a:pt x="963" y="194"/>
                    </a:lnTo>
                    <a:lnTo>
                      <a:pt x="968" y="277"/>
                    </a:lnTo>
                    <a:lnTo>
                      <a:pt x="974" y="286"/>
                    </a:lnTo>
                    <a:lnTo>
                      <a:pt x="980" y="277"/>
                    </a:lnTo>
                    <a:lnTo>
                      <a:pt x="985" y="185"/>
                    </a:lnTo>
                    <a:lnTo>
                      <a:pt x="991" y="160"/>
                    </a:lnTo>
                    <a:lnTo>
                      <a:pt x="997" y="168"/>
                    </a:lnTo>
                    <a:lnTo>
                      <a:pt x="1002" y="135"/>
                    </a:lnTo>
                    <a:lnTo>
                      <a:pt x="1008" y="76"/>
                    </a:lnTo>
                    <a:lnTo>
                      <a:pt x="1014" y="26"/>
                    </a:lnTo>
                    <a:lnTo>
                      <a:pt x="1019" y="59"/>
                    </a:lnTo>
                    <a:lnTo>
                      <a:pt x="1025" y="51"/>
                    </a:lnTo>
                    <a:lnTo>
                      <a:pt x="1031" y="76"/>
                    </a:lnTo>
                    <a:lnTo>
                      <a:pt x="1036" y="118"/>
                    </a:lnTo>
                    <a:lnTo>
                      <a:pt x="1042" y="42"/>
                    </a:lnTo>
                    <a:lnTo>
                      <a:pt x="1048" y="26"/>
                    </a:lnTo>
                    <a:lnTo>
                      <a:pt x="1053" y="17"/>
                    </a:lnTo>
                    <a:lnTo>
                      <a:pt x="1059" y="135"/>
                    </a:lnTo>
                    <a:lnTo>
                      <a:pt x="1065" y="0"/>
                    </a:lnTo>
                    <a:lnTo>
                      <a:pt x="1070" y="286"/>
                    </a:lnTo>
                    <a:lnTo>
                      <a:pt x="1076" y="269"/>
                    </a:lnTo>
                    <a:lnTo>
                      <a:pt x="1082" y="236"/>
                    </a:lnTo>
                    <a:lnTo>
                      <a:pt x="1088" y="93"/>
                    </a:lnTo>
                    <a:lnTo>
                      <a:pt x="1093" y="177"/>
                    </a:lnTo>
                    <a:lnTo>
                      <a:pt x="1099" y="135"/>
                    </a:lnTo>
                    <a:lnTo>
                      <a:pt x="1105" y="361"/>
                    </a:lnTo>
                    <a:lnTo>
                      <a:pt x="1110" y="269"/>
                    </a:lnTo>
                    <a:lnTo>
                      <a:pt x="1116" y="387"/>
                    </a:lnTo>
                    <a:lnTo>
                      <a:pt x="1122" y="420"/>
                    </a:lnTo>
                    <a:lnTo>
                      <a:pt x="1127" y="403"/>
                    </a:lnTo>
                    <a:lnTo>
                      <a:pt x="1133" y="479"/>
                    </a:lnTo>
                    <a:lnTo>
                      <a:pt x="1139" y="479"/>
                    </a:lnTo>
                    <a:lnTo>
                      <a:pt x="1144" y="546"/>
                    </a:lnTo>
                    <a:lnTo>
                      <a:pt x="1150" y="479"/>
                    </a:lnTo>
                    <a:lnTo>
                      <a:pt x="1156" y="571"/>
                    </a:lnTo>
                    <a:lnTo>
                      <a:pt x="1161" y="521"/>
                    </a:lnTo>
                    <a:lnTo>
                      <a:pt x="1167" y="580"/>
                    </a:lnTo>
                    <a:lnTo>
                      <a:pt x="1173" y="622"/>
                    </a:lnTo>
                    <a:lnTo>
                      <a:pt x="1178" y="563"/>
                    </a:lnTo>
                    <a:lnTo>
                      <a:pt x="1184" y="605"/>
                    </a:lnTo>
                    <a:lnTo>
                      <a:pt x="1190" y="630"/>
                    </a:lnTo>
                    <a:lnTo>
                      <a:pt x="1195" y="680"/>
                    </a:lnTo>
                    <a:lnTo>
                      <a:pt x="1201" y="680"/>
                    </a:lnTo>
                    <a:lnTo>
                      <a:pt x="1206" y="647"/>
                    </a:lnTo>
                    <a:lnTo>
                      <a:pt x="1212" y="672"/>
                    </a:lnTo>
                    <a:lnTo>
                      <a:pt x="1218" y="697"/>
                    </a:lnTo>
                    <a:lnTo>
                      <a:pt x="1223" y="739"/>
                    </a:lnTo>
                    <a:lnTo>
                      <a:pt x="1229" y="731"/>
                    </a:lnTo>
                    <a:lnTo>
                      <a:pt x="1235" y="739"/>
                    </a:lnTo>
                    <a:lnTo>
                      <a:pt x="1240" y="731"/>
                    </a:lnTo>
                    <a:lnTo>
                      <a:pt x="1246" y="773"/>
                    </a:lnTo>
                    <a:lnTo>
                      <a:pt x="1252" y="756"/>
                    </a:lnTo>
                    <a:lnTo>
                      <a:pt x="1257" y="765"/>
                    </a:lnTo>
                    <a:lnTo>
                      <a:pt x="1263" y="765"/>
                    </a:lnTo>
                    <a:lnTo>
                      <a:pt x="1269" y="765"/>
                    </a:lnTo>
                    <a:lnTo>
                      <a:pt x="1274" y="765"/>
                    </a:lnTo>
                    <a:lnTo>
                      <a:pt x="1280" y="773"/>
                    </a:lnTo>
                    <a:lnTo>
                      <a:pt x="1286" y="773"/>
                    </a:lnTo>
                    <a:lnTo>
                      <a:pt x="1291" y="773"/>
                    </a:lnTo>
                    <a:lnTo>
                      <a:pt x="1297" y="773"/>
                    </a:lnTo>
                    <a:lnTo>
                      <a:pt x="1303" y="773"/>
                    </a:lnTo>
                    <a:lnTo>
                      <a:pt x="1308" y="773"/>
                    </a:lnTo>
                    <a:lnTo>
                      <a:pt x="1314" y="773"/>
                    </a:lnTo>
                    <a:lnTo>
                      <a:pt x="1320" y="773"/>
                    </a:lnTo>
                    <a:lnTo>
                      <a:pt x="1325" y="773"/>
                    </a:lnTo>
                    <a:lnTo>
                      <a:pt x="1331" y="773"/>
                    </a:lnTo>
                    <a:lnTo>
                      <a:pt x="1337" y="773"/>
                    </a:lnTo>
                    <a:lnTo>
                      <a:pt x="1342" y="773"/>
                    </a:lnTo>
                    <a:lnTo>
                      <a:pt x="1348" y="773"/>
                    </a:lnTo>
                    <a:lnTo>
                      <a:pt x="1354" y="773"/>
                    </a:lnTo>
                    <a:lnTo>
                      <a:pt x="1359" y="773"/>
                    </a:lnTo>
                    <a:lnTo>
                      <a:pt x="1365" y="773"/>
                    </a:lnTo>
                    <a:lnTo>
                      <a:pt x="1371" y="773"/>
                    </a:lnTo>
                    <a:lnTo>
                      <a:pt x="1376" y="773"/>
                    </a:lnTo>
                    <a:lnTo>
                      <a:pt x="1382" y="773"/>
                    </a:lnTo>
                    <a:lnTo>
                      <a:pt x="1388" y="773"/>
                    </a:lnTo>
                    <a:lnTo>
                      <a:pt x="1393" y="773"/>
                    </a:lnTo>
                    <a:lnTo>
                      <a:pt x="1399" y="773"/>
                    </a:lnTo>
                    <a:lnTo>
                      <a:pt x="1405" y="773"/>
                    </a:lnTo>
                    <a:lnTo>
                      <a:pt x="1411" y="773"/>
                    </a:lnTo>
                    <a:lnTo>
                      <a:pt x="1416" y="773"/>
                    </a:lnTo>
                    <a:lnTo>
                      <a:pt x="1422" y="773"/>
                    </a:lnTo>
                    <a:lnTo>
                      <a:pt x="1428" y="773"/>
                    </a:lnTo>
                    <a:lnTo>
                      <a:pt x="1433" y="773"/>
                    </a:lnTo>
                    <a:lnTo>
                      <a:pt x="1439" y="773"/>
                    </a:lnTo>
                    <a:lnTo>
                      <a:pt x="1445" y="773"/>
                    </a:lnTo>
                    <a:lnTo>
                      <a:pt x="1450" y="773"/>
                    </a:lnTo>
                    <a:lnTo>
                      <a:pt x="0" y="773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81" name="Freeform 113"/>
              <p:cNvSpPr>
                <a:spLocks/>
              </p:cNvSpPr>
              <p:nvPr/>
            </p:nvSpPr>
            <p:spPr bwMode="auto">
              <a:xfrm>
                <a:off x="3883025" y="6396038"/>
                <a:ext cx="2301875" cy="1227137"/>
              </a:xfrm>
              <a:custGeom>
                <a:avLst/>
                <a:gdLst/>
                <a:ahLst/>
                <a:cxnLst>
                  <a:cxn ang="0">
                    <a:pos x="17" y="773"/>
                  </a:cxn>
                  <a:cxn ang="0">
                    <a:pos x="45" y="773"/>
                  </a:cxn>
                  <a:cxn ang="0">
                    <a:pos x="73" y="773"/>
                  </a:cxn>
                  <a:cxn ang="0">
                    <a:pos x="102" y="773"/>
                  </a:cxn>
                  <a:cxn ang="0">
                    <a:pos x="130" y="773"/>
                  </a:cxn>
                  <a:cxn ang="0">
                    <a:pos x="158" y="773"/>
                  </a:cxn>
                  <a:cxn ang="0">
                    <a:pos x="187" y="773"/>
                  </a:cxn>
                  <a:cxn ang="0">
                    <a:pos x="215" y="773"/>
                  </a:cxn>
                  <a:cxn ang="0">
                    <a:pos x="243" y="773"/>
                  </a:cxn>
                  <a:cxn ang="0">
                    <a:pos x="272" y="773"/>
                  </a:cxn>
                  <a:cxn ang="0">
                    <a:pos x="300" y="773"/>
                  </a:cxn>
                  <a:cxn ang="0">
                    <a:pos x="328" y="773"/>
                  </a:cxn>
                  <a:cxn ang="0">
                    <a:pos x="357" y="773"/>
                  </a:cxn>
                  <a:cxn ang="0">
                    <a:pos x="385" y="773"/>
                  </a:cxn>
                  <a:cxn ang="0">
                    <a:pos x="413" y="765"/>
                  </a:cxn>
                  <a:cxn ang="0">
                    <a:pos x="441" y="773"/>
                  </a:cxn>
                  <a:cxn ang="0">
                    <a:pos x="470" y="773"/>
                  </a:cxn>
                  <a:cxn ang="0">
                    <a:pos x="498" y="765"/>
                  </a:cxn>
                  <a:cxn ang="0">
                    <a:pos x="527" y="773"/>
                  </a:cxn>
                  <a:cxn ang="0">
                    <a:pos x="555" y="773"/>
                  </a:cxn>
                  <a:cxn ang="0">
                    <a:pos x="583" y="773"/>
                  </a:cxn>
                  <a:cxn ang="0">
                    <a:pos x="612" y="748"/>
                  </a:cxn>
                  <a:cxn ang="0">
                    <a:pos x="640" y="706"/>
                  </a:cxn>
                  <a:cxn ang="0">
                    <a:pos x="668" y="722"/>
                  </a:cxn>
                  <a:cxn ang="0">
                    <a:pos x="696" y="722"/>
                  </a:cxn>
                  <a:cxn ang="0">
                    <a:pos x="725" y="706"/>
                  </a:cxn>
                  <a:cxn ang="0">
                    <a:pos x="753" y="706"/>
                  </a:cxn>
                  <a:cxn ang="0">
                    <a:pos x="782" y="664"/>
                  </a:cxn>
                  <a:cxn ang="0">
                    <a:pos x="810" y="706"/>
                  </a:cxn>
                  <a:cxn ang="0">
                    <a:pos x="838" y="630"/>
                  </a:cxn>
                  <a:cxn ang="0">
                    <a:pos x="867" y="647"/>
                  </a:cxn>
                  <a:cxn ang="0">
                    <a:pos x="895" y="580"/>
                  </a:cxn>
                  <a:cxn ang="0">
                    <a:pos x="923" y="445"/>
                  </a:cxn>
                  <a:cxn ang="0">
                    <a:pos x="951" y="353"/>
                  </a:cxn>
                  <a:cxn ang="0">
                    <a:pos x="980" y="277"/>
                  </a:cxn>
                  <a:cxn ang="0">
                    <a:pos x="1008" y="76"/>
                  </a:cxn>
                  <a:cxn ang="0">
                    <a:pos x="1036" y="118"/>
                  </a:cxn>
                  <a:cxn ang="0">
                    <a:pos x="1065" y="0"/>
                  </a:cxn>
                  <a:cxn ang="0">
                    <a:pos x="1093" y="177"/>
                  </a:cxn>
                  <a:cxn ang="0">
                    <a:pos x="1122" y="420"/>
                  </a:cxn>
                  <a:cxn ang="0">
                    <a:pos x="1150" y="479"/>
                  </a:cxn>
                  <a:cxn ang="0">
                    <a:pos x="1178" y="563"/>
                  </a:cxn>
                  <a:cxn ang="0">
                    <a:pos x="1206" y="647"/>
                  </a:cxn>
                  <a:cxn ang="0">
                    <a:pos x="1235" y="739"/>
                  </a:cxn>
                  <a:cxn ang="0">
                    <a:pos x="1263" y="765"/>
                  </a:cxn>
                  <a:cxn ang="0">
                    <a:pos x="1291" y="773"/>
                  </a:cxn>
                  <a:cxn ang="0">
                    <a:pos x="1320" y="773"/>
                  </a:cxn>
                  <a:cxn ang="0">
                    <a:pos x="1348" y="773"/>
                  </a:cxn>
                  <a:cxn ang="0">
                    <a:pos x="1376" y="773"/>
                  </a:cxn>
                  <a:cxn ang="0">
                    <a:pos x="1405" y="773"/>
                  </a:cxn>
                  <a:cxn ang="0">
                    <a:pos x="1433" y="773"/>
                  </a:cxn>
                </a:cxnLst>
                <a:rect l="0" t="0" r="r" b="b"/>
                <a:pathLst>
                  <a:path w="1450" h="773">
                    <a:moveTo>
                      <a:pt x="0" y="773"/>
                    </a:moveTo>
                    <a:lnTo>
                      <a:pt x="0" y="773"/>
                    </a:lnTo>
                    <a:lnTo>
                      <a:pt x="5" y="773"/>
                    </a:lnTo>
                    <a:lnTo>
                      <a:pt x="11" y="773"/>
                    </a:lnTo>
                    <a:lnTo>
                      <a:pt x="17" y="773"/>
                    </a:lnTo>
                    <a:lnTo>
                      <a:pt x="22" y="773"/>
                    </a:lnTo>
                    <a:lnTo>
                      <a:pt x="28" y="773"/>
                    </a:lnTo>
                    <a:lnTo>
                      <a:pt x="34" y="773"/>
                    </a:lnTo>
                    <a:lnTo>
                      <a:pt x="39" y="773"/>
                    </a:lnTo>
                    <a:lnTo>
                      <a:pt x="45" y="773"/>
                    </a:lnTo>
                    <a:lnTo>
                      <a:pt x="51" y="773"/>
                    </a:lnTo>
                    <a:lnTo>
                      <a:pt x="56" y="773"/>
                    </a:lnTo>
                    <a:lnTo>
                      <a:pt x="62" y="773"/>
                    </a:lnTo>
                    <a:lnTo>
                      <a:pt x="68" y="773"/>
                    </a:lnTo>
                    <a:lnTo>
                      <a:pt x="73" y="773"/>
                    </a:lnTo>
                    <a:lnTo>
                      <a:pt x="79" y="773"/>
                    </a:lnTo>
                    <a:lnTo>
                      <a:pt x="85" y="773"/>
                    </a:lnTo>
                    <a:lnTo>
                      <a:pt x="90" y="773"/>
                    </a:lnTo>
                    <a:lnTo>
                      <a:pt x="96" y="773"/>
                    </a:lnTo>
                    <a:lnTo>
                      <a:pt x="102" y="773"/>
                    </a:lnTo>
                    <a:lnTo>
                      <a:pt x="107" y="773"/>
                    </a:lnTo>
                    <a:lnTo>
                      <a:pt x="113" y="773"/>
                    </a:lnTo>
                    <a:lnTo>
                      <a:pt x="119" y="773"/>
                    </a:lnTo>
                    <a:lnTo>
                      <a:pt x="124" y="773"/>
                    </a:lnTo>
                    <a:lnTo>
                      <a:pt x="130" y="773"/>
                    </a:lnTo>
                    <a:lnTo>
                      <a:pt x="136" y="773"/>
                    </a:lnTo>
                    <a:lnTo>
                      <a:pt x="141" y="773"/>
                    </a:lnTo>
                    <a:lnTo>
                      <a:pt x="147" y="773"/>
                    </a:lnTo>
                    <a:lnTo>
                      <a:pt x="153" y="773"/>
                    </a:lnTo>
                    <a:lnTo>
                      <a:pt x="158" y="773"/>
                    </a:lnTo>
                    <a:lnTo>
                      <a:pt x="164" y="773"/>
                    </a:lnTo>
                    <a:lnTo>
                      <a:pt x="170" y="773"/>
                    </a:lnTo>
                    <a:lnTo>
                      <a:pt x="175" y="773"/>
                    </a:lnTo>
                    <a:lnTo>
                      <a:pt x="181" y="773"/>
                    </a:lnTo>
                    <a:lnTo>
                      <a:pt x="187" y="773"/>
                    </a:lnTo>
                    <a:lnTo>
                      <a:pt x="192" y="773"/>
                    </a:lnTo>
                    <a:lnTo>
                      <a:pt x="198" y="773"/>
                    </a:lnTo>
                    <a:lnTo>
                      <a:pt x="204" y="773"/>
                    </a:lnTo>
                    <a:lnTo>
                      <a:pt x="209" y="773"/>
                    </a:lnTo>
                    <a:lnTo>
                      <a:pt x="215" y="773"/>
                    </a:lnTo>
                    <a:lnTo>
                      <a:pt x="221" y="773"/>
                    </a:lnTo>
                    <a:lnTo>
                      <a:pt x="226" y="773"/>
                    </a:lnTo>
                    <a:lnTo>
                      <a:pt x="232" y="773"/>
                    </a:lnTo>
                    <a:lnTo>
                      <a:pt x="238" y="773"/>
                    </a:lnTo>
                    <a:lnTo>
                      <a:pt x="243" y="773"/>
                    </a:lnTo>
                    <a:lnTo>
                      <a:pt x="249" y="773"/>
                    </a:lnTo>
                    <a:lnTo>
                      <a:pt x="255" y="773"/>
                    </a:lnTo>
                    <a:lnTo>
                      <a:pt x="260" y="773"/>
                    </a:lnTo>
                    <a:lnTo>
                      <a:pt x="266" y="773"/>
                    </a:lnTo>
                    <a:lnTo>
                      <a:pt x="272" y="773"/>
                    </a:lnTo>
                    <a:lnTo>
                      <a:pt x="277" y="773"/>
                    </a:lnTo>
                    <a:lnTo>
                      <a:pt x="283" y="773"/>
                    </a:lnTo>
                    <a:lnTo>
                      <a:pt x="289" y="773"/>
                    </a:lnTo>
                    <a:lnTo>
                      <a:pt x="294" y="773"/>
                    </a:lnTo>
                    <a:lnTo>
                      <a:pt x="300" y="773"/>
                    </a:lnTo>
                    <a:lnTo>
                      <a:pt x="306" y="773"/>
                    </a:lnTo>
                    <a:lnTo>
                      <a:pt x="311" y="773"/>
                    </a:lnTo>
                    <a:lnTo>
                      <a:pt x="317" y="773"/>
                    </a:lnTo>
                    <a:lnTo>
                      <a:pt x="323" y="773"/>
                    </a:lnTo>
                    <a:lnTo>
                      <a:pt x="328" y="773"/>
                    </a:lnTo>
                    <a:lnTo>
                      <a:pt x="334" y="773"/>
                    </a:lnTo>
                    <a:lnTo>
                      <a:pt x="340" y="773"/>
                    </a:lnTo>
                    <a:lnTo>
                      <a:pt x="345" y="773"/>
                    </a:lnTo>
                    <a:lnTo>
                      <a:pt x="351" y="773"/>
                    </a:lnTo>
                    <a:lnTo>
                      <a:pt x="357" y="773"/>
                    </a:lnTo>
                    <a:lnTo>
                      <a:pt x="362" y="773"/>
                    </a:lnTo>
                    <a:lnTo>
                      <a:pt x="368" y="773"/>
                    </a:lnTo>
                    <a:lnTo>
                      <a:pt x="374" y="773"/>
                    </a:lnTo>
                    <a:lnTo>
                      <a:pt x="379" y="773"/>
                    </a:lnTo>
                    <a:lnTo>
                      <a:pt x="385" y="773"/>
                    </a:lnTo>
                    <a:lnTo>
                      <a:pt x="391" y="765"/>
                    </a:lnTo>
                    <a:lnTo>
                      <a:pt x="396" y="773"/>
                    </a:lnTo>
                    <a:lnTo>
                      <a:pt x="402" y="773"/>
                    </a:lnTo>
                    <a:lnTo>
                      <a:pt x="408" y="773"/>
                    </a:lnTo>
                    <a:lnTo>
                      <a:pt x="413" y="765"/>
                    </a:lnTo>
                    <a:lnTo>
                      <a:pt x="419" y="773"/>
                    </a:lnTo>
                    <a:lnTo>
                      <a:pt x="425" y="773"/>
                    </a:lnTo>
                    <a:lnTo>
                      <a:pt x="430" y="773"/>
                    </a:lnTo>
                    <a:lnTo>
                      <a:pt x="436" y="773"/>
                    </a:lnTo>
                    <a:lnTo>
                      <a:pt x="441" y="773"/>
                    </a:lnTo>
                    <a:lnTo>
                      <a:pt x="447" y="773"/>
                    </a:lnTo>
                    <a:lnTo>
                      <a:pt x="453" y="765"/>
                    </a:lnTo>
                    <a:lnTo>
                      <a:pt x="458" y="773"/>
                    </a:lnTo>
                    <a:lnTo>
                      <a:pt x="464" y="773"/>
                    </a:lnTo>
                    <a:lnTo>
                      <a:pt x="470" y="773"/>
                    </a:lnTo>
                    <a:lnTo>
                      <a:pt x="476" y="765"/>
                    </a:lnTo>
                    <a:lnTo>
                      <a:pt x="481" y="773"/>
                    </a:lnTo>
                    <a:lnTo>
                      <a:pt x="487" y="773"/>
                    </a:lnTo>
                    <a:lnTo>
                      <a:pt x="493" y="765"/>
                    </a:lnTo>
                    <a:lnTo>
                      <a:pt x="498" y="765"/>
                    </a:lnTo>
                    <a:lnTo>
                      <a:pt x="504" y="765"/>
                    </a:lnTo>
                    <a:lnTo>
                      <a:pt x="510" y="773"/>
                    </a:lnTo>
                    <a:lnTo>
                      <a:pt x="515" y="773"/>
                    </a:lnTo>
                    <a:lnTo>
                      <a:pt x="521" y="773"/>
                    </a:lnTo>
                    <a:lnTo>
                      <a:pt x="527" y="773"/>
                    </a:lnTo>
                    <a:lnTo>
                      <a:pt x="532" y="773"/>
                    </a:lnTo>
                    <a:lnTo>
                      <a:pt x="538" y="773"/>
                    </a:lnTo>
                    <a:lnTo>
                      <a:pt x="544" y="773"/>
                    </a:lnTo>
                    <a:lnTo>
                      <a:pt x="549" y="765"/>
                    </a:lnTo>
                    <a:lnTo>
                      <a:pt x="555" y="773"/>
                    </a:lnTo>
                    <a:lnTo>
                      <a:pt x="561" y="756"/>
                    </a:lnTo>
                    <a:lnTo>
                      <a:pt x="566" y="756"/>
                    </a:lnTo>
                    <a:lnTo>
                      <a:pt x="572" y="765"/>
                    </a:lnTo>
                    <a:lnTo>
                      <a:pt x="578" y="773"/>
                    </a:lnTo>
                    <a:lnTo>
                      <a:pt x="583" y="773"/>
                    </a:lnTo>
                    <a:lnTo>
                      <a:pt x="589" y="748"/>
                    </a:lnTo>
                    <a:lnTo>
                      <a:pt x="595" y="739"/>
                    </a:lnTo>
                    <a:lnTo>
                      <a:pt x="600" y="756"/>
                    </a:lnTo>
                    <a:lnTo>
                      <a:pt x="606" y="756"/>
                    </a:lnTo>
                    <a:lnTo>
                      <a:pt x="612" y="748"/>
                    </a:lnTo>
                    <a:lnTo>
                      <a:pt x="617" y="765"/>
                    </a:lnTo>
                    <a:lnTo>
                      <a:pt x="623" y="765"/>
                    </a:lnTo>
                    <a:lnTo>
                      <a:pt x="629" y="748"/>
                    </a:lnTo>
                    <a:lnTo>
                      <a:pt x="634" y="765"/>
                    </a:lnTo>
                    <a:lnTo>
                      <a:pt x="640" y="706"/>
                    </a:lnTo>
                    <a:lnTo>
                      <a:pt x="646" y="748"/>
                    </a:lnTo>
                    <a:lnTo>
                      <a:pt x="651" y="756"/>
                    </a:lnTo>
                    <a:lnTo>
                      <a:pt x="657" y="748"/>
                    </a:lnTo>
                    <a:lnTo>
                      <a:pt x="663" y="748"/>
                    </a:lnTo>
                    <a:lnTo>
                      <a:pt x="668" y="722"/>
                    </a:lnTo>
                    <a:lnTo>
                      <a:pt x="674" y="714"/>
                    </a:lnTo>
                    <a:lnTo>
                      <a:pt x="680" y="680"/>
                    </a:lnTo>
                    <a:lnTo>
                      <a:pt x="685" y="714"/>
                    </a:lnTo>
                    <a:lnTo>
                      <a:pt x="691" y="748"/>
                    </a:lnTo>
                    <a:lnTo>
                      <a:pt x="696" y="722"/>
                    </a:lnTo>
                    <a:lnTo>
                      <a:pt x="702" y="672"/>
                    </a:lnTo>
                    <a:lnTo>
                      <a:pt x="708" y="722"/>
                    </a:lnTo>
                    <a:lnTo>
                      <a:pt x="713" y="706"/>
                    </a:lnTo>
                    <a:lnTo>
                      <a:pt x="719" y="697"/>
                    </a:lnTo>
                    <a:lnTo>
                      <a:pt x="725" y="706"/>
                    </a:lnTo>
                    <a:lnTo>
                      <a:pt x="730" y="655"/>
                    </a:lnTo>
                    <a:lnTo>
                      <a:pt x="736" y="697"/>
                    </a:lnTo>
                    <a:lnTo>
                      <a:pt x="742" y="697"/>
                    </a:lnTo>
                    <a:lnTo>
                      <a:pt x="747" y="689"/>
                    </a:lnTo>
                    <a:lnTo>
                      <a:pt x="753" y="706"/>
                    </a:lnTo>
                    <a:lnTo>
                      <a:pt x="759" y="672"/>
                    </a:lnTo>
                    <a:lnTo>
                      <a:pt x="764" y="647"/>
                    </a:lnTo>
                    <a:lnTo>
                      <a:pt x="770" y="706"/>
                    </a:lnTo>
                    <a:lnTo>
                      <a:pt x="776" y="639"/>
                    </a:lnTo>
                    <a:lnTo>
                      <a:pt x="782" y="664"/>
                    </a:lnTo>
                    <a:lnTo>
                      <a:pt x="787" y="664"/>
                    </a:lnTo>
                    <a:lnTo>
                      <a:pt x="793" y="639"/>
                    </a:lnTo>
                    <a:lnTo>
                      <a:pt x="799" y="714"/>
                    </a:lnTo>
                    <a:lnTo>
                      <a:pt x="804" y="714"/>
                    </a:lnTo>
                    <a:lnTo>
                      <a:pt x="810" y="706"/>
                    </a:lnTo>
                    <a:lnTo>
                      <a:pt x="816" y="655"/>
                    </a:lnTo>
                    <a:lnTo>
                      <a:pt x="821" y="647"/>
                    </a:lnTo>
                    <a:lnTo>
                      <a:pt x="827" y="622"/>
                    </a:lnTo>
                    <a:lnTo>
                      <a:pt x="833" y="605"/>
                    </a:lnTo>
                    <a:lnTo>
                      <a:pt x="838" y="630"/>
                    </a:lnTo>
                    <a:lnTo>
                      <a:pt x="844" y="597"/>
                    </a:lnTo>
                    <a:lnTo>
                      <a:pt x="850" y="622"/>
                    </a:lnTo>
                    <a:lnTo>
                      <a:pt x="855" y="597"/>
                    </a:lnTo>
                    <a:lnTo>
                      <a:pt x="861" y="613"/>
                    </a:lnTo>
                    <a:lnTo>
                      <a:pt x="867" y="647"/>
                    </a:lnTo>
                    <a:lnTo>
                      <a:pt x="872" y="597"/>
                    </a:lnTo>
                    <a:lnTo>
                      <a:pt x="878" y="555"/>
                    </a:lnTo>
                    <a:lnTo>
                      <a:pt x="884" y="563"/>
                    </a:lnTo>
                    <a:lnTo>
                      <a:pt x="889" y="538"/>
                    </a:lnTo>
                    <a:lnTo>
                      <a:pt x="895" y="580"/>
                    </a:lnTo>
                    <a:lnTo>
                      <a:pt x="901" y="571"/>
                    </a:lnTo>
                    <a:lnTo>
                      <a:pt x="906" y="471"/>
                    </a:lnTo>
                    <a:lnTo>
                      <a:pt x="912" y="521"/>
                    </a:lnTo>
                    <a:lnTo>
                      <a:pt x="918" y="504"/>
                    </a:lnTo>
                    <a:lnTo>
                      <a:pt x="923" y="445"/>
                    </a:lnTo>
                    <a:lnTo>
                      <a:pt x="929" y="403"/>
                    </a:lnTo>
                    <a:lnTo>
                      <a:pt x="935" y="395"/>
                    </a:lnTo>
                    <a:lnTo>
                      <a:pt x="940" y="361"/>
                    </a:lnTo>
                    <a:lnTo>
                      <a:pt x="946" y="378"/>
                    </a:lnTo>
                    <a:lnTo>
                      <a:pt x="951" y="353"/>
                    </a:lnTo>
                    <a:lnTo>
                      <a:pt x="957" y="328"/>
                    </a:lnTo>
                    <a:lnTo>
                      <a:pt x="963" y="194"/>
                    </a:lnTo>
                    <a:lnTo>
                      <a:pt x="968" y="277"/>
                    </a:lnTo>
                    <a:lnTo>
                      <a:pt x="974" y="286"/>
                    </a:lnTo>
                    <a:lnTo>
                      <a:pt x="980" y="277"/>
                    </a:lnTo>
                    <a:lnTo>
                      <a:pt x="985" y="185"/>
                    </a:lnTo>
                    <a:lnTo>
                      <a:pt x="991" y="160"/>
                    </a:lnTo>
                    <a:lnTo>
                      <a:pt x="997" y="168"/>
                    </a:lnTo>
                    <a:lnTo>
                      <a:pt x="1002" y="135"/>
                    </a:lnTo>
                    <a:lnTo>
                      <a:pt x="1008" y="76"/>
                    </a:lnTo>
                    <a:lnTo>
                      <a:pt x="1014" y="26"/>
                    </a:lnTo>
                    <a:lnTo>
                      <a:pt x="1019" y="59"/>
                    </a:lnTo>
                    <a:lnTo>
                      <a:pt x="1025" y="51"/>
                    </a:lnTo>
                    <a:lnTo>
                      <a:pt x="1031" y="76"/>
                    </a:lnTo>
                    <a:lnTo>
                      <a:pt x="1036" y="118"/>
                    </a:lnTo>
                    <a:lnTo>
                      <a:pt x="1042" y="42"/>
                    </a:lnTo>
                    <a:lnTo>
                      <a:pt x="1048" y="26"/>
                    </a:lnTo>
                    <a:lnTo>
                      <a:pt x="1053" y="17"/>
                    </a:lnTo>
                    <a:lnTo>
                      <a:pt x="1059" y="135"/>
                    </a:lnTo>
                    <a:lnTo>
                      <a:pt x="1065" y="0"/>
                    </a:lnTo>
                    <a:lnTo>
                      <a:pt x="1070" y="286"/>
                    </a:lnTo>
                    <a:lnTo>
                      <a:pt x="1076" y="269"/>
                    </a:lnTo>
                    <a:lnTo>
                      <a:pt x="1082" y="236"/>
                    </a:lnTo>
                    <a:lnTo>
                      <a:pt x="1088" y="93"/>
                    </a:lnTo>
                    <a:lnTo>
                      <a:pt x="1093" y="177"/>
                    </a:lnTo>
                    <a:lnTo>
                      <a:pt x="1099" y="135"/>
                    </a:lnTo>
                    <a:lnTo>
                      <a:pt x="1105" y="361"/>
                    </a:lnTo>
                    <a:lnTo>
                      <a:pt x="1110" y="269"/>
                    </a:lnTo>
                    <a:lnTo>
                      <a:pt x="1116" y="387"/>
                    </a:lnTo>
                    <a:lnTo>
                      <a:pt x="1122" y="420"/>
                    </a:lnTo>
                    <a:lnTo>
                      <a:pt x="1127" y="403"/>
                    </a:lnTo>
                    <a:lnTo>
                      <a:pt x="1133" y="479"/>
                    </a:lnTo>
                    <a:lnTo>
                      <a:pt x="1139" y="479"/>
                    </a:lnTo>
                    <a:lnTo>
                      <a:pt x="1144" y="546"/>
                    </a:lnTo>
                    <a:lnTo>
                      <a:pt x="1150" y="479"/>
                    </a:lnTo>
                    <a:lnTo>
                      <a:pt x="1156" y="571"/>
                    </a:lnTo>
                    <a:lnTo>
                      <a:pt x="1161" y="521"/>
                    </a:lnTo>
                    <a:lnTo>
                      <a:pt x="1167" y="580"/>
                    </a:lnTo>
                    <a:lnTo>
                      <a:pt x="1173" y="622"/>
                    </a:lnTo>
                    <a:lnTo>
                      <a:pt x="1178" y="563"/>
                    </a:lnTo>
                    <a:lnTo>
                      <a:pt x="1184" y="605"/>
                    </a:lnTo>
                    <a:lnTo>
                      <a:pt x="1190" y="630"/>
                    </a:lnTo>
                    <a:lnTo>
                      <a:pt x="1195" y="680"/>
                    </a:lnTo>
                    <a:lnTo>
                      <a:pt x="1201" y="680"/>
                    </a:lnTo>
                    <a:lnTo>
                      <a:pt x="1206" y="647"/>
                    </a:lnTo>
                    <a:lnTo>
                      <a:pt x="1212" y="672"/>
                    </a:lnTo>
                    <a:lnTo>
                      <a:pt x="1218" y="697"/>
                    </a:lnTo>
                    <a:lnTo>
                      <a:pt x="1223" y="739"/>
                    </a:lnTo>
                    <a:lnTo>
                      <a:pt x="1229" y="731"/>
                    </a:lnTo>
                    <a:lnTo>
                      <a:pt x="1235" y="739"/>
                    </a:lnTo>
                    <a:lnTo>
                      <a:pt x="1240" y="731"/>
                    </a:lnTo>
                    <a:lnTo>
                      <a:pt x="1246" y="773"/>
                    </a:lnTo>
                    <a:lnTo>
                      <a:pt x="1252" y="756"/>
                    </a:lnTo>
                    <a:lnTo>
                      <a:pt x="1257" y="765"/>
                    </a:lnTo>
                    <a:lnTo>
                      <a:pt x="1263" y="765"/>
                    </a:lnTo>
                    <a:lnTo>
                      <a:pt x="1269" y="765"/>
                    </a:lnTo>
                    <a:lnTo>
                      <a:pt x="1274" y="765"/>
                    </a:lnTo>
                    <a:lnTo>
                      <a:pt x="1280" y="773"/>
                    </a:lnTo>
                    <a:lnTo>
                      <a:pt x="1286" y="773"/>
                    </a:lnTo>
                    <a:lnTo>
                      <a:pt x="1291" y="773"/>
                    </a:lnTo>
                    <a:lnTo>
                      <a:pt x="1297" y="773"/>
                    </a:lnTo>
                    <a:lnTo>
                      <a:pt x="1303" y="773"/>
                    </a:lnTo>
                    <a:lnTo>
                      <a:pt x="1308" y="773"/>
                    </a:lnTo>
                    <a:lnTo>
                      <a:pt x="1314" y="773"/>
                    </a:lnTo>
                    <a:lnTo>
                      <a:pt x="1320" y="773"/>
                    </a:lnTo>
                    <a:lnTo>
                      <a:pt x="1325" y="773"/>
                    </a:lnTo>
                    <a:lnTo>
                      <a:pt x="1331" y="773"/>
                    </a:lnTo>
                    <a:lnTo>
                      <a:pt x="1337" y="773"/>
                    </a:lnTo>
                    <a:lnTo>
                      <a:pt x="1342" y="773"/>
                    </a:lnTo>
                    <a:lnTo>
                      <a:pt x="1348" y="773"/>
                    </a:lnTo>
                    <a:lnTo>
                      <a:pt x="1354" y="773"/>
                    </a:lnTo>
                    <a:lnTo>
                      <a:pt x="1359" y="773"/>
                    </a:lnTo>
                    <a:lnTo>
                      <a:pt x="1365" y="773"/>
                    </a:lnTo>
                    <a:lnTo>
                      <a:pt x="1371" y="773"/>
                    </a:lnTo>
                    <a:lnTo>
                      <a:pt x="1376" y="773"/>
                    </a:lnTo>
                    <a:lnTo>
                      <a:pt x="1382" y="773"/>
                    </a:lnTo>
                    <a:lnTo>
                      <a:pt x="1388" y="773"/>
                    </a:lnTo>
                    <a:lnTo>
                      <a:pt x="1393" y="773"/>
                    </a:lnTo>
                    <a:lnTo>
                      <a:pt x="1399" y="773"/>
                    </a:lnTo>
                    <a:lnTo>
                      <a:pt x="1405" y="773"/>
                    </a:lnTo>
                    <a:lnTo>
                      <a:pt x="1411" y="773"/>
                    </a:lnTo>
                    <a:lnTo>
                      <a:pt x="1416" y="773"/>
                    </a:lnTo>
                    <a:lnTo>
                      <a:pt x="1422" y="773"/>
                    </a:lnTo>
                    <a:lnTo>
                      <a:pt x="1428" y="773"/>
                    </a:lnTo>
                    <a:lnTo>
                      <a:pt x="1433" y="773"/>
                    </a:lnTo>
                    <a:lnTo>
                      <a:pt x="1439" y="773"/>
                    </a:lnTo>
                    <a:lnTo>
                      <a:pt x="1445" y="773"/>
                    </a:lnTo>
                    <a:lnTo>
                      <a:pt x="1450" y="773"/>
                    </a:lnTo>
                    <a:lnTo>
                      <a:pt x="0" y="77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482" name="Rectangle 114"/>
              <p:cNvSpPr>
                <a:spLocks noChangeArrowheads="1"/>
              </p:cNvSpPr>
              <p:nvPr/>
            </p:nvSpPr>
            <p:spPr bwMode="auto">
              <a:xfrm>
                <a:off x="3883025" y="5783263"/>
                <a:ext cx="2301875" cy="18399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199" name="Groep 198"/>
            <p:cNvGrpSpPr/>
            <p:nvPr/>
          </p:nvGrpSpPr>
          <p:grpSpPr>
            <a:xfrm>
              <a:off x="5140145" y="2528127"/>
              <a:ext cx="1163039" cy="1191023"/>
              <a:chOff x="6475413" y="4702175"/>
              <a:chExt cx="2301875" cy="1839913"/>
            </a:xfrm>
          </p:grpSpPr>
          <p:sp>
            <p:nvSpPr>
              <p:cNvPr id="58514" name="Freeform 146"/>
              <p:cNvSpPr>
                <a:spLocks/>
              </p:cNvSpPr>
              <p:nvPr/>
            </p:nvSpPr>
            <p:spPr bwMode="auto">
              <a:xfrm>
                <a:off x="6475413" y="4711700"/>
                <a:ext cx="2301875" cy="1830388"/>
              </a:xfrm>
              <a:custGeom>
                <a:avLst/>
                <a:gdLst/>
                <a:ahLst/>
                <a:cxnLst>
                  <a:cxn ang="0">
                    <a:pos x="17" y="1153"/>
                  </a:cxn>
                  <a:cxn ang="0">
                    <a:pos x="45" y="1153"/>
                  </a:cxn>
                  <a:cxn ang="0">
                    <a:pos x="73" y="1153"/>
                  </a:cxn>
                  <a:cxn ang="0">
                    <a:pos x="102" y="1153"/>
                  </a:cxn>
                  <a:cxn ang="0">
                    <a:pos x="130" y="1153"/>
                  </a:cxn>
                  <a:cxn ang="0">
                    <a:pos x="158" y="1153"/>
                  </a:cxn>
                  <a:cxn ang="0">
                    <a:pos x="187" y="1153"/>
                  </a:cxn>
                  <a:cxn ang="0">
                    <a:pos x="215" y="1153"/>
                  </a:cxn>
                  <a:cxn ang="0">
                    <a:pos x="243" y="1153"/>
                  </a:cxn>
                  <a:cxn ang="0">
                    <a:pos x="272" y="1153"/>
                  </a:cxn>
                  <a:cxn ang="0">
                    <a:pos x="300" y="1153"/>
                  </a:cxn>
                  <a:cxn ang="0">
                    <a:pos x="328" y="1153"/>
                  </a:cxn>
                  <a:cxn ang="0">
                    <a:pos x="357" y="1153"/>
                  </a:cxn>
                  <a:cxn ang="0">
                    <a:pos x="385" y="1153"/>
                  </a:cxn>
                  <a:cxn ang="0">
                    <a:pos x="413" y="1153"/>
                  </a:cxn>
                  <a:cxn ang="0">
                    <a:pos x="441" y="1143"/>
                  </a:cxn>
                  <a:cxn ang="0">
                    <a:pos x="470" y="1153"/>
                  </a:cxn>
                  <a:cxn ang="0">
                    <a:pos x="498" y="1153"/>
                  </a:cxn>
                  <a:cxn ang="0">
                    <a:pos x="527" y="1153"/>
                  </a:cxn>
                  <a:cxn ang="0">
                    <a:pos x="555" y="1134"/>
                  </a:cxn>
                  <a:cxn ang="0">
                    <a:pos x="583" y="1143"/>
                  </a:cxn>
                  <a:cxn ang="0">
                    <a:pos x="612" y="1124"/>
                  </a:cxn>
                  <a:cxn ang="0">
                    <a:pos x="640" y="1124"/>
                  </a:cxn>
                  <a:cxn ang="0">
                    <a:pos x="668" y="1134"/>
                  </a:cxn>
                  <a:cxn ang="0">
                    <a:pos x="696" y="1143"/>
                  </a:cxn>
                  <a:cxn ang="0">
                    <a:pos x="725" y="1134"/>
                  </a:cxn>
                  <a:cxn ang="0">
                    <a:pos x="753" y="1134"/>
                  </a:cxn>
                  <a:cxn ang="0">
                    <a:pos x="782" y="1114"/>
                  </a:cxn>
                  <a:cxn ang="0">
                    <a:pos x="810" y="1143"/>
                  </a:cxn>
                  <a:cxn ang="0">
                    <a:pos x="838" y="1124"/>
                  </a:cxn>
                  <a:cxn ang="0">
                    <a:pos x="867" y="1114"/>
                  </a:cxn>
                  <a:cxn ang="0">
                    <a:pos x="895" y="1143"/>
                  </a:cxn>
                  <a:cxn ang="0">
                    <a:pos x="923" y="1124"/>
                  </a:cxn>
                  <a:cxn ang="0">
                    <a:pos x="951" y="1134"/>
                  </a:cxn>
                  <a:cxn ang="0">
                    <a:pos x="980" y="1066"/>
                  </a:cxn>
                  <a:cxn ang="0">
                    <a:pos x="1008" y="1143"/>
                  </a:cxn>
                  <a:cxn ang="0">
                    <a:pos x="1036" y="1076"/>
                  </a:cxn>
                  <a:cxn ang="0">
                    <a:pos x="1065" y="1047"/>
                  </a:cxn>
                  <a:cxn ang="0">
                    <a:pos x="1093" y="1018"/>
                  </a:cxn>
                  <a:cxn ang="0">
                    <a:pos x="1122" y="979"/>
                  </a:cxn>
                  <a:cxn ang="0">
                    <a:pos x="1150" y="989"/>
                  </a:cxn>
                  <a:cxn ang="0">
                    <a:pos x="1178" y="776"/>
                  </a:cxn>
                  <a:cxn ang="0">
                    <a:pos x="1206" y="805"/>
                  </a:cxn>
                  <a:cxn ang="0">
                    <a:pos x="1235" y="718"/>
                  </a:cxn>
                  <a:cxn ang="0">
                    <a:pos x="1263" y="506"/>
                  </a:cxn>
                  <a:cxn ang="0">
                    <a:pos x="1291" y="409"/>
                  </a:cxn>
                  <a:cxn ang="0">
                    <a:pos x="1320" y="380"/>
                  </a:cxn>
                  <a:cxn ang="0">
                    <a:pos x="1348" y="467"/>
                  </a:cxn>
                  <a:cxn ang="0">
                    <a:pos x="1376" y="641"/>
                  </a:cxn>
                  <a:cxn ang="0">
                    <a:pos x="1405" y="612"/>
                  </a:cxn>
                  <a:cxn ang="0">
                    <a:pos x="1433" y="1018"/>
                  </a:cxn>
                </a:cxnLst>
                <a:rect l="0" t="0" r="r" b="b"/>
                <a:pathLst>
                  <a:path w="1450" h="1153">
                    <a:moveTo>
                      <a:pt x="0" y="1153"/>
                    </a:moveTo>
                    <a:lnTo>
                      <a:pt x="0" y="1153"/>
                    </a:lnTo>
                    <a:lnTo>
                      <a:pt x="5" y="1153"/>
                    </a:lnTo>
                    <a:lnTo>
                      <a:pt x="11" y="1153"/>
                    </a:lnTo>
                    <a:lnTo>
                      <a:pt x="17" y="1153"/>
                    </a:lnTo>
                    <a:lnTo>
                      <a:pt x="22" y="1153"/>
                    </a:lnTo>
                    <a:lnTo>
                      <a:pt x="28" y="1153"/>
                    </a:lnTo>
                    <a:lnTo>
                      <a:pt x="34" y="1153"/>
                    </a:lnTo>
                    <a:lnTo>
                      <a:pt x="39" y="1153"/>
                    </a:lnTo>
                    <a:lnTo>
                      <a:pt x="45" y="1153"/>
                    </a:lnTo>
                    <a:lnTo>
                      <a:pt x="51" y="1153"/>
                    </a:lnTo>
                    <a:lnTo>
                      <a:pt x="56" y="1153"/>
                    </a:lnTo>
                    <a:lnTo>
                      <a:pt x="62" y="1153"/>
                    </a:lnTo>
                    <a:lnTo>
                      <a:pt x="68" y="1153"/>
                    </a:lnTo>
                    <a:lnTo>
                      <a:pt x="73" y="1153"/>
                    </a:lnTo>
                    <a:lnTo>
                      <a:pt x="79" y="1153"/>
                    </a:lnTo>
                    <a:lnTo>
                      <a:pt x="85" y="1153"/>
                    </a:lnTo>
                    <a:lnTo>
                      <a:pt x="90" y="1153"/>
                    </a:lnTo>
                    <a:lnTo>
                      <a:pt x="96" y="1153"/>
                    </a:lnTo>
                    <a:lnTo>
                      <a:pt x="102" y="1153"/>
                    </a:lnTo>
                    <a:lnTo>
                      <a:pt x="107" y="1153"/>
                    </a:lnTo>
                    <a:lnTo>
                      <a:pt x="113" y="1153"/>
                    </a:lnTo>
                    <a:lnTo>
                      <a:pt x="119" y="1153"/>
                    </a:lnTo>
                    <a:lnTo>
                      <a:pt x="124" y="1153"/>
                    </a:lnTo>
                    <a:lnTo>
                      <a:pt x="130" y="1153"/>
                    </a:lnTo>
                    <a:lnTo>
                      <a:pt x="136" y="1153"/>
                    </a:lnTo>
                    <a:lnTo>
                      <a:pt x="141" y="1153"/>
                    </a:lnTo>
                    <a:lnTo>
                      <a:pt x="147" y="1153"/>
                    </a:lnTo>
                    <a:lnTo>
                      <a:pt x="153" y="1153"/>
                    </a:lnTo>
                    <a:lnTo>
                      <a:pt x="158" y="1153"/>
                    </a:lnTo>
                    <a:lnTo>
                      <a:pt x="164" y="1153"/>
                    </a:lnTo>
                    <a:lnTo>
                      <a:pt x="170" y="1153"/>
                    </a:lnTo>
                    <a:lnTo>
                      <a:pt x="175" y="1153"/>
                    </a:lnTo>
                    <a:lnTo>
                      <a:pt x="181" y="1153"/>
                    </a:lnTo>
                    <a:lnTo>
                      <a:pt x="187" y="1153"/>
                    </a:lnTo>
                    <a:lnTo>
                      <a:pt x="192" y="1153"/>
                    </a:lnTo>
                    <a:lnTo>
                      <a:pt x="198" y="1153"/>
                    </a:lnTo>
                    <a:lnTo>
                      <a:pt x="204" y="1153"/>
                    </a:lnTo>
                    <a:lnTo>
                      <a:pt x="209" y="1143"/>
                    </a:lnTo>
                    <a:lnTo>
                      <a:pt x="215" y="1153"/>
                    </a:lnTo>
                    <a:lnTo>
                      <a:pt x="221" y="1153"/>
                    </a:lnTo>
                    <a:lnTo>
                      <a:pt x="226" y="1153"/>
                    </a:lnTo>
                    <a:lnTo>
                      <a:pt x="232" y="1153"/>
                    </a:lnTo>
                    <a:lnTo>
                      <a:pt x="238" y="1153"/>
                    </a:lnTo>
                    <a:lnTo>
                      <a:pt x="243" y="1153"/>
                    </a:lnTo>
                    <a:lnTo>
                      <a:pt x="249" y="1153"/>
                    </a:lnTo>
                    <a:lnTo>
                      <a:pt x="255" y="1153"/>
                    </a:lnTo>
                    <a:lnTo>
                      <a:pt x="260" y="1153"/>
                    </a:lnTo>
                    <a:lnTo>
                      <a:pt x="266" y="1153"/>
                    </a:lnTo>
                    <a:lnTo>
                      <a:pt x="272" y="1153"/>
                    </a:lnTo>
                    <a:lnTo>
                      <a:pt x="277" y="1153"/>
                    </a:lnTo>
                    <a:lnTo>
                      <a:pt x="283" y="1153"/>
                    </a:lnTo>
                    <a:lnTo>
                      <a:pt x="289" y="1153"/>
                    </a:lnTo>
                    <a:lnTo>
                      <a:pt x="294" y="1153"/>
                    </a:lnTo>
                    <a:lnTo>
                      <a:pt x="300" y="1153"/>
                    </a:lnTo>
                    <a:lnTo>
                      <a:pt x="306" y="1153"/>
                    </a:lnTo>
                    <a:lnTo>
                      <a:pt x="311" y="1153"/>
                    </a:lnTo>
                    <a:lnTo>
                      <a:pt x="317" y="1153"/>
                    </a:lnTo>
                    <a:lnTo>
                      <a:pt x="323" y="1153"/>
                    </a:lnTo>
                    <a:lnTo>
                      <a:pt x="328" y="1153"/>
                    </a:lnTo>
                    <a:lnTo>
                      <a:pt x="334" y="1153"/>
                    </a:lnTo>
                    <a:lnTo>
                      <a:pt x="340" y="1153"/>
                    </a:lnTo>
                    <a:lnTo>
                      <a:pt x="345" y="1153"/>
                    </a:lnTo>
                    <a:lnTo>
                      <a:pt x="351" y="1143"/>
                    </a:lnTo>
                    <a:lnTo>
                      <a:pt x="357" y="1153"/>
                    </a:lnTo>
                    <a:lnTo>
                      <a:pt x="362" y="1143"/>
                    </a:lnTo>
                    <a:lnTo>
                      <a:pt x="368" y="1153"/>
                    </a:lnTo>
                    <a:lnTo>
                      <a:pt x="374" y="1153"/>
                    </a:lnTo>
                    <a:lnTo>
                      <a:pt x="379" y="1153"/>
                    </a:lnTo>
                    <a:lnTo>
                      <a:pt x="385" y="1153"/>
                    </a:lnTo>
                    <a:lnTo>
                      <a:pt x="391" y="1153"/>
                    </a:lnTo>
                    <a:lnTo>
                      <a:pt x="396" y="1153"/>
                    </a:lnTo>
                    <a:lnTo>
                      <a:pt x="402" y="1153"/>
                    </a:lnTo>
                    <a:lnTo>
                      <a:pt x="408" y="1153"/>
                    </a:lnTo>
                    <a:lnTo>
                      <a:pt x="413" y="1153"/>
                    </a:lnTo>
                    <a:lnTo>
                      <a:pt x="419" y="1143"/>
                    </a:lnTo>
                    <a:lnTo>
                      <a:pt x="425" y="1143"/>
                    </a:lnTo>
                    <a:lnTo>
                      <a:pt x="430" y="1153"/>
                    </a:lnTo>
                    <a:lnTo>
                      <a:pt x="436" y="1153"/>
                    </a:lnTo>
                    <a:lnTo>
                      <a:pt x="441" y="1143"/>
                    </a:lnTo>
                    <a:lnTo>
                      <a:pt x="447" y="1143"/>
                    </a:lnTo>
                    <a:lnTo>
                      <a:pt x="453" y="1153"/>
                    </a:lnTo>
                    <a:lnTo>
                      <a:pt x="458" y="1153"/>
                    </a:lnTo>
                    <a:lnTo>
                      <a:pt x="464" y="1153"/>
                    </a:lnTo>
                    <a:lnTo>
                      <a:pt x="470" y="1153"/>
                    </a:lnTo>
                    <a:lnTo>
                      <a:pt x="476" y="1153"/>
                    </a:lnTo>
                    <a:lnTo>
                      <a:pt x="481" y="1143"/>
                    </a:lnTo>
                    <a:lnTo>
                      <a:pt x="487" y="1153"/>
                    </a:lnTo>
                    <a:lnTo>
                      <a:pt x="493" y="1153"/>
                    </a:lnTo>
                    <a:lnTo>
                      <a:pt x="498" y="1153"/>
                    </a:lnTo>
                    <a:lnTo>
                      <a:pt x="504" y="1153"/>
                    </a:lnTo>
                    <a:lnTo>
                      <a:pt x="510" y="1143"/>
                    </a:lnTo>
                    <a:lnTo>
                      <a:pt x="515" y="1143"/>
                    </a:lnTo>
                    <a:lnTo>
                      <a:pt x="521" y="1124"/>
                    </a:lnTo>
                    <a:lnTo>
                      <a:pt x="527" y="1153"/>
                    </a:lnTo>
                    <a:lnTo>
                      <a:pt x="532" y="1143"/>
                    </a:lnTo>
                    <a:lnTo>
                      <a:pt x="538" y="1143"/>
                    </a:lnTo>
                    <a:lnTo>
                      <a:pt x="544" y="1134"/>
                    </a:lnTo>
                    <a:lnTo>
                      <a:pt x="549" y="1153"/>
                    </a:lnTo>
                    <a:lnTo>
                      <a:pt x="555" y="1134"/>
                    </a:lnTo>
                    <a:lnTo>
                      <a:pt x="561" y="1085"/>
                    </a:lnTo>
                    <a:lnTo>
                      <a:pt x="566" y="1143"/>
                    </a:lnTo>
                    <a:lnTo>
                      <a:pt x="572" y="1134"/>
                    </a:lnTo>
                    <a:lnTo>
                      <a:pt x="578" y="1143"/>
                    </a:lnTo>
                    <a:lnTo>
                      <a:pt x="583" y="1143"/>
                    </a:lnTo>
                    <a:lnTo>
                      <a:pt x="589" y="1114"/>
                    </a:lnTo>
                    <a:lnTo>
                      <a:pt x="595" y="1143"/>
                    </a:lnTo>
                    <a:lnTo>
                      <a:pt x="600" y="1143"/>
                    </a:lnTo>
                    <a:lnTo>
                      <a:pt x="606" y="1134"/>
                    </a:lnTo>
                    <a:lnTo>
                      <a:pt x="612" y="1124"/>
                    </a:lnTo>
                    <a:lnTo>
                      <a:pt x="617" y="1143"/>
                    </a:lnTo>
                    <a:lnTo>
                      <a:pt x="623" y="1124"/>
                    </a:lnTo>
                    <a:lnTo>
                      <a:pt x="629" y="1143"/>
                    </a:lnTo>
                    <a:lnTo>
                      <a:pt x="634" y="1153"/>
                    </a:lnTo>
                    <a:lnTo>
                      <a:pt x="640" y="1124"/>
                    </a:lnTo>
                    <a:lnTo>
                      <a:pt x="646" y="1114"/>
                    </a:lnTo>
                    <a:lnTo>
                      <a:pt x="651" y="1143"/>
                    </a:lnTo>
                    <a:lnTo>
                      <a:pt x="657" y="1105"/>
                    </a:lnTo>
                    <a:lnTo>
                      <a:pt x="663" y="1124"/>
                    </a:lnTo>
                    <a:lnTo>
                      <a:pt x="668" y="1134"/>
                    </a:lnTo>
                    <a:lnTo>
                      <a:pt x="674" y="1153"/>
                    </a:lnTo>
                    <a:lnTo>
                      <a:pt x="680" y="1095"/>
                    </a:lnTo>
                    <a:lnTo>
                      <a:pt x="685" y="1124"/>
                    </a:lnTo>
                    <a:lnTo>
                      <a:pt x="691" y="1124"/>
                    </a:lnTo>
                    <a:lnTo>
                      <a:pt x="696" y="1143"/>
                    </a:lnTo>
                    <a:lnTo>
                      <a:pt x="702" y="1143"/>
                    </a:lnTo>
                    <a:lnTo>
                      <a:pt x="708" y="1153"/>
                    </a:lnTo>
                    <a:lnTo>
                      <a:pt x="713" y="1143"/>
                    </a:lnTo>
                    <a:lnTo>
                      <a:pt x="719" y="1143"/>
                    </a:lnTo>
                    <a:lnTo>
                      <a:pt x="725" y="1134"/>
                    </a:lnTo>
                    <a:lnTo>
                      <a:pt x="730" y="1134"/>
                    </a:lnTo>
                    <a:lnTo>
                      <a:pt x="736" y="1143"/>
                    </a:lnTo>
                    <a:lnTo>
                      <a:pt x="742" y="1114"/>
                    </a:lnTo>
                    <a:lnTo>
                      <a:pt x="747" y="1124"/>
                    </a:lnTo>
                    <a:lnTo>
                      <a:pt x="753" y="1134"/>
                    </a:lnTo>
                    <a:lnTo>
                      <a:pt x="759" y="1153"/>
                    </a:lnTo>
                    <a:lnTo>
                      <a:pt x="764" y="1124"/>
                    </a:lnTo>
                    <a:lnTo>
                      <a:pt x="770" y="1134"/>
                    </a:lnTo>
                    <a:lnTo>
                      <a:pt x="776" y="1143"/>
                    </a:lnTo>
                    <a:lnTo>
                      <a:pt x="782" y="1114"/>
                    </a:lnTo>
                    <a:lnTo>
                      <a:pt x="787" y="1143"/>
                    </a:lnTo>
                    <a:lnTo>
                      <a:pt x="793" y="1153"/>
                    </a:lnTo>
                    <a:lnTo>
                      <a:pt x="799" y="1143"/>
                    </a:lnTo>
                    <a:lnTo>
                      <a:pt x="804" y="1114"/>
                    </a:lnTo>
                    <a:lnTo>
                      <a:pt x="810" y="1143"/>
                    </a:lnTo>
                    <a:lnTo>
                      <a:pt x="816" y="1143"/>
                    </a:lnTo>
                    <a:lnTo>
                      <a:pt x="821" y="1124"/>
                    </a:lnTo>
                    <a:lnTo>
                      <a:pt x="827" y="1153"/>
                    </a:lnTo>
                    <a:lnTo>
                      <a:pt x="833" y="1153"/>
                    </a:lnTo>
                    <a:lnTo>
                      <a:pt x="838" y="1124"/>
                    </a:lnTo>
                    <a:lnTo>
                      <a:pt x="844" y="1124"/>
                    </a:lnTo>
                    <a:lnTo>
                      <a:pt x="850" y="1153"/>
                    </a:lnTo>
                    <a:lnTo>
                      <a:pt x="855" y="1143"/>
                    </a:lnTo>
                    <a:lnTo>
                      <a:pt x="861" y="1114"/>
                    </a:lnTo>
                    <a:lnTo>
                      <a:pt x="867" y="1114"/>
                    </a:lnTo>
                    <a:lnTo>
                      <a:pt x="872" y="1134"/>
                    </a:lnTo>
                    <a:lnTo>
                      <a:pt x="878" y="1124"/>
                    </a:lnTo>
                    <a:lnTo>
                      <a:pt x="884" y="1143"/>
                    </a:lnTo>
                    <a:lnTo>
                      <a:pt x="889" y="1134"/>
                    </a:lnTo>
                    <a:lnTo>
                      <a:pt x="895" y="1143"/>
                    </a:lnTo>
                    <a:lnTo>
                      <a:pt x="901" y="1143"/>
                    </a:lnTo>
                    <a:lnTo>
                      <a:pt x="906" y="1124"/>
                    </a:lnTo>
                    <a:lnTo>
                      <a:pt x="912" y="1124"/>
                    </a:lnTo>
                    <a:lnTo>
                      <a:pt x="918" y="1143"/>
                    </a:lnTo>
                    <a:lnTo>
                      <a:pt x="923" y="1124"/>
                    </a:lnTo>
                    <a:lnTo>
                      <a:pt x="929" y="1105"/>
                    </a:lnTo>
                    <a:lnTo>
                      <a:pt x="935" y="1105"/>
                    </a:lnTo>
                    <a:lnTo>
                      <a:pt x="940" y="1143"/>
                    </a:lnTo>
                    <a:lnTo>
                      <a:pt x="946" y="1105"/>
                    </a:lnTo>
                    <a:lnTo>
                      <a:pt x="951" y="1134"/>
                    </a:lnTo>
                    <a:lnTo>
                      <a:pt x="957" y="1134"/>
                    </a:lnTo>
                    <a:lnTo>
                      <a:pt x="963" y="1134"/>
                    </a:lnTo>
                    <a:lnTo>
                      <a:pt x="968" y="1085"/>
                    </a:lnTo>
                    <a:lnTo>
                      <a:pt x="974" y="1124"/>
                    </a:lnTo>
                    <a:lnTo>
                      <a:pt x="980" y="1066"/>
                    </a:lnTo>
                    <a:lnTo>
                      <a:pt x="985" y="1095"/>
                    </a:lnTo>
                    <a:lnTo>
                      <a:pt x="991" y="1095"/>
                    </a:lnTo>
                    <a:lnTo>
                      <a:pt x="997" y="1076"/>
                    </a:lnTo>
                    <a:lnTo>
                      <a:pt x="1002" y="1085"/>
                    </a:lnTo>
                    <a:lnTo>
                      <a:pt x="1008" y="1143"/>
                    </a:lnTo>
                    <a:lnTo>
                      <a:pt x="1014" y="1047"/>
                    </a:lnTo>
                    <a:lnTo>
                      <a:pt x="1019" y="1085"/>
                    </a:lnTo>
                    <a:lnTo>
                      <a:pt x="1025" y="1076"/>
                    </a:lnTo>
                    <a:lnTo>
                      <a:pt x="1031" y="1056"/>
                    </a:lnTo>
                    <a:lnTo>
                      <a:pt x="1036" y="1076"/>
                    </a:lnTo>
                    <a:lnTo>
                      <a:pt x="1042" y="1076"/>
                    </a:lnTo>
                    <a:lnTo>
                      <a:pt x="1048" y="1027"/>
                    </a:lnTo>
                    <a:lnTo>
                      <a:pt x="1053" y="979"/>
                    </a:lnTo>
                    <a:lnTo>
                      <a:pt x="1059" y="1037"/>
                    </a:lnTo>
                    <a:lnTo>
                      <a:pt x="1065" y="1047"/>
                    </a:lnTo>
                    <a:lnTo>
                      <a:pt x="1070" y="1008"/>
                    </a:lnTo>
                    <a:lnTo>
                      <a:pt x="1076" y="1018"/>
                    </a:lnTo>
                    <a:lnTo>
                      <a:pt x="1082" y="1027"/>
                    </a:lnTo>
                    <a:lnTo>
                      <a:pt x="1088" y="912"/>
                    </a:lnTo>
                    <a:lnTo>
                      <a:pt x="1093" y="1018"/>
                    </a:lnTo>
                    <a:lnTo>
                      <a:pt x="1099" y="969"/>
                    </a:lnTo>
                    <a:lnTo>
                      <a:pt x="1105" y="950"/>
                    </a:lnTo>
                    <a:lnTo>
                      <a:pt x="1110" y="989"/>
                    </a:lnTo>
                    <a:lnTo>
                      <a:pt x="1116" y="989"/>
                    </a:lnTo>
                    <a:lnTo>
                      <a:pt x="1122" y="979"/>
                    </a:lnTo>
                    <a:lnTo>
                      <a:pt x="1127" y="940"/>
                    </a:lnTo>
                    <a:lnTo>
                      <a:pt x="1133" y="989"/>
                    </a:lnTo>
                    <a:lnTo>
                      <a:pt x="1139" y="931"/>
                    </a:lnTo>
                    <a:lnTo>
                      <a:pt x="1144" y="998"/>
                    </a:lnTo>
                    <a:lnTo>
                      <a:pt x="1150" y="989"/>
                    </a:lnTo>
                    <a:lnTo>
                      <a:pt x="1156" y="931"/>
                    </a:lnTo>
                    <a:lnTo>
                      <a:pt x="1161" y="834"/>
                    </a:lnTo>
                    <a:lnTo>
                      <a:pt x="1167" y="931"/>
                    </a:lnTo>
                    <a:lnTo>
                      <a:pt x="1173" y="873"/>
                    </a:lnTo>
                    <a:lnTo>
                      <a:pt x="1178" y="776"/>
                    </a:lnTo>
                    <a:lnTo>
                      <a:pt x="1184" y="912"/>
                    </a:lnTo>
                    <a:lnTo>
                      <a:pt x="1190" y="786"/>
                    </a:lnTo>
                    <a:lnTo>
                      <a:pt x="1195" y="815"/>
                    </a:lnTo>
                    <a:lnTo>
                      <a:pt x="1201" y="834"/>
                    </a:lnTo>
                    <a:lnTo>
                      <a:pt x="1206" y="805"/>
                    </a:lnTo>
                    <a:lnTo>
                      <a:pt x="1212" y="709"/>
                    </a:lnTo>
                    <a:lnTo>
                      <a:pt x="1218" y="738"/>
                    </a:lnTo>
                    <a:lnTo>
                      <a:pt x="1223" y="699"/>
                    </a:lnTo>
                    <a:lnTo>
                      <a:pt x="1229" y="709"/>
                    </a:lnTo>
                    <a:lnTo>
                      <a:pt x="1235" y="718"/>
                    </a:lnTo>
                    <a:lnTo>
                      <a:pt x="1240" y="805"/>
                    </a:lnTo>
                    <a:lnTo>
                      <a:pt x="1246" y="554"/>
                    </a:lnTo>
                    <a:lnTo>
                      <a:pt x="1252" y="709"/>
                    </a:lnTo>
                    <a:lnTo>
                      <a:pt x="1257" y="718"/>
                    </a:lnTo>
                    <a:lnTo>
                      <a:pt x="1263" y="506"/>
                    </a:lnTo>
                    <a:lnTo>
                      <a:pt x="1269" y="593"/>
                    </a:lnTo>
                    <a:lnTo>
                      <a:pt x="1274" y="554"/>
                    </a:lnTo>
                    <a:lnTo>
                      <a:pt x="1280" y="458"/>
                    </a:lnTo>
                    <a:lnTo>
                      <a:pt x="1286" y="458"/>
                    </a:lnTo>
                    <a:lnTo>
                      <a:pt x="1291" y="409"/>
                    </a:lnTo>
                    <a:lnTo>
                      <a:pt x="1297" y="487"/>
                    </a:lnTo>
                    <a:lnTo>
                      <a:pt x="1303" y="477"/>
                    </a:lnTo>
                    <a:lnTo>
                      <a:pt x="1308" y="448"/>
                    </a:lnTo>
                    <a:lnTo>
                      <a:pt x="1314" y="525"/>
                    </a:lnTo>
                    <a:lnTo>
                      <a:pt x="1320" y="380"/>
                    </a:lnTo>
                    <a:lnTo>
                      <a:pt x="1325" y="583"/>
                    </a:lnTo>
                    <a:lnTo>
                      <a:pt x="1331" y="583"/>
                    </a:lnTo>
                    <a:lnTo>
                      <a:pt x="1337" y="506"/>
                    </a:lnTo>
                    <a:lnTo>
                      <a:pt x="1342" y="574"/>
                    </a:lnTo>
                    <a:lnTo>
                      <a:pt x="1348" y="467"/>
                    </a:lnTo>
                    <a:lnTo>
                      <a:pt x="1354" y="390"/>
                    </a:lnTo>
                    <a:lnTo>
                      <a:pt x="1359" y="545"/>
                    </a:lnTo>
                    <a:lnTo>
                      <a:pt x="1365" y="680"/>
                    </a:lnTo>
                    <a:lnTo>
                      <a:pt x="1371" y="506"/>
                    </a:lnTo>
                    <a:lnTo>
                      <a:pt x="1376" y="641"/>
                    </a:lnTo>
                    <a:lnTo>
                      <a:pt x="1382" y="554"/>
                    </a:lnTo>
                    <a:lnTo>
                      <a:pt x="1388" y="689"/>
                    </a:lnTo>
                    <a:lnTo>
                      <a:pt x="1393" y="612"/>
                    </a:lnTo>
                    <a:lnTo>
                      <a:pt x="1399" y="660"/>
                    </a:lnTo>
                    <a:lnTo>
                      <a:pt x="1405" y="612"/>
                    </a:lnTo>
                    <a:lnTo>
                      <a:pt x="1411" y="535"/>
                    </a:lnTo>
                    <a:lnTo>
                      <a:pt x="1416" y="400"/>
                    </a:lnTo>
                    <a:lnTo>
                      <a:pt x="1422" y="0"/>
                    </a:lnTo>
                    <a:lnTo>
                      <a:pt x="1428" y="429"/>
                    </a:lnTo>
                    <a:lnTo>
                      <a:pt x="1433" y="1018"/>
                    </a:lnTo>
                    <a:lnTo>
                      <a:pt x="1439" y="989"/>
                    </a:lnTo>
                    <a:lnTo>
                      <a:pt x="1445" y="1095"/>
                    </a:lnTo>
                    <a:lnTo>
                      <a:pt x="1450" y="1153"/>
                    </a:lnTo>
                    <a:lnTo>
                      <a:pt x="0" y="1153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15" name="Freeform 147"/>
              <p:cNvSpPr>
                <a:spLocks/>
              </p:cNvSpPr>
              <p:nvPr/>
            </p:nvSpPr>
            <p:spPr bwMode="auto">
              <a:xfrm>
                <a:off x="6475413" y="4711700"/>
                <a:ext cx="2301875" cy="1830388"/>
              </a:xfrm>
              <a:custGeom>
                <a:avLst/>
                <a:gdLst/>
                <a:ahLst/>
                <a:cxnLst>
                  <a:cxn ang="0">
                    <a:pos x="17" y="1153"/>
                  </a:cxn>
                  <a:cxn ang="0">
                    <a:pos x="45" y="1153"/>
                  </a:cxn>
                  <a:cxn ang="0">
                    <a:pos x="73" y="1153"/>
                  </a:cxn>
                  <a:cxn ang="0">
                    <a:pos x="102" y="1153"/>
                  </a:cxn>
                  <a:cxn ang="0">
                    <a:pos x="130" y="1153"/>
                  </a:cxn>
                  <a:cxn ang="0">
                    <a:pos x="158" y="1153"/>
                  </a:cxn>
                  <a:cxn ang="0">
                    <a:pos x="187" y="1153"/>
                  </a:cxn>
                  <a:cxn ang="0">
                    <a:pos x="215" y="1153"/>
                  </a:cxn>
                  <a:cxn ang="0">
                    <a:pos x="243" y="1153"/>
                  </a:cxn>
                  <a:cxn ang="0">
                    <a:pos x="272" y="1153"/>
                  </a:cxn>
                  <a:cxn ang="0">
                    <a:pos x="300" y="1153"/>
                  </a:cxn>
                  <a:cxn ang="0">
                    <a:pos x="328" y="1153"/>
                  </a:cxn>
                  <a:cxn ang="0">
                    <a:pos x="357" y="1153"/>
                  </a:cxn>
                  <a:cxn ang="0">
                    <a:pos x="385" y="1153"/>
                  </a:cxn>
                  <a:cxn ang="0">
                    <a:pos x="413" y="1153"/>
                  </a:cxn>
                  <a:cxn ang="0">
                    <a:pos x="441" y="1143"/>
                  </a:cxn>
                  <a:cxn ang="0">
                    <a:pos x="470" y="1153"/>
                  </a:cxn>
                  <a:cxn ang="0">
                    <a:pos x="498" y="1153"/>
                  </a:cxn>
                  <a:cxn ang="0">
                    <a:pos x="527" y="1153"/>
                  </a:cxn>
                  <a:cxn ang="0">
                    <a:pos x="555" y="1134"/>
                  </a:cxn>
                  <a:cxn ang="0">
                    <a:pos x="583" y="1143"/>
                  </a:cxn>
                  <a:cxn ang="0">
                    <a:pos x="612" y="1124"/>
                  </a:cxn>
                  <a:cxn ang="0">
                    <a:pos x="640" y="1124"/>
                  </a:cxn>
                  <a:cxn ang="0">
                    <a:pos x="668" y="1134"/>
                  </a:cxn>
                  <a:cxn ang="0">
                    <a:pos x="696" y="1143"/>
                  </a:cxn>
                  <a:cxn ang="0">
                    <a:pos x="725" y="1134"/>
                  </a:cxn>
                  <a:cxn ang="0">
                    <a:pos x="753" y="1134"/>
                  </a:cxn>
                  <a:cxn ang="0">
                    <a:pos x="782" y="1114"/>
                  </a:cxn>
                  <a:cxn ang="0">
                    <a:pos x="810" y="1143"/>
                  </a:cxn>
                  <a:cxn ang="0">
                    <a:pos x="838" y="1124"/>
                  </a:cxn>
                  <a:cxn ang="0">
                    <a:pos x="867" y="1114"/>
                  </a:cxn>
                  <a:cxn ang="0">
                    <a:pos x="895" y="1143"/>
                  </a:cxn>
                  <a:cxn ang="0">
                    <a:pos x="923" y="1124"/>
                  </a:cxn>
                  <a:cxn ang="0">
                    <a:pos x="951" y="1134"/>
                  </a:cxn>
                  <a:cxn ang="0">
                    <a:pos x="980" y="1066"/>
                  </a:cxn>
                  <a:cxn ang="0">
                    <a:pos x="1008" y="1143"/>
                  </a:cxn>
                  <a:cxn ang="0">
                    <a:pos x="1036" y="1076"/>
                  </a:cxn>
                  <a:cxn ang="0">
                    <a:pos x="1065" y="1047"/>
                  </a:cxn>
                  <a:cxn ang="0">
                    <a:pos x="1093" y="1018"/>
                  </a:cxn>
                  <a:cxn ang="0">
                    <a:pos x="1122" y="979"/>
                  </a:cxn>
                  <a:cxn ang="0">
                    <a:pos x="1150" y="989"/>
                  </a:cxn>
                  <a:cxn ang="0">
                    <a:pos x="1178" y="776"/>
                  </a:cxn>
                  <a:cxn ang="0">
                    <a:pos x="1206" y="805"/>
                  </a:cxn>
                  <a:cxn ang="0">
                    <a:pos x="1235" y="718"/>
                  </a:cxn>
                  <a:cxn ang="0">
                    <a:pos x="1263" y="506"/>
                  </a:cxn>
                  <a:cxn ang="0">
                    <a:pos x="1291" y="409"/>
                  </a:cxn>
                  <a:cxn ang="0">
                    <a:pos x="1320" y="380"/>
                  </a:cxn>
                  <a:cxn ang="0">
                    <a:pos x="1348" y="467"/>
                  </a:cxn>
                  <a:cxn ang="0">
                    <a:pos x="1376" y="641"/>
                  </a:cxn>
                  <a:cxn ang="0">
                    <a:pos x="1405" y="612"/>
                  </a:cxn>
                  <a:cxn ang="0">
                    <a:pos x="1433" y="1018"/>
                  </a:cxn>
                </a:cxnLst>
                <a:rect l="0" t="0" r="r" b="b"/>
                <a:pathLst>
                  <a:path w="1450" h="1153">
                    <a:moveTo>
                      <a:pt x="0" y="1153"/>
                    </a:moveTo>
                    <a:lnTo>
                      <a:pt x="0" y="1153"/>
                    </a:lnTo>
                    <a:lnTo>
                      <a:pt x="5" y="1153"/>
                    </a:lnTo>
                    <a:lnTo>
                      <a:pt x="11" y="1153"/>
                    </a:lnTo>
                    <a:lnTo>
                      <a:pt x="17" y="1153"/>
                    </a:lnTo>
                    <a:lnTo>
                      <a:pt x="22" y="1153"/>
                    </a:lnTo>
                    <a:lnTo>
                      <a:pt x="28" y="1153"/>
                    </a:lnTo>
                    <a:lnTo>
                      <a:pt x="34" y="1153"/>
                    </a:lnTo>
                    <a:lnTo>
                      <a:pt x="39" y="1153"/>
                    </a:lnTo>
                    <a:lnTo>
                      <a:pt x="45" y="1153"/>
                    </a:lnTo>
                    <a:lnTo>
                      <a:pt x="51" y="1153"/>
                    </a:lnTo>
                    <a:lnTo>
                      <a:pt x="56" y="1153"/>
                    </a:lnTo>
                    <a:lnTo>
                      <a:pt x="62" y="1153"/>
                    </a:lnTo>
                    <a:lnTo>
                      <a:pt x="68" y="1153"/>
                    </a:lnTo>
                    <a:lnTo>
                      <a:pt x="73" y="1153"/>
                    </a:lnTo>
                    <a:lnTo>
                      <a:pt x="79" y="1153"/>
                    </a:lnTo>
                    <a:lnTo>
                      <a:pt x="85" y="1153"/>
                    </a:lnTo>
                    <a:lnTo>
                      <a:pt x="90" y="1153"/>
                    </a:lnTo>
                    <a:lnTo>
                      <a:pt x="96" y="1153"/>
                    </a:lnTo>
                    <a:lnTo>
                      <a:pt x="102" y="1153"/>
                    </a:lnTo>
                    <a:lnTo>
                      <a:pt x="107" y="1153"/>
                    </a:lnTo>
                    <a:lnTo>
                      <a:pt x="113" y="1153"/>
                    </a:lnTo>
                    <a:lnTo>
                      <a:pt x="119" y="1153"/>
                    </a:lnTo>
                    <a:lnTo>
                      <a:pt x="124" y="1153"/>
                    </a:lnTo>
                    <a:lnTo>
                      <a:pt x="130" y="1153"/>
                    </a:lnTo>
                    <a:lnTo>
                      <a:pt x="136" y="1153"/>
                    </a:lnTo>
                    <a:lnTo>
                      <a:pt x="141" y="1153"/>
                    </a:lnTo>
                    <a:lnTo>
                      <a:pt x="147" y="1153"/>
                    </a:lnTo>
                    <a:lnTo>
                      <a:pt x="153" y="1153"/>
                    </a:lnTo>
                    <a:lnTo>
                      <a:pt x="158" y="1153"/>
                    </a:lnTo>
                    <a:lnTo>
                      <a:pt x="164" y="1153"/>
                    </a:lnTo>
                    <a:lnTo>
                      <a:pt x="170" y="1153"/>
                    </a:lnTo>
                    <a:lnTo>
                      <a:pt x="175" y="1153"/>
                    </a:lnTo>
                    <a:lnTo>
                      <a:pt x="181" y="1153"/>
                    </a:lnTo>
                    <a:lnTo>
                      <a:pt x="187" y="1153"/>
                    </a:lnTo>
                    <a:lnTo>
                      <a:pt x="192" y="1153"/>
                    </a:lnTo>
                    <a:lnTo>
                      <a:pt x="198" y="1153"/>
                    </a:lnTo>
                    <a:lnTo>
                      <a:pt x="204" y="1153"/>
                    </a:lnTo>
                    <a:lnTo>
                      <a:pt x="209" y="1143"/>
                    </a:lnTo>
                    <a:lnTo>
                      <a:pt x="215" y="1153"/>
                    </a:lnTo>
                    <a:lnTo>
                      <a:pt x="221" y="1153"/>
                    </a:lnTo>
                    <a:lnTo>
                      <a:pt x="226" y="1153"/>
                    </a:lnTo>
                    <a:lnTo>
                      <a:pt x="232" y="1153"/>
                    </a:lnTo>
                    <a:lnTo>
                      <a:pt x="238" y="1153"/>
                    </a:lnTo>
                    <a:lnTo>
                      <a:pt x="243" y="1153"/>
                    </a:lnTo>
                    <a:lnTo>
                      <a:pt x="249" y="1153"/>
                    </a:lnTo>
                    <a:lnTo>
                      <a:pt x="255" y="1153"/>
                    </a:lnTo>
                    <a:lnTo>
                      <a:pt x="260" y="1153"/>
                    </a:lnTo>
                    <a:lnTo>
                      <a:pt x="266" y="1153"/>
                    </a:lnTo>
                    <a:lnTo>
                      <a:pt x="272" y="1153"/>
                    </a:lnTo>
                    <a:lnTo>
                      <a:pt x="277" y="1153"/>
                    </a:lnTo>
                    <a:lnTo>
                      <a:pt x="283" y="1153"/>
                    </a:lnTo>
                    <a:lnTo>
                      <a:pt x="289" y="1153"/>
                    </a:lnTo>
                    <a:lnTo>
                      <a:pt x="294" y="1153"/>
                    </a:lnTo>
                    <a:lnTo>
                      <a:pt x="300" y="1153"/>
                    </a:lnTo>
                    <a:lnTo>
                      <a:pt x="306" y="1153"/>
                    </a:lnTo>
                    <a:lnTo>
                      <a:pt x="311" y="1153"/>
                    </a:lnTo>
                    <a:lnTo>
                      <a:pt x="317" y="1153"/>
                    </a:lnTo>
                    <a:lnTo>
                      <a:pt x="323" y="1153"/>
                    </a:lnTo>
                    <a:lnTo>
                      <a:pt x="328" y="1153"/>
                    </a:lnTo>
                    <a:lnTo>
                      <a:pt x="334" y="1153"/>
                    </a:lnTo>
                    <a:lnTo>
                      <a:pt x="340" y="1153"/>
                    </a:lnTo>
                    <a:lnTo>
                      <a:pt x="345" y="1153"/>
                    </a:lnTo>
                    <a:lnTo>
                      <a:pt x="351" y="1143"/>
                    </a:lnTo>
                    <a:lnTo>
                      <a:pt x="357" y="1153"/>
                    </a:lnTo>
                    <a:lnTo>
                      <a:pt x="362" y="1143"/>
                    </a:lnTo>
                    <a:lnTo>
                      <a:pt x="368" y="1153"/>
                    </a:lnTo>
                    <a:lnTo>
                      <a:pt x="374" y="1153"/>
                    </a:lnTo>
                    <a:lnTo>
                      <a:pt x="379" y="1153"/>
                    </a:lnTo>
                    <a:lnTo>
                      <a:pt x="385" y="1153"/>
                    </a:lnTo>
                    <a:lnTo>
                      <a:pt x="391" y="1153"/>
                    </a:lnTo>
                    <a:lnTo>
                      <a:pt x="396" y="1153"/>
                    </a:lnTo>
                    <a:lnTo>
                      <a:pt x="402" y="1153"/>
                    </a:lnTo>
                    <a:lnTo>
                      <a:pt x="408" y="1153"/>
                    </a:lnTo>
                    <a:lnTo>
                      <a:pt x="413" y="1153"/>
                    </a:lnTo>
                    <a:lnTo>
                      <a:pt x="419" y="1143"/>
                    </a:lnTo>
                    <a:lnTo>
                      <a:pt x="425" y="1143"/>
                    </a:lnTo>
                    <a:lnTo>
                      <a:pt x="430" y="1153"/>
                    </a:lnTo>
                    <a:lnTo>
                      <a:pt x="436" y="1153"/>
                    </a:lnTo>
                    <a:lnTo>
                      <a:pt x="441" y="1143"/>
                    </a:lnTo>
                    <a:lnTo>
                      <a:pt x="447" y="1143"/>
                    </a:lnTo>
                    <a:lnTo>
                      <a:pt x="453" y="1153"/>
                    </a:lnTo>
                    <a:lnTo>
                      <a:pt x="458" y="1153"/>
                    </a:lnTo>
                    <a:lnTo>
                      <a:pt x="464" y="1153"/>
                    </a:lnTo>
                    <a:lnTo>
                      <a:pt x="470" y="1153"/>
                    </a:lnTo>
                    <a:lnTo>
                      <a:pt x="476" y="1153"/>
                    </a:lnTo>
                    <a:lnTo>
                      <a:pt x="481" y="1143"/>
                    </a:lnTo>
                    <a:lnTo>
                      <a:pt x="487" y="1153"/>
                    </a:lnTo>
                    <a:lnTo>
                      <a:pt x="493" y="1153"/>
                    </a:lnTo>
                    <a:lnTo>
                      <a:pt x="498" y="1153"/>
                    </a:lnTo>
                    <a:lnTo>
                      <a:pt x="504" y="1153"/>
                    </a:lnTo>
                    <a:lnTo>
                      <a:pt x="510" y="1143"/>
                    </a:lnTo>
                    <a:lnTo>
                      <a:pt x="515" y="1143"/>
                    </a:lnTo>
                    <a:lnTo>
                      <a:pt x="521" y="1124"/>
                    </a:lnTo>
                    <a:lnTo>
                      <a:pt x="527" y="1153"/>
                    </a:lnTo>
                    <a:lnTo>
                      <a:pt x="532" y="1143"/>
                    </a:lnTo>
                    <a:lnTo>
                      <a:pt x="538" y="1143"/>
                    </a:lnTo>
                    <a:lnTo>
                      <a:pt x="544" y="1134"/>
                    </a:lnTo>
                    <a:lnTo>
                      <a:pt x="549" y="1153"/>
                    </a:lnTo>
                    <a:lnTo>
                      <a:pt x="555" y="1134"/>
                    </a:lnTo>
                    <a:lnTo>
                      <a:pt x="561" y="1085"/>
                    </a:lnTo>
                    <a:lnTo>
                      <a:pt x="566" y="1143"/>
                    </a:lnTo>
                    <a:lnTo>
                      <a:pt x="572" y="1134"/>
                    </a:lnTo>
                    <a:lnTo>
                      <a:pt x="578" y="1143"/>
                    </a:lnTo>
                    <a:lnTo>
                      <a:pt x="583" y="1143"/>
                    </a:lnTo>
                    <a:lnTo>
                      <a:pt x="589" y="1114"/>
                    </a:lnTo>
                    <a:lnTo>
                      <a:pt x="595" y="1143"/>
                    </a:lnTo>
                    <a:lnTo>
                      <a:pt x="600" y="1143"/>
                    </a:lnTo>
                    <a:lnTo>
                      <a:pt x="606" y="1134"/>
                    </a:lnTo>
                    <a:lnTo>
                      <a:pt x="612" y="1124"/>
                    </a:lnTo>
                    <a:lnTo>
                      <a:pt x="617" y="1143"/>
                    </a:lnTo>
                    <a:lnTo>
                      <a:pt x="623" y="1124"/>
                    </a:lnTo>
                    <a:lnTo>
                      <a:pt x="629" y="1143"/>
                    </a:lnTo>
                    <a:lnTo>
                      <a:pt x="634" y="1153"/>
                    </a:lnTo>
                    <a:lnTo>
                      <a:pt x="640" y="1124"/>
                    </a:lnTo>
                    <a:lnTo>
                      <a:pt x="646" y="1114"/>
                    </a:lnTo>
                    <a:lnTo>
                      <a:pt x="651" y="1143"/>
                    </a:lnTo>
                    <a:lnTo>
                      <a:pt x="657" y="1105"/>
                    </a:lnTo>
                    <a:lnTo>
                      <a:pt x="663" y="1124"/>
                    </a:lnTo>
                    <a:lnTo>
                      <a:pt x="668" y="1134"/>
                    </a:lnTo>
                    <a:lnTo>
                      <a:pt x="674" y="1153"/>
                    </a:lnTo>
                    <a:lnTo>
                      <a:pt x="680" y="1095"/>
                    </a:lnTo>
                    <a:lnTo>
                      <a:pt x="685" y="1124"/>
                    </a:lnTo>
                    <a:lnTo>
                      <a:pt x="691" y="1124"/>
                    </a:lnTo>
                    <a:lnTo>
                      <a:pt x="696" y="1143"/>
                    </a:lnTo>
                    <a:lnTo>
                      <a:pt x="702" y="1143"/>
                    </a:lnTo>
                    <a:lnTo>
                      <a:pt x="708" y="1153"/>
                    </a:lnTo>
                    <a:lnTo>
                      <a:pt x="713" y="1143"/>
                    </a:lnTo>
                    <a:lnTo>
                      <a:pt x="719" y="1143"/>
                    </a:lnTo>
                    <a:lnTo>
                      <a:pt x="725" y="1134"/>
                    </a:lnTo>
                    <a:lnTo>
                      <a:pt x="730" y="1134"/>
                    </a:lnTo>
                    <a:lnTo>
                      <a:pt x="736" y="1143"/>
                    </a:lnTo>
                    <a:lnTo>
                      <a:pt x="742" y="1114"/>
                    </a:lnTo>
                    <a:lnTo>
                      <a:pt x="747" y="1124"/>
                    </a:lnTo>
                    <a:lnTo>
                      <a:pt x="753" y="1134"/>
                    </a:lnTo>
                    <a:lnTo>
                      <a:pt x="759" y="1153"/>
                    </a:lnTo>
                    <a:lnTo>
                      <a:pt x="764" y="1124"/>
                    </a:lnTo>
                    <a:lnTo>
                      <a:pt x="770" y="1134"/>
                    </a:lnTo>
                    <a:lnTo>
                      <a:pt x="776" y="1143"/>
                    </a:lnTo>
                    <a:lnTo>
                      <a:pt x="782" y="1114"/>
                    </a:lnTo>
                    <a:lnTo>
                      <a:pt x="787" y="1143"/>
                    </a:lnTo>
                    <a:lnTo>
                      <a:pt x="793" y="1153"/>
                    </a:lnTo>
                    <a:lnTo>
                      <a:pt x="799" y="1143"/>
                    </a:lnTo>
                    <a:lnTo>
                      <a:pt x="804" y="1114"/>
                    </a:lnTo>
                    <a:lnTo>
                      <a:pt x="810" y="1143"/>
                    </a:lnTo>
                    <a:lnTo>
                      <a:pt x="816" y="1143"/>
                    </a:lnTo>
                    <a:lnTo>
                      <a:pt x="821" y="1124"/>
                    </a:lnTo>
                    <a:lnTo>
                      <a:pt x="827" y="1153"/>
                    </a:lnTo>
                    <a:lnTo>
                      <a:pt x="833" y="1153"/>
                    </a:lnTo>
                    <a:lnTo>
                      <a:pt x="838" y="1124"/>
                    </a:lnTo>
                    <a:lnTo>
                      <a:pt x="844" y="1124"/>
                    </a:lnTo>
                    <a:lnTo>
                      <a:pt x="850" y="1153"/>
                    </a:lnTo>
                    <a:lnTo>
                      <a:pt x="855" y="1143"/>
                    </a:lnTo>
                    <a:lnTo>
                      <a:pt x="861" y="1114"/>
                    </a:lnTo>
                    <a:lnTo>
                      <a:pt x="867" y="1114"/>
                    </a:lnTo>
                    <a:lnTo>
                      <a:pt x="872" y="1134"/>
                    </a:lnTo>
                    <a:lnTo>
                      <a:pt x="878" y="1124"/>
                    </a:lnTo>
                    <a:lnTo>
                      <a:pt x="884" y="1143"/>
                    </a:lnTo>
                    <a:lnTo>
                      <a:pt x="889" y="1134"/>
                    </a:lnTo>
                    <a:lnTo>
                      <a:pt x="895" y="1143"/>
                    </a:lnTo>
                    <a:lnTo>
                      <a:pt x="901" y="1143"/>
                    </a:lnTo>
                    <a:lnTo>
                      <a:pt x="906" y="1124"/>
                    </a:lnTo>
                    <a:lnTo>
                      <a:pt x="912" y="1124"/>
                    </a:lnTo>
                    <a:lnTo>
                      <a:pt x="918" y="1143"/>
                    </a:lnTo>
                    <a:lnTo>
                      <a:pt x="923" y="1124"/>
                    </a:lnTo>
                    <a:lnTo>
                      <a:pt x="929" y="1105"/>
                    </a:lnTo>
                    <a:lnTo>
                      <a:pt x="935" y="1105"/>
                    </a:lnTo>
                    <a:lnTo>
                      <a:pt x="940" y="1143"/>
                    </a:lnTo>
                    <a:lnTo>
                      <a:pt x="946" y="1105"/>
                    </a:lnTo>
                    <a:lnTo>
                      <a:pt x="951" y="1134"/>
                    </a:lnTo>
                    <a:lnTo>
                      <a:pt x="957" y="1134"/>
                    </a:lnTo>
                    <a:lnTo>
                      <a:pt x="963" y="1134"/>
                    </a:lnTo>
                    <a:lnTo>
                      <a:pt x="968" y="1085"/>
                    </a:lnTo>
                    <a:lnTo>
                      <a:pt x="974" y="1124"/>
                    </a:lnTo>
                    <a:lnTo>
                      <a:pt x="980" y="1066"/>
                    </a:lnTo>
                    <a:lnTo>
                      <a:pt x="985" y="1095"/>
                    </a:lnTo>
                    <a:lnTo>
                      <a:pt x="991" y="1095"/>
                    </a:lnTo>
                    <a:lnTo>
                      <a:pt x="997" y="1076"/>
                    </a:lnTo>
                    <a:lnTo>
                      <a:pt x="1002" y="1085"/>
                    </a:lnTo>
                    <a:lnTo>
                      <a:pt x="1008" y="1143"/>
                    </a:lnTo>
                    <a:lnTo>
                      <a:pt x="1014" y="1047"/>
                    </a:lnTo>
                    <a:lnTo>
                      <a:pt x="1019" y="1085"/>
                    </a:lnTo>
                    <a:lnTo>
                      <a:pt x="1025" y="1076"/>
                    </a:lnTo>
                    <a:lnTo>
                      <a:pt x="1031" y="1056"/>
                    </a:lnTo>
                    <a:lnTo>
                      <a:pt x="1036" y="1076"/>
                    </a:lnTo>
                    <a:lnTo>
                      <a:pt x="1042" y="1076"/>
                    </a:lnTo>
                    <a:lnTo>
                      <a:pt x="1048" y="1027"/>
                    </a:lnTo>
                    <a:lnTo>
                      <a:pt x="1053" y="979"/>
                    </a:lnTo>
                    <a:lnTo>
                      <a:pt x="1059" y="1037"/>
                    </a:lnTo>
                    <a:lnTo>
                      <a:pt x="1065" y="1047"/>
                    </a:lnTo>
                    <a:lnTo>
                      <a:pt x="1070" y="1008"/>
                    </a:lnTo>
                    <a:lnTo>
                      <a:pt x="1076" y="1018"/>
                    </a:lnTo>
                    <a:lnTo>
                      <a:pt x="1082" y="1027"/>
                    </a:lnTo>
                    <a:lnTo>
                      <a:pt x="1088" y="912"/>
                    </a:lnTo>
                    <a:lnTo>
                      <a:pt x="1093" y="1018"/>
                    </a:lnTo>
                    <a:lnTo>
                      <a:pt x="1099" y="969"/>
                    </a:lnTo>
                    <a:lnTo>
                      <a:pt x="1105" y="950"/>
                    </a:lnTo>
                    <a:lnTo>
                      <a:pt x="1110" y="989"/>
                    </a:lnTo>
                    <a:lnTo>
                      <a:pt x="1116" y="989"/>
                    </a:lnTo>
                    <a:lnTo>
                      <a:pt x="1122" y="979"/>
                    </a:lnTo>
                    <a:lnTo>
                      <a:pt x="1127" y="940"/>
                    </a:lnTo>
                    <a:lnTo>
                      <a:pt x="1133" y="989"/>
                    </a:lnTo>
                    <a:lnTo>
                      <a:pt x="1139" y="931"/>
                    </a:lnTo>
                    <a:lnTo>
                      <a:pt x="1144" y="998"/>
                    </a:lnTo>
                    <a:lnTo>
                      <a:pt x="1150" y="989"/>
                    </a:lnTo>
                    <a:lnTo>
                      <a:pt x="1156" y="931"/>
                    </a:lnTo>
                    <a:lnTo>
                      <a:pt x="1161" y="834"/>
                    </a:lnTo>
                    <a:lnTo>
                      <a:pt x="1167" y="931"/>
                    </a:lnTo>
                    <a:lnTo>
                      <a:pt x="1173" y="873"/>
                    </a:lnTo>
                    <a:lnTo>
                      <a:pt x="1178" y="776"/>
                    </a:lnTo>
                    <a:lnTo>
                      <a:pt x="1184" y="912"/>
                    </a:lnTo>
                    <a:lnTo>
                      <a:pt x="1190" y="786"/>
                    </a:lnTo>
                    <a:lnTo>
                      <a:pt x="1195" y="815"/>
                    </a:lnTo>
                    <a:lnTo>
                      <a:pt x="1201" y="834"/>
                    </a:lnTo>
                    <a:lnTo>
                      <a:pt x="1206" y="805"/>
                    </a:lnTo>
                    <a:lnTo>
                      <a:pt x="1212" y="709"/>
                    </a:lnTo>
                    <a:lnTo>
                      <a:pt x="1218" y="738"/>
                    </a:lnTo>
                    <a:lnTo>
                      <a:pt x="1223" y="699"/>
                    </a:lnTo>
                    <a:lnTo>
                      <a:pt x="1229" y="709"/>
                    </a:lnTo>
                    <a:lnTo>
                      <a:pt x="1235" y="718"/>
                    </a:lnTo>
                    <a:lnTo>
                      <a:pt x="1240" y="805"/>
                    </a:lnTo>
                    <a:lnTo>
                      <a:pt x="1246" y="554"/>
                    </a:lnTo>
                    <a:lnTo>
                      <a:pt x="1252" y="709"/>
                    </a:lnTo>
                    <a:lnTo>
                      <a:pt x="1257" y="718"/>
                    </a:lnTo>
                    <a:lnTo>
                      <a:pt x="1263" y="506"/>
                    </a:lnTo>
                    <a:lnTo>
                      <a:pt x="1269" y="593"/>
                    </a:lnTo>
                    <a:lnTo>
                      <a:pt x="1274" y="554"/>
                    </a:lnTo>
                    <a:lnTo>
                      <a:pt x="1280" y="458"/>
                    </a:lnTo>
                    <a:lnTo>
                      <a:pt x="1286" y="458"/>
                    </a:lnTo>
                    <a:lnTo>
                      <a:pt x="1291" y="409"/>
                    </a:lnTo>
                    <a:lnTo>
                      <a:pt x="1297" y="487"/>
                    </a:lnTo>
                    <a:lnTo>
                      <a:pt x="1303" y="477"/>
                    </a:lnTo>
                    <a:lnTo>
                      <a:pt x="1308" y="448"/>
                    </a:lnTo>
                    <a:lnTo>
                      <a:pt x="1314" y="525"/>
                    </a:lnTo>
                    <a:lnTo>
                      <a:pt x="1320" y="380"/>
                    </a:lnTo>
                    <a:lnTo>
                      <a:pt x="1325" y="583"/>
                    </a:lnTo>
                    <a:lnTo>
                      <a:pt x="1331" y="583"/>
                    </a:lnTo>
                    <a:lnTo>
                      <a:pt x="1337" y="506"/>
                    </a:lnTo>
                    <a:lnTo>
                      <a:pt x="1342" y="574"/>
                    </a:lnTo>
                    <a:lnTo>
                      <a:pt x="1348" y="467"/>
                    </a:lnTo>
                    <a:lnTo>
                      <a:pt x="1354" y="390"/>
                    </a:lnTo>
                    <a:lnTo>
                      <a:pt x="1359" y="545"/>
                    </a:lnTo>
                    <a:lnTo>
                      <a:pt x="1365" y="680"/>
                    </a:lnTo>
                    <a:lnTo>
                      <a:pt x="1371" y="506"/>
                    </a:lnTo>
                    <a:lnTo>
                      <a:pt x="1376" y="641"/>
                    </a:lnTo>
                    <a:lnTo>
                      <a:pt x="1382" y="554"/>
                    </a:lnTo>
                    <a:lnTo>
                      <a:pt x="1388" y="689"/>
                    </a:lnTo>
                    <a:lnTo>
                      <a:pt x="1393" y="612"/>
                    </a:lnTo>
                    <a:lnTo>
                      <a:pt x="1399" y="660"/>
                    </a:lnTo>
                    <a:lnTo>
                      <a:pt x="1405" y="612"/>
                    </a:lnTo>
                    <a:lnTo>
                      <a:pt x="1411" y="535"/>
                    </a:lnTo>
                    <a:lnTo>
                      <a:pt x="1416" y="400"/>
                    </a:lnTo>
                    <a:lnTo>
                      <a:pt x="1422" y="0"/>
                    </a:lnTo>
                    <a:lnTo>
                      <a:pt x="1428" y="429"/>
                    </a:lnTo>
                    <a:lnTo>
                      <a:pt x="1433" y="1018"/>
                    </a:lnTo>
                    <a:lnTo>
                      <a:pt x="1439" y="989"/>
                    </a:lnTo>
                    <a:lnTo>
                      <a:pt x="1445" y="1095"/>
                    </a:lnTo>
                    <a:lnTo>
                      <a:pt x="1450" y="1153"/>
                    </a:lnTo>
                    <a:lnTo>
                      <a:pt x="0" y="1153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16" name="Rectangle 148"/>
              <p:cNvSpPr>
                <a:spLocks noChangeArrowheads="1"/>
              </p:cNvSpPr>
              <p:nvPr/>
            </p:nvSpPr>
            <p:spPr bwMode="auto">
              <a:xfrm>
                <a:off x="6475413" y="4702175"/>
                <a:ext cx="2301875" cy="1839913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sp>
          <p:nvSpPr>
            <p:cNvPr id="205" name="Tekstvak 204"/>
            <p:cNvSpPr txBox="1"/>
            <p:nvPr/>
          </p:nvSpPr>
          <p:spPr>
            <a:xfrm>
              <a:off x="834360" y="2178191"/>
              <a:ext cx="110501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600" b="1" dirty="0" err="1" smtClean="0"/>
                <a:t>Control</a:t>
              </a:r>
              <a:endParaRPr lang="nl-NL" sz="1600" b="1" dirty="0"/>
            </a:p>
          </p:txBody>
        </p:sp>
        <p:cxnSp>
          <p:nvCxnSpPr>
            <p:cNvPr id="207" name="Rechte verbindingslijn met pijl 206"/>
            <p:cNvCxnSpPr/>
            <p:nvPr/>
          </p:nvCxnSpPr>
          <p:spPr>
            <a:xfrm>
              <a:off x="3131840" y="1512243"/>
              <a:ext cx="46526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Rechte verbindingslijn met pijl 207"/>
            <p:cNvCxnSpPr/>
            <p:nvPr/>
          </p:nvCxnSpPr>
          <p:spPr>
            <a:xfrm>
              <a:off x="3131840" y="3168427"/>
              <a:ext cx="46526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0" name="Tekstvak 409"/>
            <p:cNvSpPr txBox="1"/>
            <p:nvPr/>
          </p:nvSpPr>
          <p:spPr>
            <a:xfrm>
              <a:off x="3781060" y="679038"/>
              <a:ext cx="2733445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F4/80-low</a:t>
              </a:r>
              <a:endParaRPr lang="nl-NL" sz="1200" b="1" dirty="0"/>
            </a:p>
          </p:txBody>
        </p:sp>
        <p:sp>
          <p:nvSpPr>
            <p:cNvPr id="411" name="Tekstvak 410"/>
            <p:cNvSpPr txBox="1"/>
            <p:nvPr/>
          </p:nvSpPr>
          <p:spPr>
            <a:xfrm>
              <a:off x="3773070" y="2308903"/>
              <a:ext cx="2733445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F4/80-high</a:t>
              </a:r>
              <a:endParaRPr lang="nl-NL" sz="1200" b="1" dirty="0"/>
            </a:p>
          </p:txBody>
        </p:sp>
        <p:sp>
          <p:nvSpPr>
            <p:cNvPr id="412" name="Tekstvak 411"/>
            <p:cNvSpPr txBox="1"/>
            <p:nvPr/>
          </p:nvSpPr>
          <p:spPr>
            <a:xfrm>
              <a:off x="2188886" y="3737571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4/80</a:t>
              </a:r>
              <a:endParaRPr lang="nl-NL" sz="1200" b="1" dirty="0"/>
            </a:p>
          </p:txBody>
        </p:sp>
        <p:cxnSp>
          <p:nvCxnSpPr>
            <p:cNvPr id="413" name="Rechte verbindingslijn met pijl 412"/>
            <p:cNvCxnSpPr/>
            <p:nvPr/>
          </p:nvCxnSpPr>
          <p:spPr>
            <a:xfrm>
              <a:off x="1935720" y="3777360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4" name="Tekstvak 413"/>
            <p:cNvSpPr txBox="1"/>
            <p:nvPr/>
          </p:nvSpPr>
          <p:spPr>
            <a:xfrm>
              <a:off x="4058315" y="3733784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</a:t>
              </a:r>
            </a:p>
          </p:txBody>
        </p:sp>
        <p:cxnSp>
          <p:nvCxnSpPr>
            <p:cNvPr id="415" name="Rechte verbindingslijn met pijl 414"/>
            <p:cNvCxnSpPr/>
            <p:nvPr/>
          </p:nvCxnSpPr>
          <p:spPr>
            <a:xfrm>
              <a:off x="3673221" y="3781431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6" name="Rechte verbindingslijn met pijl 415"/>
            <p:cNvCxnSpPr/>
            <p:nvPr/>
          </p:nvCxnSpPr>
          <p:spPr>
            <a:xfrm>
              <a:off x="5156614" y="3781932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7" name="Tekstvak 416"/>
            <p:cNvSpPr txBox="1"/>
            <p:nvPr/>
          </p:nvSpPr>
          <p:spPr>
            <a:xfrm>
              <a:off x="5369838" y="3728136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I/III</a:t>
              </a:r>
            </a:p>
          </p:txBody>
        </p:sp>
        <p:grpSp>
          <p:nvGrpSpPr>
            <p:cNvPr id="247" name="Groep 246"/>
            <p:cNvGrpSpPr/>
            <p:nvPr/>
          </p:nvGrpSpPr>
          <p:grpSpPr>
            <a:xfrm>
              <a:off x="1867199" y="5940299"/>
              <a:ext cx="1163039" cy="1191023"/>
              <a:chOff x="1074738" y="6502400"/>
              <a:chExt cx="2074862" cy="1992313"/>
            </a:xfrm>
          </p:grpSpPr>
          <p:sp>
            <p:nvSpPr>
              <p:cNvPr id="58548" name="Freeform 180"/>
              <p:cNvSpPr>
                <a:spLocks/>
              </p:cNvSpPr>
              <p:nvPr/>
            </p:nvSpPr>
            <p:spPr bwMode="auto">
              <a:xfrm>
                <a:off x="1074738" y="7165975"/>
                <a:ext cx="2074862" cy="1328738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37"/>
                  </a:cxn>
                  <a:cxn ang="0">
                    <a:pos x="92" y="825"/>
                  </a:cxn>
                  <a:cxn ang="0">
                    <a:pos x="117" y="837"/>
                  </a:cxn>
                  <a:cxn ang="0">
                    <a:pos x="143" y="825"/>
                  </a:cxn>
                  <a:cxn ang="0">
                    <a:pos x="168" y="837"/>
                  </a:cxn>
                  <a:cxn ang="0">
                    <a:pos x="194" y="825"/>
                  </a:cxn>
                  <a:cxn ang="0">
                    <a:pos x="219" y="825"/>
                  </a:cxn>
                  <a:cxn ang="0">
                    <a:pos x="245" y="825"/>
                  </a:cxn>
                  <a:cxn ang="0">
                    <a:pos x="270" y="753"/>
                  </a:cxn>
                  <a:cxn ang="0">
                    <a:pos x="296" y="765"/>
                  </a:cxn>
                  <a:cxn ang="0">
                    <a:pos x="321" y="693"/>
                  </a:cxn>
                  <a:cxn ang="0">
                    <a:pos x="347" y="753"/>
                  </a:cxn>
                  <a:cxn ang="0">
                    <a:pos x="372" y="693"/>
                  </a:cxn>
                  <a:cxn ang="0">
                    <a:pos x="398" y="705"/>
                  </a:cxn>
                  <a:cxn ang="0">
                    <a:pos x="424" y="670"/>
                  </a:cxn>
                  <a:cxn ang="0">
                    <a:pos x="449" y="574"/>
                  </a:cxn>
                  <a:cxn ang="0">
                    <a:pos x="475" y="646"/>
                  </a:cxn>
                  <a:cxn ang="0">
                    <a:pos x="500" y="717"/>
                  </a:cxn>
                  <a:cxn ang="0">
                    <a:pos x="526" y="693"/>
                  </a:cxn>
                  <a:cxn ang="0">
                    <a:pos x="551" y="693"/>
                  </a:cxn>
                  <a:cxn ang="0">
                    <a:pos x="577" y="681"/>
                  </a:cxn>
                  <a:cxn ang="0">
                    <a:pos x="602" y="634"/>
                  </a:cxn>
                  <a:cxn ang="0">
                    <a:pos x="628" y="729"/>
                  </a:cxn>
                  <a:cxn ang="0">
                    <a:pos x="653" y="598"/>
                  </a:cxn>
                  <a:cxn ang="0">
                    <a:pos x="679" y="693"/>
                  </a:cxn>
                  <a:cxn ang="0">
                    <a:pos x="704" y="658"/>
                  </a:cxn>
                  <a:cxn ang="0">
                    <a:pos x="730" y="538"/>
                  </a:cxn>
                  <a:cxn ang="0">
                    <a:pos x="755" y="526"/>
                  </a:cxn>
                  <a:cxn ang="0">
                    <a:pos x="781" y="526"/>
                  </a:cxn>
                  <a:cxn ang="0">
                    <a:pos x="807" y="431"/>
                  </a:cxn>
                  <a:cxn ang="0">
                    <a:pos x="832" y="490"/>
                  </a:cxn>
                  <a:cxn ang="0">
                    <a:pos x="858" y="335"/>
                  </a:cxn>
                  <a:cxn ang="0">
                    <a:pos x="883" y="251"/>
                  </a:cxn>
                  <a:cxn ang="0">
                    <a:pos x="909" y="227"/>
                  </a:cxn>
                  <a:cxn ang="0">
                    <a:pos x="934" y="180"/>
                  </a:cxn>
                  <a:cxn ang="0">
                    <a:pos x="960" y="227"/>
                  </a:cxn>
                  <a:cxn ang="0">
                    <a:pos x="985" y="132"/>
                  </a:cxn>
                  <a:cxn ang="0">
                    <a:pos x="1011" y="0"/>
                  </a:cxn>
                  <a:cxn ang="0">
                    <a:pos x="1036" y="287"/>
                  </a:cxn>
                  <a:cxn ang="0">
                    <a:pos x="1062" y="216"/>
                  </a:cxn>
                  <a:cxn ang="0">
                    <a:pos x="1087" y="502"/>
                  </a:cxn>
                  <a:cxn ang="0">
                    <a:pos x="1113" y="550"/>
                  </a:cxn>
                  <a:cxn ang="0">
                    <a:pos x="1139" y="693"/>
                  </a:cxn>
                  <a:cxn ang="0">
                    <a:pos x="1164" y="789"/>
                  </a:cxn>
                  <a:cxn ang="0">
                    <a:pos x="1189" y="837"/>
                  </a:cxn>
                  <a:cxn ang="0">
                    <a:pos x="1215" y="837"/>
                  </a:cxn>
                  <a:cxn ang="0">
                    <a:pos x="1240" y="837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3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37"/>
                    </a:lnTo>
                    <a:lnTo>
                      <a:pt x="71" y="837"/>
                    </a:lnTo>
                    <a:lnTo>
                      <a:pt x="76" y="837"/>
                    </a:lnTo>
                    <a:lnTo>
                      <a:pt x="82" y="825"/>
                    </a:lnTo>
                    <a:lnTo>
                      <a:pt x="87" y="837"/>
                    </a:lnTo>
                    <a:lnTo>
                      <a:pt x="92" y="825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25"/>
                    </a:lnTo>
                    <a:lnTo>
                      <a:pt x="117" y="837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37"/>
                    </a:lnTo>
                    <a:lnTo>
                      <a:pt x="158" y="837"/>
                    </a:lnTo>
                    <a:lnTo>
                      <a:pt x="163" y="825"/>
                    </a:lnTo>
                    <a:lnTo>
                      <a:pt x="168" y="837"/>
                    </a:lnTo>
                    <a:lnTo>
                      <a:pt x="173" y="825"/>
                    </a:lnTo>
                    <a:lnTo>
                      <a:pt x="179" y="825"/>
                    </a:lnTo>
                    <a:lnTo>
                      <a:pt x="184" y="825"/>
                    </a:lnTo>
                    <a:lnTo>
                      <a:pt x="189" y="825"/>
                    </a:lnTo>
                    <a:lnTo>
                      <a:pt x="194" y="825"/>
                    </a:lnTo>
                    <a:lnTo>
                      <a:pt x="199" y="825"/>
                    </a:lnTo>
                    <a:lnTo>
                      <a:pt x="204" y="813"/>
                    </a:lnTo>
                    <a:lnTo>
                      <a:pt x="209" y="801"/>
                    </a:lnTo>
                    <a:lnTo>
                      <a:pt x="214" y="825"/>
                    </a:lnTo>
                    <a:lnTo>
                      <a:pt x="219" y="825"/>
                    </a:lnTo>
                    <a:lnTo>
                      <a:pt x="224" y="825"/>
                    </a:lnTo>
                    <a:lnTo>
                      <a:pt x="230" y="825"/>
                    </a:lnTo>
                    <a:lnTo>
                      <a:pt x="235" y="813"/>
                    </a:lnTo>
                    <a:lnTo>
                      <a:pt x="240" y="789"/>
                    </a:lnTo>
                    <a:lnTo>
                      <a:pt x="245" y="825"/>
                    </a:lnTo>
                    <a:lnTo>
                      <a:pt x="250" y="777"/>
                    </a:lnTo>
                    <a:lnTo>
                      <a:pt x="255" y="753"/>
                    </a:lnTo>
                    <a:lnTo>
                      <a:pt x="260" y="825"/>
                    </a:lnTo>
                    <a:lnTo>
                      <a:pt x="265" y="765"/>
                    </a:lnTo>
                    <a:lnTo>
                      <a:pt x="270" y="753"/>
                    </a:lnTo>
                    <a:lnTo>
                      <a:pt x="275" y="777"/>
                    </a:lnTo>
                    <a:lnTo>
                      <a:pt x="281" y="753"/>
                    </a:lnTo>
                    <a:lnTo>
                      <a:pt x="286" y="801"/>
                    </a:lnTo>
                    <a:lnTo>
                      <a:pt x="291" y="813"/>
                    </a:lnTo>
                    <a:lnTo>
                      <a:pt x="296" y="765"/>
                    </a:lnTo>
                    <a:lnTo>
                      <a:pt x="301" y="705"/>
                    </a:lnTo>
                    <a:lnTo>
                      <a:pt x="306" y="813"/>
                    </a:lnTo>
                    <a:lnTo>
                      <a:pt x="311" y="777"/>
                    </a:lnTo>
                    <a:lnTo>
                      <a:pt x="316" y="765"/>
                    </a:lnTo>
                    <a:lnTo>
                      <a:pt x="321" y="693"/>
                    </a:lnTo>
                    <a:lnTo>
                      <a:pt x="327" y="729"/>
                    </a:lnTo>
                    <a:lnTo>
                      <a:pt x="332" y="765"/>
                    </a:lnTo>
                    <a:lnTo>
                      <a:pt x="337" y="717"/>
                    </a:lnTo>
                    <a:lnTo>
                      <a:pt x="342" y="777"/>
                    </a:lnTo>
                    <a:lnTo>
                      <a:pt x="347" y="753"/>
                    </a:lnTo>
                    <a:lnTo>
                      <a:pt x="352" y="705"/>
                    </a:lnTo>
                    <a:lnTo>
                      <a:pt x="357" y="717"/>
                    </a:lnTo>
                    <a:lnTo>
                      <a:pt x="362" y="705"/>
                    </a:lnTo>
                    <a:lnTo>
                      <a:pt x="367" y="646"/>
                    </a:lnTo>
                    <a:lnTo>
                      <a:pt x="372" y="693"/>
                    </a:lnTo>
                    <a:lnTo>
                      <a:pt x="378" y="753"/>
                    </a:lnTo>
                    <a:lnTo>
                      <a:pt x="383" y="741"/>
                    </a:lnTo>
                    <a:lnTo>
                      <a:pt x="388" y="634"/>
                    </a:lnTo>
                    <a:lnTo>
                      <a:pt x="393" y="693"/>
                    </a:lnTo>
                    <a:lnTo>
                      <a:pt x="398" y="705"/>
                    </a:lnTo>
                    <a:lnTo>
                      <a:pt x="403" y="670"/>
                    </a:lnTo>
                    <a:lnTo>
                      <a:pt x="408" y="693"/>
                    </a:lnTo>
                    <a:lnTo>
                      <a:pt x="413" y="670"/>
                    </a:lnTo>
                    <a:lnTo>
                      <a:pt x="419" y="646"/>
                    </a:lnTo>
                    <a:lnTo>
                      <a:pt x="424" y="670"/>
                    </a:lnTo>
                    <a:lnTo>
                      <a:pt x="429" y="634"/>
                    </a:lnTo>
                    <a:lnTo>
                      <a:pt x="434" y="622"/>
                    </a:lnTo>
                    <a:lnTo>
                      <a:pt x="439" y="765"/>
                    </a:lnTo>
                    <a:lnTo>
                      <a:pt x="444" y="717"/>
                    </a:lnTo>
                    <a:lnTo>
                      <a:pt x="449" y="574"/>
                    </a:lnTo>
                    <a:lnTo>
                      <a:pt x="454" y="681"/>
                    </a:lnTo>
                    <a:lnTo>
                      <a:pt x="459" y="729"/>
                    </a:lnTo>
                    <a:lnTo>
                      <a:pt x="464" y="610"/>
                    </a:lnTo>
                    <a:lnTo>
                      <a:pt x="470" y="646"/>
                    </a:lnTo>
                    <a:lnTo>
                      <a:pt x="475" y="646"/>
                    </a:lnTo>
                    <a:lnTo>
                      <a:pt x="480" y="693"/>
                    </a:lnTo>
                    <a:lnTo>
                      <a:pt x="485" y="693"/>
                    </a:lnTo>
                    <a:lnTo>
                      <a:pt x="490" y="658"/>
                    </a:lnTo>
                    <a:lnTo>
                      <a:pt x="495" y="729"/>
                    </a:lnTo>
                    <a:lnTo>
                      <a:pt x="500" y="717"/>
                    </a:lnTo>
                    <a:lnTo>
                      <a:pt x="505" y="646"/>
                    </a:lnTo>
                    <a:lnTo>
                      <a:pt x="510" y="681"/>
                    </a:lnTo>
                    <a:lnTo>
                      <a:pt x="515" y="705"/>
                    </a:lnTo>
                    <a:lnTo>
                      <a:pt x="521" y="658"/>
                    </a:lnTo>
                    <a:lnTo>
                      <a:pt x="526" y="693"/>
                    </a:lnTo>
                    <a:lnTo>
                      <a:pt x="531" y="681"/>
                    </a:lnTo>
                    <a:lnTo>
                      <a:pt x="536" y="693"/>
                    </a:lnTo>
                    <a:lnTo>
                      <a:pt x="541" y="634"/>
                    </a:lnTo>
                    <a:lnTo>
                      <a:pt x="546" y="729"/>
                    </a:lnTo>
                    <a:lnTo>
                      <a:pt x="551" y="693"/>
                    </a:lnTo>
                    <a:lnTo>
                      <a:pt x="556" y="670"/>
                    </a:lnTo>
                    <a:lnTo>
                      <a:pt x="561" y="717"/>
                    </a:lnTo>
                    <a:lnTo>
                      <a:pt x="567" y="777"/>
                    </a:lnTo>
                    <a:lnTo>
                      <a:pt x="572" y="693"/>
                    </a:lnTo>
                    <a:lnTo>
                      <a:pt x="577" y="681"/>
                    </a:lnTo>
                    <a:lnTo>
                      <a:pt x="582" y="717"/>
                    </a:lnTo>
                    <a:lnTo>
                      <a:pt x="587" y="658"/>
                    </a:lnTo>
                    <a:lnTo>
                      <a:pt x="592" y="681"/>
                    </a:lnTo>
                    <a:lnTo>
                      <a:pt x="597" y="753"/>
                    </a:lnTo>
                    <a:lnTo>
                      <a:pt x="602" y="634"/>
                    </a:lnTo>
                    <a:lnTo>
                      <a:pt x="607" y="598"/>
                    </a:lnTo>
                    <a:lnTo>
                      <a:pt x="612" y="693"/>
                    </a:lnTo>
                    <a:lnTo>
                      <a:pt x="618" y="646"/>
                    </a:lnTo>
                    <a:lnTo>
                      <a:pt x="623" y="729"/>
                    </a:lnTo>
                    <a:lnTo>
                      <a:pt x="628" y="729"/>
                    </a:lnTo>
                    <a:lnTo>
                      <a:pt x="633" y="681"/>
                    </a:lnTo>
                    <a:lnTo>
                      <a:pt x="638" y="681"/>
                    </a:lnTo>
                    <a:lnTo>
                      <a:pt x="643" y="634"/>
                    </a:lnTo>
                    <a:lnTo>
                      <a:pt x="648" y="729"/>
                    </a:lnTo>
                    <a:lnTo>
                      <a:pt x="653" y="598"/>
                    </a:lnTo>
                    <a:lnTo>
                      <a:pt x="659" y="634"/>
                    </a:lnTo>
                    <a:lnTo>
                      <a:pt x="664" y="538"/>
                    </a:lnTo>
                    <a:lnTo>
                      <a:pt x="669" y="729"/>
                    </a:lnTo>
                    <a:lnTo>
                      <a:pt x="674" y="670"/>
                    </a:lnTo>
                    <a:lnTo>
                      <a:pt x="679" y="693"/>
                    </a:lnTo>
                    <a:lnTo>
                      <a:pt x="684" y="646"/>
                    </a:lnTo>
                    <a:lnTo>
                      <a:pt x="689" y="741"/>
                    </a:lnTo>
                    <a:lnTo>
                      <a:pt x="694" y="622"/>
                    </a:lnTo>
                    <a:lnTo>
                      <a:pt x="699" y="622"/>
                    </a:lnTo>
                    <a:lnTo>
                      <a:pt x="704" y="658"/>
                    </a:lnTo>
                    <a:lnTo>
                      <a:pt x="710" y="598"/>
                    </a:lnTo>
                    <a:lnTo>
                      <a:pt x="715" y="538"/>
                    </a:lnTo>
                    <a:lnTo>
                      <a:pt x="720" y="574"/>
                    </a:lnTo>
                    <a:lnTo>
                      <a:pt x="725" y="586"/>
                    </a:lnTo>
                    <a:lnTo>
                      <a:pt x="730" y="538"/>
                    </a:lnTo>
                    <a:lnTo>
                      <a:pt x="735" y="490"/>
                    </a:lnTo>
                    <a:lnTo>
                      <a:pt x="740" y="550"/>
                    </a:lnTo>
                    <a:lnTo>
                      <a:pt x="745" y="610"/>
                    </a:lnTo>
                    <a:lnTo>
                      <a:pt x="750" y="634"/>
                    </a:lnTo>
                    <a:lnTo>
                      <a:pt x="755" y="526"/>
                    </a:lnTo>
                    <a:lnTo>
                      <a:pt x="761" y="574"/>
                    </a:lnTo>
                    <a:lnTo>
                      <a:pt x="766" y="610"/>
                    </a:lnTo>
                    <a:lnTo>
                      <a:pt x="771" y="466"/>
                    </a:lnTo>
                    <a:lnTo>
                      <a:pt x="776" y="443"/>
                    </a:lnTo>
                    <a:lnTo>
                      <a:pt x="781" y="526"/>
                    </a:lnTo>
                    <a:lnTo>
                      <a:pt x="786" y="526"/>
                    </a:lnTo>
                    <a:lnTo>
                      <a:pt x="791" y="419"/>
                    </a:lnTo>
                    <a:lnTo>
                      <a:pt x="796" y="478"/>
                    </a:lnTo>
                    <a:lnTo>
                      <a:pt x="801" y="478"/>
                    </a:lnTo>
                    <a:lnTo>
                      <a:pt x="807" y="431"/>
                    </a:lnTo>
                    <a:lnTo>
                      <a:pt x="812" y="490"/>
                    </a:lnTo>
                    <a:lnTo>
                      <a:pt x="817" y="502"/>
                    </a:lnTo>
                    <a:lnTo>
                      <a:pt x="822" y="502"/>
                    </a:lnTo>
                    <a:lnTo>
                      <a:pt x="827" y="383"/>
                    </a:lnTo>
                    <a:lnTo>
                      <a:pt x="832" y="490"/>
                    </a:lnTo>
                    <a:lnTo>
                      <a:pt x="837" y="216"/>
                    </a:lnTo>
                    <a:lnTo>
                      <a:pt x="842" y="454"/>
                    </a:lnTo>
                    <a:lnTo>
                      <a:pt x="847" y="347"/>
                    </a:lnTo>
                    <a:lnTo>
                      <a:pt x="852" y="443"/>
                    </a:lnTo>
                    <a:lnTo>
                      <a:pt x="858" y="335"/>
                    </a:lnTo>
                    <a:lnTo>
                      <a:pt x="863" y="323"/>
                    </a:lnTo>
                    <a:lnTo>
                      <a:pt x="868" y="24"/>
                    </a:lnTo>
                    <a:lnTo>
                      <a:pt x="873" y="383"/>
                    </a:lnTo>
                    <a:lnTo>
                      <a:pt x="878" y="323"/>
                    </a:lnTo>
                    <a:lnTo>
                      <a:pt x="883" y="251"/>
                    </a:lnTo>
                    <a:lnTo>
                      <a:pt x="888" y="108"/>
                    </a:lnTo>
                    <a:lnTo>
                      <a:pt x="893" y="251"/>
                    </a:lnTo>
                    <a:lnTo>
                      <a:pt x="899" y="263"/>
                    </a:lnTo>
                    <a:lnTo>
                      <a:pt x="904" y="287"/>
                    </a:lnTo>
                    <a:lnTo>
                      <a:pt x="909" y="227"/>
                    </a:lnTo>
                    <a:lnTo>
                      <a:pt x="914" y="180"/>
                    </a:lnTo>
                    <a:lnTo>
                      <a:pt x="919" y="120"/>
                    </a:lnTo>
                    <a:lnTo>
                      <a:pt x="924" y="108"/>
                    </a:lnTo>
                    <a:lnTo>
                      <a:pt x="929" y="72"/>
                    </a:lnTo>
                    <a:lnTo>
                      <a:pt x="934" y="180"/>
                    </a:lnTo>
                    <a:lnTo>
                      <a:pt x="939" y="84"/>
                    </a:lnTo>
                    <a:lnTo>
                      <a:pt x="944" y="168"/>
                    </a:lnTo>
                    <a:lnTo>
                      <a:pt x="950" y="72"/>
                    </a:lnTo>
                    <a:lnTo>
                      <a:pt x="955" y="120"/>
                    </a:lnTo>
                    <a:lnTo>
                      <a:pt x="960" y="227"/>
                    </a:lnTo>
                    <a:lnTo>
                      <a:pt x="965" y="84"/>
                    </a:lnTo>
                    <a:lnTo>
                      <a:pt x="970" y="168"/>
                    </a:lnTo>
                    <a:lnTo>
                      <a:pt x="975" y="36"/>
                    </a:lnTo>
                    <a:lnTo>
                      <a:pt x="980" y="144"/>
                    </a:lnTo>
                    <a:lnTo>
                      <a:pt x="985" y="132"/>
                    </a:lnTo>
                    <a:lnTo>
                      <a:pt x="990" y="60"/>
                    </a:lnTo>
                    <a:lnTo>
                      <a:pt x="995" y="168"/>
                    </a:lnTo>
                    <a:lnTo>
                      <a:pt x="1000" y="120"/>
                    </a:lnTo>
                    <a:lnTo>
                      <a:pt x="1006" y="192"/>
                    </a:lnTo>
                    <a:lnTo>
                      <a:pt x="1011" y="0"/>
                    </a:lnTo>
                    <a:lnTo>
                      <a:pt x="1016" y="132"/>
                    </a:lnTo>
                    <a:lnTo>
                      <a:pt x="1021" y="287"/>
                    </a:lnTo>
                    <a:lnTo>
                      <a:pt x="1026" y="144"/>
                    </a:lnTo>
                    <a:lnTo>
                      <a:pt x="1031" y="263"/>
                    </a:lnTo>
                    <a:lnTo>
                      <a:pt x="1036" y="287"/>
                    </a:lnTo>
                    <a:lnTo>
                      <a:pt x="1041" y="311"/>
                    </a:lnTo>
                    <a:lnTo>
                      <a:pt x="1047" y="335"/>
                    </a:lnTo>
                    <a:lnTo>
                      <a:pt x="1052" y="275"/>
                    </a:lnTo>
                    <a:lnTo>
                      <a:pt x="1057" y="359"/>
                    </a:lnTo>
                    <a:lnTo>
                      <a:pt x="1062" y="216"/>
                    </a:lnTo>
                    <a:lnTo>
                      <a:pt x="1067" y="478"/>
                    </a:lnTo>
                    <a:lnTo>
                      <a:pt x="1072" y="383"/>
                    </a:lnTo>
                    <a:lnTo>
                      <a:pt x="1077" y="419"/>
                    </a:lnTo>
                    <a:lnTo>
                      <a:pt x="1082" y="419"/>
                    </a:lnTo>
                    <a:lnTo>
                      <a:pt x="1087" y="502"/>
                    </a:lnTo>
                    <a:lnTo>
                      <a:pt x="1092" y="574"/>
                    </a:lnTo>
                    <a:lnTo>
                      <a:pt x="1098" y="634"/>
                    </a:lnTo>
                    <a:lnTo>
                      <a:pt x="1103" y="538"/>
                    </a:lnTo>
                    <a:lnTo>
                      <a:pt x="1108" y="526"/>
                    </a:lnTo>
                    <a:lnTo>
                      <a:pt x="1113" y="550"/>
                    </a:lnTo>
                    <a:lnTo>
                      <a:pt x="1118" y="622"/>
                    </a:lnTo>
                    <a:lnTo>
                      <a:pt x="1123" y="610"/>
                    </a:lnTo>
                    <a:lnTo>
                      <a:pt x="1128" y="634"/>
                    </a:lnTo>
                    <a:lnTo>
                      <a:pt x="1133" y="658"/>
                    </a:lnTo>
                    <a:lnTo>
                      <a:pt x="1139" y="693"/>
                    </a:lnTo>
                    <a:lnTo>
                      <a:pt x="1144" y="777"/>
                    </a:lnTo>
                    <a:lnTo>
                      <a:pt x="1149" y="753"/>
                    </a:lnTo>
                    <a:lnTo>
                      <a:pt x="1154" y="777"/>
                    </a:lnTo>
                    <a:lnTo>
                      <a:pt x="1159" y="753"/>
                    </a:lnTo>
                    <a:lnTo>
                      <a:pt x="1164" y="789"/>
                    </a:lnTo>
                    <a:lnTo>
                      <a:pt x="1169" y="777"/>
                    </a:lnTo>
                    <a:lnTo>
                      <a:pt x="1174" y="813"/>
                    </a:lnTo>
                    <a:lnTo>
                      <a:pt x="1179" y="789"/>
                    </a:lnTo>
                    <a:lnTo>
                      <a:pt x="1184" y="825"/>
                    </a:lnTo>
                    <a:lnTo>
                      <a:pt x="1189" y="837"/>
                    </a:lnTo>
                    <a:lnTo>
                      <a:pt x="1195" y="813"/>
                    </a:lnTo>
                    <a:lnTo>
                      <a:pt x="1200" y="825"/>
                    </a:lnTo>
                    <a:lnTo>
                      <a:pt x="1205" y="825"/>
                    </a:lnTo>
                    <a:lnTo>
                      <a:pt x="1210" y="837"/>
                    </a:lnTo>
                    <a:lnTo>
                      <a:pt x="1215" y="837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37"/>
                    </a:lnTo>
                    <a:lnTo>
                      <a:pt x="1240" y="837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49" name="Freeform 181"/>
              <p:cNvSpPr>
                <a:spLocks/>
              </p:cNvSpPr>
              <p:nvPr/>
            </p:nvSpPr>
            <p:spPr bwMode="auto">
              <a:xfrm>
                <a:off x="1074738" y="7165975"/>
                <a:ext cx="2074862" cy="1328738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37"/>
                  </a:cxn>
                  <a:cxn ang="0">
                    <a:pos x="92" y="825"/>
                  </a:cxn>
                  <a:cxn ang="0">
                    <a:pos x="117" y="837"/>
                  </a:cxn>
                  <a:cxn ang="0">
                    <a:pos x="143" y="825"/>
                  </a:cxn>
                  <a:cxn ang="0">
                    <a:pos x="168" y="837"/>
                  </a:cxn>
                  <a:cxn ang="0">
                    <a:pos x="194" y="825"/>
                  </a:cxn>
                  <a:cxn ang="0">
                    <a:pos x="219" y="825"/>
                  </a:cxn>
                  <a:cxn ang="0">
                    <a:pos x="245" y="825"/>
                  </a:cxn>
                  <a:cxn ang="0">
                    <a:pos x="270" y="753"/>
                  </a:cxn>
                  <a:cxn ang="0">
                    <a:pos x="296" y="765"/>
                  </a:cxn>
                  <a:cxn ang="0">
                    <a:pos x="321" y="693"/>
                  </a:cxn>
                  <a:cxn ang="0">
                    <a:pos x="347" y="753"/>
                  </a:cxn>
                  <a:cxn ang="0">
                    <a:pos x="372" y="693"/>
                  </a:cxn>
                  <a:cxn ang="0">
                    <a:pos x="398" y="705"/>
                  </a:cxn>
                  <a:cxn ang="0">
                    <a:pos x="424" y="670"/>
                  </a:cxn>
                  <a:cxn ang="0">
                    <a:pos x="449" y="574"/>
                  </a:cxn>
                  <a:cxn ang="0">
                    <a:pos x="475" y="646"/>
                  </a:cxn>
                  <a:cxn ang="0">
                    <a:pos x="500" y="717"/>
                  </a:cxn>
                  <a:cxn ang="0">
                    <a:pos x="526" y="693"/>
                  </a:cxn>
                  <a:cxn ang="0">
                    <a:pos x="551" y="693"/>
                  </a:cxn>
                  <a:cxn ang="0">
                    <a:pos x="577" y="681"/>
                  </a:cxn>
                  <a:cxn ang="0">
                    <a:pos x="602" y="634"/>
                  </a:cxn>
                  <a:cxn ang="0">
                    <a:pos x="628" y="729"/>
                  </a:cxn>
                  <a:cxn ang="0">
                    <a:pos x="653" y="598"/>
                  </a:cxn>
                  <a:cxn ang="0">
                    <a:pos x="679" y="693"/>
                  </a:cxn>
                  <a:cxn ang="0">
                    <a:pos x="704" y="658"/>
                  </a:cxn>
                  <a:cxn ang="0">
                    <a:pos x="730" y="538"/>
                  </a:cxn>
                  <a:cxn ang="0">
                    <a:pos x="755" y="526"/>
                  </a:cxn>
                  <a:cxn ang="0">
                    <a:pos x="781" y="526"/>
                  </a:cxn>
                  <a:cxn ang="0">
                    <a:pos x="807" y="431"/>
                  </a:cxn>
                  <a:cxn ang="0">
                    <a:pos x="832" y="490"/>
                  </a:cxn>
                  <a:cxn ang="0">
                    <a:pos x="858" y="335"/>
                  </a:cxn>
                  <a:cxn ang="0">
                    <a:pos x="883" y="251"/>
                  </a:cxn>
                  <a:cxn ang="0">
                    <a:pos x="909" y="227"/>
                  </a:cxn>
                  <a:cxn ang="0">
                    <a:pos x="934" y="180"/>
                  </a:cxn>
                  <a:cxn ang="0">
                    <a:pos x="960" y="227"/>
                  </a:cxn>
                  <a:cxn ang="0">
                    <a:pos x="985" y="132"/>
                  </a:cxn>
                  <a:cxn ang="0">
                    <a:pos x="1011" y="0"/>
                  </a:cxn>
                  <a:cxn ang="0">
                    <a:pos x="1036" y="287"/>
                  </a:cxn>
                  <a:cxn ang="0">
                    <a:pos x="1062" y="216"/>
                  </a:cxn>
                  <a:cxn ang="0">
                    <a:pos x="1087" y="502"/>
                  </a:cxn>
                  <a:cxn ang="0">
                    <a:pos x="1113" y="550"/>
                  </a:cxn>
                  <a:cxn ang="0">
                    <a:pos x="1139" y="693"/>
                  </a:cxn>
                  <a:cxn ang="0">
                    <a:pos x="1164" y="789"/>
                  </a:cxn>
                  <a:cxn ang="0">
                    <a:pos x="1189" y="837"/>
                  </a:cxn>
                  <a:cxn ang="0">
                    <a:pos x="1215" y="837"/>
                  </a:cxn>
                  <a:cxn ang="0">
                    <a:pos x="1240" y="837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3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37"/>
                    </a:lnTo>
                    <a:lnTo>
                      <a:pt x="71" y="837"/>
                    </a:lnTo>
                    <a:lnTo>
                      <a:pt x="76" y="837"/>
                    </a:lnTo>
                    <a:lnTo>
                      <a:pt x="82" y="825"/>
                    </a:lnTo>
                    <a:lnTo>
                      <a:pt x="87" y="837"/>
                    </a:lnTo>
                    <a:lnTo>
                      <a:pt x="92" y="825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25"/>
                    </a:lnTo>
                    <a:lnTo>
                      <a:pt x="117" y="837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37"/>
                    </a:lnTo>
                    <a:lnTo>
                      <a:pt x="158" y="837"/>
                    </a:lnTo>
                    <a:lnTo>
                      <a:pt x="163" y="825"/>
                    </a:lnTo>
                    <a:lnTo>
                      <a:pt x="168" y="837"/>
                    </a:lnTo>
                    <a:lnTo>
                      <a:pt x="173" y="825"/>
                    </a:lnTo>
                    <a:lnTo>
                      <a:pt x="179" y="825"/>
                    </a:lnTo>
                    <a:lnTo>
                      <a:pt x="184" y="825"/>
                    </a:lnTo>
                    <a:lnTo>
                      <a:pt x="189" y="825"/>
                    </a:lnTo>
                    <a:lnTo>
                      <a:pt x="194" y="825"/>
                    </a:lnTo>
                    <a:lnTo>
                      <a:pt x="199" y="825"/>
                    </a:lnTo>
                    <a:lnTo>
                      <a:pt x="204" y="813"/>
                    </a:lnTo>
                    <a:lnTo>
                      <a:pt x="209" y="801"/>
                    </a:lnTo>
                    <a:lnTo>
                      <a:pt x="214" y="825"/>
                    </a:lnTo>
                    <a:lnTo>
                      <a:pt x="219" y="825"/>
                    </a:lnTo>
                    <a:lnTo>
                      <a:pt x="224" y="825"/>
                    </a:lnTo>
                    <a:lnTo>
                      <a:pt x="230" y="825"/>
                    </a:lnTo>
                    <a:lnTo>
                      <a:pt x="235" y="813"/>
                    </a:lnTo>
                    <a:lnTo>
                      <a:pt x="240" y="789"/>
                    </a:lnTo>
                    <a:lnTo>
                      <a:pt x="245" y="825"/>
                    </a:lnTo>
                    <a:lnTo>
                      <a:pt x="250" y="777"/>
                    </a:lnTo>
                    <a:lnTo>
                      <a:pt x="255" y="753"/>
                    </a:lnTo>
                    <a:lnTo>
                      <a:pt x="260" y="825"/>
                    </a:lnTo>
                    <a:lnTo>
                      <a:pt x="265" y="765"/>
                    </a:lnTo>
                    <a:lnTo>
                      <a:pt x="270" y="753"/>
                    </a:lnTo>
                    <a:lnTo>
                      <a:pt x="275" y="777"/>
                    </a:lnTo>
                    <a:lnTo>
                      <a:pt x="281" y="753"/>
                    </a:lnTo>
                    <a:lnTo>
                      <a:pt x="286" y="801"/>
                    </a:lnTo>
                    <a:lnTo>
                      <a:pt x="291" y="813"/>
                    </a:lnTo>
                    <a:lnTo>
                      <a:pt x="296" y="765"/>
                    </a:lnTo>
                    <a:lnTo>
                      <a:pt x="301" y="705"/>
                    </a:lnTo>
                    <a:lnTo>
                      <a:pt x="306" y="813"/>
                    </a:lnTo>
                    <a:lnTo>
                      <a:pt x="311" y="777"/>
                    </a:lnTo>
                    <a:lnTo>
                      <a:pt x="316" y="765"/>
                    </a:lnTo>
                    <a:lnTo>
                      <a:pt x="321" y="693"/>
                    </a:lnTo>
                    <a:lnTo>
                      <a:pt x="327" y="729"/>
                    </a:lnTo>
                    <a:lnTo>
                      <a:pt x="332" y="765"/>
                    </a:lnTo>
                    <a:lnTo>
                      <a:pt x="337" y="717"/>
                    </a:lnTo>
                    <a:lnTo>
                      <a:pt x="342" y="777"/>
                    </a:lnTo>
                    <a:lnTo>
                      <a:pt x="347" y="753"/>
                    </a:lnTo>
                    <a:lnTo>
                      <a:pt x="352" y="705"/>
                    </a:lnTo>
                    <a:lnTo>
                      <a:pt x="357" y="717"/>
                    </a:lnTo>
                    <a:lnTo>
                      <a:pt x="362" y="705"/>
                    </a:lnTo>
                    <a:lnTo>
                      <a:pt x="367" y="646"/>
                    </a:lnTo>
                    <a:lnTo>
                      <a:pt x="372" y="693"/>
                    </a:lnTo>
                    <a:lnTo>
                      <a:pt x="378" y="753"/>
                    </a:lnTo>
                    <a:lnTo>
                      <a:pt x="383" y="741"/>
                    </a:lnTo>
                    <a:lnTo>
                      <a:pt x="388" y="634"/>
                    </a:lnTo>
                    <a:lnTo>
                      <a:pt x="393" y="693"/>
                    </a:lnTo>
                    <a:lnTo>
                      <a:pt x="398" y="705"/>
                    </a:lnTo>
                    <a:lnTo>
                      <a:pt x="403" y="670"/>
                    </a:lnTo>
                    <a:lnTo>
                      <a:pt x="408" y="693"/>
                    </a:lnTo>
                    <a:lnTo>
                      <a:pt x="413" y="670"/>
                    </a:lnTo>
                    <a:lnTo>
                      <a:pt x="419" y="646"/>
                    </a:lnTo>
                    <a:lnTo>
                      <a:pt x="424" y="670"/>
                    </a:lnTo>
                    <a:lnTo>
                      <a:pt x="429" y="634"/>
                    </a:lnTo>
                    <a:lnTo>
                      <a:pt x="434" y="622"/>
                    </a:lnTo>
                    <a:lnTo>
                      <a:pt x="439" y="765"/>
                    </a:lnTo>
                    <a:lnTo>
                      <a:pt x="444" y="717"/>
                    </a:lnTo>
                    <a:lnTo>
                      <a:pt x="449" y="574"/>
                    </a:lnTo>
                    <a:lnTo>
                      <a:pt x="454" y="681"/>
                    </a:lnTo>
                    <a:lnTo>
                      <a:pt x="459" y="729"/>
                    </a:lnTo>
                    <a:lnTo>
                      <a:pt x="464" y="610"/>
                    </a:lnTo>
                    <a:lnTo>
                      <a:pt x="470" y="646"/>
                    </a:lnTo>
                    <a:lnTo>
                      <a:pt x="475" y="646"/>
                    </a:lnTo>
                    <a:lnTo>
                      <a:pt x="480" y="693"/>
                    </a:lnTo>
                    <a:lnTo>
                      <a:pt x="485" y="693"/>
                    </a:lnTo>
                    <a:lnTo>
                      <a:pt x="490" y="658"/>
                    </a:lnTo>
                    <a:lnTo>
                      <a:pt x="495" y="729"/>
                    </a:lnTo>
                    <a:lnTo>
                      <a:pt x="500" y="717"/>
                    </a:lnTo>
                    <a:lnTo>
                      <a:pt x="505" y="646"/>
                    </a:lnTo>
                    <a:lnTo>
                      <a:pt x="510" y="681"/>
                    </a:lnTo>
                    <a:lnTo>
                      <a:pt x="515" y="705"/>
                    </a:lnTo>
                    <a:lnTo>
                      <a:pt x="521" y="658"/>
                    </a:lnTo>
                    <a:lnTo>
                      <a:pt x="526" y="693"/>
                    </a:lnTo>
                    <a:lnTo>
                      <a:pt x="531" y="681"/>
                    </a:lnTo>
                    <a:lnTo>
                      <a:pt x="536" y="693"/>
                    </a:lnTo>
                    <a:lnTo>
                      <a:pt x="541" y="634"/>
                    </a:lnTo>
                    <a:lnTo>
                      <a:pt x="546" y="729"/>
                    </a:lnTo>
                    <a:lnTo>
                      <a:pt x="551" y="693"/>
                    </a:lnTo>
                    <a:lnTo>
                      <a:pt x="556" y="670"/>
                    </a:lnTo>
                    <a:lnTo>
                      <a:pt x="561" y="717"/>
                    </a:lnTo>
                    <a:lnTo>
                      <a:pt x="567" y="777"/>
                    </a:lnTo>
                    <a:lnTo>
                      <a:pt x="572" y="693"/>
                    </a:lnTo>
                    <a:lnTo>
                      <a:pt x="577" y="681"/>
                    </a:lnTo>
                    <a:lnTo>
                      <a:pt x="582" y="717"/>
                    </a:lnTo>
                    <a:lnTo>
                      <a:pt x="587" y="658"/>
                    </a:lnTo>
                    <a:lnTo>
                      <a:pt x="592" y="681"/>
                    </a:lnTo>
                    <a:lnTo>
                      <a:pt x="597" y="753"/>
                    </a:lnTo>
                    <a:lnTo>
                      <a:pt x="602" y="634"/>
                    </a:lnTo>
                    <a:lnTo>
                      <a:pt x="607" y="598"/>
                    </a:lnTo>
                    <a:lnTo>
                      <a:pt x="612" y="693"/>
                    </a:lnTo>
                    <a:lnTo>
                      <a:pt x="618" y="646"/>
                    </a:lnTo>
                    <a:lnTo>
                      <a:pt x="623" y="729"/>
                    </a:lnTo>
                    <a:lnTo>
                      <a:pt x="628" y="729"/>
                    </a:lnTo>
                    <a:lnTo>
                      <a:pt x="633" y="681"/>
                    </a:lnTo>
                    <a:lnTo>
                      <a:pt x="638" y="681"/>
                    </a:lnTo>
                    <a:lnTo>
                      <a:pt x="643" y="634"/>
                    </a:lnTo>
                    <a:lnTo>
                      <a:pt x="648" y="729"/>
                    </a:lnTo>
                    <a:lnTo>
                      <a:pt x="653" y="598"/>
                    </a:lnTo>
                    <a:lnTo>
                      <a:pt x="659" y="634"/>
                    </a:lnTo>
                    <a:lnTo>
                      <a:pt x="664" y="538"/>
                    </a:lnTo>
                    <a:lnTo>
                      <a:pt x="669" y="729"/>
                    </a:lnTo>
                    <a:lnTo>
                      <a:pt x="674" y="670"/>
                    </a:lnTo>
                    <a:lnTo>
                      <a:pt x="679" y="693"/>
                    </a:lnTo>
                    <a:lnTo>
                      <a:pt x="684" y="646"/>
                    </a:lnTo>
                    <a:lnTo>
                      <a:pt x="689" y="741"/>
                    </a:lnTo>
                    <a:lnTo>
                      <a:pt x="694" y="622"/>
                    </a:lnTo>
                    <a:lnTo>
                      <a:pt x="699" y="622"/>
                    </a:lnTo>
                    <a:lnTo>
                      <a:pt x="704" y="658"/>
                    </a:lnTo>
                    <a:lnTo>
                      <a:pt x="710" y="598"/>
                    </a:lnTo>
                    <a:lnTo>
                      <a:pt x="715" y="538"/>
                    </a:lnTo>
                    <a:lnTo>
                      <a:pt x="720" y="574"/>
                    </a:lnTo>
                    <a:lnTo>
                      <a:pt x="725" y="586"/>
                    </a:lnTo>
                    <a:lnTo>
                      <a:pt x="730" y="538"/>
                    </a:lnTo>
                    <a:lnTo>
                      <a:pt x="735" y="490"/>
                    </a:lnTo>
                    <a:lnTo>
                      <a:pt x="740" y="550"/>
                    </a:lnTo>
                    <a:lnTo>
                      <a:pt x="745" y="610"/>
                    </a:lnTo>
                    <a:lnTo>
                      <a:pt x="750" y="634"/>
                    </a:lnTo>
                    <a:lnTo>
                      <a:pt x="755" y="526"/>
                    </a:lnTo>
                    <a:lnTo>
                      <a:pt x="761" y="574"/>
                    </a:lnTo>
                    <a:lnTo>
                      <a:pt x="766" y="610"/>
                    </a:lnTo>
                    <a:lnTo>
                      <a:pt x="771" y="466"/>
                    </a:lnTo>
                    <a:lnTo>
                      <a:pt x="776" y="443"/>
                    </a:lnTo>
                    <a:lnTo>
                      <a:pt x="781" y="526"/>
                    </a:lnTo>
                    <a:lnTo>
                      <a:pt x="786" y="526"/>
                    </a:lnTo>
                    <a:lnTo>
                      <a:pt x="791" y="419"/>
                    </a:lnTo>
                    <a:lnTo>
                      <a:pt x="796" y="478"/>
                    </a:lnTo>
                    <a:lnTo>
                      <a:pt x="801" y="478"/>
                    </a:lnTo>
                    <a:lnTo>
                      <a:pt x="807" y="431"/>
                    </a:lnTo>
                    <a:lnTo>
                      <a:pt x="812" y="490"/>
                    </a:lnTo>
                    <a:lnTo>
                      <a:pt x="817" y="502"/>
                    </a:lnTo>
                    <a:lnTo>
                      <a:pt x="822" y="502"/>
                    </a:lnTo>
                    <a:lnTo>
                      <a:pt x="827" y="383"/>
                    </a:lnTo>
                    <a:lnTo>
                      <a:pt x="832" y="490"/>
                    </a:lnTo>
                    <a:lnTo>
                      <a:pt x="837" y="216"/>
                    </a:lnTo>
                    <a:lnTo>
                      <a:pt x="842" y="454"/>
                    </a:lnTo>
                    <a:lnTo>
                      <a:pt x="847" y="347"/>
                    </a:lnTo>
                    <a:lnTo>
                      <a:pt x="852" y="443"/>
                    </a:lnTo>
                    <a:lnTo>
                      <a:pt x="858" y="335"/>
                    </a:lnTo>
                    <a:lnTo>
                      <a:pt x="863" y="323"/>
                    </a:lnTo>
                    <a:lnTo>
                      <a:pt x="868" y="24"/>
                    </a:lnTo>
                    <a:lnTo>
                      <a:pt x="873" y="383"/>
                    </a:lnTo>
                    <a:lnTo>
                      <a:pt x="878" y="323"/>
                    </a:lnTo>
                    <a:lnTo>
                      <a:pt x="883" y="251"/>
                    </a:lnTo>
                    <a:lnTo>
                      <a:pt x="888" y="108"/>
                    </a:lnTo>
                    <a:lnTo>
                      <a:pt x="893" y="251"/>
                    </a:lnTo>
                    <a:lnTo>
                      <a:pt x="899" y="263"/>
                    </a:lnTo>
                    <a:lnTo>
                      <a:pt x="904" y="287"/>
                    </a:lnTo>
                    <a:lnTo>
                      <a:pt x="909" y="227"/>
                    </a:lnTo>
                    <a:lnTo>
                      <a:pt x="914" y="180"/>
                    </a:lnTo>
                    <a:lnTo>
                      <a:pt x="919" y="120"/>
                    </a:lnTo>
                    <a:lnTo>
                      <a:pt x="924" y="108"/>
                    </a:lnTo>
                    <a:lnTo>
                      <a:pt x="929" y="72"/>
                    </a:lnTo>
                    <a:lnTo>
                      <a:pt x="934" y="180"/>
                    </a:lnTo>
                    <a:lnTo>
                      <a:pt x="939" y="84"/>
                    </a:lnTo>
                    <a:lnTo>
                      <a:pt x="944" y="168"/>
                    </a:lnTo>
                    <a:lnTo>
                      <a:pt x="950" y="72"/>
                    </a:lnTo>
                    <a:lnTo>
                      <a:pt x="955" y="120"/>
                    </a:lnTo>
                    <a:lnTo>
                      <a:pt x="960" y="227"/>
                    </a:lnTo>
                    <a:lnTo>
                      <a:pt x="965" y="84"/>
                    </a:lnTo>
                    <a:lnTo>
                      <a:pt x="970" y="168"/>
                    </a:lnTo>
                    <a:lnTo>
                      <a:pt x="975" y="36"/>
                    </a:lnTo>
                    <a:lnTo>
                      <a:pt x="980" y="144"/>
                    </a:lnTo>
                    <a:lnTo>
                      <a:pt x="985" y="132"/>
                    </a:lnTo>
                    <a:lnTo>
                      <a:pt x="990" y="60"/>
                    </a:lnTo>
                    <a:lnTo>
                      <a:pt x="995" y="168"/>
                    </a:lnTo>
                    <a:lnTo>
                      <a:pt x="1000" y="120"/>
                    </a:lnTo>
                    <a:lnTo>
                      <a:pt x="1006" y="192"/>
                    </a:lnTo>
                    <a:lnTo>
                      <a:pt x="1011" y="0"/>
                    </a:lnTo>
                    <a:lnTo>
                      <a:pt x="1016" y="132"/>
                    </a:lnTo>
                    <a:lnTo>
                      <a:pt x="1021" y="287"/>
                    </a:lnTo>
                    <a:lnTo>
                      <a:pt x="1026" y="144"/>
                    </a:lnTo>
                    <a:lnTo>
                      <a:pt x="1031" y="263"/>
                    </a:lnTo>
                    <a:lnTo>
                      <a:pt x="1036" y="287"/>
                    </a:lnTo>
                    <a:lnTo>
                      <a:pt x="1041" y="311"/>
                    </a:lnTo>
                    <a:lnTo>
                      <a:pt x="1047" y="335"/>
                    </a:lnTo>
                    <a:lnTo>
                      <a:pt x="1052" y="275"/>
                    </a:lnTo>
                    <a:lnTo>
                      <a:pt x="1057" y="359"/>
                    </a:lnTo>
                    <a:lnTo>
                      <a:pt x="1062" y="216"/>
                    </a:lnTo>
                    <a:lnTo>
                      <a:pt x="1067" y="478"/>
                    </a:lnTo>
                    <a:lnTo>
                      <a:pt x="1072" y="383"/>
                    </a:lnTo>
                    <a:lnTo>
                      <a:pt x="1077" y="419"/>
                    </a:lnTo>
                    <a:lnTo>
                      <a:pt x="1082" y="419"/>
                    </a:lnTo>
                    <a:lnTo>
                      <a:pt x="1087" y="502"/>
                    </a:lnTo>
                    <a:lnTo>
                      <a:pt x="1092" y="574"/>
                    </a:lnTo>
                    <a:lnTo>
                      <a:pt x="1098" y="634"/>
                    </a:lnTo>
                    <a:lnTo>
                      <a:pt x="1103" y="538"/>
                    </a:lnTo>
                    <a:lnTo>
                      <a:pt x="1108" y="526"/>
                    </a:lnTo>
                    <a:lnTo>
                      <a:pt x="1113" y="550"/>
                    </a:lnTo>
                    <a:lnTo>
                      <a:pt x="1118" y="622"/>
                    </a:lnTo>
                    <a:lnTo>
                      <a:pt x="1123" y="610"/>
                    </a:lnTo>
                    <a:lnTo>
                      <a:pt x="1128" y="634"/>
                    </a:lnTo>
                    <a:lnTo>
                      <a:pt x="1133" y="658"/>
                    </a:lnTo>
                    <a:lnTo>
                      <a:pt x="1139" y="693"/>
                    </a:lnTo>
                    <a:lnTo>
                      <a:pt x="1144" y="777"/>
                    </a:lnTo>
                    <a:lnTo>
                      <a:pt x="1149" y="753"/>
                    </a:lnTo>
                    <a:lnTo>
                      <a:pt x="1154" y="777"/>
                    </a:lnTo>
                    <a:lnTo>
                      <a:pt x="1159" y="753"/>
                    </a:lnTo>
                    <a:lnTo>
                      <a:pt x="1164" y="789"/>
                    </a:lnTo>
                    <a:lnTo>
                      <a:pt x="1169" y="777"/>
                    </a:lnTo>
                    <a:lnTo>
                      <a:pt x="1174" y="813"/>
                    </a:lnTo>
                    <a:lnTo>
                      <a:pt x="1179" y="789"/>
                    </a:lnTo>
                    <a:lnTo>
                      <a:pt x="1184" y="825"/>
                    </a:lnTo>
                    <a:lnTo>
                      <a:pt x="1189" y="837"/>
                    </a:lnTo>
                    <a:lnTo>
                      <a:pt x="1195" y="813"/>
                    </a:lnTo>
                    <a:lnTo>
                      <a:pt x="1200" y="825"/>
                    </a:lnTo>
                    <a:lnTo>
                      <a:pt x="1205" y="825"/>
                    </a:lnTo>
                    <a:lnTo>
                      <a:pt x="1210" y="837"/>
                    </a:lnTo>
                    <a:lnTo>
                      <a:pt x="1215" y="837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37"/>
                    </a:lnTo>
                    <a:lnTo>
                      <a:pt x="1240" y="837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50" name="Freeform 182"/>
              <p:cNvSpPr>
                <a:spLocks/>
              </p:cNvSpPr>
              <p:nvPr/>
            </p:nvSpPr>
            <p:spPr bwMode="auto">
              <a:xfrm flipV="1">
                <a:off x="2292350" y="6873875"/>
                <a:ext cx="781050" cy="6381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63"/>
                  </a:cxn>
                  <a:cxn ang="0">
                    <a:pos x="2893" y="2363"/>
                  </a:cxn>
                  <a:cxn ang="0">
                    <a:pos x="2893" y="0"/>
                  </a:cxn>
                </a:cxnLst>
                <a:rect l="0" t="0" r="r" b="b"/>
                <a:pathLst>
                  <a:path w="2893" h="2363">
                    <a:moveTo>
                      <a:pt x="0" y="0"/>
                    </a:moveTo>
                    <a:lnTo>
                      <a:pt x="0" y="2363"/>
                    </a:lnTo>
                    <a:lnTo>
                      <a:pt x="2893" y="2363"/>
                    </a:lnTo>
                    <a:lnTo>
                      <a:pt x="2893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54" name="Rectangle 186"/>
              <p:cNvSpPr>
                <a:spLocks noChangeArrowheads="1"/>
              </p:cNvSpPr>
              <p:nvPr/>
            </p:nvSpPr>
            <p:spPr bwMode="auto">
              <a:xfrm>
                <a:off x="1074738" y="6502400"/>
                <a:ext cx="2074862" cy="1992313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248" name="Groep 247"/>
            <p:cNvGrpSpPr/>
            <p:nvPr/>
          </p:nvGrpSpPr>
          <p:grpSpPr>
            <a:xfrm>
              <a:off x="1862555" y="4261622"/>
              <a:ext cx="1163039" cy="1191023"/>
              <a:chOff x="1074738" y="6502400"/>
              <a:chExt cx="2074862" cy="1992313"/>
            </a:xfrm>
          </p:grpSpPr>
          <p:sp>
            <p:nvSpPr>
              <p:cNvPr id="249" name="Freeform 180"/>
              <p:cNvSpPr>
                <a:spLocks/>
              </p:cNvSpPr>
              <p:nvPr/>
            </p:nvSpPr>
            <p:spPr bwMode="auto">
              <a:xfrm>
                <a:off x="1074738" y="7165975"/>
                <a:ext cx="2074862" cy="1328738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37"/>
                  </a:cxn>
                  <a:cxn ang="0">
                    <a:pos x="92" y="825"/>
                  </a:cxn>
                  <a:cxn ang="0">
                    <a:pos x="117" y="837"/>
                  </a:cxn>
                  <a:cxn ang="0">
                    <a:pos x="143" y="825"/>
                  </a:cxn>
                  <a:cxn ang="0">
                    <a:pos x="168" y="837"/>
                  </a:cxn>
                  <a:cxn ang="0">
                    <a:pos x="194" y="825"/>
                  </a:cxn>
                  <a:cxn ang="0">
                    <a:pos x="219" y="825"/>
                  </a:cxn>
                  <a:cxn ang="0">
                    <a:pos x="245" y="825"/>
                  </a:cxn>
                  <a:cxn ang="0">
                    <a:pos x="270" y="753"/>
                  </a:cxn>
                  <a:cxn ang="0">
                    <a:pos x="296" y="765"/>
                  </a:cxn>
                  <a:cxn ang="0">
                    <a:pos x="321" y="693"/>
                  </a:cxn>
                  <a:cxn ang="0">
                    <a:pos x="347" y="753"/>
                  </a:cxn>
                  <a:cxn ang="0">
                    <a:pos x="372" y="693"/>
                  </a:cxn>
                  <a:cxn ang="0">
                    <a:pos x="398" y="705"/>
                  </a:cxn>
                  <a:cxn ang="0">
                    <a:pos x="424" y="670"/>
                  </a:cxn>
                  <a:cxn ang="0">
                    <a:pos x="449" y="574"/>
                  </a:cxn>
                  <a:cxn ang="0">
                    <a:pos x="475" y="646"/>
                  </a:cxn>
                  <a:cxn ang="0">
                    <a:pos x="500" y="717"/>
                  </a:cxn>
                  <a:cxn ang="0">
                    <a:pos x="526" y="693"/>
                  </a:cxn>
                  <a:cxn ang="0">
                    <a:pos x="551" y="693"/>
                  </a:cxn>
                  <a:cxn ang="0">
                    <a:pos x="577" y="681"/>
                  </a:cxn>
                  <a:cxn ang="0">
                    <a:pos x="602" y="634"/>
                  </a:cxn>
                  <a:cxn ang="0">
                    <a:pos x="628" y="729"/>
                  </a:cxn>
                  <a:cxn ang="0">
                    <a:pos x="653" y="598"/>
                  </a:cxn>
                  <a:cxn ang="0">
                    <a:pos x="679" y="693"/>
                  </a:cxn>
                  <a:cxn ang="0">
                    <a:pos x="704" y="658"/>
                  </a:cxn>
                  <a:cxn ang="0">
                    <a:pos x="730" y="538"/>
                  </a:cxn>
                  <a:cxn ang="0">
                    <a:pos x="755" y="526"/>
                  </a:cxn>
                  <a:cxn ang="0">
                    <a:pos x="781" y="526"/>
                  </a:cxn>
                  <a:cxn ang="0">
                    <a:pos x="807" y="431"/>
                  </a:cxn>
                  <a:cxn ang="0">
                    <a:pos x="832" y="490"/>
                  </a:cxn>
                  <a:cxn ang="0">
                    <a:pos x="858" y="335"/>
                  </a:cxn>
                  <a:cxn ang="0">
                    <a:pos x="883" y="251"/>
                  </a:cxn>
                  <a:cxn ang="0">
                    <a:pos x="909" y="227"/>
                  </a:cxn>
                  <a:cxn ang="0">
                    <a:pos x="934" y="180"/>
                  </a:cxn>
                  <a:cxn ang="0">
                    <a:pos x="960" y="227"/>
                  </a:cxn>
                  <a:cxn ang="0">
                    <a:pos x="985" y="132"/>
                  </a:cxn>
                  <a:cxn ang="0">
                    <a:pos x="1011" y="0"/>
                  </a:cxn>
                  <a:cxn ang="0">
                    <a:pos x="1036" y="287"/>
                  </a:cxn>
                  <a:cxn ang="0">
                    <a:pos x="1062" y="216"/>
                  </a:cxn>
                  <a:cxn ang="0">
                    <a:pos x="1087" y="502"/>
                  </a:cxn>
                  <a:cxn ang="0">
                    <a:pos x="1113" y="550"/>
                  </a:cxn>
                  <a:cxn ang="0">
                    <a:pos x="1139" y="693"/>
                  </a:cxn>
                  <a:cxn ang="0">
                    <a:pos x="1164" y="789"/>
                  </a:cxn>
                  <a:cxn ang="0">
                    <a:pos x="1189" y="837"/>
                  </a:cxn>
                  <a:cxn ang="0">
                    <a:pos x="1215" y="837"/>
                  </a:cxn>
                  <a:cxn ang="0">
                    <a:pos x="1240" y="837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3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37"/>
                    </a:lnTo>
                    <a:lnTo>
                      <a:pt x="71" y="837"/>
                    </a:lnTo>
                    <a:lnTo>
                      <a:pt x="76" y="837"/>
                    </a:lnTo>
                    <a:lnTo>
                      <a:pt x="82" y="825"/>
                    </a:lnTo>
                    <a:lnTo>
                      <a:pt x="87" y="837"/>
                    </a:lnTo>
                    <a:lnTo>
                      <a:pt x="92" y="825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25"/>
                    </a:lnTo>
                    <a:lnTo>
                      <a:pt x="117" y="837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37"/>
                    </a:lnTo>
                    <a:lnTo>
                      <a:pt x="158" y="837"/>
                    </a:lnTo>
                    <a:lnTo>
                      <a:pt x="163" y="825"/>
                    </a:lnTo>
                    <a:lnTo>
                      <a:pt x="168" y="837"/>
                    </a:lnTo>
                    <a:lnTo>
                      <a:pt x="173" y="825"/>
                    </a:lnTo>
                    <a:lnTo>
                      <a:pt x="179" y="825"/>
                    </a:lnTo>
                    <a:lnTo>
                      <a:pt x="184" y="825"/>
                    </a:lnTo>
                    <a:lnTo>
                      <a:pt x="189" y="825"/>
                    </a:lnTo>
                    <a:lnTo>
                      <a:pt x="194" y="825"/>
                    </a:lnTo>
                    <a:lnTo>
                      <a:pt x="199" y="825"/>
                    </a:lnTo>
                    <a:lnTo>
                      <a:pt x="204" y="813"/>
                    </a:lnTo>
                    <a:lnTo>
                      <a:pt x="209" y="801"/>
                    </a:lnTo>
                    <a:lnTo>
                      <a:pt x="214" y="825"/>
                    </a:lnTo>
                    <a:lnTo>
                      <a:pt x="219" y="825"/>
                    </a:lnTo>
                    <a:lnTo>
                      <a:pt x="224" y="825"/>
                    </a:lnTo>
                    <a:lnTo>
                      <a:pt x="230" y="825"/>
                    </a:lnTo>
                    <a:lnTo>
                      <a:pt x="235" y="813"/>
                    </a:lnTo>
                    <a:lnTo>
                      <a:pt x="240" y="789"/>
                    </a:lnTo>
                    <a:lnTo>
                      <a:pt x="245" y="825"/>
                    </a:lnTo>
                    <a:lnTo>
                      <a:pt x="250" y="777"/>
                    </a:lnTo>
                    <a:lnTo>
                      <a:pt x="255" y="753"/>
                    </a:lnTo>
                    <a:lnTo>
                      <a:pt x="260" y="825"/>
                    </a:lnTo>
                    <a:lnTo>
                      <a:pt x="265" y="765"/>
                    </a:lnTo>
                    <a:lnTo>
                      <a:pt x="270" y="753"/>
                    </a:lnTo>
                    <a:lnTo>
                      <a:pt x="275" y="777"/>
                    </a:lnTo>
                    <a:lnTo>
                      <a:pt x="281" y="753"/>
                    </a:lnTo>
                    <a:lnTo>
                      <a:pt x="286" y="801"/>
                    </a:lnTo>
                    <a:lnTo>
                      <a:pt x="291" y="813"/>
                    </a:lnTo>
                    <a:lnTo>
                      <a:pt x="296" y="765"/>
                    </a:lnTo>
                    <a:lnTo>
                      <a:pt x="301" y="705"/>
                    </a:lnTo>
                    <a:lnTo>
                      <a:pt x="306" y="813"/>
                    </a:lnTo>
                    <a:lnTo>
                      <a:pt x="311" y="777"/>
                    </a:lnTo>
                    <a:lnTo>
                      <a:pt x="316" y="765"/>
                    </a:lnTo>
                    <a:lnTo>
                      <a:pt x="321" y="693"/>
                    </a:lnTo>
                    <a:lnTo>
                      <a:pt x="327" y="729"/>
                    </a:lnTo>
                    <a:lnTo>
                      <a:pt x="332" y="765"/>
                    </a:lnTo>
                    <a:lnTo>
                      <a:pt x="337" y="717"/>
                    </a:lnTo>
                    <a:lnTo>
                      <a:pt x="342" y="777"/>
                    </a:lnTo>
                    <a:lnTo>
                      <a:pt x="347" y="753"/>
                    </a:lnTo>
                    <a:lnTo>
                      <a:pt x="352" y="705"/>
                    </a:lnTo>
                    <a:lnTo>
                      <a:pt x="357" y="717"/>
                    </a:lnTo>
                    <a:lnTo>
                      <a:pt x="362" y="705"/>
                    </a:lnTo>
                    <a:lnTo>
                      <a:pt x="367" y="646"/>
                    </a:lnTo>
                    <a:lnTo>
                      <a:pt x="372" y="693"/>
                    </a:lnTo>
                    <a:lnTo>
                      <a:pt x="378" y="753"/>
                    </a:lnTo>
                    <a:lnTo>
                      <a:pt x="383" y="741"/>
                    </a:lnTo>
                    <a:lnTo>
                      <a:pt x="388" y="634"/>
                    </a:lnTo>
                    <a:lnTo>
                      <a:pt x="393" y="693"/>
                    </a:lnTo>
                    <a:lnTo>
                      <a:pt x="398" y="705"/>
                    </a:lnTo>
                    <a:lnTo>
                      <a:pt x="403" y="670"/>
                    </a:lnTo>
                    <a:lnTo>
                      <a:pt x="408" y="693"/>
                    </a:lnTo>
                    <a:lnTo>
                      <a:pt x="413" y="670"/>
                    </a:lnTo>
                    <a:lnTo>
                      <a:pt x="419" y="646"/>
                    </a:lnTo>
                    <a:lnTo>
                      <a:pt x="424" y="670"/>
                    </a:lnTo>
                    <a:lnTo>
                      <a:pt x="429" y="634"/>
                    </a:lnTo>
                    <a:lnTo>
                      <a:pt x="434" y="622"/>
                    </a:lnTo>
                    <a:lnTo>
                      <a:pt x="439" y="765"/>
                    </a:lnTo>
                    <a:lnTo>
                      <a:pt x="444" y="717"/>
                    </a:lnTo>
                    <a:lnTo>
                      <a:pt x="449" y="574"/>
                    </a:lnTo>
                    <a:lnTo>
                      <a:pt x="454" y="681"/>
                    </a:lnTo>
                    <a:lnTo>
                      <a:pt x="459" y="729"/>
                    </a:lnTo>
                    <a:lnTo>
                      <a:pt x="464" y="610"/>
                    </a:lnTo>
                    <a:lnTo>
                      <a:pt x="470" y="646"/>
                    </a:lnTo>
                    <a:lnTo>
                      <a:pt x="475" y="646"/>
                    </a:lnTo>
                    <a:lnTo>
                      <a:pt x="480" y="693"/>
                    </a:lnTo>
                    <a:lnTo>
                      <a:pt x="485" y="693"/>
                    </a:lnTo>
                    <a:lnTo>
                      <a:pt x="490" y="658"/>
                    </a:lnTo>
                    <a:lnTo>
                      <a:pt x="495" y="729"/>
                    </a:lnTo>
                    <a:lnTo>
                      <a:pt x="500" y="717"/>
                    </a:lnTo>
                    <a:lnTo>
                      <a:pt x="505" y="646"/>
                    </a:lnTo>
                    <a:lnTo>
                      <a:pt x="510" y="681"/>
                    </a:lnTo>
                    <a:lnTo>
                      <a:pt x="515" y="705"/>
                    </a:lnTo>
                    <a:lnTo>
                      <a:pt x="521" y="658"/>
                    </a:lnTo>
                    <a:lnTo>
                      <a:pt x="526" y="693"/>
                    </a:lnTo>
                    <a:lnTo>
                      <a:pt x="531" y="681"/>
                    </a:lnTo>
                    <a:lnTo>
                      <a:pt x="536" y="693"/>
                    </a:lnTo>
                    <a:lnTo>
                      <a:pt x="541" y="634"/>
                    </a:lnTo>
                    <a:lnTo>
                      <a:pt x="546" y="729"/>
                    </a:lnTo>
                    <a:lnTo>
                      <a:pt x="551" y="693"/>
                    </a:lnTo>
                    <a:lnTo>
                      <a:pt x="556" y="670"/>
                    </a:lnTo>
                    <a:lnTo>
                      <a:pt x="561" y="717"/>
                    </a:lnTo>
                    <a:lnTo>
                      <a:pt x="567" y="777"/>
                    </a:lnTo>
                    <a:lnTo>
                      <a:pt x="572" y="693"/>
                    </a:lnTo>
                    <a:lnTo>
                      <a:pt x="577" y="681"/>
                    </a:lnTo>
                    <a:lnTo>
                      <a:pt x="582" y="717"/>
                    </a:lnTo>
                    <a:lnTo>
                      <a:pt x="587" y="658"/>
                    </a:lnTo>
                    <a:lnTo>
                      <a:pt x="592" y="681"/>
                    </a:lnTo>
                    <a:lnTo>
                      <a:pt x="597" y="753"/>
                    </a:lnTo>
                    <a:lnTo>
                      <a:pt x="602" y="634"/>
                    </a:lnTo>
                    <a:lnTo>
                      <a:pt x="607" y="598"/>
                    </a:lnTo>
                    <a:lnTo>
                      <a:pt x="612" y="693"/>
                    </a:lnTo>
                    <a:lnTo>
                      <a:pt x="618" y="646"/>
                    </a:lnTo>
                    <a:lnTo>
                      <a:pt x="623" y="729"/>
                    </a:lnTo>
                    <a:lnTo>
                      <a:pt x="628" y="729"/>
                    </a:lnTo>
                    <a:lnTo>
                      <a:pt x="633" y="681"/>
                    </a:lnTo>
                    <a:lnTo>
                      <a:pt x="638" y="681"/>
                    </a:lnTo>
                    <a:lnTo>
                      <a:pt x="643" y="634"/>
                    </a:lnTo>
                    <a:lnTo>
                      <a:pt x="648" y="729"/>
                    </a:lnTo>
                    <a:lnTo>
                      <a:pt x="653" y="598"/>
                    </a:lnTo>
                    <a:lnTo>
                      <a:pt x="659" y="634"/>
                    </a:lnTo>
                    <a:lnTo>
                      <a:pt x="664" y="538"/>
                    </a:lnTo>
                    <a:lnTo>
                      <a:pt x="669" y="729"/>
                    </a:lnTo>
                    <a:lnTo>
                      <a:pt x="674" y="670"/>
                    </a:lnTo>
                    <a:lnTo>
                      <a:pt x="679" y="693"/>
                    </a:lnTo>
                    <a:lnTo>
                      <a:pt x="684" y="646"/>
                    </a:lnTo>
                    <a:lnTo>
                      <a:pt x="689" y="741"/>
                    </a:lnTo>
                    <a:lnTo>
                      <a:pt x="694" y="622"/>
                    </a:lnTo>
                    <a:lnTo>
                      <a:pt x="699" y="622"/>
                    </a:lnTo>
                    <a:lnTo>
                      <a:pt x="704" y="658"/>
                    </a:lnTo>
                    <a:lnTo>
                      <a:pt x="710" y="598"/>
                    </a:lnTo>
                    <a:lnTo>
                      <a:pt x="715" y="538"/>
                    </a:lnTo>
                    <a:lnTo>
                      <a:pt x="720" y="574"/>
                    </a:lnTo>
                    <a:lnTo>
                      <a:pt x="725" y="586"/>
                    </a:lnTo>
                    <a:lnTo>
                      <a:pt x="730" y="538"/>
                    </a:lnTo>
                    <a:lnTo>
                      <a:pt x="735" y="490"/>
                    </a:lnTo>
                    <a:lnTo>
                      <a:pt x="740" y="550"/>
                    </a:lnTo>
                    <a:lnTo>
                      <a:pt x="745" y="610"/>
                    </a:lnTo>
                    <a:lnTo>
                      <a:pt x="750" y="634"/>
                    </a:lnTo>
                    <a:lnTo>
                      <a:pt x="755" y="526"/>
                    </a:lnTo>
                    <a:lnTo>
                      <a:pt x="761" y="574"/>
                    </a:lnTo>
                    <a:lnTo>
                      <a:pt x="766" y="610"/>
                    </a:lnTo>
                    <a:lnTo>
                      <a:pt x="771" y="466"/>
                    </a:lnTo>
                    <a:lnTo>
                      <a:pt x="776" y="443"/>
                    </a:lnTo>
                    <a:lnTo>
                      <a:pt x="781" y="526"/>
                    </a:lnTo>
                    <a:lnTo>
                      <a:pt x="786" y="526"/>
                    </a:lnTo>
                    <a:lnTo>
                      <a:pt x="791" y="419"/>
                    </a:lnTo>
                    <a:lnTo>
                      <a:pt x="796" y="478"/>
                    </a:lnTo>
                    <a:lnTo>
                      <a:pt x="801" y="478"/>
                    </a:lnTo>
                    <a:lnTo>
                      <a:pt x="807" y="431"/>
                    </a:lnTo>
                    <a:lnTo>
                      <a:pt x="812" y="490"/>
                    </a:lnTo>
                    <a:lnTo>
                      <a:pt x="817" y="502"/>
                    </a:lnTo>
                    <a:lnTo>
                      <a:pt x="822" y="502"/>
                    </a:lnTo>
                    <a:lnTo>
                      <a:pt x="827" y="383"/>
                    </a:lnTo>
                    <a:lnTo>
                      <a:pt x="832" y="490"/>
                    </a:lnTo>
                    <a:lnTo>
                      <a:pt x="837" y="216"/>
                    </a:lnTo>
                    <a:lnTo>
                      <a:pt x="842" y="454"/>
                    </a:lnTo>
                    <a:lnTo>
                      <a:pt x="847" y="347"/>
                    </a:lnTo>
                    <a:lnTo>
                      <a:pt x="852" y="443"/>
                    </a:lnTo>
                    <a:lnTo>
                      <a:pt x="858" y="335"/>
                    </a:lnTo>
                    <a:lnTo>
                      <a:pt x="863" y="323"/>
                    </a:lnTo>
                    <a:lnTo>
                      <a:pt x="868" y="24"/>
                    </a:lnTo>
                    <a:lnTo>
                      <a:pt x="873" y="383"/>
                    </a:lnTo>
                    <a:lnTo>
                      <a:pt x="878" y="323"/>
                    </a:lnTo>
                    <a:lnTo>
                      <a:pt x="883" y="251"/>
                    </a:lnTo>
                    <a:lnTo>
                      <a:pt x="888" y="108"/>
                    </a:lnTo>
                    <a:lnTo>
                      <a:pt x="893" y="251"/>
                    </a:lnTo>
                    <a:lnTo>
                      <a:pt x="899" y="263"/>
                    </a:lnTo>
                    <a:lnTo>
                      <a:pt x="904" y="287"/>
                    </a:lnTo>
                    <a:lnTo>
                      <a:pt x="909" y="227"/>
                    </a:lnTo>
                    <a:lnTo>
                      <a:pt x="914" y="180"/>
                    </a:lnTo>
                    <a:lnTo>
                      <a:pt x="919" y="120"/>
                    </a:lnTo>
                    <a:lnTo>
                      <a:pt x="924" y="108"/>
                    </a:lnTo>
                    <a:lnTo>
                      <a:pt x="929" y="72"/>
                    </a:lnTo>
                    <a:lnTo>
                      <a:pt x="934" y="180"/>
                    </a:lnTo>
                    <a:lnTo>
                      <a:pt x="939" y="84"/>
                    </a:lnTo>
                    <a:lnTo>
                      <a:pt x="944" y="168"/>
                    </a:lnTo>
                    <a:lnTo>
                      <a:pt x="950" y="72"/>
                    </a:lnTo>
                    <a:lnTo>
                      <a:pt x="955" y="120"/>
                    </a:lnTo>
                    <a:lnTo>
                      <a:pt x="960" y="227"/>
                    </a:lnTo>
                    <a:lnTo>
                      <a:pt x="965" y="84"/>
                    </a:lnTo>
                    <a:lnTo>
                      <a:pt x="970" y="168"/>
                    </a:lnTo>
                    <a:lnTo>
                      <a:pt x="975" y="36"/>
                    </a:lnTo>
                    <a:lnTo>
                      <a:pt x="980" y="144"/>
                    </a:lnTo>
                    <a:lnTo>
                      <a:pt x="985" y="132"/>
                    </a:lnTo>
                    <a:lnTo>
                      <a:pt x="990" y="60"/>
                    </a:lnTo>
                    <a:lnTo>
                      <a:pt x="995" y="168"/>
                    </a:lnTo>
                    <a:lnTo>
                      <a:pt x="1000" y="120"/>
                    </a:lnTo>
                    <a:lnTo>
                      <a:pt x="1006" y="192"/>
                    </a:lnTo>
                    <a:lnTo>
                      <a:pt x="1011" y="0"/>
                    </a:lnTo>
                    <a:lnTo>
                      <a:pt x="1016" y="132"/>
                    </a:lnTo>
                    <a:lnTo>
                      <a:pt x="1021" y="287"/>
                    </a:lnTo>
                    <a:lnTo>
                      <a:pt x="1026" y="144"/>
                    </a:lnTo>
                    <a:lnTo>
                      <a:pt x="1031" y="263"/>
                    </a:lnTo>
                    <a:lnTo>
                      <a:pt x="1036" y="287"/>
                    </a:lnTo>
                    <a:lnTo>
                      <a:pt x="1041" y="311"/>
                    </a:lnTo>
                    <a:lnTo>
                      <a:pt x="1047" y="335"/>
                    </a:lnTo>
                    <a:lnTo>
                      <a:pt x="1052" y="275"/>
                    </a:lnTo>
                    <a:lnTo>
                      <a:pt x="1057" y="359"/>
                    </a:lnTo>
                    <a:lnTo>
                      <a:pt x="1062" y="216"/>
                    </a:lnTo>
                    <a:lnTo>
                      <a:pt x="1067" y="478"/>
                    </a:lnTo>
                    <a:lnTo>
                      <a:pt x="1072" y="383"/>
                    </a:lnTo>
                    <a:lnTo>
                      <a:pt x="1077" y="419"/>
                    </a:lnTo>
                    <a:lnTo>
                      <a:pt x="1082" y="419"/>
                    </a:lnTo>
                    <a:lnTo>
                      <a:pt x="1087" y="502"/>
                    </a:lnTo>
                    <a:lnTo>
                      <a:pt x="1092" y="574"/>
                    </a:lnTo>
                    <a:lnTo>
                      <a:pt x="1098" y="634"/>
                    </a:lnTo>
                    <a:lnTo>
                      <a:pt x="1103" y="538"/>
                    </a:lnTo>
                    <a:lnTo>
                      <a:pt x="1108" y="526"/>
                    </a:lnTo>
                    <a:lnTo>
                      <a:pt x="1113" y="550"/>
                    </a:lnTo>
                    <a:lnTo>
                      <a:pt x="1118" y="622"/>
                    </a:lnTo>
                    <a:lnTo>
                      <a:pt x="1123" y="610"/>
                    </a:lnTo>
                    <a:lnTo>
                      <a:pt x="1128" y="634"/>
                    </a:lnTo>
                    <a:lnTo>
                      <a:pt x="1133" y="658"/>
                    </a:lnTo>
                    <a:lnTo>
                      <a:pt x="1139" y="693"/>
                    </a:lnTo>
                    <a:lnTo>
                      <a:pt x="1144" y="777"/>
                    </a:lnTo>
                    <a:lnTo>
                      <a:pt x="1149" y="753"/>
                    </a:lnTo>
                    <a:lnTo>
                      <a:pt x="1154" y="777"/>
                    </a:lnTo>
                    <a:lnTo>
                      <a:pt x="1159" y="753"/>
                    </a:lnTo>
                    <a:lnTo>
                      <a:pt x="1164" y="789"/>
                    </a:lnTo>
                    <a:lnTo>
                      <a:pt x="1169" y="777"/>
                    </a:lnTo>
                    <a:lnTo>
                      <a:pt x="1174" y="813"/>
                    </a:lnTo>
                    <a:lnTo>
                      <a:pt x="1179" y="789"/>
                    </a:lnTo>
                    <a:lnTo>
                      <a:pt x="1184" y="825"/>
                    </a:lnTo>
                    <a:lnTo>
                      <a:pt x="1189" y="837"/>
                    </a:lnTo>
                    <a:lnTo>
                      <a:pt x="1195" y="813"/>
                    </a:lnTo>
                    <a:lnTo>
                      <a:pt x="1200" y="825"/>
                    </a:lnTo>
                    <a:lnTo>
                      <a:pt x="1205" y="825"/>
                    </a:lnTo>
                    <a:lnTo>
                      <a:pt x="1210" y="837"/>
                    </a:lnTo>
                    <a:lnTo>
                      <a:pt x="1215" y="837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37"/>
                    </a:lnTo>
                    <a:lnTo>
                      <a:pt x="1240" y="837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50" name="Freeform 181"/>
              <p:cNvSpPr>
                <a:spLocks/>
              </p:cNvSpPr>
              <p:nvPr/>
            </p:nvSpPr>
            <p:spPr bwMode="auto">
              <a:xfrm>
                <a:off x="1074738" y="7165975"/>
                <a:ext cx="2074862" cy="1328738"/>
              </a:xfrm>
              <a:custGeom>
                <a:avLst/>
                <a:gdLst/>
                <a:ahLst/>
                <a:cxnLst>
                  <a:cxn ang="0">
                    <a:pos x="15" y="837"/>
                  </a:cxn>
                  <a:cxn ang="0">
                    <a:pos x="41" y="837"/>
                  </a:cxn>
                  <a:cxn ang="0">
                    <a:pos x="66" y="837"/>
                  </a:cxn>
                  <a:cxn ang="0">
                    <a:pos x="92" y="825"/>
                  </a:cxn>
                  <a:cxn ang="0">
                    <a:pos x="117" y="837"/>
                  </a:cxn>
                  <a:cxn ang="0">
                    <a:pos x="143" y="825"/>
                  </a:cxn>
                  <a:cxn ang="0">
                    <a:pos x="168" y="837"/>
                  </a:cxn>
                  <a:cxn ang="0">
                    <a:pos x="194" y="825"/>
                  </a:cxn>
                  <a:cxn ang="0">
                    <a:pos x="219" y="825"/>
                  </a:cxn>
                  <a:cxn ang="0">
                    <a:pos x="245" y="825"/>
                  </a:cxn>
                  <a:cxn ang="0">
                    <a:pos x="270" y="753"/>
                  </a:cxn>
                  <a:cxn ang="0">
                    <a:pos x="296" y="765"/>
                  </a:cxn>
                  <a:cxn ang="0">
                    <a:pos x="321" y="693"/>
                  </a:cxn>
                  <a:cxn ang="0">
                    <a:pos x="347" y="753"/>
                  </a:cxn>
                  <a:cxn ang="0">
                    <a:pos x="372" y="693"/>
                  </a:cxn>
                  <a:cxn ang="0">
                    <a:pos x="398" y="705"/>
                  </a:cxn>
                  <a:cxn ang="0">
                    <a:pos x="424" y="670"/>
                  </a:cxn>
                  <a:cxn ang="0">
                    <a:pos x="449" y="574"/>
                  </a:cxn>
                  <a:cxn ang="0">
                    <a:pos x="475" y="646"/>
                  </a:cxn>
                  <a:cxn ang="0">
                    <a:pos x="500" y="717"/>
                  </a:cxn>
                  <a:cxn ang="0">
                    <a:pos x="526" y="693"/>
                  </a:cxn>
                  <a:cxn ang="0">
                    <a:pos x="551" y="693"/>
                  </a:cxn>
                  <a:cxn ang="0">
                    <a:pos x="577" y="681"/>
                  </a:cxn>
                  <a:cxn ang="0">
                    <a:pos x="602" y="634"/>
                  </a:cxn>
                  <a:cxn ang="0">
                    <a:pos x="628" y="729"/>
                  </a:cxn>
                  <a:cxn ang="0">
                    <a:pos x="653" y="598"/>
                  </a:cxn>
                  <a:cxn ang="0">
                    <a:pos x="679" y="693"/>
                  </a:cxn>
                  <a:cxn ang="0">
                    <a:pos x="704" y="658"/>
                  </a:cxn>
                  <a:cxn ang="0">
                    <a:pos x="730" y="538"/>
                  </a:cxn>
                  <a:cxn ang="0">
                    <a:pos x="755" y="526"/>
                  </a:cxn>
                  <a:cxn ang="0">
                    <a:pos x="781" y="526"/>
                  </a:cxn>
                  <a:cxn ang="0">
                    <a:pos x="807" y="431"/>
                  </a:cxn>
                  <a:cxn ang="0">
                    <a:pos x="832" y="490"/>
                  </a:cxn>
                  <a:cxn ang="0">
                    <a:pos x="858" y="335"/>
                  </a:cxn>
                  <a:cxn ang="0">
                    <a:pos x="883" y="251"/>
                  </a:cxn>
                  <a:cxn ang="0">
                    <a:pos x="909" y="227"/>
                  </a:cxn>
                  <a:cxn ang="0">
                    <a:pos x="934" y="180"/>
                  </a:cxn>
                  <a:cxn ang="0">
                    <a:pos x="960" y="227"/>
                  </a:cxn>
                  <a:cxn ang="0">
                    <a:pos x="985" y="132"/>
                  </a:cxn>
                  <a:cxn ang="0">
                    <a:pos x="1011" y="0"/>
                  </a:cxn>
                  <a:cxn ang="0">
                    <a:pos x="1036" y="287"/>
                  </a:cxn>
                  <a:cxn ang="0">
                    <a:pos x="1062" y="216"/>
                  </a:cxn>
                  <a:cxn ang="0">
                    <a:pos x="1087" y="502"/>
                  </a:cxn>
                  <a:cxn ang="0">
                    <a:pos x="1113" y="550"/>
                  </a:cxn>
                  <a:cxn ang="0">
                    <a:pos x="1139" y="693"/>
                  </a:cxn>
                  <a:cxn ang="0">
                    <a:pos x="1164" y="789"/>
                  </a:cxn>
                  <a:cxn ang="0">
                    <a:pos x="1189" y="837"/>
                  </a:cxn>
                  <a:cxn ang="0">
                    <a:pos x="1215" y="837"/>
                  </a:cxn>
                  <a:cxn ang="0">
                    <a:pos x="1240" y="837"/>
                  </a:cxn>
                  <a:cxn ang="0">
                    <a:pos x="1266" y="837"/>
                  </a:cxn>
                  <a:cxn ang="0">
                    <a:pos x="1292" y="837"/>
                  </a:cxn>
                </a:cxnLst>
                <a:rect l="0" t="0" r="r" b="b"/>
                <a:pathLst>
                  <a:path w="1307" h="837">
                    <a:moveTo>
                      <a:pt x="0" y="837"/>
                    </a:moveTo>
                    <a:lnTo>
                      <a:pt x="0" y="813"/>
                    </a:lnTo>
                    <a:lnTo>
                      <a:pt x="5" y="837"/>
                    </a:lnTo>
                    <a:lnTo>
                      <a:pt x="10" y="837"/>
                    </a:lnTo>
                    <a:lnTo>
                      <a:pt x="15" y="837"/>
                    </a:lnTo>
                    <a:lnTo>
                      <a:pt x="20" y="837"/>
                    </a:lnTo>
                    <a:lnTo>
                      <a:pt x="25" y="837"/>
                    </a:lnTo>
                    <a:lnTo>
                      <a:pt x="30" y="837"/>
                    </a:lnTo>
                    <a:lnTo>
                      <a:pt x="35" y="837"/>
                    </a:lnTo>
                    <a:lnTo>
                      <a:pt x="41" y="837"/>
                    </a:lnTo>
                    <a:lnTo>
                      <a:pt x="46" y="837"/>
                    </a:lnTo>
                    <a:lnTo>
                      <a:pt x="51" y="837"/>
                    </a:lnTo>
                    <a:lnTo>
                      <a:pt x="56" y="837"/>
                    </a:lnTo>
                    <a:lnTo>
                      <a:pt x="61" y="837"/>
                    </a:lnTo>
                    <a:lnTo>
                      <a:pt x="66" y="837"/>
                    </a:lnTo>
                    <a:lnTo>
                      <a:pt x="71" y="837"/>
                    </a:lnTo>
                    <a:lnTo>
                      <a:pt x="76" y="837"/>
                    </a:lnTo>
                    <a:lnTo>
                      <a:pt x="82" y="825"/>
                    </a:lnTo>
                    <a:lnTo>
                      <a:pt x="87" y="837"/>
                    </a:lnTo>
                    <a:lnTo>
                      <a:pt x="92" y="825"/>
                    </a:lnTo>
                    <a:lnTo>
                      <a:pt x="97" y="837"/>
                    </a:lnTo>
                    <a:lnTo>
                      <a:pt x="102" y="837"/>
                    </a:lnTo>
                    <a:lnTo>
                      <a:pt x="107" y="837"/>
                    </a:lnTo>
                    <a:lnTo>
                      <a:pt x="112" y="825"/>
                    </a:lnTo>
                    <a:lnTo>
                      <a:pt x="117" y="837"/>
                    </a:lnTo>
                    <a:lnTo>
                      <a:pt x="122" y="837"/>
                    </a:lnTo>
                    <a:lnTo>
                      <a:pt x="127" y="837"/>
                    </a:lnTo>
                    <a:lnTo>
                      <a:pt x="132" y="837"/>
                    </a:lnTo>
                    <a:lnTo>
                      <a:pt x="138" y="837"/>
                    </a:lnTo>
                    <a:lnTo>
                      <a:pt x="143" y="825"/>
                    </a:lnTo>
                    <a:lnTo>
                      <a:pt x="148" y="837"/>
                    </a:lnTo>
                    <a:lnTo>
                      <a:pt x="153" y="837"/>
                    </a:lnTo>
                    <a:lnTo>
                      <a:pt x="158" y="837"/>
                    </a:lnTo>
                    <a:lnTo>
                      <a:pt x="163" y="825"/>
                    </a:lnTo>
                    <a:lnTo>
                      <a:pt x="168" y="837"/>
                    </a:lnTo>
                    <a:lnTo>
                      <a:pt x="173" y="825"/>
                    </a:lnTo>
                    <a:lnTo>
                      <a:pt x="179" y="825"/>
                    </a:lnTo>
                    <a:lnTo>
                      <a:pt x="184" y="825"/>
                    </a:lnTo>
                    <a:lnTo>
                      <a:pt x="189" y="825"/>
                    </a:lnTo>
                    <a:lnTo>
                      <a:pt x="194" y="825"/>
                    </a:lnTo>
                    <a:lnTo>
                      <a:pt x="199" y="825"/>
                    </a:lnTo>
                    <a:lnTo>
                      <a:pt x="204" y="813"/>
                    </a:lnTo>
                    <a:lnTo>
                      <a:pt x="209" y="801"/>
                    </a:lnTo>
                    <a:lnTo>
                      <a:pt x="214" y="825"/>
                    </a:lnTo>
                    <a:lnTo>
                      <a:pt x="219" y="825"/>
                    </a:lnTo>
                    <a:lnTo>
                      <a:pt x="224" y="825"/>
                    </a:lnTo>
                    <a:lnTo>
                      <a:pt x="230" y="825"/>
                    </a:lnTo>
                    <a:lnTo>
                      <a:pt x="235" y="813"/>
                    </a:lnTo>
                    <a:lnTo>
                      <a:pt x="240" y="789"/>
                    </a:lnTo>
                    <a:lnTo>
                      <a:pt x="245" y="825"/>
                    </a:lnTo>
                    <a:lnTo>
                      <a:pt x="250" y="777"/>
                    </a:lnTo>
                    <a:lnTo>
                      <a:pt x="255" y="753"/>
                    </a:lnTo>
                    <a:lnTo>
                      <a:pt x="260" y="825"/>
                    </a:lnTo>
                    <a:lnTo>
                      <a:pt x="265" y="765"/>
                    </a:lnTo>
                    <a:lnTo>
                      <a:pt x="270" y="753"/>
                    </a:lnTo>
                    <a:lnTo>
                      <a:pt x="275" y="777"/>
                    </a:lnTo>
                    <a:lnTo>
                      <a:pt x="281" y="753"/>
                    </a:lnTo>
                    <a:lnTo>
                      <a:pt x="286" y="801"/>
                    </a:lnTo>
                    <a:lnTo>
                      <a:pt x="291" y="813"/>
                    </a:lnTo>
                    <a:lnTo>
                      <a:pt x="296" y="765"/>
                    </a:lnTo>
                    <a:lnTo>
                      <a:pt x="301" y="705"/>
                    </a:lnTo>
                    <a:lnTo>
                      <a:pt x="306" y="813"/>
                    </a:lnTo>
                    <a:lnTo>
                      <a:pt x="311" y="777"/>
                    </a:lnTo>
                    <a:lnTo>
                      <a:pt x="316" y="765"/>
                    </a:lnTo>
                    <a:lnTo>
                      <a:pt x="321" y="693"/>
                    </a:lnTo>
                    <a:lnTo>
                      <a:pt x="327" y="729"/>
                    </a:lnTo>
                    <a:lnTo>
                      <a:pt x="332" y="765"/>
                    </a:lnTo>
                    <a:lnTo>
                      <a:pt x="337" y="717"/>
                    </a:lnTo>
                    <a:lnTo>
                      <a:pt x="342" y="777"/>
                    </a:lnTo>
                    <a:lnTo>
                      <a:pt x="347" y="753"/>
                    </a:lnTo>
                    <a:lnTo>
                      <a:pt x="352" y="705"/>
                    </a:lnTo>
                    <a:lnTo>
                      <a:pt x="357" y="717"/>
                    </a:lnTo>
                    <a:lnTo>
                      <a:pt x="362" y="705"/>
                    </a:lnTo>
                    <a:lnTo>
                      <a:pt x="367" y="646"/>
                    </a:lnTo>
                    <a:lnTo>
                      <a:pt x="372" y="693"/>
                    </a:lnTo>
                    <a:lnTo>
                      <a:pt x="378" y="753"/>
                    </a:lnTo>
                    <a:lnTo>
                      <a:pt x="383" y="741"/>
                    </a:lnTo>
                    <a:lnTo>
                      <a:pt x="388" y="634"/>
                    </a:lnTo>
                    <a:lnTo>
                      <a:pt x="393" y="693"/>
                    </a:lnTo>
                    <a:lnTo>
                      <a:pt x="398" y="705"/>
                    </a:lnTo>
                    <a:lnTo>
                      <a:pt x="403" y="670"/>
                    </a:lnTo>
                    <a:lnTo>
                      <a:pt x="408" y="693"/>
                    </a:lnTo>
                    <a:lnTo>
                      <a:pt x="413" y="670"/>
                    </a:lnTo>
                    <a:lnTo>
                      <a:pt x="419" y="646"/>
                    </a:lnTo>
                    <a:lnTo>
                      <a:pt x="424" y="670"/>
                    </a:lnTo>
                    <a:lnTo>
                      <a:pt x="429" y="634"/>
                    </a:lnTo>
                    <a:lnTo>
                      <a:pt x="434" y="622"/>
                    </a:lnTo>
                    <a:lnTo>
                      <a:pt x="439" y="765"/>
                    </a:lnTo>
                    <a:lnTo>
                      <a:pt x="444" y="717"/>
                    </a:lnTo>
                    <a:lnTo>
                      <a:pt x="449" y="574"/>
                    </a:lnTo>
                    <a:lnTo>
                      <a:pt x="454" y="681"/>
                    </a:lnTo>
                    <a:lnTo>
                      <a:pt x="459" y="729"/>
                    </a:lnTo>
                    <a:lnTo>
                      <a:pt x="464" y="610"/>
                    </a:lnTo>
                    <a:lnTo>
                      <a:pt x="470" y="646"/>
                    </a:lnTo>
                    <a:lnTo>
                      <a:pt x="475" y="646"/>
                    </a:lnTo>
                    <a:lnTo>
                      <a:pt x="480" y="693"/>
                    </a:lnTo>
                    <a:lnTo>
                      <a:pt x="485" y="693"/>
                    </a:lnTo>
                    <a:lnTo>
                      <a:pt x="490" y="658"/>
                    </a:lnTo>
                    <a:lnTo>
                      <a:pt x="495" y="729"/>
                    </a:lnTo>
                    <a:lnTo>
                      <a:pt x="500" y="717"/>
                    </a:lnTo>
                    <a:lnTo>
                      <a:pt x="505" y="646"/>
                    </a:lnTo>
                    <a:lnTo>
                      <a:pt x="510" y="681"/>
                    </a:lnTo>
                    <a:lnTo>
                      <a:pt x="515" y="705"/>
                    </a:lnTo>
                    <a:lnTo>
                      <a:pt x="521" y="658"/>
                    </a:lnTo>
                    <a:lnTo>
                      <a:pt x="526" y="693"/>
                    </a:lnTo>
                    <a:lnTo>
                      <a:pt x="531" y="681"/>
                    </a:lnTo>
                    <a:lnTo>
                      <a:pt x="536" y="693"/>
                    </a:lnTo>
                    <a:lnTo>
                      <a:pt x="541" y="634"/>
                    </a:lnTo>
                    <a:lnTo>
                      <a:pt x="546" y="729"/>
                    </a:lnTo>
                    <a:lnTo>
                      <a:pt x="551" y="693"/>
                    </a:lnTo>
                    <a:lnTo>
                      <a:pt x="556" y="670"/>
                    </a:lnTo>
                    <a:lnTo>
                      <a:pt x="561" y="717"/>
                    </a:lnTo>
                    <a:lnTo>
                      <a:pt x="567" y="777"/>
                    </a:lnTo>
                    <a:lnTo>
                      <a:pt x="572" y="693"/>
                    </a:lnTo>
                    <a:lnTo>
                      <a:pt x="577" y="681"/>
                    </a:lnTo>
                    <a:lnTo>
                      <a:pt x="582" y="717"/>
                    </a:lnTo>
                    <a:lnTo>
                      <a:pt x="587" y="658"/>
                    </a:lnTo>
                    <a:lnTo>
                      <a:pt x="592" y="681"/>
                    </a:lnTo>
                    <a:lnTo>
                      <a:pt x="597" y="753"/>
                    </a:lnTo>
                    <a:lnTo>
                      <a:pt x="602" y="634"/>
                    </a:lnTo>
                    <a:lnTo>
                      <a:pt x="607" y="598"/>
                    </a:lnTo>
                    <a:lnTo>
                      <a:pt x="612" y="693"/>
                    </a:lnTo>
                    <a:lnTo>
                      <a:pt x="618" y="646"/>
                    </a:lnTo>
                    <a:lnTo>
                      <a:pt x="623" y="729"/>
                    </a:lnTo>
                    <a:lnTo>
                      <a:pt x="628" y="729"/>
                    </a:lnTo>
                    <a:lnTo>
                      <a:pt x="633" y="681"/>
                    </a:lnTo>
                    <a:lnTo>
                      <a:pt x="638" y="681"/>
                    </a:lnTo>
                    <a:lnTo>
                      <a:pt x="643" y="634"/>
                    </a:lnTo>
                    <a:lnTo>
                      <a:pt x="648" y="729"/>
                    </a:lnTo>
                    <a:lnTo>
                      <a:pt x="653" y="598"/>
                    </a:lnTo>
                    <a:lnTo>
                      <a:pt x="659" y="634"/>
                    </a:lnTo>
                    <a:lnTo>
                      <a:pt x="664" y="538"/>
                    </a:lnTo>
                    <a:lnTo>
                      <a:pt x="669" y="729"/>
                    </a:lnTo>
                    <a:lnTo>
                      <a:pt x="674" y="670"/>
                    </a:lnTo>
                    <a:lnTo>
                      <a:pt x="679" y="693"/>
                    </a:lnTo>
                    <a:lnTo>
                      <a:pt x="684" y="646"/>
                    </a:lnTo>
                    <a:lnTo>
                      <a:pt x="689" y="741"/>
                    </a:lnTo>
                    <a:lnTo>
                      <a:pt x="694" y="622"/>
                    </a:lnTo>
                    <a:lnTo>
                      <a:pt x="699" y="622"/>
                    </a:lnTo>
                    <a:lnTo>
                      <a:pt x="704" y="658"/>
                    </a:lnTo>
                    <a:lnTo>
                      <a:pt x="710" y="598"/>
                    </a:lnTo>
                    <a:lnTo>
                      <a:pt x="715" y="538"/>
                    </a:lnTo>
                    <a:lnTo>
                      <a:pt x="720" y="574"/>
                    </a:lnTo>
                    <a:lnTo>
                      <a:pt x="725" y="586"/>
                    </a:lnTo>
                    <a:lnTo>
                      <a:pt x="730" y="538"/>
                    </a:lnTo>
                    <a:lnTo>
                      <a:pt x="735" y="490"/>
                    </a:lnTo>
                    <a:lnTo>
                      <a:pt x="740" y="550"/>
                    </a:lnTo>
                    <a:lnTo>
                      <a:pt x="745" y="610"/>
                    </a:lnTo>
                    <a:lnTo>
                      <a:pt x="750" y="634"/>
                    </a:lnTo>
                    <a:lnTo>
                      <a:pt x="755" y="526"/>
                    </a:lnTo>
                    <a:lnTo>
                      <a:pt x="761" y="574"/>
                    </a:lnTo>
                    <a:lnTo>
                      <a:pt x="766" y="610"/>
                    </a:lnTo>
                    <a:lnTo>
                      <a:pt x="771" y="466"/>
                    </a:lnTo>
                    <a:lnTo>
                      <a:pt x="776" y="443"/>
                    </a:lnTo>
                    <a:lnTo>
                      <a:pt x="781" y="526"/>
                    </a:lnTo>
                    <a:lnTo>
                      <a:pt x="786" y="526"/>
                    </a:lnTo>
                    <a:lnTo>
                      <a:pt x="791" y="419"/>
                    </a:lnTo>
                    <a:lnTo>
                      <a:pt x="796" y="478"/>
                    </a:lnTo>
                    <a:lnTo>
                      <a:pt x="801" y="478"/>
                    </a:lnTo>
                    <a:lnTo>
                      <a:pt x="807" y="431"/>
                    </a:lnTo>
                    <a:lnTo>
                      <a:pt x="812" y="490"/>
                    </a:lnTo>
                    <a:lnTo>
                      <a:pt x="817" y="502"/>
                    </a:lnTo>
                    <a:lnTo>
                      <a:pt x="822" y="502"/>
                    </a:lnTo>
                    <a:lnTo>
                      <a:pt x="827" y="383"/>
                    </a:lnTo>
                    <a:lnTo>
                      <a:pt x="832" y="490"/>
                    </a:lnTo>
                    <a:lnTo>
                      <a:pt x="837" y="216"/>
                    </a:lnTo>
                    <a:lnTo>
                      <a:pt x="842" y="454"/>
                    </a:lnTo>
                    <a:lnTo>
                      <a:pt x="847" y="347"/>
                    </a:lnTo>
                    <a:lnTo>
                      <a:pt x="852" y="443"/>
                    </a:lnTo>
                    <a:lnTo>
                      <a:pt x="858" y="335"/>
                    </a:lnTo>
                    <a:lnTo>
                      <a:pt x="863" y="323"/>
                    </a:lnTo>
                    <a:lnTo>
                      <a:pt x="868" y="24"/>
                    </a:lnTo>
                    <a:lnTo>
                      <a:pt x="873" y="383"/>
                    </a:lnTo>
                    <a:lnTo>
                      <a:pt x="878" y="323"/>
                    </a:lnTo>
                    <a:lnTo>
                      <a:pt x="883" y="251"/>
                    </a:lnTo>
                    <a:lnTo>
                      <a:pt x="888" y="108"/>
                    </a:lnTo>
                    <a:lnTo>
                      <a:pt x="893" y="251"/>
                    </a:lnTo>
                    <a:lnTo>
                      <a:pt x="899" y="263"/>
                    </a:lnTo>
                    <a:lnTo>
                      <a:pt x="904" y="287"/>
                    </a:lnTo>
                    <a:lnTo>
                      <a:pt x="909" y="227"/>
                    </a:lnTo>
                    <a:lnTo>
                      <a:pt x="914" y="180"/>
                    </a:lnTo>
                    <a:lnTo>
                      <a:pt x="919" y="120"/>
                    </a:lnTo>
                    <a:lnTo>
                      <a:pt x="924" y="108"/>
                    </a:lnTo>
                    <a:lnTo>
                      <a:pt x="929" y="72"/>
                    </a:lnTo>
                    <a:lnTo>
                      <a:pt x="934" y="180"/>
                    </a:lnTo>
                    <a:lnTo>
                      <a:pt x="939" y="84"/>
                    </a:lnTo>
                    <a:lnTo>
                      <a:pt x="944" y="168"/>
                    </a:lnTo>
                    <a:lnTo>
                      <a:pt x="950" y="72"/>
                    </a:lnTo>
                    <a:lnTo>
                      <a:pt x="955" y="120"/>
                    </a:lnTo>
                    <a:lnTo>
                      <a:pt x="960" y="227"/>
                    </a:lnTo>
                    <a:lnTo>
                      <a:pt x="965" y="84"/>
                    </a:lnTo>
                    <a:lnTo>
                      <a:pt x="970" y="168"/>
                    </a:lnTo>
                    <a:lnTo>
                      <a:pt x="975" y="36"/>
                    </a:lnTo>
                    <a:lnTo>
                      <a:pt x="980" y="144"/>
                    </a:lnTo>
                    <a:lnTo>
                      <a:pt x="985" y="132"/>
                    </a:lnTo>
                    <a:lnTo>
                      <a:pt x="990" y="60"/>
                    </a:lnTo>
                    <a:lnTo>
                      <a:pt x="995" y="168"/>
                    </a:lnTo>
                    <a:lnTo>
                      <a:pt x="1000" y="120"/>
                    </a:lnTo>
                    <a:lnTo>
                      <a:pt x="1006" y="192"/>
                    </a:lnTo>
                    <a:lnTo>
                      <a:pt x="1011" y="0"/>
                    </a:lnTo>
                    <a:lnTo>
                      <a:pt x="1016" y="132"/>
                    </a:lnTo>
                    <a:lnTo>
                      <a:pt x="1021" y="287"/>
                    </a:lnTo>
                    <a:lnTo>
                      <a:pt x="1026" y="144"/>
                    </a:lnTo>
                    <a:lnTo>
                      <a:pt x="1031" y="263"/>
                    </a:lnTo>
                    <a:lnTo>
                      <a:pt x="1036" y="287"/>
                    </a:lnTo>
                    <a:lnTo>
                      <a:pt x="1041" y="311"/>
                    </a:lnTo>
                    <a:lnTo>
                      <a:pt x="1047" y="335"/>
                    </a:lnTo>
                    <a:lnTo>
                      <a:pt x="1052" y="275"/>
                    </a:lnTo>
                    <a:lnTo>
                      <a:pt x="1057" y="359"/>
                    </a:lnTo>
                    <a:lnTo>
                      <a:pt x="1062" y="216"/>
                    </a:lnTo>
                    <a:lnTo>
                      <a:pt x="1067" y="478"/>
                    </a:lnTo>
                    <a:lnTo>
                      <a:pt x="1072" y="383"/>
                    </a:lnTo>
                    <a:lnTo>
                      <a:pt x="1077" y="419"/>
                    </a:lnTo>
                    <a:lnTo>
                      <a:pt x="1082" y="419"/>
                    </a:lnTo>
                    <a:lnTo>
                      <a:pt x="1087" y="502"/>
                    </a:lnTo>
                    <a:lnTo>
                      <a:pt x="1092" y="574"/>
                    </a:lnTo>
                    <a:lnTo>
                      <a:pt x="1098" y="634"/>
                    </a:lnTo>
                    <a:lnTo>
                      <a:pt x="1103" y="538"/>
                    </a:lnTo>
                    <a:lnTo>
                      <a:pt x="1108" y="526"/>
                    </a:lnTo>
                    <a:lnTo>
                      <a:pt x="1113" y="550"/>
                    </a:lnTo>
                    <a:lnTo>
                      <a:pt x="1118" y="622"/>
                    </a:lnTo>
                    <a:lnTo>
                      <a:pt x="1123" y="610"/>
                    </a:lnTo>
                    <a:lnTo>
                      <a:pt x="1128" y="634"/>
                    </a:lnTo>
                    <a:lnTo>
                      <a:pt x="1133" y="658"/>
                    </a:lnTo>
                    <a:lnTo>
                      <a:pt x="1139" y="693"/>
                    </a:lnTo>
                    <a:lnTo>
                      <a:pt x="1144" y="777"/>
                    </a:lnTo>
                    <a:lnTo>
                      <a:pt x="1149" y="753"/>
                    </a:lnTo>
                    <a:lnTo>
                      <a:pt x="1154" y="777"/>
                    </a:lnTo>
                    <a:lnTo>
                      <a:pt x="1159" y="753"/>
                    </a:lnTo>
                    <a:lnTo>
                      <a:pt x="1164" y="789"/>
                    </a:lnTo>
                    <a:lnTo>
                      <a:pt x="1169" y="777"/>
                    </a:lnTo>
                    <a:lnTo>
                      <a:pt x="1174" y="813"/>
                    </a:lnTo>
                    <a:lnTo>
                      <a:pt x="1179" y="789"/>
                    </a:lnTo>
                    <a:lnTo>
                      <a:pt x="1184" y="825"/>
                    </a:lnTo>
                    <a:lnTo>
                      <a:pt x="1189" y="837"/>
                    </a:lnTo>
                    <a:lnTo>
                      <a:pt x="1195" y="813"/>
                    </a:lnTo>
                    <a:lnTo>
                      <a:pt x="1200" y="825"/>
                    </a:lnTo>
                    <a:lnTo>
                      <a:pt x="1205" y="825"/>
                    </a:lnTo>
                    <a:lnTo>
                      <a:pt x="1210" y="837"/>
                    </a:lnTo>
                    <a:lnTo>
                      <a:pt x="1215" y="837"/>
                    </a:lnTo>
                    <a:lnTo>
                      <a:pt x="1220" y="837"/>
                    </a:lnTo>
                    <a:lnTo>
                      <a:pt x="1225" y="837"/>
                    </a:lnTo>
                    <a:lnTo>
                      <a:pt x="1230" y="837"/>
                    </a:lnTo>
                    <a:lnTo>
                      <a:pt x="1235" y="837"/>
                    </a:lnTo>
                    <a:lnTo>
                      <a:pt x="1240" y="837"/>
                    </a:lnTo>
                    <a:lnTo>
                      <a:pt x="1246" y="837"/>
                    </a:lnTo>
                    <a:lnTo>
                      <a:pt x="1251" y="837"/>
                    </a:lnTo>
                    <a:lnTo>
                      <a:pt x="1256" y="837"/>
                    </a:lnTo>
                    <a:lnTo>
                      <a:pt x="1261" y="837"/>
                    </a:lnTo>
                    <a:lnTo>
                      <a:pt x="1266" y="837"/>
                    </a:lnTo>
                    <a:lnTo>
                      <a:pt x="1271" y="837"/>
                    </a:lnTo>
                    <a:lnTo>
                      <a:pt x="1276" y="837"/>
                    </a:lnTo>
                    <a:lnTo>
                      <a:pt x="1281" y="837"/>
                    </a:lnTo>
                    <a:lnTo>
                      <a:pt x="1287" y="837"/>
                    </a:lnTo>
                    <a:lnTo>
                      <a:pt x="1292" y="837"/>
                    </a:lnTo>
                    <a:lnTo>
                      <a:pt x="1297" y="837"/>
                    </a:lnTo>
                    <a:lnTo>
                      <a:pt x="1302" y="837"/>
                    </a:lnTo>
                    <a:lnTo>
                      <a:pt x="1307" y="837"/>
                    </a:lnTo>
                    <a:lnTo>
                      <a:pt x="0" y="837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53" name="Freeform 184"/>
              <p:cNvSpPr>
                <a:spLocks/>
              </p:cNvSpPr>
              <p:nvPr/>
            </p:nvSpPr>
            <p:spPr bwMode="auto">
              <a:xfrm flipV="1">
                <a:off x="1206431" y="6927682"/>
                <a:ext cx="1057344" cy="584366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399"/>
                  </a:cxn>
                  <a:cxn ang="0">
                    <a:pos x="2822" y="2399"/>
                  </a:cxn>
                  <a:cxn ang="0">
                    <a:pos x="2822" y="0"/>
                  </a:cxn>
                </a:cxnLst>
                <a:rect l="0" t="0" r="r" b="b"/>
                <a:pathLst>
                  <a:path w="2822" h="2399">
                    <a:moveTo>
                      <a:pt x="0" y="0"/>
                    </a:moveTo>
                    <a:lnTo>
                      <a:pt x="0" y="2399"/>
                    </a:lnTo>
                    <a:lnTo>
                      <a:pt x="2822" y="2399"/>
                    </a:lnTo>
                    <a:lnTo>
                      <a:pt x="2822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255" name="Rectangle 186"/>
              <p:cNvSpPr>
                <a:spLocks noChangeArrowheads="1"/>
              </p:cNvSpPr>
              <p:nvPr/>
            </p:nvSpPr>
            <p:spPr bwMode="auto">
              <a:xfrm>
                <a:off x="1074738" y="6502400"/>
                <a:ext cx="2074862" cy="1992313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cxnSp>
          <p:nvCxnSpPr>
            <p:cNvPr id="261" name="Rechte verbindingslijn met pijl 260"/>
            <p:cNvCxnSpPr/>
            <p:nvPr/>
          </p:nvCxnSpPr>
          <p:spPr>
            <a:xfrm>
              <a:off x="3131840" y="4896619"/>
              <a:ext cx="46526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Rechte verbindingslijn met pijl 261"/>
            <p:cNvCxnSpPr/>
            <p:nvPr/>
          </p:nvCxnSpPr>
          <p:spPr>
            <a:xfrm>
              <a:off x="3131840" y="6552803"/>
              <a:ext cx="465267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96" name="Groep 295"/>
            <p:cNvGrpSpPr/>
            <p:nvPr/>
          </p:nvGrpSpPr>
          <p:grpSpPr>
            <a:xfrm>
              <a:off x="3635896" y="4253765"/>
              <a:ext cx="1163039" cy="1191023"/>
              <a:chOff x="4824413" y="6502400"/>
              <a:chExt cx="2368550" cy="2297113"/>
            </a:xfrm>
          </p:grpSpPr>
          <p:sp>
            <p:nvSpPr>
              <p:cNvPr id="58586" name="Freeform 218"/>
              <p:cNvSpPr>
                <a:spLocks/>
              </p:cNvSpPr>
              <p:nvPr/>
            </p:nvSpPr>
            <p:spPr bwMode="auto">
              <a:xfrm>
                <a:off x="4824413" y="7354888"/>
                <a:ext cx="2368550" cy="1444625"/>
              </a:xfrm>
              <a:custGeom>
                <a:avLst/>
                <a:gdLst/>
                <a:ahLst/>
                <a:cxnLst>
                  <a:cxn ang="0">
                    <a:pos x="17" y="910"/>
                  </a:cxn>
                  <a:cxn ang="0">
                    <a:pos x="46" y="910"/>
                  </a:cxn>
                  <a:cxn ang="0">
                    <a:pos x="75" y="910"/>
                  </a:cxn>
                  <a:cxn ang="0">
                    <a:pos x="105" y="910"/>
                  </a:cxn>
                  <a:cxn ang="0">
                    <a:pos x="134" y="910"/>
                  </a:cxn>
                  <a:cxn ang="0">
                    <a:pos x="163" y="910"/>
                  </a:cxn>
                  <a:cxn ang="0">
                    <a:pos x="192" y="910"/>
                  </a:cxn>
                  <a:cxn ang="0">
                    <a:pos x="221" y="910"/>
                  </a:cxn>
                  <a:cxn ang="0">
                    <a:pos x="250" y="910"/>
                  </a:cxn>
                  <a:cxn ang="0">
                    <a:pos x="279" y="910"/>
                  </a:cxn>
                  <a:cxn ang="0">
                    <a:pos x="309" y="786"/>
                  </a:cxn>
                  <a:cxn ang="0">
                    <a:pos x="338" y="869"/>
                  </a:cxn>
                  <a:cxn ang="0">
                    <a:pos x="367" y="703"/>
                  </a:cxn>
                  <a:cxn ang="0">
                    <a:pos x="396" y="497"/>
                  </a:cxn>
                  <a:cxn ang="0">
                    <a:pos x="425" y="579"/>
                  </a:cxn>
                  <a:cxn ang="0">
                    <a:pos x="454" y="538"/>
                  </a:cxn>
                  <a:cxn ang="0">
                    <a:pos x="484" y="579"/>
                  </a:cxn>
                  <a:cxn ang="0">
                    <a:pos x="513" y="579"/>
                  </a:cxn>
                  <a:cxn ang="0">
                    <a:pos x="542" y="786"/>
                  </a:cxn>
                  <a:cxn ang="0">
                    <a:pos x="571" y="662"/>
                  </a:cxn>
                  <a:cxn ang="0">
                    <a:pos x="600" y="703"/>
                  </a:cxn>
                  <a:cxn ang="0">
                    <a:pos x="629" y="703"/>
                  </a:cxn>
                  <a:cxn ang="0">
                    <a:pos x="659" y="744"/>
                  </a:cxn>
                  <a:cxn ang="0">
                    <a:pos x="688" y="621"/>
                  </a:cxn>
                  <a:cxn ang="0">
                    <a:pos x="717" y="579"/>
                  </a:cxn>
                  <a:cxn ang="0">
                    <a:pos x="746" y="579"/>
                  </a:cxn>
                  <a:cxn ang="0">
                    <a:pos x="775" y="455"/>
                  </a:cxn>
                  <a:cxn ang="0">
                    <a:pos x="804" y="538"/>
                  </a:cxn>
                  <a:cxn ang="0">
                    <a:pos x="833" y="621"/>
                  </a:cxn>
                  <a:cxn ang="0">
                    <a:pos x="863" y="42"/>
                  </a:cxn>
                  <a:cxn ang="0">
                    <a:pos x="892" y="248"/>
                  </a:cxn>
                  <a:cxn ang="0">
                    <a:pos x="921" y="331"/>
                  </a:cxn>
                  <a:cxn ang="0">
                    <a:pos x="950" y="166"/>
                  </a:cxn>
                  <a:cxn ang="0">
                    <a:pos x="979" y="372"/>
                  </a:cxn>
                  <a:cxn ang="0">
                    <a:pos x="1008" y="331"/>
                  </a:cxn>
                  <a:cxn ang="0">
                    <a:pos x="1037" y="497"/>
                  </a:cxn>
                  <a:cxn ang="0">
                    <a:pos x="1067" y="579"/>
                  </a:cxn>
                  <a:cxn ang="0">
                    <a:pos x="1096" y="662"/>
                  </a:cxn>
                  <a:cxn ang="0">
                    <a:pos x="1125" y="744"/>
                  </a:cxn>
                  <a:cxn ang="0">
                    <a:pos x="1154" y="869"/>
                  </a:cxn>
                  <a:cxn ang="0">
                    <a:pos x="1183" y="869"/>
                  </a:cxn>
                  <a:cxn ang="0">
                    <a:pos x="1212" y="869"/>
                  </a:cxn>
                  <a:cxn ang="0">
                    <a:pos x="1241" y="910"/>
                  </a:cxn>
                  <a:cxn ang="0">
                    <a:pos x="1271" y="910"/>
                  </a:cxn>
                  <a:cxn ang="0">
                    <a:pos x="1300" y="910"/>
                  </a:cxn>
                  <a:cxn ang="0">
                    <a:pos x="1329" y="910"/>
                  </a:cxn>
                  <a:cxn ang="0">
                    <a:pos x="1358" y="910"/>
                  </a:cxn>
                  <a:cxn ang="0">
                    <a:pos x="1387" y="910"/>
                  </a:cxn>
                  <a:cxn ang="0">
                    <a:pos x="1416" y="910"/>
                  </a:cxn>
                  <a:cxn ang="0">
                    <a:pos x="1445" y="910"/>
                  </a:cxn>
                  <a:cxn ang="0">
                    <a:pos x="1475" y="910"/>
                  </a:cxn>
                </a:cxnLst>
                <a:rect l="0" t="0" r="r" b="b"/>
                <a:pathLst>
                  <a:path w="1492" h="910">
                    <a:moveTo>
                      <a:pt x="0" y="910"/>
                    </a:moveTo>
                    <a:lnTo>
                      <a:pt x="0" y="910"/>
                    </a:lnTo>
                    <a:lnTo>
                      <a:pt x="5" y="910"/>
                    </a:lnTo>
                    <a:lnTo>
                      <a:pt x="11" y="910"/>
                    </a:lnTo>
                    <a:lnTo>
                      <a:pt x="17" y="910"/>
                    </a:lnTo>
                    <a:lnTo>
                      <a:pt x="23" y="910"/>
                    </a:lnTo>
                    <a:lnTo>
                      <a:pt x="29" y="910"/>
                    </a:lnTo>
                    <a:lnTo>
                      <a:pt x="35" y="910"/>
                    </a:lnTo>
                    <a:lnTo>
                      <a:pt x="40" y="910"/>
                    </a:lnTo>
                    <a:lnTo>
                      <a:pt x="46" y="910"/>
                    </a:lnTo>
                    <a:lnTo>
                      <a:pt x="52" y="910"/>
                    </a:lnTo>
                    <a:lnTo>
                      <a:pt x="58" y="910"/>
                    </a:lnTo>
                    <a:lnTo>
                      <a:pt x="64" y="910"/>
                    </a:lnTo>
                    <a:lnTo>
                      <a:pt x="70" y="910"/>
                    </a:lnTo>
                    <a:lnTo>
                      <a:pt x="75" y="910"/>
                    </a:lnTo>
                    <a:lnTo>
                      <a:pt x="81" y="910"/>
                    </a:lnTo>
                    <a:lnTo>
                      <a:pt x="87" y="910"/>
                    </a:lnTo>
                    <a:lnTo>
                      <a:pt x="93" y="910"/>
                    </a:lnTo>
                    <a:lnTo>
                      <a:pt x="99" y="910"/>
                    </a:lnTo>
                    <a:lnTo>
                      <a:pt x="105" y="910"/>
                    </a:lnTo>
                    <a:lnTo>
                      <a:pt x="110" y="910"/>
                    </a:lnTo>
                    <a:lnTo>
                      <a:pt x="116" y="910"/>
                    </a:lnTo>
                    <a:lnTo>
                      <a:pt x="122" y="910"/>
                    </a:lnTo>
                    <a:lnTo>
                      <a:pt x="128" y="910"/>
                    </a:lnTo>
                    <a:lnTo>
                      <a:pt x="134" y="910"/>
                    </a:lnTo>
                    <a:lnTo>
                      <a:pt x="140" y="910"/>
                    </a:lnTo>
                    <a:lnTo>
                      <a:pt x="145" y="910"/>
                    </a:lnTo>
                    <a:lnTo>
                      <a:pt x="151" y="910"/>
                    </a:lnTo>
                    <a:lnTo>
                      <a:pt x="157" y="910"/>
                    </a:lnTo>
                    <a:lnTo>
                      <a:pt x="163" y="910"/>
                    </a:lnTo>
                    <a:lnTo>
                      <a:pt x="169" y="910"/>
                    </a:lnTo>
                    <a:lnTo>
                      <a:pt x="175" y="910"/>
                    </a:lnTo>
                    <a:lnTo>
                      <a:pt x="180" y="910"/>
                    </a:lnTo>
                    <a:lnTo>
                      <a:pt x="186" y="910"/>
                    </a:lnTo>
                    <a:lnTo>
                      <a:pt x="192" y="910"/>
                    </a:lnTo>
                    <a:lnTo>
                      <a:pt x="198" y="910"/>
                    </a:lnTo>
                    <a:lnTo>
                      <a:pt x="204" y="910"/>
                    </a:lnTo>
                    <a:lnTo>
                      <a:pt x="209" y="910"/>
                    </a:lnTo>
                    <a:lnTo>
                      <a:pt x="215" y="910"/>
                    </a:lnTo>
                    <a:lnTo>
                      <a:pt x="221" y="910"/>
                    </a:lnTo>
                    <a:lnTo>
                      <a:pt x="227" y="910"/>
                    </a:lnTo>
                    <a:lnTo>
                      <a:pt x="233" y="910"/>
                    </a:lnTo>
                    <a:lnTo>
                      <a:pt x="239" y="910"/>
                    </a:lnTo>
                    <a:lnTo>
                      <a:pt x="244" y="869"/>
                    </a:lnTo>
                    <a:lnTo>
                      <a:pt x="250" y="910"/>
                    </a:lnTo>
                    <a:lnTo>
                      <a:pt x="256" y="910"/>
                    </a:lnTo>
                    <a:lnTo>
                      <a:pt x="262" y="910"/>
                    </a:lnTo>
                    <a:lnTo>
                      <a:pt x="268" y="869"/>
                    </a:lnTo>
                    <a:lnTo>
                      <a:pt x="274" y="827"/>
                    </a:lnTo>
                    <a:lnTo>
                      <a:pt x="279" y="910"/>
                    </a:lnTo>
                    <a:lnTo>
                      <a:pt x="285" y="869"/>
                    </a:lnTo>
                    <a:lnTo>
                      <a:pt x="291" y="910"/>
                    </a:lnTo>
                    <a:lnTo>
                      <a:pt x="297" y="827"/>
                    </a:lnTo>
                    <a:lnTo>
                      <a:pt x="303" y="786"/>
                    </a:lnTo>
                    <a:lnTo>
                      <a:pt x="309" y="786"/>
                    </a:lnTo>
                    <a:lnTo>
                      <a:pt x="314" y="869"/>
                    </a:lnTo>
                    <a:lnTo>
                      <a:pt x="320" y="786"/>
                    </a:lnTo>
                    <a:lnTo>
                      <a:pt x="326" y="910"/>
                    </a:lnTo>
                    <a:lnTo>
                      <a:pt x="332" y="786"/>
                    </a:lnTo>
                    <a:lnTo>
                      <a:pt x="338" y="869"/>
                    </a:lnTo>
                    <a:lnTo>
                      <a:pt x="344" y="744"/>
                    </a:lnTo>
                    <a:lnTo>
                      <a:pt x="349" y="744"/>
                    </a:lnTo>
                    <a:lnTo>
                      <a:pt x="355" y="579"/>
                    </a:lnTo>
                    <a:lnTo>
                      <a:pt x="361" y="579"/>
                    </a:lnTo>
                    <a:lnTo>
                      <a:pt x="367" y="703"/>
                    </a:lnTo>
                    <a:lnTo>
                      <a:pt x="373" y="621"/>
                    </a:lnTo>
                    <a:lnTo>
                      <a:pt x="379" y="662"/>
                    </a:lnTo>
                    <a:lnTo>
                      <a:pt x="384" y="662"/>
                    </a:lnTo>
                    <a:lnTo>
                      <a:pt x="390" y="744"/>
                    </a:lnTo>
                    <a:lnTo>
                      <a:pt x="396" y="497"/>
                    </a:lnTo>
                    <a:lnTo>
                      <a:pt x="402" y="414"/>
                    </a:lnTo>
                    <a:lnTo>
                      <a:pt x="408" y="579"/>
                    </a:lnTo>
                    <a:lnTo>
                      <a:pt x="414" y="621"/>
                    </a:lnTo>
                    <a:lnTo>
                      <a:pt x="419" y="538"/>
                    </a:lnTo>
                    <a:lnTo>
                      <a:pt x="425" y="579"/>
                    </a:lnTo>
                    <a:lnTo>
                      <a:pt x="431" y="497"/>
                    </a:lnTo>
                    <a:lnTo>
                      <a:pt x="437" y="414"/>
                    </a:lnTo>
                    <a:lnTo>
                      <a:pt x="443" y="538"/>
                    </a:lnTo>
                    <a:lnTo>
                      <a:pt x="449" y="372"/>
                    </a:lnTo>
                    <a:lnTo>
                      <a:pt x="454" y="538"/>
                    </a:lnTo>
                    <a:lnTo>
                      <a:pt x="460" y="579"/>
                    </a:lnTo>
                    <a:lnTo>
                      <a:pt x="466" y="538"/>
                    </a:lnTo>
                    <a:lnTo>
                      <a:pt x="472" y="372"/>
                    </a:lnTo>
                    <a:lnTo>
                      <a:pt x="478" y="579"/>
                    </a:lnTo>
                    <a:lnTo>
                      <a:pt x="484" y="579"/>
                    </a:lnTo>
                    <a:lnTo>
                      <a:pt x="489" y="538"/>
                    </a:lnTo>
                    <a:lnTo>
                      <a:pt x="495" y="621"/>
                    </a:lnTo>
                    <a:lnTo>
                      <a:pt x="501" y="538"/>
                    </a:lnTo>
                    <a:lnTo>
                      <a:pt x="507" y="497"/>
                    </a:lnTo>
                    <a:lnTo>
                      <a:pt x="513" y="579"/>
                    </a:lnTo>
                    <a:lnTo>
                      <a:pt x="519" y="579"/>
                    </a:lnTo>
                    <a:lnTo>
                      <a:pt x="524" y="703"/>
                    </a:lnTo>
                    <a:lnTo>
                      <a:pt x="530" y="744"/>
                    </a:lnTo>
                    <a:lnTo>
                      <a:pt x="536" y="662"/>
                    </a:lnTo>
                    <a:lnTo>
                      <a:pt x="542" y="786"/>
                    </a:lnTo>
                    <a:lnTo>
                      <a:pt x="548" y="786"/>
                    </a:lnTo>
                    <a:lnTo>
                      <a:pt x="554" y="786"/>
                    </a:lnTo>
                    <a:lnTo>
                      <a:pt x="559" y="786"/>
                    </a:lnTo>
                    <a:lnTo>
                      <a:pt x="565" y="786"/>
                    </a:lnTo>
                    <a:lnTo>
                      <a:pt x="571" y="662"/>
                    </a:lnTo>
                    <a:lnTo>
                      <a:pt x="577" y="786"/>
                    </a:lnTo>
                    <a:lnTo>
                      <a:pt x="583" y="662"/>
                    </a:lnTo>
                    <a:lnTo>
                      <a:pt x="589" y="662"/>
                    </a:lnTo>
                    <a:lnTo>
                      <a:pt x="594" y="662"/>
                    </a:lnTo>
                    <a:lnTo>
                      <a:pt x="600" y="703"/>
                    </a:lnTo>
                    <a:lnTo>
                      <a:pt x="606" y="827"/>
                    </a:lnTo>
                    <a:lnTo>
                      <a:pt x="612" y="827"/>
                    </a:lnTo>
                    <a:lnTo>
                      <a:pt x="618" y="621"/>
                    </a:lnTo>
                    <a:lnTo>
                      <a:pt x="624" y="662"/>
                    </a:lnTo>
                    <a:lnTo>
                      <a:pt x="629" y="703"/>
                    </a:lnTo>
                    <a:lnTo>
                      <a:pt x="635" y="703"/>
                    </a:lnTo>
                    <a:lnTo>
                      <a:pt x="641" y="621"/>
                    </a:lnTo>
                    <a:lnTo>
                      <a:pt x="647" y="662"/>
                    </a:lnTo>
                    <a:lnTo>
                      <a:pt x="653" y="869"/>
                    </a:lnTo>
                    <a:lnTo>
                      <a:pt x="659" y="744"/>
                    </a:lnTo>
                    <a:lnTo>
                      <a:pt x="664" y="579"/>
                    </a:lnTo>
                    <a:lnTo>
                      <a:pt x="670" y="662"/>
                    </a:lnTo>
                    <a:lnTo>
                      <a:pt x="676" y="538"/>
                    </a:lnTo>
                    <a:lnTo>
                      <a:pt x="682" y="703"/>
                    </a:lnTo>
                    <a:lnTo>
                      <a:pt x="688" y="621"/>
                    </a:lnTo>
                    <a:lnTo>
                      <a:pt x="694" y="827"/>
                    </a:lnTo>
                    <a:lnTo>
                      <a:pt x="699" y="662"/>
                    </a:lnTo>
                    <a:lnTo>
                      <a:pt x="705" y="414"/>
                    </a:lnTo>
                    <a:lnTo>
                      <a:pt x="711" y="786"/>
                    </a:lnTo>
                    <a:lnTo>
                      <a:pt x="717" y="579"/>
                    </a:lnTo>
                    <a:lnTo>
                      <a:pt x="723" y="703"/>
                    </a:lnTo>
                    <a:lnTo>
                      <a:pt x="729" y="703"/>
                    </a:lnTo>
                    <a:lnTo>
                      <a:pt x="734" y="621"/>
                    </a:lnTo>
                    <a:lnTo>
                      <a:pt x="740" y="703"/>
                    </a:lnTo>
                    <a:lnTo>
                      <a:pt x="746" y="579"/>
                    </a:lnTo>
                    <a:lnTo>
                      <a:pt x="752" y="621"/>
                    </a:lnTo>
                    <a:lnTo>
                      <a:pt x="758" y="579"/>
                    </a:lnTo>
                    <a:lnTo>
                      <a:pt x="763" y="621"/>
                    </a:lnTo>
                    <a:lnTo>
                      <a:pt x="769" y="538"/>
                    </a:lnTo>
                    <a:lnTo>
                      <a:pt x="775" y="455"/>
                    </a:lnTo>
                    <a:lnTo>
                      <a:pt x="781" y="538"/>
                    </a:lnTo>
                    <a:lnTo>
                      <a:pt x="787" y="497"/>
                    </a:lnTo>
                    <a:lnTo>
                      <a:pt x="793" y="248"/>
                    </a:lnTo>
                    <a:lnTo>
                      <a:pt x="798" y="497"/>
                    </a:lnTo>
                    <a:lnTo>
                      <a:pt x="804" y="538"/>
                    </a:lnTo>
                    <a:lnTo>
                      <a:pt x="810" y="414"/>
                    </a:lnTo>
                    <a:lnTo>
                      <a:pt x="816" y="621"/>
                    </a:lnTo>
                    <a:lnTo>
                      <a:pt x="822" y="248"/>
                    </a:lnTo>
                    <a:lnTo>
                      <a:pt x="828" y="83"/>
                    </a:lnTo>
                    <a:lnTo>
                      <a:pt x="833" y="621"/>
                    </a:lnTo>
                    <a:lnTo>
                      <a:pt x="839" y="579"/>
                    </a:lnTo>
                    <a:lnTo>
                      <a:pt x="845" y="331"/>
                    </a:lnTo>
                    <a:lnTo>
                      <a:pt x="851" y="372"/>
                    </a:lnTo>
                    <a:lnTo>
                      <a:pt x="857" y="207"/>
                    </a:lnTo>
                    <a:lnTo>
                      <a:pt x="863" y="42"/>
                    </a:lnTo>
                    <a:lnTo>
                      <a:pt x="868" y="414"/>
                    </a:lnTo>
                    <a:lnTo>
                      <a:pt x="874" y="372"/>
                    </a:lnTo>
                    <a:lnTo>
                      <a:pt x="880" y="414"/>
                    </a:lnTo>
                    <a:lnTo>
                      <a:pt x="886" y="290"/>
                    </a:lnTo>
                    <a:lnTo>
                      <a:pt x="892" y="248"/>
                    </a:lnTo>
                    <a:lnTo>
                      <a:pt x="898" y="166"/>
                    </a:lnTo>
                    <a:lnTo>
                      <a:pt x="903" y="290"/>
                    </a:lnTo>
                    <a:lnTo>
                      <a:pt x="909" y="621"/>
                    </a:lnTo>
                    <a:lnTo>
                      <a:pt x="915" y="538"/>
                    </a:lnTo>
                    <a:lnTo>
                      <a:pt x="921" y="331"/>
                    </a:lnTo>
                    <a:lnTo>
                      <a:pt x="927" y="372"/>
                    </a:lnTo>
                    <a:lnTo>
                      <a:pt x="933" y="248"/>
                    </a:lnTo>
                    <a:lnTo>
                      <a:pt x="938" y="497"/>
                    </a:lnTo>
                    <a:lnTo>
                      <a:pt x="944" y="497"/>
                    </a:lnTo>
                    <a:lnTo>
                      <a:pt x="950" y="166"/>
                    </a:lnTo>
                    <a:lnTo>
                      <a:pt x="956" y="579"/>
                    </a:lnTo>
                    <a:lnTo>
                      <a:pt x="962" y="248"/>
                    </a:lnTo>
                    <a:lnTo>
                      <a:pt x="968" y="0"/>
                    </a:lnTo>
                    <a:lnTo>
                      <a:pt x="973" y="166"/>
                    </a:lnTo>
                    <a:lnTo>
                      <a:pt x="979" y="372"/>
                    </a:lnTo>
                    <a:lnTo>
                      <a:pt x="985" y="207"/>
                    </a:lnTo>
                    <a:lnTo>
                      <a:pt x="991" y="166"/>
                    </a:lnTo>
                    <a:lnTo>
                      <a:pt x="997" y="414"/>
                    </a:lnTo>
                    <a:lnTo>
                      <a:pt x="1002" y="290"/>
                    </a:lnTo>
                    <a:lnTo>
                      <a:pt x="1008" y="331"/>
                    </a:lnTo>
                    <a:lnTo>
                      <a:pt x="1014" y="455"/>
                    </a:lnTo>
                    <a:lnTo>
                      <a:pt x="1020" y="372"/>
                    </a:lnTo>
                    <a:lnTo>
                      <a:pt x="1026" y="414"/>
                    </a:lnTo>
                    <a:lnTo>
                      <a:pt x="1032" y="621"/>
                    </a:lnTo>
                    <a:lnTo>
                      <a:pt x="1037" y="497"/>
                    </a:lnTo>
                    <a:lnTo>
                      <a:pt x="1043" y="538"/>
                    </a:lnTo>
                    <a:lnTo>
                      <a:pt x="1049" y="579"/>
                    </a:lnTo>
                    <a:lnTo>
                      <a:pt x="1055" y="538"/>
                    </a:lnTo>
                    <a:lnTo>
                      <a:pt x="1061" y="579"/>
                    </a:lnTo>
                    <a:lnTo>
                      <a:pt x="1067" y="579"/>
                    </a:lnTo>
                    <a:lnTo>
                      <a:pt x="1072" y="703"/>
                    </a:lnTo>
                    <a:lnTo>
                      <a:pt x="1078" y="538"/>
                    </a:lnTo>
                    <a:lnTo>
                      <a:pt x="1084" y="621"/>
                    </a:lnTo>
                    <a:lnTo>
                      <a:pt x="1090" y="621"/>
                    </a:lnTo>
                    <a:lnTo>
                      <a:pt x="1096" y="662"/>
                    </a:lnTo>
                    <a:lnTo>
                      <a:pt x="1102" y="869"/>
                    </a:lnTo>
                    <a:lnTo>
                      <a:pt x="1107" y="786"/>
                    </a:lnTo>
                    <a:lnTo>
                      <a:pt x="1113" y="744"/>
                    </a:lnTo>
                    <a:lnTo>
                      <a:pt x="1119" y="827"/>
                    </a:lnTo>
                    <a:lnTo>
                      <a:pt x="1125" y="744"/>
                    </a:lnTo>
                    <a:lnTo>
                      <a:pt x="1131" y="744"/>
                    </a:lnTo>
                    <a:lnTo>
                      <a:pt x="1137" y="910"/>
                    </a:lnTo>
                    <a:lnTo>
                      <a:pt x="1142" y="910"/>
                    </a:lnTo>
                    <a:lnTo>
                      <a:pt x="1148" y="869"/>
                    </a:lnTo>
                    <a:lnTo>
                      <a:pt x="1154" y="869"/>
                    </a:lnTo>
                    <a:lnTo>
                      <a:pt x="1160" y="910"/>
                    </a:lnTo>
                    <a:lnTo>
                      <a:pt x="1166" y="910"/>
                    </a:lnTo>
                    <a:lnTo>
                      <a:pt x="1172" y="910"/>
                    </a:lnTo>
                    <a:lnTo>
                      <a:pt x="1177" y="910"/>
                    </a:lnTo>
                    <a:lnTo>
                      <a:pt x="1183" y="869"/>
                    </a:lnTo>
                    <a:lnTo>
                      <a:pt x="1189" y="910"/>
                    </a:lnTo>
                    <a:lnTo>
                      <a:pt x="1195" y="910"/>
                    </a:lnTo>
                    <a:lnTo>
                      <a:pt x="1201" y="910"/>
                    </a:lnTo>
                    <a:lnTo>
                      <a:pt x="1206" y="910"/>
                    </a:lnTo>
                    <a:lnTo>
                      <a:pt x="1212" y="869"/>
                    </a:lnTo>
                    <a:lnTo>
                      <a:pt x="1218" y="910"/>
                    </a:lnTo>
                    <a:lnTo>
                      <a:pt x="1224" y="910"/>
                    </a:lnTo>
                    <a:lnTo>
                      <a:pt x="1230" y="910"/>
                    </a:lnTo>
                    <a:lnTo>
                      <a:pt x="1236" y="910"/>
                    </a:lnTo>
                    <a:lnTo>
                      <a:pt x="1241" y="910"/>
                    </a:lnTo>
                    <a:lnTo>
                      <a:pt x="1247" y="910"/>
                    </a:lnTo>
                    <a:lnTo>
                      <a:pt x="1253" y="910"/>
                    </a:lnTo>
                    <a:lnTo>
                      <a:pt x="1259" y="910"/>
                    </a:lnTo>
                    <a:lnTo>
                      <a:pt x="1265" y="910"/>
                    </a:lnTo>
                    <a:lnTo>
                      <a:pt x="1271" y="910"/>
                    </a:lnTo>
                    <a:lnTo>
                      <a:pt x="1276" y="910"/>
                    </a:lnTo>
                    <a:lnTo>
                      <a:pt x="1282" y="910"/>
                    </a:lnTo>
                    <a:lnTo>
                      <a:pt x="1288" y="910"/>
                    </a:lnTo>
                    <a:lnTo>
                      <a:pt x="1294" y="910"/>
                    </a:lnTo>
                    <a:lnTo>
                      <a:pt x="1300" y="910"/>
                    </a:lnTo>
                    <a:lnTo>
                      <a:pt x="1306" y="910"/>
                    </a:lnTo>
                    <a:lnTo>
                      <a:pt x="1311" y="910"/>
                    </a:lnTo>
                    <a:lnTo>
                      <a:pt x="1317" y="910"/>
                    </a:lnTo>
                    <a:lnTo>
                      <a:pt x="1323" y="910"/>
                    </a:lnTo>
                    <a:lnTo>
                      <a:pt x="1329" y="910"/>
                    </a:lnTo>
                    <a:lnTo>
                      <a:pt x="1335" y="910"/>
                    </a:lnTo>
                    <a:lnTo>
                      <a:pt x="1341" y="910"/>
                    </a:lnTo>
                    <a:lnTo>
                      <a:pt x="1346" y="910"/>
                    </a:lnTo>
                    <a:lnTo>
                      <a:pt x="1352" y="910"/>
                    </a:lnTo>
                    <a:lnTo>
                      <a:pt x="1358" y="910"/>
                    </a:lnTo>
                    <a:lnTo>
                      <a:pt x="1364" y="910"/>
                    </a:lnTo>
                    <a:lnTo>
                      <a:pt x="1370" y="910"/>
                    </a:lnTo>
                    <a:lnTo>
                      <a:pt x="1376" y="910"/>
                    </a:lnTo>
                    <a:lnTo>
                      <a:pt x="1381" y="910"/>
                    </a:lnTo>
                    <a:lnTo>
                      <a:pt x="1387" y="910"/>
                    </a:lnTo>
                    <a:lnTo>
                      <a:pt x="1393" y="910"/>
                    </a:lnTo>
                    <a:lnTo>
                      <a:pt x="1399" y="910"/>
                    </a:lnTo>
                    <a:lnTo>
                      <a:pt x="1405" y="910"/>
                    </a:lnTo>
                    <a:lnTo>
                      <a:pt x="1411" y="910"/>
                    </a:lnTo>
                    <a:lnTo>
                      <a:pt x="1416" y="910"/>
                    </a:lnTo>
                    <a:lnTo>
                      <a:pt x="1422" y="910"/>
                    </a:lnTo>
                    <a:lnTo>
                      <a:pt x="1428" y="910"/>
                    </a:lnTo>
                    <a:lnTo>
                      <a:pt x="1434" y="910"/>
                    </a:lnTo>
                    <a:lnTo>
                      <a:pt x="1440" y="910"/>
                    </a:lnTo>
                    <a:lnTo>
                      <a:pt x="1445" y="910"/>
                    </a:lnTo>
                    <a:lnTo>
                      <a:pt x="1451" y="910"/>
                    </a:lnTo>
                    <a:lnTo>
                      <a:pt x="1457" y="910"/>
                    </a:lnTo>
                    <a:lnTo>
                      <a:pt x="1463" y="910"/>
                    </a:lnTo>
                    <a:lnTo>
                      <a:pt x="1469" y="910"/>
                    </a:lnTo>
                    <a:lnTo>
                      <a:pt x="1475" y="910"/>
                    </a:lnTo>
                    <a:lnTo>
                      <a:pt x="1480" y="910"/>
                    </a:lnTo>
                    <a:lnTo>
                      <a:pt x="1486" y="910"/>
                    </a:lnTo>
                    <a:lnTo>
                      <a:pt x="1492" y="910"/>
                    </a:lnTo>
                    <a:lnTo>
                      <a:pt x="0" y="910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87" name="Freeform 219"/>
              <p:cNvSpPr>
                <a:spLocks/>
              </p:cNvSpPr>
              <p:nvPr/>
            </p:nvSpPr>
            <p:spPr bwMode="auto">
              <a:xfrm>
                <a:off x="4824413" y="7354888"/>
                <a:ext cx="2368550" cy="1444625"/>
              </a:xfrm>
              <a:custGeom>
                <a:avLst/>
                <a:gdLst/>
                <a:ahLst/>
                <a:cxnLst>
                  <a:cxn ang="0">
                    <a:pos x="17" y="910"/>
                  </a:cxn>
                  <a:cxn ang="0">
                    <a:pos x="46" y="910"/>
                  </a:cxn>
                  <a:cxn ang="0">
                    <a:pos x="75" y="910"/>
                  </a:cxn>
                  <a:cxn ang="0">
                    <a:pos x="105" y="910"/>
                  </a:cxn>
                  <a:cxn ang="0">
                    <a:pos x="134" y="910"/>
                  </a:cxn>
                  <a:cxn ang="0">
                    <a:pos x="163" y="910"/>
                  </a:cxn>
                  <a:cxn ang="0">
                    <a:pos x="192" y="910"/>
                  </a:cxn>
                  <a:cxn ang="0">
                    <a:pos x="221" y="910"/>
                  </a:cxn>
                  <a:cxn ang="0">
                    <a:pos x="250" y="910"/>
                  </a:cxn>
                  <a:cxn ang="0">
                    <a:pos x="279" y="910"/>
                  </a:cxn>
                  <a:cxn ang="0">
                    <a:pos x="309" y="786"/>
                  </a:cxn>
                  <a:cxn ang="0">
                    <a:pos x="338" y="869"/>
                  </a:cxn>
                  <a:cxn ang="0">
                    <a:pos x="367" y="703"/>
                  </a:cxn>
                  <a:cxn ang="0">
                    <a:pos x="396" y="497"/>
                  </a:cxn>
                  <a:cxn ang="0">
                    <a:pos x="425" y="579"/>
                  </a:cxn>
                  <a:cxn ang="0">
                    <a:pos x="454" y="538"/>
                  </a:cxn>
                  <a:cxn ang="0">
                    <a:pos x="484" y="579"/>
                  </a:cxn>
                  <a:cxn ang="0">
                    <a:pos x="513" y="579"/>
                  </a:cxn>
                  <a:cxn ang="0">
                    <a:pos x="542" y="786"/>
                  </a:cxn>
                  <a:cxn ang="0">
                    <a:pos x="571" y="662"/>
                  </a:cxn>
                  <a:cxn ang="0">
                    <a:pos x="600" y="703"/>
                  </a:cxn>
                  <a:cxn ang="0">
                    <a:pos x="629" y="703"/>
                  </a:cxn>
                  <a:cxn ang="0">
                    <a:pos x="659" y="744"/>
                  </a:cxn>
                  <a:cxn ang="0">
                    <a:pos x="688" y="621"/>
                  </a:cxn>
                  <a:cxn ang="0">
                    <a:pos x="717" y="579"/>
                  </a:cxn>
                  <a:cxn ang="0">
                    <a:pos x="746" y="579"/>
                  </a:cxn>
                  <a:cxn ang="0">
                    <a:pos x="775" y="455"/>
                  </a:cxn>
                  <a:cxn ang="0">
                    <a:pos x="804" y="538"/>
                  </a:cxn>
                  <a:cxn ang="0">
                    <a:pos x="833" y="621"/>
                  </a:cxn>
                  <a:cxn ang="0">
                    <a:pos x="863" y="42"/>
                  </a:cxn>
                  <a:cxn ang="0">
                    <a:pos x="892" y="248"/>
                  </a:cxn>
                  <a:cxn ang="0">
                    <a:pos x="921" y="331"/>
                  </a:cxn>
                  <a:cxn ang="0">
                    <a:pos x="950" y="166"/>
                  </a:cxn>
                  <a:cxn ang="0">
                    <a:pos x="979" y="372"/>
                  </a:cxn>
                  <a:cxn ang="0">
                    <a:pos x="1008" y="331"/>
                  </a:cxn>
                  <a:cxn ang="0">
                    <a:pos x="1037" y="497"/>
                  </a:cxn>
                  <a:cxn ang="0">
                    <a:pos x="1067" y="579"/>
                  </a:cxn>
                  <a:cxn ang="0">
                    <a:pos x="1096" y="662"/>
                  </a:cxn>
                  <a:cxn ang="0">
                    <a:pos x="1125" y="744"/>
                  </a:cxn>
                  <a:cxn ang="0">
                    <a:pos x="1154" y="869"/>
                  </a:cxn>
                  <a:cxn ang="0">
                    <a:pos x="1183" y="869"/>
                  </a:cxn>
                  <a:cxn ang="0">
                    <a:pos x="1212" y="869"/>
                  </a:cxn>
                  <a:cxn ang="0">
                    <a:pos x="1241" y="910"/>
                  </a:cxn>
                  <a:cxn ang="0">
                    <a:pos x="1271" y="910"/>
                  </a:cxn>
                  <a:cxn ang="0">
                    <a:pos x="1300" y="910"/>
                  </a:cxn>
                  <a:cxn ang="0">
                    <a:pos x="1329" y="910"/>
                  </a:cxn>
                  <a:cxn ang="0">
                    <a:pos x="1358" y="910"/>
                  </a:cxn>
                  <a:cxn ang="0">
                    <a:pos x="1387" y="910"/>
                  </a:cxn>
                  <a:cxn ang="0">
                    <a:pos x="1416" y="910"/>
                  </a:cxn>
                  <a:cxn ang="0">
                    <a:pos x="1445" y="910"/>
                  </a:cxn>
                  <a:cxn ang="0">
                    <a:pos x="1475" y="910"/>
                  </a:cxn>
                </a:cxnLst>
                <a:rect l="0" t="0" r="r" b="b"/>
                <a:pathLst>
                  <a:path w="1492" h="910">
                    <a:moveTo>
                      <a:pt x="0" y="910"/>
                    </a:moveTo>
                    <a:lnTo>
                      <a:pt x="0" y="910"/>
                    </a:lnTo>
                    <a:lnTo>
                      <a:pt x="5" y="910"/>
                    </a:lnTo>
                    <a:lnTo>
                      <a:pt x="11" y="910"/>
                    </a:lnTo>
                    <a:lnTo>
                      <a:pt x="17" y="910"/>
                    </a:lnTo>
                    <a:lnTo>
                      <a:pt x="23" y="910"/>
                    </a:lnTo>
                    <a:lnTo>
                      <a:pt x="29" y="910"/>
                    </a:lnTo>
                    <a:lnTo>
                      <a:pt x="35" y="910"/>
                    </a:lnTo>
                    <a:lnTo>
                      <a:pt x="40" y="910"/>
                    </a:lnTo>
                    <a:lnTo>
                      <a:pt x="46" y="910"/>
                    </a:lnTo>
                    <a:lnTo>
                      <a:pt x="52" y="910"/>
                    </a:lnTo>
                    <a:lnTo>
                      <a:pt x="58" y="910"/>
                    </a:lnTo>
                    <a:lnTo>
                      <a:pt x="64" y="910"/>
                    </a:lnTo>
                    <a:lnTo>
                      <a:pt x="70" y="910"/>
                    </a:lnTo>
                    <a:lnTo>
                      <a:pt x="75" y="910"/>
                    </a:lnTo>
                    <a:lnTo>
                      <a:pt x="81" y="910"/>
                    </a:lnTo>
                    <a:lnTo>
                      <a:pt x="87" y="910"/>
                    </a:lnTo>
                    <a:lnTo>
                      <a:pt x="93" y="910"/>
                    </a:lnTo>
                    <a:lnTo>
                      <a:pt x="99" y="910"/>
                    </a:lnTo>
                    <a:lnTo>
                      <a:pt x="105" y="910"/>
                    </a:lnTo>
                    <a:lnTo>
                      <a:pt x="110" y="910"/>
                    </a:lnTo>
                    <a:lnTo>
                      <a:pt x="116" y="910"/>
                    </a:lnTo>
                    <a:lnTo>
                      <a:pt x="122" y="910"/>
                    </a:lnTo>
                    <a:lnTo>
                      <a:pt x="128" y="910"/>
                    </a:lnTo>
                    <a:lnTo>
                      <a:pt x="134" y="910"/>
                    </a:lnTo>
                    <a:lnTo>
                      <a:pt x="140" y="910"/>
                    </a:lnTo>
                    <a:lnTo>
                      <a:pt x="145" y="910"/>
                    </a:lnTo>
                    <a:lnTo>
                      <a:pt x="151" y="910"/>
                    </a:lnTo>
                    <a:lnTo>
                      <a:pt x="157" y="910"/>
                    </a:lnTo>
                    <a:lnTo>
                      <a:pt x="163" y="910"/>
                    </a:lnTo>
                    <a:lnTo>
                      <a:pt x="169" y="910"/>
                    </a:lnTo>
                    <a:lnTo>
                      <a:pt x="175" y="910"/>
                    </a:lnTo>
                    <a:lnTo>
                      <a:pt x="180" y="910"/>
                    </a:lnTo>
                    <a:lnTo>
                      <a:pt x="186" y="910"/>
                    </a:lnTo>
                    <a:lnTo>
                      <a:pt x="192" y="910"/>
                    </a:lnTo>
                    <a:lnTo>
                      <a:pt x="198" y="910"/>
                    </a:lnTo>
                    <a:lnTo>
                      <a:pt x="204" y="910"/>
                    </a:lnTo>
                    <a:lnTo>
                      <a:pt x="209" y="910"/>
                    </a:lnTo>
                    <a:lnTo>
                      <a:pt x="215" y="910"/>
                    </a:lnTo>
                    <a:lnTo>
                      <a:pt x="221" y="910"/>
                    </a:lnTo>
                    <a:lnTo>
                      <a:pt x="227" y="910"/>
                    </a:lnTo>
                    <a:lnTo>
                      <a:pt x="233" y="910"/>
                    </a:lnTo>
                    <a:lnTo>
                      <a:pt x="239" y="910"/>
                    </a:lnTo>
                    <a:lnTo>
                      <a:pt x="244" y="869"/>
                    </a:lnTo>
                    <a:lnTo>
                      <a:pt x="250" y="910"/>
                    </a:lnTo>
                    <a:lnTo>
                      <a:pt x="256" y="910"/>
                    </a:lnTo>
                    <a:lnTo>
                      <a:pt x="262" y="910"/>
                    </a:lnTo>
                    <a:lnTo>
                      <a:pt x="268" y="869"/>
                    </a:lnTo>
                    <a:lnTo>
                      <a:pt x="274" y="827"/>
                    </a:lnTo>
                    <a:lnTo>
                      <a:pt x="279" y="910"/>
                    </a:lnTo>
                    <a:lnTo>
                      <a:pt x="285" y="869"/>
                    </a:lnTo>
                    <a:lnTo>
                      <a:pt x="291" y="910"/>
                    </a:lnTo>
                    <a:lnTo>
                      <a:pt x="297" y="827"/>
                    </a:lnTo>
                    <a:lnTo>
                      <a:pt x="303" y="786"/>
                    </a:lnTo>
                    <a:lnTo>
                      <a:pt x="309" y="786"/>
                    </a:lnTo>
                    <a:lnTo>
                      <a:pt x="314" y="869"/>
                    </a:lnTo>
                    <a:lnTo>
                      <a:pt x="320" y="786"/>
                    </a:lnTo>
                    <a:lnTo>
                      <a:pt x="326" y="910"/>
                    </a:lnTo>
                    <a:lnTo>
                      <a:pt x="332" y="786"/>
                    </a:lnTo>
                    <a:lnTo>
                      <a:pt x="338" y="869"/>
                    </a:lnTo>
                    <a:lnTo>
                      <a:pt x="344" y="744"/>
                    </a:lnTo>
                    <a:lnTo>
                      <a:pt x="349" y="744"/>
                    </a:lnTo>
                    <a:lnTo>
                      <a:pt x="355" y="579"/>
                    </a:lnTo>
                    <a:lnTo>
                      <a:pt x="361" y="579"/>
                    </a:lnTo>
                    <a:lnTo>
                      <a:pt x="367" y="703"/>
                    </a:lnTo>
                    <a:lnTo>
                      <a:pt x="373" y="621"/>
                    </a:lnTo>
                    <a:lnTo>
                      <a:pt x="379" y="662"/>
                    </a:lnTo>
                    <a:lnTo>
                      <a:pt x="384" y="662"/>
                    </a:lnTo>
                    <a:lnTo>
                      <a:pt x="390" y="744"/>
                    </a:lnTo>
                    <a:lnTo>
                      <a:pt x="396" y="497"/>
                    </a:lnTo>
                    <a:lnTo>
                      <a:pt x="402" y="414"/>
                    </a:lnTo>
                    <a:lnTo>
                      <a:pt x="408" y="579"/>
                    </a:lnTo>
                    <a:lnTo>
                      <a:pt x="414" y="621"/>
                    </a:lnTo>
                    <a:lnTo>
                      <a:pt x="419" y="538"/>
                    </a:lnTo>
                    <a:lnTo>
                      <a:pt x="425" y="579"/>
                    </a:lnTo>
                    <a:lnTo>
                      <a:pt x="431" y="497"/>
                    </a:lnTo>
                    <a:lnTo>
                      <a:pt x="437" y="414"/>
                    </a:lnTo>
                    <a:lnTo>
                      <a:pt x="443" y="538"/>
                    </a:lnTo>
                    <a:lnTo>
                      <a:pt x="449" y="372"/>
                    </a:lnTo>
                    <a:lnTo>
                      <a:pt x="454" y="538"/>
                    </a:lnTo>
                    <a:lnTo>
                      <a:pt x="460" y="579"/>
                    </a:lnTo>
                    <a:lnTo>
                      <a:pt x="466" y="538"/>
                    </a:lnTo>
                    <a:lnTo>
                      <a:pt x="472" y="372"/>
                    </a:lnTo>
                    <a:lnTo>
                      <a:pt x="478" y="579"/>
                    </a:lnTo>
                    <a:lnTo>
                      <a:pt x="484" y="579"/>
                    </a:lnTo>
                    <a:lnTo>
                      <a:pt x="489" y="538"/>
                    </a:lnTo>
                    <a:lnTo>
                      <a:pt x="495" y="621"/>
                    </a:lnTo>
                    <a:lnTo>
                      <a:pt x="501" y="538"/>
                    </a:lnTo>
                    <a:lnTo>
                      <a:pt x="507" y="497"/>
                    </a:lnTo>
                    <a:lnTo>
                      <a:pt x="513" y="579"/>
                    </a:lnTo>
                    <a:lnTo>
                      <a:pt x="519" y="579"/>
                    </a:lnTo>
                    <a:lnTo>
                      <a:pt x="524" y="703"/>
                    </a:lnTo>
                    <a:lnTo>
                      <a:pt x="530" y="744"/>
                    </a:lnTo>
                    <a:lnTo>
                      <a:pt x="536" y="662"/>
                    </a:lnTo>
                    <a:lnTo>
                      <a:pt x="542" y="786"/>
                    </a:lnTo>
                    <a:lnTo>
                      <a:pt x="548" y="786"/>
                    </a:lnTo>
                    <a:lnTo>
                      <a:pt x="554" y="786"/>
                    </a:lnTo>
                    <a:lnTo>
                      <a:pt x="559" y="786"/>
                    </a:lnTo>
                    <a:lnTo>
                      <a:pt x="565" y="786"/>
                    </a:lnTo>
                    <a:lnTo>
                      <a:pt x="571" y="662"/>
                    </a:lnTo>
                    <a:lnTo>
                      <a:pt x="577" y="786"/>
                    </a:lnTo>
                    <a:lnTo>
                      <a:pt x="583" y="662"/>
                    </a:lnTo>
                    <a:lnTo>
                      <a:pt x="589" y="662"/>
                    </a:lnTo>
                    <a:lnTo>
                      <a:pt x="594" y="662"/>
                    </a:lnTo>
                    <a:lnTo>
                      <a:pt x="600" y="703"/>
                    </a:lnTo>
                    <a:lnTo>
                      <a:pt x="606" y="827"/>
                    </a:lnTo>
                    <a:lnTo>
                      <a:pt x="612" y="827"/>
                    </a:lnTo>
                    <a:lnTo>
                      <a:pt x="618" y="621"/>
                    </a:lnTo>
                    <a:lnTo>
                      <a:pt x="624" y="662"/>
                    </a:lnTo>
                    <a:lnTo>
                      <a:pt x="629" y="703"/>
                    </a:lnTo>
                    <a:lnTo>
                      <a:pt x="635" y="703"/>
                    </a:lnTo>
                    <a:lnTo>
                      <a:pt x="641" y="621"/>
                    </a:lnTo>
                    <a:lnTo>
                      <a:pt x="647" y="662"/>
                    </a:lnTo>
                    <a:lnTo>
                      <a:pt x="653" y="869"/>
                    </a:lnTo>
                    <a:lnTo>
                      <a:pt x="659" y="744"/>
                    </a:lnTo>
                    <a:lnTo>
                      <a:pt x="664" y="579"/>
                    </a:lnTo>
                    <a:lnTo>
                      <a:pt x="670" y="662"/>
                    </a:lnTo>
                    <a:lnTo>
                      <a:pt x="676" y="538"/>
                    </a:lnTo>
                    <a:lnTo>
                      <a:pt x="682" y="703"/>
                    </a:lnTo>
                    <a:lnTo>
                      <a:pt x="688" y="621"/>
                    </a:lnTo>
                    <a:lnTo>
                      <a:pt x="694" y="827"/>
                    </a:lnTo>
                    <a:lnTo>
                      <a:pt x="699" y="662"/>
                    </a:lnTo>
                    <a:lnTo>
                      <a:pt x="705" y="414"/>
                    </a:lnTo>
                    <a:lnTo>
                      <a:pt x="711" y="786"/>
                    </a:lnTo>
                    <a:lnTo>
                      <a:pt x="717" y="579"/>
                    </a:lnTo>
                    <a:lnTo>
                      <a:pt x="723" y="703"/>
                    </a:lnTo>
                    <a:lnTo>
                      <a:pt x="729" y="703"/>
                    </a:lnTo>
                    <a:lnTo>
                      <a:pt x="734" y="621"/>
                    </a:lnTo>
                    <a:lnTo>
                      <a:pt x="740" y="703"/>
                    </a:lnTo>
                    <a:lnTo>
                      <a:pt x="746" y="579"/>
                    </a:lnTo>
                    <a:lnTo>
                      <a:pt x="752" y="621"/>
                    </a:lnTo>
                    <a:lnTo>
                      <a:pt x="758" y="579"/>
                    </a:lnTo>
                    <a:lnTo>
                      <a:pt x="763" y="621"/>
                    </a:lnTo>
                    <a:lnTo>
                      <a:pt x="769" y="538"/>
                    </a:lnTo>
                    <a:lnTo>
                      <a:pt x="775" y="455"/>
                    </a:lnTo>
                    <a:lnTo>
                      <a:pt x="781" y="538"/>
                    </a:lnTo>
                    <a:lnTo>
                      <a:pt x="787" y="497"/>
                    </a:lnTo>
                    <a:lnTo>
                      <a:pt x="793" y="248"/>
                    </a:lnTo>
                    <a:lnTo>
                      <a:pt x="798" y="497"/>
                    </a:lnTo>
                    <a:lnTo>
                      <a:pt x="804" y="538"/>
                    </a:lnTo>
                    <a:lnTo>
                      <a:pt x="810" y="414"/>
                    </a:lnTo>
                    <a:lnTo>
                      <a:pt x="816" y="621"/>
                    </a:lnTo>
                    <a:lnTo>
                      <a:pt x="822" y="248"/>
                    </a:lnTo>
                    <a:lnTo>
                      <a:pt x="828" y="83"/>
                    </a:lnTo>
                    <a:lnTo>
                      <a:pt x="833" y="621"/>
                    </a:lnTo>
                    <a:lnTo>
                      <a:pt x="839" y="579"/>
                    </a:lnTo>
                    <a:lnTo>
                      <a:pt x="845" y="331"/>
                    </a:lnTo>
                    <a:lnTo>
                      <a:pt x="851" y="372"/>
                    </a:lnTo>
                    <a:lnTo>
                      <a:pt x="857" y="207"/>
                    </a:lnTo>
                    <a:lnTo>
                      <a:pt x="863" y="42"/>
                    </a:lnTo>
                    <a:lnTo>
                      <a:pt x="868" y="414"/>
                    </a:lnTo>
                    <a:lnTo>
                      <a:pt x="874" y="372"/>
                    </a:lnTo>
                    <a:lnTo>
                      <a:pt x="880" y="414"/>
                    </a:lnTo>
                    <a:lnTo>
                      <a:pt x="886" y="290"/>
                    </a:lnTo>
                    <a:lnTo>
                      <a:pt x="892" y="248"/>
                    </a:lnTo>
                    <a:lnTo>
                      <a:pt x="898" y="166"/>
                    </a:lnTo>
                    <a:lnTo>
                      <a:pt x="903" y="290"/>
                    </a:lnTo>
                    <a:lnTo>
                      <a:pt x="909" y="621"/>
                    </a:lnTo>
                    <a:lnTo>
                      <a:pt x="915" y="538"/>
                    </a:lnTo>
                    <a:lnTo>
                      <a:pt x="921" y="331"/>
                    </a:lnTo>
                    <a:lnTo>
                      <a:pt x="927" y="372"/>
                    </a:lnTo>
                    <a:lnTo>
                      <a:pt x="933" y="248"/>
                    </a:lnTo>
                    <a:lnTo>
                      <a:pt x="938" y="497"/>
                    </a:lnTo>
                    <a:lnTo>
                      <a:pt x="944" y="497"/>
                    </a:lnTo>
                    <a:lnTo>
                      <a:pt x="950" y="166"/>
                    </a:lnTo>
                    <a:lnTo>
                      <a:pt x="956" y="579"/>
                    </a:lnTo>
                    <a:lnTo>
                      <a:pt x="962" y="248"/>
                    </a:lnTo>
                    <a:lnTo>
                      <a:pt x="968" y="0"/>
                    </a:lnTo>
                    <a:lnTo>
                      <a:pt x="973" y="166"/>
                    </a:lnTo>
                    <a:lnTo>
                      <a:pt x="979" y="372"/>
                    </a:lnTo>
                    <a:lnTo>
                      <a:pt x="985" y="207"/>
                    </a:lnTo>
                    <a:lnTo>
                      <a:pt x="991" y="166"/>
                    </a:lnTo>
                    <a:lnTo>
                      <a:pt x="997" y="414"/>
                    </a:lnTo>
                    <a:lnTo>
                      <a:pt x="1002" y="290"/>
                    </a:lnTo>
                    <a:lnTo>
                      <a:pt x="1008" y="331"/>
                    </a:lnTo>
                    <a:lnTo>
                      <a:pt x="1014" y="455"/>
                    </a:lnTo>
                    <a:lnTo>
                      <a:pt x="1020" y="372"/>
                    </a:lnTo>
                    <a:lnTo>
                      <a:pt x="1026" y="414"/>
                    </a:lnTo>
                    <a:lnTo>
                      <a:pt x="1032" y="621"/>
                    </a:lnTo>
                    <a:lnTo>
                      <a:pt x="1037" y="497"/>
                    </a:lnTo>
                    <a:lnTo>
                      <a:pt x="1043" y="538"/>
                    </a:lnTo>
                    <a:lnTo>
                      <a:pt x="1049" y="579"/>
                    </a:lnTo>
                    <a:lnTo>
                      <a:pt x="1055" y="538"/>
                    </a:lnTo>
                    <a:lnTo>
                      <a:pt x="1061" y="579"/>
                    </a:lnTo>
                    <a:lnTo>
                      <a:pt x="1067" y="579"/>
                    </a:lnTo>
                    <a:lnTo>
                      <a:pt x="1072" y="703"/>
                    </a:lnTo>
                    <a:lnTo>
                      <a:pt x="1078" y="538"/>
                    </a:lnTo>
                    <a:lnTo>
                      <a:pt x="1084" y="621"/>
                    </a:lnTo>
                    <a:lnTo>
                      <a:pt x="1090" y="621"/>
                    </a:lnTo>
                    <a:lnTo>
                      <a:pt x="1096" y="662"/>
                    </a:lnTo>
                    <a:lnTo>
                      <a:pt x="1102" y="869"/>
                    </a:lnTo>
                    <a:lnTo>
                      <a:pt x="1107" y="786"/>
                    </a:lnTo>
                    <a:lnTo>
                      <a:pt x="1113" y="744"/>
                    </a:lnTo>
                    <a:lnTo>
                      <a:pt x="1119" y="827"/>
                    </a:lnTo>
                    <a:lnTo>
                      <a:pt x="1125" y="744"/>
                    </a:lnTo>
                    <a:lnTo>
                      <a:pt x="1131" y="744"/>
                    </a:lnTo>
                    <a:lnTo>
                      <a:pt x="1137" y="910"/>
                    </a:lnTo>
                    <a:lnTo>
                      <a:pt x="1142" y="910"/>
                    </a:lnTo>
                    <a:lnTo>
                      <a:pt x="1148" y="869"/>
                    </a:lnTo>
                    <a:lnTo>
                      <a:pt x="1154" y="869"/>
                    </a:lnTo>
                    <a:lnTo>
                      <a:pt x="1160" y="910"/>
                    </a:lnTo>
                    <a:lnTo>
                      <a:pt x="1166" y="910"/>
                    </a:lnTo>
                    <a:lnTo>
                      <a:pt x="1172" y="910"/>
                    </a:lnTo>
                    <a:lnTo>
                      <a:pt x="1177" y="910"/>
                    </a:lnTo>
                    <a:lnTo>
                      <a:pt x="1183" y="869"/>
                    </a:lnTo>
                    <a:lnTo>
                      <a:pt x="1189" y="910"/>
                    </a:lnTo>
                    <a:lnTo>
                      <a:pt x="1195" y="910"/>
                    </a:lnTo>
                    <a:lnTo>
                      <a:pt x="1201" y="910"/>
                    </a:lnTo>
                    <a:lnTo>
                      <a:pt x="1206" y="910"/>
                    </a:lnTo>
                    <a:lnTo>
                      <a:pt x="1212" y="869"/>
                    </a:lnTo>
                    <a:lnTo>
                      <a:pt x="1218" y="910"/>
                    </a:lnTo>
                    <a:lnTo>
                      <a:pt x="1224" y="910"/>
                    </a:lnTo>
                    <a:lnTo>
                      <a:pt x="1230" y="910"/>
                    </a:lnTo>
                    <a:lnTo>
                      <a:pt x="1236" y="910"/>
                    </a:lnTo>
                    <a:lnTo>
                      <a:pt x="1241" y="910"/>
                    </a:lnTo>
                    <a:lnTo>
                      <a:pt x="1247" y="910"/>
                    </a:lnTo>
                    <a:lnTo>
                      <a:pt x="1253" y="910"/>
                    </a:lnTo>
                    <a:lnTo>
                      <a:pt x="1259" y="910"/>
                    </a:lnTo>
                    <a:lnTo>
                      <a:pt x="1265" y="910"/>
                    </a:lnTo>
                    <a:lnTo>
                      <a:pt x="1271" y="910"/>
                    </a:lnTo>
                    <a:lnTo>
                      <a:pt x="1276" y="910"/>
                    </a:lnTo>
                    <a:lnTo>
                      <a:pt x="1282" y="910"/>
                    </a:lnTo>
                    <a:lnTo>
                      <a:pt x="1288" y="910"/>
                    </a:lnTo>
                    <a:lnTo>
                      <a:pt x="1294" y="910"/>
                    </a:lnTo>
                    <a:lnTo>
                      <a:pt x="1300" y="910"/>
                    </a:lnTo>
                    <a:lnTo>
                      <a:pt x="1306" y="910"/>
                    </a:lnTo>
                    <a:lnTo>
                      <a:pt x="1311" y="910"/>
                    </a:lnTo>
                    <a:lnTo>
                      <a:pt x="1317" y="910"/>
                    </a:lnTo>
                    <a:lnTo>
                      <a:pt x="1323" y="910"/>
                    </a:lnTo>
                    <a:lnTo>
                      <a:pt x="1329" y="910"/>
                    </a:lnTo>
                    <a:lnTo>
                      <a:pt x="1335" y="910"/>
                    </a:lnTo>
                    <a:lnTo>
                      <a:pt x="1341" y="910"/>
                    </a:lnTo>
                    <a:lnTo>
                      <a:pt x="1346" y="910"/>
                    </a:lnTo>
                    <a:lnTo>
                      <a:pt x="1352" y="910"/>
                    </a:lnTo>
                    <a:lnTo>
                      <a:pt x="1358" y="910"/>
                    </a:lnTo>
                    <a:lnTo>
                      <a:pt x="1364" y="910"/>
                    </a:lnTo>
                    <a:lnTo>
                      <a:pt x="1370" y="910"/>
                    </a:lnTo>
                    <a:lnTo>
                      <a:pt x="1376" y="910"/>
                    </a:lnTo>
                    <a:lnTo>
                      <a:pt x="1381" y="910"/>
                    </a:lnTo>
                    <a:lnTo>
                      <a:pt x="1387" y="910"/>
                    </a:lnTo>
                    <a:lnTo>
                      <a:pt x="1393" y="910"/>
                    </a:lnTo>
                    <a:lnTo>
                      <a:pt x="1399" y="910"/>
                    </a:lnTo>
                    <a:lnTo>
                      <a:pt x="1405" y="910"/>
                    </a:lnTo>
                    <a:lnTo>
                      <a:pt x="1411" y="910"/>
                    </a:lnTo>
                    <a:lnTo>
                      <a:pt x="1416" y="910"/>
                    </a:lnTo>
                    <a:lnTo>
                      <a:pt x="1422" y="910"/>
                    </a:lnTo>
                    <a:lnTo>
                      <a:pt x="1428" y="910"/>
                    </a:lnTo>
                    <a:lnTo>
                      <a:pt x="1434" y="910"/>
                    </a:lnTo>
                    <a:lnTo>
                      <a:pt x="1440" y="910"/>
                    </a:lnTo>
                    <a:lnTo>
                      <a:pt x="1445" y="910"/>
                    </a:lnTo>
                    <a:lnTo>
                      <a:pt x="1451" y="910"/>
                    </a:lnTo>
                    <a:lnTo>
                      <a:pt x="1457" y="910"/>
                    </a:lnTo>
                    <a:lnTo>
                      <a:pt x="1463" y="910"/>
                    </a:lnTo>
                    <a:lnTo>
                      <a:pt x="1469" y="910"/>
                    </a:lnTo>
                    <a:lnTo>
                      <a:pt x="1475" y="910"/>
                    </a:lnTo>
                    <a:lnTo>
                      <a:pt x="1480" y="910"/>
                    </a:lnTo>
                    <a:lnTo>
                      <a:pt x="1486" y="910"/>
                    </a:lnTo>
                    <a:lnTo>
                      <a:pt x="1492" y="910"/>
                    </a:lnTo>
                    <a:lnTo>
                      <a:pt x="0" y="910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588" name="Rectangle 220"/>
              <p:cNvSpPr>
                <a:spLocks noChangeArrowheads="1"/>
              </p:cNvSpPr>
              <p:nvPr/>
            </p:nvSpPr>
            <p:spPr bwMode="auto">
              <a:xfrm>
                <a:off x="4824413" y="6502400"/>
                <a:ext cx="2368550" cy="2297113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330" name="Groep 329"/>
            <p:cNvGrpSpPr/>
            <p:nvPr/>
          </p:nvGrpSpPr>
          <p:grpSpPr>
            <a:xfrm>
              <a:off x="5115815" y="4250333"/>
              <a:ext cx="1163039" cy="1191023"/>
              <a:chOff x="6551613" y="5926138"/>
              <a:chExt cx="2368550" cy="2297112"/>
            </a:xfrm>
          </p:grpSpPr>
          <p:sp>
            <p:nvSpPr>
              <p:cNvPr id="58620" name="Freeform 252"/>
              <p:cNvSpPr>
                <a:spLocks/>
              </p:cNvSpPr>
              <p:nvPr/>
            </p:nvSpPr>
            <p:spPr bwMode="auto">
              <a:xfrm>
                <a:off x="6551613" y="6713538"/>
                <a:ext cx="2368550" cy="1509712"/>
              </a:xfrm>
              <a:custGeom>
                <a:avLst/>
                <a:gdLst/>
                <a:ahLst/>
                <a:cxnLst>
                  <a:cxn ang="0">
                    <a:pos x="17" y="951"/>
                  </a:cxn>
                  <a:cxn ang="0">
                    <a:pos x="46" y="951"/>
                  </a:cxn>
                  <a:cxn ang="0">
                    <a:pos x="75" y="951"/>
                  </a:cxn>
                  <a:cxn ang="0">
                    <a:pos x="105" y="951"/>
                  </a:cxn>
                  <a:cxn ang="0">
                    <a:pos x="134" y="951"/>
                  </a:cxn>
                  <a:cxn ang="0">
                    <a:pos x="163" y="951"/>
                  </a:cxn>
                  <a:cxn ang="0">
                    <a:pos x="192" y="910"/>
                  </a:cxn>
                  <a:cxn ang="0">
                    <a:pos x="221" y="951"/>
                  </a:cxn>
                  <a:cxn ang="0">
                    <a:pos x="250" y="951"/>
                  </a:cxn>
                  <a:cxn ang="0">
                    <a:pos x="279" y="910"/>
                  </a:cxn>
                  <a:cxn ang="0">
                    <a:pos x="309" y="951"/>
                  </a:cxn>
                  <a:cxn ang="0">
                    <a:pos x="338" y="951"/>
                  </a:cxn>
                  <a:cxn ang="0">
                    <a:pos x="367" y="868"/>
                  </a:cxn>
                  <a:cxn ang="0">
                    <a:pos x="396" y="951"/>
                  </a:cxn>
                  <a:cxn ang="0">
                    <a:pos x="425" y="827"/>
                  </a:cxn>
                  <a:cxn ang="0">
                    <a:pos x="454" y="827"/>
                  </a:cxn>
                  <a:cxn ang="0">
                    <a:pos x="484" y="868"/>
                  </a:cxn>
                  <a:cxn ang="0">
                    <a:pos x="513" y="910"/>
                  </a:cxn>
                  <a:cxn ang="0">
                    <a:pos x="542" y="910"/>
                  </a:cxn>
                  <a:cxn ang="0">
                    <a:pos x="571" y="868"/>
                  </a:cxn>
                  <a:cxn ang="0">
                    <a:pos x="600" y="785"/>
                  </a:cxn>
                  <a:cxn ang="0">
                    <a:pos x="629" y="910"/>
                  </a:cxn>
                  <a:cxn ang="0">
                    <a:pos x="659" y="703"/>
                  </a:cxn>
                  <a:cxn ang="0">
                    <a:pos x="688" y="662"/>
                  </a:cxn>
                  <a:cxn ang="0">
                    <a:pos x="717" y="703"/>
                  </a:cxn>
                  <a:cxn ang="0">
                    <a:pos x="746" y="703"/>
                  </a:cxn>
                  <a:cxn ang="0">
                    <a:pos x="775" y="785"/>
                  </a:cxn>
                  <a:cxn ang="0">
                    <a:pos x="804" y="703"/>
                  </a:cxn>
                  <a:cxn ang="0">
                    <a:pos x="833" y="744"/>
                  </a:cxn>
                  <a:cxn ang="0">
                    <a:pos x="863" y="785"/>
                  </a:cxn>
                  <a:cxn ang="0">
                    <a:pos x="892" y="538"/>
                  </a:cxn>
                  <a:cxn ang="0">
                    <a:pos x="921" y="662"/>
                  </a:cxn>
                  <a:cxn ang="0">
                    <a:pos x="950" y="620"/>
                  </a:cxn>
                  <a:cxn ang="0">
                    <a:pos x="979" y="289"/>
                  </a:cxn>
                  <a:cxn ang="0">
                    <a:pos x="1008" y="207"/>
                  </a:cxn>
                  <a:cxn ang="0">
                    <a:pos x="1037" y="538"/>
                  </a:cxn>
                  <a:cxn ang="0">
                    <a:pos x="1067" y="579"/>
                  </a:cxn>
                  <a:cxn ang="0">
                    <a:pos x="1096" y="744"/>
                  </a:cxn>
                  <a:cxn ang="0">
                    <a:pos x="1125" y="785"/>
                  </a:cxn>
                  <a:cxn ang="0">
                    <a:pos x="1154" y="538"/>
                  </a:cxn>
                  <a:cxn ang="0">
                    <a:pos x="1183" y="496"/>
                  </a:cxn>
                  <a:cxn ang="0">
                    <a:pos x="1212" y="496"/>
                  </a:cxn>
                  <a:cxn ang="0">
                    <a:pos x="1241" y="496"/>
                  </a:cxn>
                  <a:cxn ang="0">
                    <a:pos x="1271" y="496"/>
                  </a:cxn>
                  <a:cxn ang="0">
                    <a:pos x="1300" y="538"/>
                  </a:cxn>
                  <a:cxn ang="0">
                    <a:pos x="1329" y="785"/>
                  </a:cxn>
                  <a:cxn ang="0">
                    <a:pos x="1358" y="413"/>
                  </a:cxn>
                  <a:cxn ang="0">
                    <a:pos x="1387" y="620"/>
                  </a:cxn>
                  <a:cxn ang="0">
                    <a:pos x="1416" y="703"/>
                  </a:cxn>
                  <a:cxn ang="0">
                    <a:pos x="1445" y="744"/>
                  </a:cxn>
                  <a:cxn ang="0">
                    <a:pos x="1475" y="951"/>
                  </a:cxn>
                </a:cxnLst>
                <a:rect l="0" t="0" r="r" b="b"/>
                <a:pathLst>
                  <a:path w="1492" h="951">
                    <a:moveTo>
                      <a:pt x="0" y="951"/>
                    </a:moveTo>
                    <a:lnTo>
                      <a:pt x="0" y="744"/>
                    </a:lnTo>
                    <a:lnTo>
                      <a:pt x="5" y="951"/>
                    </a:lnTo>
                    <a:lnTo>
                      <a:pt x="11" y="910"/>
                    </a:lnTo>
                    <a:lnTo>
                      <a:pt x="17" y="951"/>
                    </a:lnTo>
                    <a:lnTo>
                      <a:pt x="23" y="951"/>
                    </a:lnTo>
                    <a:lnTo>
                      <a:pt x="29" y="951"/>
                    </a:lnTo>
                    <a:lnTo>
                      <a:pt x="35" y="951"/>
                    </a:lnTo>
                    <a:lnTo>
                      <a:pt x="40" y="951"/>
                    </a:lnTo>
                    <a:lnTo>
                      <a:pt x="46" y="951"/>
                    </a:lnTo>
                    <a:lnTo>
                      <a:pt x="52" y="951"/>
                    </a:lnTo>
                    <a:lnTo>
                      <a:pt x="58" y="951"/>
                    </a:lnTo>
                    <a:lnTo>
                      <a:pt x="64" y="951"/>
                    </a:lnTo>
                    <a:lnTo>
                      <a:pt x="70" y="951"/>
                    </a:lnTo>
                    <a:lnTo>
                      <a:pt x="75" y="951"/>
                    </a:lnTo>
                    <a:lnTo>
                      <a:pt x="81" y="951"/>
                    </a:lnTo>
                    <a:lnTo>
                      <a:pt x="87" y="951"/>
                    </a:lnTo>
                    <a:lnTo>
                      <a:pt x="93" y="951"/>
                    </a:lnTo>
                    <a:lnTo>
                      <a:pt x="99" y="951"/>
                    </a:lnTo>
                    <a:lnTo>
                      <a:pt x="105" y="951"/>
                    </a:lnTo>
                    <a:lnTo>
                      <a:pt x="110" y="951"/>
                    </a:lnTo>
                    <a:lnTo>
                      <a:pt x="116" y="951"/>
                    </a:lnTo>
                    <a:lnTo>
                      <a:pt x="122" y="910"/>
                    </a:lnTo>
                    <a:lnTo>
                      <a:pt x="128" y="951"/>
                    </a:lnTo>
                    <a:lnTo>
                      <a:pt x="134" y="951"/>
                    </a:lnTo>
                    <a:lnTo>
                      <a:pt x="140" y="951"/>
                    </a:lnTo>
                    <a:lnTo>
                      <a:pt x="145" y="951"/>
                    </a:lnTo>
                    <a:lnTo>
                      <a:pt x="151" y="951"/>
                    </a:lnTo>
                    <a:lnTo>
                      <a:pt x="157" y="951"/>
                    </a:lnTo>
                    <a:lnTo>
                      <a:pt x="163" y="951"/>
                    </a:lnTo>
                    <a:lnTo>
                      <a:pt x="169" y="951"/>
                    </a:lnTo>
                    <a:lnTo>
                      <a:pt x="175" y="951"/>
                    </a:lnTo>
                    <a:lnTo>
                      <a:pt x="180" y="951"/>
                    </a:lnTo>
                    <a:lnTo>
                      <a:pt x="186" y="910"/>
                    </a:lnTo>
                    <a:lnTo>
                      <a:pt x="192" y="910"/>
                    </a:lnTo>
                    <a:lnTo>
                      <a:pt x="198" y="951"/>
                    </a:lnTo>
                    <a:lnTo>
                      <a:pt x="204" y="951"/>
                    </a:lnTo>
                    <a:lnTo>
                      <a:pt x="209" y="951"/>
                    </a:lnTo>
                    <a:lnTo>
                      <a:pt x="215" y="951"/>
                    </a:lnTo>
                    <a:lnTo>
                      <a:pt x="221" y="951"/>
                    </a:lnTo>
                    <a:lnTo>
                      <a:pt x="227" y="951"/>
                    </a:lnTo>
                    <a:lnTo>
                      <a:pt x="233" y="951"/>
                    </a:lnTo>
                    <a:lnTo>
                      <a:pt x="239" y="951"/>
                    </a:lnTo>
                    <a:lnTo>
                      <a:pt x="244" y="951"/>
                    </a:lnTo>
                    <a:lnTo>
                      <a:pt x="250" y="951"/>
                    </a:lnTo>
                    <a:lnTo>
                      <a:pt x="256" y="951"/>
                    </a:lnTo>
                    <a:lnTo>
                      <a:pt x="262" y="951"/>
                    </a:lnTo>
                    <a:lnTo>
                      <a:pt x="268" y="951"/>
                    </a:lnTo>
                    <a:lnTo>
                      <a:pt x="274" y="951"/>
                    </a:lnTo>
                    <a:lnTo>
                      <a:pt x="279" y="910"/>
                    </a:lnTo>
                    <a:lnTo>
                      <a:pt x="285" y="951"/>
                    </a:lnTo>
                    <a:lnTo>
                      <a:pt x="291" y="910"/>
                    </a:lnTo>
                    <a:lnTo>
                      <a:pt x="297" y="910"/>
                    </a:lnTo>
                    <a:lnTo>
                      <a:pt x="303" y="951"/>
                    </a:lnTo>
                    <a:lnTo>
                      <a:pt x="309" y="951"/>
                    </a:lnTo>
                    <a:lnTo>
                      <a:pt x="314" y="868"/>
                    </a:lnTo>
                    <a:lnTo>
                      <a:pt x="320" y="868"/>
                    </a:lnTo>
                    <a:lnTo>
                      <a:pt x="326" y="868"/>
                    </a:lnTo>
                    <a:lnTo>
                      <a:pt x="332" y="951"/>
                    </a:lnTo>
                    <a:lnTo>
                      <a:pt x="338" y="951"/>
                    </a:lnTo>
                    <a:lnTo>
                      <a:pt x="344" y="951"/>
                    </a:lnTo>
                    <a:lnTo>
                      <a:pt x="349" y="951"/>
                    </a:lnTo>
                    <a:lnTo>
                      <a:pt x="355" y="951"/>
                    </a:lnTo>
                    <a:lnTo>
                      <a:pt x="361" y="910"/>
                    </a:lnTo>
                    <a:lnTo>
                      <a:pt x="367" y="868"/>
                    </a:lnTo>
                    <a:lnTo>
                      <a:pt x="373" y="951"/>
                    </a:lnTo>
                    <a:lnTo>
                      <a:pt x="379" y="951"/>
                    </a:lnTo>
                    <a:lnTo>
                      <a:pt x="384" y="910"/>
                    </a:lnTo>
                    <a:lnTo>
                      <a:pt x="390" y="910"/>
                    </a:lnTo>
                    <a:lnTo>
                      <a:pt x="396" y="951"/>
                    </a:lnTo>
                    <a:lnTo>
                      <a:pt x="402" y="951"/>
                    </a:lnTo>
                    <a:lnTo>
                      <a:pt x="408" y="827"/>
                    </a:lnTo>
                    <a:lnTo>
                      <a:pt x="414" y="910"/>
                    </a:lnTo>
                    <a:lnTo>
                      <a:pt x="419" y="910"/>
                    </a:lnTo>
                    <a:lnTo>
                      <a:pt x="425" y="827"/>
                    </a:lnTo>
                    <a:lnTo>
                      <a:pt x="431" y="868"/>
                    </a:lnTo>
                    <a:lnTo>
                      <a:pt x="437" y="868"/>
                    </a:lnTo>
                    <a:lnTo>
                      <a:pt x="443" y="785"/>
                    </a:lnTo>
                    <a:lnTo>
                      <a:pt x="449" y="951"/>
                    </a:lnTo>
                    <a:lnTo>
                      <a:pt x="454" y="827"/>
                    </a:lnTo>
                    <a:lnTo>
                      <a:pt x="460" y="827"/>
                    </a:lnTo>
                    <a:lnTo>
                      <a:pt x="466" y="951"/>
                    </a:lnTo>
                    <a:lnTo>
                      <a:pt x="472" y="951"/>
                    </a:lnTo>
                    <a:lnTo>
                      <a:pt x="478" y="785"/>
                    </a:lnTo>
                    <a:lnTo>
                      <a:pt x="484" y="868"/>
                    </a:lnTo>
                    <a:lnTo>
                      <a:pt x="489" y="868"/>
                    </a:lnTo>
                    <a:lnTo>
                      <a:pt x="495" y="910"/>
                    </a:lnTo>
                    <a:lnTo>
                      <a:pt x="501" y="785"/>
                    </a:lnTo>
                    <a:lnTo>
                      <a:pt x="507" y="827"/>
                    </a:lnTo>
                    <a:lnTo>
                      <a:pt x="513" y="910"/>
                    </a:lnTo>
                    <a:lnTo>
                      <a:pt x="519" y="910"/>
                    </a:lnTo>
                    <a:lnTo>
                      <a:pt x="524" y="868"/>
                    </a:lnTo>
                    <a:lnTo>
                      <a:pt x="530" y="744"/>
                    </a:lnTo>
                    <a:lnTo>
                      <a:pt x="536" y="744"/>
                    </a:lnTo>
                    <a:lnTo>
                      <a:pt x="542" y="910"/>
                    </a:lnTo>
                    <a:lnTo>
                      <a:pt x="548" y="868"/>
                    </a:lnTo>
                    <a:lnTo>
                      <a:pt x="554" y="827"/>
                    </a:lnTo>
                    <a:lnTo>
                      <a:pt x="559" y="868"/>
                    </a:lnTo>
                    <a:lnTo>
                      <a:pt x="565" y="868"/>
                    </a:lnTo>
                    <a:lnTo>
                      <a:pt x="571" y="868"/>
                    </a:lnTo>
                    <a:lnTo>
                      <a:pt x="577" y="910"/>
                    </a:lnTo>
                    <a:lnTo>
                      <a:pt x="583" y="827"/>
                    </a:lnTo>
                    <a:lnTo>
                      <a:pt x="589" y="951"/>
                    </a:lnTo>
                    <a:lnTo>
                      <a:pt x="594" y="868"/>
                    </a:lnTo>
                    <a:lnTo>
                      <a:pt x="600" y="785"/>
                    </a:lnTo>
                    <a:lnTo>
                      <a:pt x="606" y="910"/>
                    </a:lnTo>
                    <a:lnTo>
                      <a:pt x="612" y="703"/>
                    </a:lnTo>
                    <a:lnTo>
                      <a:pt x="618" y="910"/>
                    </a:lnTo>
                    <a:lnTo>
                      <a:pt x="624" y="868"/>
                    </a:lnTo>
                    <a:lnTo>
                      <a:pt x="629" y="910"/>
                    </a:lnTo>
                    <a:lnTo>
                      <a:pt x="635" y="868"/>
                    </a:lnTo>
                    <a:lnTo>
                      <a:pt x="641" y="868"/>
                    </a:lnTo>
                    <a:lnTo>
                      <a:pt x="647" y="868"/>
                    </a:lnTo>
                    <a:lnTo>
                      <a:pt x="653" y="827"/>
                    </a:lnTo>
                    <a:lnTo>
                      <a:pt x="659" y="703"/>
                    </a:lnTo>
                    <a:lnTo>
                      <a:pt x="664" y="827"/>
                    </a:lnTo>
                    <a:lnTo>
                      <a:pt x="670" y="703"/>
                    </a:lnTo>
                    <a:lnTo>
                      <a:pt x="676" y="951"/>
                    </a:lnTo>
                    <a:lnTo>
                      <a:pt x="682" y="910"/>
                    </a:lnTo>
                    <a:lnTo>
                      <a:pt x="688" y="662"/>
                    </a:lnTo>
                    <a:lnTo>
                      <a:pt x="694" y="785"/>
                    </a:lnTo>
                    <a:lnTo>
                      <a:pt x="699" y="785"/>
                    </a:lnTo>
                    <a:lnTo>
                      <a:pt x="705" y="868"/>
                    </a:lnTo>
                    <a:lnTo>
                      <a:pt x="711" y="785"/>
                    </a:lnTo>
                    <a:lnTo>
                      <a:pt x="717" y="703"/>
                    </a:lnTo>
                    <a:lnTo>
                      <a:pt x="723" y="785"/>
                    </a:lnTo>
                    <a:lnTo>
                      <a:pt x="729" y="827"/>
                    </a:lnTo>
                    <a:lnTo>
                      <a:pt x="734" y="827"/>
                    </a:lnTo>
                    <a:lnTo>
                      <a:pt x="740" y="951"/>
                    </a:lnTo>
                    <a:lnTo>
                      <a:pt x="746" y="703"/>
                    </a:lnTo>
                    <a:lnTo>
                      <a:pt x="752" y="827"/>
                    </a:lnTo>
                    <a:lnTo>
                      <a:pt x="758" y="785"/>
                    </a:lnTo>
                    <a:lnTo>
                      <a:pt x="763" y="827"/>
                    </a:lnTo>
                    <a:lnTo>
                      <a:pt x="769" y="662"/>
                    </a:lnTo>
                    <a:lnTo>
                      <a:pt x="775" y="785"/>
                    </a:lnTo>
                    <a:lnTo>
                      <a:pt x="781" y="785"/>
                    </a:lnTo>
                    <a:lnTo>
                      <a:pt x="787" y="662"/>
                    </a:lnTo>
                    <a:lnTo>
                      <a:pt x="793" y="744"/>
                    </a:lnTo>
                    <a:lnTo>
                      <a:pt x="798" y="827"/>
                    </a:lnTo>
                    <a:lnTo>
                      <a:pt x="804" y="703"/>
                    </a:lnTo>
                    <a:lnTo>
                      <a:pt x="810" y="827"/>
                    </a:lnTo>
                    <a:lnTo>
                      <a:pt x="816" y="744"/>
                    </a:lnTo>
                    <a:lnTo>
                      <a:pt x="822" y="703"/>
                    </a:lnTo>
                    <a:lnTo>
                      <a:pt x="828" y="827"/>
                    </a:lnTo>
                    <a:lnTo>
                      <a:pt x="833" y="744"/>
                    </a:lnTo>
                    <a:lnTo>
                      <a:pt x="839" y="910"/>
                    </a:lnTo>
                    <a:lnTo>
                      <a:pt x="845" y="620"/>
                    </a:lnTo>
                    <a:lnTo>
                      <a:pt x="851" y="744"/>
                    </a:lnTo>
                    <a:lnTo>
                      <a:pt x="857" y="620"/>
                    </a:lnTo>
                    <a:lnTo>
                      <a:pt x="863" y="785"/>
                    </a:lnTo>
                    <a:lnTo>
                      <a:pt x="868" y="620"/>
                    </a:lnTo>
                    <a:lnTo>
                      <a:pt x="874" y="496"/>
                    </a:lnTo>
                    <a:lnTo>
                      <a:pt x="880" y="703"/>
                    </a:lnTo>
                    <a:lnTo>
                      <a:pt x="886" y="579"/>
                    </a:lnTo>
                    <a:lnTo>
                      <a:pt x="892" y="538"/>
                    </a:lnTo>
                    <a:lnTo>
                      <a:pt x="898" y="455"/>
                    </a:lnTo>
                    <a:lnTo>
                      <a:pt x="903" y="703"/>
                    </a:lnTo>
                    <a:lnTo>
                      <a:pt x="909" y="538"/>
                    </a:lnTo>
                    <a:lnTo>
                      <a:pt x="915" y="662"/>
                    </a:lnTo>
                    <a:lnTo>
                      <a:pt x="921" y="662"/>
                    </a:lnTo>
                    <a:lnTo>
                      <a:pt x="927" y="579"/>
                    </a:lnTo>
                    <a:lnTo>
                      <a:pt x="933" y="455"/>
                    </a:lnTo>
                    <a:lnTo>
                      <a:pt x="938" y="372"/>
                    </a:lnTo>
                    <a:lnTo>
                      <a:pt x="944" y="579"/>
                    </a:lnTo>
                    <a:lnTo>
                      <a:pt x="950" y="620"/>
                    </a:lnTo>
                    <a:lnTo>
                      <a:pt x="956" y="331"/>
                    </a:lnTo>
                    <a:lnTo>
                      <a:pt x="962" y="413"/>
                    </a:lnTo>
                    <a:lnTo>
                      <a:pt x="968" y="413"/>
                    </a:lnTo>
                    <a:lnTo>
                      <a:pt x="973" y="413"/>
                    </a:lnTo>
                    <a:lnTo>
                      <a:pt x="979" y="289"/>
                    </a:lnTo>
                    <a:lnTo>
                      <a:pt x="985" y="289"/>
                    </a:lnTo>
                    <a:lnTo>
                      <a:pt x="991" y="579"/>
                    </a:lnTo>
                    <a:lnTo>
                      <a:pt x="997" y="620"/>
                    </a:lnTo>
                    <a:lnTo>
                      <a:pt x="1002" y="0"/>
                    </a:lnTo>
                    <a:lnTo>
                      <a:pt x="1008" y="207"/>
                    </a:lnTo>
                    <a:lnTo>
                      <a:pt x="1014" y="496"/>
                    </a:lnTo>
                    <a:lnTo>
                      <a:pt x="1020" y="331"/>
                    </a:lnTo>
                    <a:lnTo>
                      <a:pt x="1026" y="496"/>
                    </a:lnTo>
                    <a:lnTo>
                      <a:pt x="1032" y="455"/>
                    </a:lnTo>
                    <a:lnTo>
                      <a:pt x="1037" y="538"/>
                    </a:lnTo>
                    <a:lnTo>
                      <a:pt x="1043" y="703"/>
                    </a:lnTo>
                    <a:lnTo>
                      <a:pt x="1049" y="496"/>
                    </a:lnTo>
                    <a:lnTo>
                      <a:pt x="1055" y="455"/>
                    </a:lnTo>
                    <a:lnTo>
                      <a:pt x="1061" y="620"/>
                    </a:lnTo>
                    <a:lnTo>
                      <a:pt x="1067" y="579"/>
                    </a:lnTo>
                    <a:lnTo>
                      <a:pt x="1072" y="372"/>
                    </a:lnTo>
                    <a:lnTo>
                      <a:pt x="1078" y="785"/>
                    </a:lnTo>
                    <a:lnTo>
                      <a:pt x="1084" y="744"/>
                    </a:lnTo>
                    <a:lnTo>
                      <a:pt x="1090" y="620"/>
                    </a:lnTo>
                    <a:lnTo>
                      <a:pt x="1096" y="744"/>
                    </a:lnTo>
                    <a:lnTo>
                      <a:pt x="1102" y="496"/>
                    </a:lnTo>
                    <a:lnTo>
                      <a:pt x="1107" y="538"/>
                    </a:lnTo>
                    <a:lnTo>
                      <a:pt x="1113" y="579"/>
                    </a:lnTo>
                    <a:lnTo>
                      <a:pt x="1119" y="703"/>
                    </a:lnTo>
                    <a:lnTo>
                      <a:pt x="1125" y="785"/>
                    </a:lnTo>
                    <a:lnTo>
                      <a:pt x="1131" y="703"/>
                    </a:lnTo>
                    <a:lnTo>
                      <a:pt x="1137" y="579"/>
                    </a:lnTo>
                    <a:lnTo>
                      <a:pt x="1142" y="703"/>
                    </a:lnTo>
                    <a:lnTo>
                      <a:pt x="1148" y="620"/>
                    </a:lnTo>
                    <a:lnTo>
                      <a:pt x="1154" y="538"/>
                    </a:lnTo>
                    <a:lnTo>
                      <a:pt x="1160" y="868"/>
                    </a:lnTo>
                    <a:lnTo>
                      <a:pt x="1166" y="538"/>
                    </a:lnTo>
                    <a:lnTo>
                      <a:pt x="1172" y="496"/>
                    </a:lnTo>
                    <a:lnTo>
                      <a:pt x="1177" y="620"/>
                    </a:lnTo>
                    <a:lnTo>
                      <a:pt x="1183" y="496"/>
                    </a:lnTo>
                    <a:lnTo>
                      <a:pt x="1189" y="496"/>
                    </a:lnTo>
                    <a:lnTo>
                      <a:pt x="1195" y="620"/>
                    </a:lnTo>
                    <a:lnTo>
                      <a:pt x="1201" y="620"/>
                    </a:lnTo>
                    <a:lnTo>
                      <a:pt x="1206" y="455"/>
                    </a:lnTo>
                    <a:lnTo>
                      <a:pt x="1212" y="496"/>
                    </a:lnTo>
                    <a:lnTo>
                      <a:pt x="1218" y="455"/>
                    </a:lnTo>
                    <a:lnTo>
                      <a:pt x="1224" y="579"/>
                    </a:lnTo>
                    <a:lnTo>
                      <a:pt x="1230" y="579"/>
                    </a:lnTo>
                    <a:lnTo>
                      <a:pt x="1236" y="620"/>
                    </a:lnTo>
                    <a:lnTo>
                      <a:pt x="1241" y="496"/>
                    </a:lnTo>
                    <a:lnTo>
                      <a:pt x="1247" y="289"/>
                    </a:lnTo>
                    <a:lnTo>
                      <a:pt x="1253" y="744"/>
                    </a:lnTo>
                    <a:lnTo>
                      <a:pt x="1259" y="496"/>
                    </a:lnTo>
                    <a:lnTo>
                      <a:pt x="1265" y="662"/>
                    </a:lnTo>
                    <a:lnTo>
                      <a:pt x="1271" y="496"/>
                    </a:lnTo>
                    <a:lnTo>
                      <a:pt x="1276" y="579"/>
                    </a:lnTo>
                    <a:lnTo>
                      <a:pt x="1282" y="620"/>
                    </a:lnTo>
                    <a:lnTo>
                      <a:pt x="1288" y="455"/>
                    </a:lnTo>
                    <a:lnTo>
                      <a:pt x="1294" y="538"/>
                    </a:lnTo>
                    <a:lnTo>
                      <a:pt x="1300" y="538"/>
                    </a:lnTo>
                    <a:lnTo>
                      <a:pt x="1306" y="620"/>
                    </a:lnTo>
                    <a:lnTo>
                      <a:pt x="1311" y="496"/>
                    </a:lnTo>
                    <a:lnTo>
                      <a:pt x="1317" y="620"/>
                    </a:lnTo>
                    <a:lnTo>
                      <a:pt x="1323" y="538"/>
                    </a:lnTo>
                    <a:lnTo>
                      <a:pt x="1329" y="785"/>
                    </a:lnTo>
                    <a:lnTo>
                      <a:pt x="1335" y="662"/>
                    </a:lnTo>
                    <a:lnTo>
                      <a:pt x="1341" y="289"/>
                    </a:lnTo>
                    <a:lnTo>
                      <a:pt x="1346" y="538"/>
                    </a:lnTo>
                    <a:lnTo>
                      <a:pt x="1352" y="496"/>
                    </a:lnTo>
                    <a:lnTo>
                      <a:pt x="1358" y="413"/>
                    </a:lnTo>
                    <a:lnTo>
                      <a:pt x="1364" y="496"/>
                    </a:lnTo>
                    <a:lnTo>
                      <a:pt x="1370" y="620"/>
                    </a:lnTo>
                    <a:lnTo>
                      <a:pt x="1376" y="744"/>
                    </a:lnTo>
                    <a:lnTo>
                      <a:pt x="1381" y="662"/>
                    </a:lnTo>
                    <a:lnTo>
                      <a:pt x="1387" y="620"/>
                    </a:lnTo>
                    <a:lnTo>
                      <a:pt x="1393" y="413"/>
                    </a:lnTo>
                    <a:lnTo>
                      <a:pt x="1399" y="662"/>
                    </a:lnTo>
                    <a:lnTo>
                      <a:pt x="1405" y="703"/>
                    </a:lnTo>
                    <a:lnTo>
                      <a:pt x="1411" y="785"/>
                    </a:lnTo>
                    <a:lnTo>
                      <a:pt x="1416" y="703"/>
                    </a:lnTo>
                    <a:lnTo>
                      <a:pt x="1422" y="785"/>
                    </a:lnTo>
                    <a:lnTo>
                      <a:pt x="1428" y="703"/>
                    </a:lnTo>
                    <a:lnTo>
                      <a:pt x="1434" y="827"/>
                    </a:lnTo>
                    <a:lnTo>
                      <a:pt x="1440" y="951"/>
                    </a:lnTo>
                    <a:lnTo>
                      <a:pt x="1445" y="744"/>
                    </a:lnTo>
                    <a:lnTo>
                      <a:pt x="1451" y="868"/>
                    </a:lnTo>
                    <a:lnTo>
                      <a:pt x="1457" y="951"/>
                    </a:lnTo>
                    <a:lnTo>
                      <a:pt x="1463" y="868"/>
                    </a:lnTo>
                    <a:lnTo>
                      <a:pt x="1469" y="785"/>
                    </a:lnTo>
                    <a:lnTo>
                      <a:pt x="1475" y="951"/>
                    </a:lnTo>
                    <a:lnTo>
                      <a:pt x="1480" y="868"/>
                    </a:lnTo>
                    <a:lnTo>
                      <a:pt x="1486" y="951"/>
                    </a:lnTo>
                    <a:lnTo>
                      <a:pt x="1492" y="951"/>
                    </a:lnTo>
                    <a:lnTo>
                      <a:pt x="0" y="951"/>
                    </a:lnTo>
                    <a:close/>
                  </a:path>
                </a:pathLst>
              </a:custGeom>
              <a:solidFill>
                <a:srgbClr val="80808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21" name="Freeform 253"/>
              <p:cNvSpPr>
                <a:spLocks/>
              </p:cNvSpPr>
              <p:nvPr/>
            </p:nvSpPr>
            <p:spPr bwMode="auto">
              <a:xfrm>
                <a:off x="6551613" y="6713538"/>
                <a:ext cx="2368550" cy="1509712"/>
              </a:xfrm>
              <a:custGeom>
                <a:avLst/>
                <a:gdLst/>
                <a:ahLst/>
                <a:cxnLst>
                  <a:cxn ang="0">
                    <a:pos x="17" y="951"/>
                  </a:cxn>
                  <a:cxn ang="0">
                    <a:pos x="46" y="951"/>
                  </a:cxn>
                  <a:cxn ang="0">
                    <a:pos x="75" y="951"/>
                  </a:cxn>
                  <a:cxn ang="0">
                    <a:pos x="105" y="951"/>
                  </a:cxn>
                  <a:cxn ang="0">
                    <a:pos x="134" y="951"/>
                  </a:cxn>
                  <a:cxn ang="0">
                    <a:pos x="163" y="951"/>
                  </a:cxn>
                  <a:cxn ang="0">
                    <a:pos x="192" y="910"/>
                  </a:cxn>
                  <a:cxn ang="0">
                    <a:pos x="221" y="951"/>
                  </a:cxn>
                  <a:cxn ang="0">
                    <a:pos x="250" y="951"/>
                  </a:cxn>
                  <a:cxn ang="0">
                    <a:pos x="279" y="910"/>
                  </a:cxn>
                  <a:cxn ang="0">
                    <a:pos x="309" y="951"/>
                  </a:cxn>
                  <a:cxn ang="0">
                    <a:pos x="338" y="951"/>
                  </a:cxn>
                  <a:cxn ang="0">
                    <a:pos x="367" y="868"/>
                  </a:cxn>
                  <a:cxn ang="0">
                    <a:pos x="396" y="951"/>
                  </a:cxn>
                  <a:cxn ang="0">
                    <a:pos x="425" y="827"/>
                  </a:cxn>
                  <a:cxn ang="0">
                    <a:pos x="454" y="827"/>
                  </a:cxn>
                  <a:cxn ang="0">
                    <a:pos x="484" y="868"/>
                  </a:cxn>
                  <a:cxn ang="0">
                    <a:pos x="513" y="910"/>
                  </a:cxn>
                  <a:cxn ang="0">
                    <a:pos x="542" y="910"/>
                  </a:cxn>
                  <a:cxn ang="0">
                    <a:pos x="571" y="868"/>
                  </a:cxn>
                  <a:cxn ang="0">
                    <a:pos x="600" y="785"/>
                  </a:cxn>
                  <a:cxn ang="0">
                    <a:pos x="629" y="910"/>
                  </a:cxn>
                  <a:cxn ang="0">
                    <a:pos x="659" y="703"/>
                  </a:cxn>
                  <a:cxn ang="0">
                    <a:pos x="688" y="662"/>
                  </a:cxn>
                  <a:cxn ang="0">
                    <a:pos x="717" y="703"/>
                  </a:cxn>
                  <a:cxn ang="0">
                    <a:pos x="746" y="703"/>
                  </a:cxn>
                  <a:cxn ang="0">
                    <a:pos x="775" y="785"/>
                  </a:cxn>
                  <a:cxn ang="0">
                    <a:pos x="804" y="703"/>
                  </a:cxn>
                  <a:cxn ang="0">
                    <a:pos x="833" y="744"/>
                  </a:cxn>
                  <a:cxn ang="0">
                    <a:pos x="863" y="785"/>
                  </a:cxn>
                  <a:cxn ang="0">
                    <a:pos x="892" y="538"/>
                  </a:cxn>
                  <a:cxn ang="0">
                    <a:pos x="921" y="662"/>
                  </a:cxn>
                  <a:cxn ang="0">
                    <a:pos x="950" y="620"/>
                  </a:cxn>
                  <a:cxn ang="0">
                    <a:pos x="979" y="289"/>
                  </a:cxn>
                  <a:cxn ang="0">
                    <a:pos x="1008" y="207"/>
                  </a:cxn>
                  <a:cxn ang="0">
                    <a:pos x="1037" y="538"/>
                  </a:cxn>
                  <a:cxn ang="0">
                    <a:pos x="1067" y="579"/>
                  </a:cxn>
                  <a:cxn ang="0">
                    <a:pos x="1096" y="744"/>
                  </a:cxn>
                  <a:cxn ang="0">
                    <a:pos x="1125" y="785"/>
                  </a:cxn>
                  <a:cxn ang="0">
                    <a:pos x="1154" y="538"/>
                  </a:cxn>
                  <a:cxn ang="0">
                    <a:pos x="1183" y="496"/>
                  </a:cxn>
                  <a:cxn ang="0">
                    <a:pos x="1212" y="496"/>
                  </a:cxn>
                  <a:cxn ang="0">
                    <a:pos x="1241" y="496"/>
                  </a:cxn>
                  <a:cxn ang="0">
                    <a:pos x="1271" y="496"/>
                  </a:cxn>
                  <a:cxn ang="0">
                    <a:pos x="1300" y="538"/>
                  </a:cxn>
                  <a:cxn ang="0">
                    <a:pos x="1329" y="785"/>
                  </a:cxn>
                  <a:cxn ang="0">
                    <a:pos x="1358" y="413"/>
                  </a:cxn>
                  <a:cxn ang="0">
                    <a:pos x="1387" y="620"/>
                  </a:cxn>
                  <a:cxn ang="0">
                    <a:pos x="1416" y="703"/>
                  </a:cxn>
                  <a:cxn ang="0">
                    <a:pos x="1445" y="744"/>
                  </a:cxn>
                  <a:cxn ang="0">
                    <a:pos x="1475" y="951"/>
                  </a:cxn>
                </a:cxnLst>
                <a:rect l="0" t="0" r="r" b="b"/>
                <a:pathLst>
                  <a:path w="1492" h="951">
                    <a:moveTo>
                      <a:pt x="0" y="951"/>
                    </a:moveTo>
                    <a:lnTo>
                      <a:pt x="0" y="744"/>
                    </a:lnTo>
                    <a:lnTo>
                      <a:pt x="5" y="951"/>
                    </a:lnTo>
                    <a:lnTo>
                      <a:pt x="11" y="910"/>
                    </a:lnTo>
                    <a:lnTo>
                      <a:pt x="17" y="951"/>
                    </a:lnTo>
                    <a:lnTo>
                      <a:pt x="23" y="951"/>
                    </a:lnTo>
                    <a:lnTo>
                      <a:pt x="29" y="951"/>
                    </a:lnTo>
                    <a:lnTo>
                      <a:pt x="35" y="951"/>
                    </a:lnTo>
                    <a:lnTo>
                      <a:pt x="40" y="951"/>
                    </a:lnTo>
                    <a:lnTo>
                      <a:pt x="46" y="951"/>
                    </a:lnTo>
                    <a:lnTo>
                      <a:pt x="52" y="951"/>
                    </a:lnTo>
                    <a:lnTo>
                      <a:pt x="58" y="951"/>
                    </a:lnTo>
                    <a:lnTo>
                      <a:pt x="64" y="951"/>
                    </a:lnTo>
                    <a:lnTo>
                      <a:pt x="70" y="951"/>
                    </a:lnTo>
                    <a:lnTo>
                      <a:pt x="75" y="951"/>
                    </a:lnTo>
                    <a:lnTo>
                      <a:pt x="81" y="951"/>
                    </a:lnTo>
                    <a:lnTo>
                      <a:pt x="87" y="951"/>
                    </a:lnTo>
                    <a:lnTo>
                      <a:pt x="93" y="951"/>
                    </a:lnTo>
                    <a:lnTo>
                      <a:pt x="99" y="951"/>
                    </a:lnTo>
                    <a:lnTo>
                      <a:pt x="105" y="951"/>
                    </a:lnTo>
                    <a:lnTo>
                      <a:pt x="110" y="951"/>
                    </a:lnTo>
                    <a:lnTo>
                      <a:pt x="116" y="951"/>
                    </a:lnTo>
                    <a:lnTo>
                      <a:pt x="122" y="910"/>
                    </a:lnTo>
                    <a:lnTo>
                      <a:pt x="128" y="951"/>
                    </a:lnTo>
                    <a:lnTo>
                      <a:pt x="134" y="951"/>
                    </a:lnTo>
                    <a:lnTo>
                      <a:pt x="140" y="951"/>
                    </a:lnTo>
                    <a:lnTo>
                      <a:pt x="145" y="951"/>
                    </a:lnTo>
                    <a:lnTo>
                      <a:pt x="151" y="951"/>
                    </a:lnTo>
                    <a:lnTo>
                      <a:pt x="157" y="951"/>
                    </a:lnTo>
                    <a:lnTo>
                      <a:pt x="163" y="951"/>
                    </a:lnTo>
                    <a:lnTo>
                      <a:pt x="169" y="951"/>
                    </a:lnTo>
                    <a:lnTo>
                      <a:pt x="175" y="951"/>
                    </a:lnTo>
                    <a:lnTo>
                      <a:pt x="180" y="951"/>
                    </a:lnTo>
                    <a:lnTo>
                      <a:pt x="186" y="910"/>
                    </a:lnTo>
                    <a:lnTo>
                      <a:pt x="192" y="910"/>
                    </a:lnTo>
                    <a:lnTo>
                      <a:pt x="198" y="951"/>
                    </a:lnTo>
                    <a:lnTo>
                      <a:pt x="204" y="951"/>
                    </a:lnTo>
                    <a:lnTo>
                      <a:pt x="209" y="951"/>
                    </a:lnTo>
                    <a:lnTo>
                      <a:pt x="215" y="951"/>
                    </a:lnTo>
                    <a:lnTo>
                      <a:pt x="221" y="951"/>
                    </a:lnTo>
                    <a:lnTo>
                      <a:pt x="227" y="951"/>
                    </a:lnTo>
                    <a:lnTo>
                      <a:pt x="233" y="951"/>
                    </a:lnTo>
                    <a:lnTo>
                      <a:pt x="239" y="951"/>
                    </a:lnTo>
                    <a:lnTo>
                      <a:pt x="244" y="951"/>
                    </a:lnTo>
                    <a:lnTo>
                      <a:pt x="250" y="951"/>
                    </a:lnTo>
                    <a:lnTo>
                      <a:pt x="256" y="951"/>
                    </a:lnTo>
                    <a:lnTo>
                      <a:pt x="262" y="951"/>
                    </a:lnTo>
                    <a:lnTo>
                      <a:pt x="268" y="951"/>
                    </a:lnTo>
                    <a:lnTo>
                      <a:pt x="274" y="951"/>
                    </a:lnTo>
                    <a:lnTo>
                      <a:pt x="279" y="910"/>
                    </a:lnTo>
                    <a:lnTo>
                      <a:pt x="285" y="951"/>
                    </a:lnTo>
                    <a:lnTo>
                      <a:pt x="291" y="910"/>
                    </a:lnTo>
                    <a:lnTo>
                      <a:pt x="297" y="910"/>
                    </a:lnTo>
                    <a:lnTo>
                      <a:pt x="303" y="951"/>
                    </a:lnTo>
                    <a:lnTo>
                      <a:pt x="309" y="951"/>
                    </a:lnTo>
                    <a:lnTo>
                      <a:pt x="314" y="868"/>
                    </a:lnTo>
                    <a:lnTo>
                      <a:pt x="320" y="868"/>
                    </a:lnTo>
                    <a:lnTo>
                      <a:pt x="326" y="868"/>
                    </a:lnTo>
                    <a:lnTo>
                      <a:pt x="332" y="951"/>
                    </a:lnTo>
                    <a:lnTo>
                      <a:pt x="338" y="951"/>
                    </a:lnTo>
                    <a:lnTo>
                      <a:pt x="344" y="951"/>
                    </a:lnTo>
                    <a:lnTo>
                      <a:pt x="349" y="951"/>
                    </a:lnTo>
                    <a:lnTo>
                      <a:pt x="355" y="951"/>
                    </a:lnTo>
                    <a:lnTo>
                      <a:pt x="361" y="910"/>
                    </a:lnTo>
                    <a:lnTo>
                      <a:pt x="367" y="868"/>
                    </a:lnTo>
                    <a:lnTo>
                      <a:pt x="373" y="951"/>
                    </a:lnTo>
                    <a:lnTo>
                      <a:pt x="379" y="951"/>
                    </a:lnTo>
                    <a:lnTo>
                      <a:pt x="384" y="910"/>
                    </a:lnTo>
                    <a:lnTo>
                      <a:pt x="390" y="910"/>
                    </a:lnTo>
                    <a:lnTo>
                      <a:pt x="396" y="951"/>
                    </a:lnTo>
                    <a:lnTo>
                      <a:pt x="402" y="951"/>
                    </a:lnTo>
                    <a:lnTo>
                      <a:pt x="408" y="827"/>
                    </a:lnTo>
                    <a:lnTo>
                      <a:pt x="414" y="910"/>
                    </a:lnTo>
                    <a:lnTo>
                      <a:pt x="419" y="910"/>
                    </a:lnTo>
                    <a:lnTo>
                      <a:pt x="425" y="827"/>
                    </a:lnTo>
                    <a:lnTo>
                      <a:pt x="431" y="868"/>
                    </a:lnTo>
                    <a:lnTo>
                      <a:pt x="437" y="868"/>
                    </a:lnTo>
                    <a:lnTo>
                      <a:pt x="443" y="785"/>
                    </a:lnTo>
                    <a:lnTo>
                      <a:pt x="449" y="951"/>
                    </a:lnTo>
                    <a:lnTo>
                      <a:pt x="454" y="827"/>
                    </a:lnTo>
                    <a:lnTo>
                      <a:pt x="460" y="827"/>
                    </a:lnTo>
                    <a:lnTo>
                      <a:pt x="466" y="951"/>
                    </a:lnTo>
                    <a:lnTo>
                      <a:pt x="472" y="951"/>
                    </a:lnTo>
                    <a:lnTo>
                      <a:pt x="478" y="785"/>
                    </a:lnTo>
                    <a:lnTo>
                      <a:pt x="484" y="868"/>
                    </a:lnTo>
                    <a:lnTo>
                      <a:pt x="489" y="868"/>
                    </a:lnTo>
                    <a:lnTo>
                      <a:pt x="495" y="910"/>
                    </a:lnTo>
                    <a:lnTo>
                      <a:pt x="501" y="785"/>
                    </a:lnTo>
                    <a:lnTo>
                      <a:pt x="507" y="827"/>
                    </a:lnTo>
                    <a:lnTo>
                      <a:pt x="513" y="910"/>
                    </a:lnTo>
                    <a:lnTo>
                      <a:pt x="519" y="910"/>
                    </a:lnTo>
                    <a:lnTo>
                      <a:pt x="524" y="868"/>
                    </a:lnTo>
                    <a:lnTo>
                      <a:pt x="530" y="744"/>
                    </a:lnTo>
                    <a:lnTo>
                      <a:pt x="536" y="744"/>
                    </a:lnTo>
                    <a:lnTo>
                      <a:pt x="542" y="910"/>
                    </a:lnTo>
                    <a:lnTo>
                      <a:pt x="548" y="868"/>
                    </a:lnTo>
                    <a:lnTo>
                      <a:pt x="554" y="827"/>
                    </a:lnTo>
                    <a:lnTo>
                      <a:pt x="559" y="868"/>
                    </a:lnTo>
                    <a:lnTo>
                      <a:pt x="565" y="868"/>
                    </a:lnTo>
                    <a:lnTo>
                      <a:pt x="571" y="868"/>
                    </a:lnTo>
                    <a:lnTo>
                      <a:pt x="577" y="910"/>
                    </a:lnTo>
                    <a:lnTo>
                      <a:pt x="583" y="827"/>
                    </a:lnTo>
                    <a:lnTo>
                      <a:pt x="589" y="951"/>
                    </a:lnTo>
                    <a:lnTo>
                      <a:pt x="594" y="868"/>
                    </a:lnTo>
                    <a:lnTo>
                      <a:pt x="600" y="785"/>
                    </a:lnTo>
                    <a:lnTo>
                      <a:pt x="606" y="910"/>
                    </a:lnTo>
                    <a:lnTo>
                      <a:pt x="612" y="703"/>
                    </a:lnTo>
                    <a:lnTo>
                      <a:pt x="618" y="910"/>
                    </a:lnTo>
                    <a:lnTo>
                      <a:pt x="624" y="868"/>
                    </a:lnTo>
                    <a:lnTo>
                      <a:pt x="629" y="910"/>
                    </a:lnTo>
                    <a:lnTo>
                      <a:pt x="635" y="868"/>
                    </a:lnTo>
                    <a:lnTo>
                      <a:pt x="641" y="868"/>
                    </a:lnTo>
                    <a:lnTo>
                      <a:pt x="647" y="868"/>
                    </a:lnTo>
                    <a:lnTo>
                      <a:pt x="653" y="827"/>
                    </a:lnTo>
                    <a:lnTo>
                      <a:pt x="659" y="703"/>
                    </a:lnTo>
                    <a:lnTo>
                      <a:pt x="664" y="827"/>
                    </a:lnTo>
                    <a:lnTo>
                      <a:pt x="670" y="703"/>
                    </a:lnTo>
                    <a:lnTo>
                      <a:pt x="676" y="951"/>
                    </a:lnTo>
                    <a:lnTo>
                      <a:pt x="682" y="910"/>
                    </a:lnTo>
                    <a:lnTo>
                      <a:pt x="688" y="662"/>
                    </a:lnTo>
                    <a:lnTo>
                      <a:pt x="694" y="785"/>
                    </a:lnTo>
                    <a:lnTo>
                      <a:pt x="699" y="785"/>
                    </a:lnTo>
                    <a:lnTo>
                      <a:pt x="705" y="868"/>
                    </a:lnTo>
                    <a:lnTo>
                      <a:pt x="711" y="785"/>
                    </a:lnTo>
                    <a:lnTo>
                      <a:pt x="717" y="703"/>
                    </a:lnTo>
                    <a:lnTo>
                      <a:pt x="723" y="785"/>
                    </a:lnTo>
                    <a:lnTo>
                      <a:pt x="729" y="827"/>
                    </a:lnTo>
                    <a:lnTo>
                      <a:pt x="734" y="827"/>
                    </a:lnTo>
                    <a:lnTo>
                      <a:pt x="740" y="951"/>
                    </a:lnTo>
                    <a:lnTo>
                      <a:pt x="746" y="703"/>
                    </a:lnTo>
                    <a:lnTo>
                      <a:pt x="752" y="827"/>
                    </a:lnTo>
                    <a:lnTo>
                      <a:pt x="758" y="785"/>
                    </a:lnTo>
                    <a:lnTo>
                      <a:pt x="763" y="827"/>
                    </a:lnTo>
                    <a:lnTo>
                      <a:pt x="769" y="662"/>
                    </a:lnTo>
                    <a:lnTo>
                      <a:pt x="775" y="785"/>
                    </a:lnTo>
                    <a:lnTo>
                      <a:pt x="781" y="785"/>
                    </a:lnTo>
                    <a:lnTo>
                      <a:pt x="787" y="662"/>
                    </a:lnTo>
                    <a:lnTo>
                      <a:pt x="793" y="744"/>
                    </a:lnTo>
                    <a:lnTo>
                      <a:pt x="798" y="827"/>
                    </a:lnTo>
                    <a:lnTo>
                      <a:pt x="804" y="703"/>
                    </a:lnTo>
                    <a:lnTo>
                      <a:pt x="810" y="827"/>
                    </a:lnTo>
                    <a:lnTo>
                      <a:pt x="816" y="744"/>
                    </a:lnTo>
                    <a:lnTo>
                      <a:pt x="822" y="703"/>
                    </a:lnTo>
                    <a:lnTo>
                      <a:pt x="828" y="827"/>
                    </a:lnTo>
                    <a:lnTo>
                      <a:pt x="833" y="744"/>
                    </a:lnTo>
                    <a:lnTo>
                      <a:pt x="839" y="910"/>
                    </a:lnTo>
                    <a:lnTo>
                      <a:pt x="845" y="620"/>
                    </a:lnTo>
                    <a:lnTo>
                      <a:pt x="851" y="744"/>
                    </a:lnTo>
                    <a:lnTo>
                      <a:pt x="857" y="620"/>
                    </a:lnTo>
                    <a:lnTo>
                      <a:pt x="863" y="785"/>
                    </a:lnTo>
                    <a:lnTo>
                      <a:pt x="868" y="620"/>
                    </a:lnTo>
                    <a:lnTo>
                      <a:pt x="874" y="496"/>
                    </a:lnTo>
                    <a:lnTo>
                      <a:pt x="880" y="703"/>
                    </a:lnTo>
                    <a:lnTo>
                      <a:pt x="886" y="579"/>
                    </a:lnTo>
                    <a:lnTo>
                      <a:pt x="892" y="538"/>
                    </a:lnTo>
                    <a:lnTo>
                      <a:pt x="898" y="455"/>
                    </a:lnTo>
                    <a:lnTo>
                      <a:pt x="903" y="703"/>
                    </a:lnTo>
                    <a:lnTo>
                      <a:pt x="909" y="538"/>
                    </a:lnTo>
                    <a:lnTo>
                      <a:pt x="915" y="662"/>
                    </a:lnTo>
                    <a:lnTo>
                      <a:pt x="921" y="662"/>
                    </a:lnTo>
                    <a:lnTo>
                      <a:pt x="927" y="579"/>
                    </a:lnTo>
                    <a:lnTo>
                      <a:pt x="933" y="455"/>
                    </a:lnTo>
                    <a:lnTo>
                      <a:pt x="938" y="372"/>
                    </a:lnTo>
                    <a:lnTo>
                      <a:pt x="944" y="579"/>
                    </a:lnTo>
                    <a:lnTo>
                      <a:pt x="950" y="620"/>
                    </a:lnTo>
                    <a:lnTo>
                      <a:pt x="956" y="331"/>
                    </a:lnTo>
                    <a:lnTo>
                      <a:pt x="962" y="413"/>
                    </a:lnTo>
                    <a:lnTo>
                      <a:pt x="968" y="413"/>
                    </a:lnTo>
                    <a:lnTo>
                      <a:pt x="973" y="413"/>
                    </a:lnTo>
                    <a:lnTo>
                      <a:pt x="979" y="289"/>
                    </a:lnTo>
                    <a:lnTo>
                      <a:pt x="985" y="289"/>
                    </a:lnTo>
                    <a:lnTo>
                      <a:pt x="991" y="579"/>
                    </a:lnTo>
                    <a:lnTo>
                      <a:pt x="997" y="620"/>
                    </a:lnTo>
                    <a:lnTo>
                      <a:pt x="1002" y="0"/>
                    </a:lnTo>
                    <a:lnTo>
                      <a:pt x="1008" y="207"/>
                    </a:lnTo>
                    <a:lnTo>
                      <a:pt x="1014" y="496"/>
                    </a:lnTo>
                    <a:lnTo>
                      <a:pt x="1020" y="331"/>
                    </a:lnTo>
                    <a:lnTo>
                      <a:pt x="1026" y="496"/>
                    </a:lnTo>
                    <a:lnTo>
                      <a:pt x="1032" y="455"/>
                    </a:lnTo>
                    <a:lnTo>
                      <a:pt x="1037" y="538"/>
                    </a:lnTo>
                    <a:lnTo>
                      <a:pt x="1043" y="703"/>
                    </a:lnTo>
                    <a:lnTo>
                      <a:pt x="1049" y="496"/>
                    </a:lnTo>
                    <a:lnTo>
                      <a:pt x="1055" y="455"/>
                    </a:lnTo>
                    <a:lnTo>
                      <a:pt x="1061" y="620"/>
                    </a:lnTo>
                    <a:lnTo>
                      <a:pt x="1067" y="579"/>
                    </a:lnTo>
                    <a:lnTo>
                      <a:pt x="1072" y="372"/>
                    </a:lnTo>
                    <a:lnTo>
                      <a:pt x="1078" y="785"/>
                    </a:lnTo>
                    <a:lnTo>
                      <a:pt x="1084" y="744"/>
                    </a:lnTo>
                    <a:lnTo>
                      <a:pt x="1090" y="620"/>
                    </a:lnTo>
                    <a:lnTo>
                      <a:pt x="1096" y="744"/>
                    </a:lnTo>
                    <a:lnTo>
                      <a:pt x="1102" y="496"/>
                    </a:lnTo>
                    <a:lnTo>
                      <a:pt x="1107" y="538"/>
                    </a:lnTo>
                    <a:lnTo>
                      <a:pt x="1113" y="579"/>
                    </a:lnTo>
                    <a:lnTo>
                      <a:pt x="1119" y="703"/>
                    </a:lnTo>
                    <a:lnTo>
                      <a:pt x="1125" y="785"/>
                    </a:lnTo>
                    <a:lnTo>
                      <a:pt x="1131" y="703"/>
                    </a:lnTo>
                    <a:lnTo>
                      <a:pt x="1137" y="579"/>
                    </a:lnTo>
                    <a:lnTo>
                      <a:pt x="1142" y="703"/>
                    </a:lnTo>
                    <a:lnTo>
                      <a:pt x="1148" y="620"/>
                    </a:lnTo>
                    <a:lnTo>
                      <a:pt x="1154" y="538"/>
                    </a:lnTo>
                    <a:lnTo>
                      <a:pt x="1160" y="868"/>
                    </a:lnTo>
                    <a:lnTo>
                      <a:pt x="1166" y="538"/>
                    </a:lnTo>
                    <a:lnTo>
                      <a:pt x="1172" y="496"/>
                    </a:lnTo>
                    <a:lnTo>
                      <a:pt x="1177" y="620"/>
                    </a:lnTo>
                    <a:lnTo>
                      <a:pt x="1183" y="496"/>
                    </a:lnTo>
                    <a:lnTo>
                      <a:pt x="1189" y="496"/>
                    </a:lnTo>
                    <a:lnTo>
                      <a:pt x="1195" y="620"/>
                    </a:lnTo>
                    <a:lnTo>
                      <a:pt x="1201" y="620"/>
                    </a:lnTo>
                    <a:lnTo>
                      <a:pt x="1206" y="455"/>
                    </a:lnTo>
                    <a:lnTo>
                      <a:pt x="1212" y="496"/>
                    </a:lnTo>
                    <a:lnTo>
                      <a:pt x="1218" y="455"/>
                    </a:lnTo>
                    <a:lnTo>
                      <a:pt x="1224" y="579"/>
                    </a:lnTo>
                    <a:lnTo>
                      <a:pt x="1230" y="579"/>
                    </a:lnTo>
                    <a:lnTo>
                      <a:pt x="1236" y="620"/>
                    </a:lnTo>
                    <a:lnTo>
                      <a:pt x="1241" y="496"/>
                    </a:lnTo>
                    <a:lnTo>
                      <a:pt x="1247" y="289"/>
                    </a:lnTo>
                    <a:lnTo>
                      <a:pt x="1253" y="744"/>
                    </a:lnTo>
                    <a:lnTo>
                      <a:pt x="1259" y="496"/>
                    </a:lnTo>
                    <a:lnTo>
                      <a:pt x="1265" y="662"/>
                    </a:lnTo>
                    <a:lnTo>
                      <a:pt x="1271" y="496"/>
                    </a:lnTo>
                    <a:lnTo>
                      <a:pt x="1276" y="579"/>
                    </a:lnTo>
                    <a:lnTo>
                      <a:pt x="1282" y="620"/>
                    </a:lnTo>
                    <a:lnTo>
                      <a:pt x="1288" y="455"/>
                    </a:lnTo>
                    <a:lnTo>
                      <a:pt x="1294" y="538"/>
                    </a:lnTo>
                    <a:lnTo>
                      <a:pt x="1300" y="538"/>
                    </a:lnTo>
                    <a:lnTo>
                      <a:pt x="1306" y="620"/>
                    </a:lnTo>
                    <a:lnTo>
                      <a:pt x="1311" y="496"/>
                    </a:lnTo>
                    <a:lnTo>
                      <a:pt x="1317" y="620"/>
                    </a:lnTo>
                    <a:lnTo>
                      <a:pt x="1323" y="538"/>
                    </a:lnTo>
                    <a:lnTo>
                      <a:pt x="1329" y="785"/>
                    </a:lnTo>
                    <a:lnTo>
                      <a:pt x="1335" y="662"/>
                    </a:lnTo>
                    <a:lnTo>
                      <a:pt x="1341" y="289"/>
                    </a:lnTo>
                    <a:lnTo>
                      <a:pt x="1346" y="538"/>
                    </a:lnTo>
                    <a:lnTo>
                      <a:pt x="1352" y="496"/>
                    </a:lnTo>
                    <a:lnTo>
                      <a:pt x="1358" y="413"/>
                    </a:lnTo>
                    <a:lnTo>
                      <a:pt x="1364" y="496"/>
                    </a:lnTo>
                    <a:lnTo>
                      <a:pt x="1370" y="620"/>
                    </a:lnTo>
                    <a:lnTo>
                      <a:pt x="1376" y="744"/>
                    </a:lnTo>
                    <a:lnTo>
                      <a:pt x="1381" y="662"/>
                    </a:lnTo>
                    <a:lnTo>
                      <a:pt x="1387" y="620"/>
                    </a:lnTo>
                    <a:lnTo>
                      <a:pt x="1393" y="413"/>
                    </a:lnTo>
                    <a:lnTo>
                      <a:pt x="1399" y="662"/>
                    </a:lnTo>
                    <a:lnTo>
                      <a:pt x="1405" y="703"/>
                    </a:lnTo>
                    <a:lnTo>
                      <a:pt x="1411" y="785"/>
                    </a:lnTo>
                    <a:lnTo>
                      <a:pt x="1416" y="703"/>
                    </a:lnTo>
                    <a:lnTo>
                      <a:pt x="1422" y="785"/>
                    </a:lnTo>
                    <a:lnTo>
                      <a:pt x="1428" y="703"/>
                    </a:lnTo>
                    <a:lnTo>
                      <a:pt x="1434" y="827"/>
                    </a:lnTo>
                    <a:lnTo>
                      <a:pt x="1440" y="951"/>
                    </a:lnTo>
                    <a:lnTo>
                      <a:pt x="1445" y="744"/>
                    </a:lnTo>
                    <a:lnTo>
                      <a:pt x="1451" y="868"/>
                    </a:lnTo>
                    <a:lnTo>
                      <a:pt x="1457" y="951"/>
                    </a:lnTo>
                    <a:lnTo>
                      <a:pt x="1463" y="868"/>
                    </a:lnTo>
                    <a:lnTo>
                      <a:pt x="1469" y="785"/>
                    </a:lnTo>
                    <a:lnTo>
                      <a:pt x="1475" y="951"/>
                    </a:lnTo>
                    <a:lnTo>
                      <a:pt x="1480" y="868"/>
                    </a:lnTo>
                    <a:lnTo>
                      <a:pt x="1486" y="951"/>
                    </a:lnTo>
                    <a:lnTo>
                      <a:pt x="1492" y="951"/>
                    </a:lnTo>
                    <a:lnTo>
                      <a:pt x="0" y="951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22" name="Rectangle 254"/>
              <p:cNvSpPr>
                <a:spLocks noChangeArrowheads="1"/>
              </p:cNvSpPr>
              <p:nvPr/>
            </p:nvSpPr>
            <p:spPr bwMode="auto">
              <a:xfrm>
                <a:off x="6551613" y="5926138"/>
                <a:ext cx="2368550" cy="22971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364" name="Groep 363"/>
            <p:cNvGrpSpPr/>
            <p:nvPr/>
          </p:nvGrpSpPr>
          <p:grpSpPr>
            <a:xfrm>
              <a:off x="3645326" y="5908368"/>
              <a:ext cx="1163039" cy="1191023"/>
              <a:chOff x="5538788" y="8618538"/>
              <a:chExt cx="2301875" cy="1839912"/>
            </a:xfrm>
          </p:grpSpPr>
          <p:sp>
            <p:nvSpPr>
              <p:cNvPr id="58654" name="Freeform 286"/>
              <p:cNvSpPr>
                <a:spLocks/>
              </p:cNvSpPr>
              <p:nvPr/>
            </p:nvSpPr>
            <p:spPr bwMode="auto">
              <a:xfrm>
                <a:off x="5538788" y="9231313"/>
                <a:ext cx="2301875" cy="1227137"/>
              </a:xfrm>
              <a:custGeom>
                <a:avLst/>
                <a:gdLst/>
                <a:ahLst/>
                <a:cxnLst>
                  <a:cxn ang="0">
                    <a:pos x="17" y="773"/>
                  </a:cxn>
                  <a:cxn ang="0">
                    <a:pos x="45" y="773"/>
                  </a:cxn>
                  <a:cxn ang="0">
                    <a:pos x="73" y="773"/>
                  </a:cxn>
                  <a:cxn ang="0">
                    <a:pos x="102" y="773"/>
                  </a:cxn>
                  <a:cxn ang="0">
                    <a:pos x="130" y="773"/>
                  </a:cxn>
                  <a:cxn ang="0">
                    <a:pos x="158" y="773"/>
                  </a:cxn>
                  <a:cxn ang="0">
                    <a:pos x="187" y="773"/>
                  </a:cxn>
                  <a:cxn ang="0">
                    <a:pos x="215" y="773"/>
                  </a:cxn>
                  <a:cxn ang="0">
                    <a:pos x="243" y="773"/>
                  </a:cxn>
                  <a:cxn ang="0">
                    <a:pos x="272" y="773"/>
                  </a:cxn>
                  <a:cxn ang="0">
                    <a:pos x="300" y="773"/>
                  </a:cxn>
                  <a:cxn ang="0">
                    <a:pos x="328" y="773"/>
                  </a:cxn>
                  <a:cxn ang="0">
                    <a:pos x="357" y="773"/>
                  </a:cxn>
                  <a:cxn ang="0">
                    <a:pos x="385" y="773"/>
                  </a:cxn>
                  <a:cxn ang="0">
                    <a:pos x="413" y="773"/>
                  </a:cxn>
                  <a:cxn ang="0">
                    <a:pos x="441" y="773"/>
                  </a:cxn>
                  <a:cxn ang="0">
                    <a:pos x="470" y="773"/>
                  </a:cxn>
                  <a:cxn ang="0">
                    <a:pos x="498" y="766"/>
                  </a:cxn>
                  <a:cxn ang="0">
                    <a:pos x="527" y="773"/>
                  </a:cxn>
                  <a:cxn ang="0">
                    <a:pos x="555" y="773"/>
                  </a:cxn>
                  <a:cxn ang="0">
                    <a:pos x="583" y="773"/>
                  </a:cxn>
                  <a:cxn ang="0">
                    <a:pos x="612" y="773"/>
                  </a:cxn>
                  <a:cxn ang="0">
                    <a:pos x="640" y="759"/>
                  </a:cxn>
                  <a:cxn ang="0">
                    <a:pos x="668" y="773"/>
                  </a:cxn>
                  <a:cxn ang="0">
                    <a:pos x="696" y="759"/>
                  </a:cxn>
                  <a:cxn ang="0">
                    <a:pos x="725" y="766"/>
                  </a:cxn>
                  <a:cxn ang="0">
                    <a:pos x="753" y="759"/>
                  </a:cxn>
                  <a:cxn ang="0">
                    <a:pos x="782" y="723"/>
                  </a:cxn>
                  <a:cxn ang="0">
                    <a:pos x="810" y="744"/>
                  </a:cxn>
                  <a:cxn ang="0">
                    <a:pos x="838" y="666"/>
                  </a:cxn>
                  <a:cxn ang="0">
                    <a:pos x="867" y="658"/>
                  </a:cxn>
                  <a:cxn ang="0">
                    <a:pos x="895" y="637"/>
                  </a:cxn>
                  <a:cxn ang="0">
                    <a:pos x="923" y="537"/>
                  </a:cxn>
                  <a:cxn ang="0">
                    <a:pos x="951" y="508"/>
                  </a:cxn>
                  <a:cxn ang="0">
                    <a:pos x="980" y="201"/>
                  </a:cxn>
                  <a:cxn ang="0">
                    <a:pos x="1008" y="101"/>
                  </a:cxn>
                  <a:cxn ang="0">
                    <a:pos x="1036" y="115"/>
                  </a:cxn>
                  <a:cxn ang="0">
                    <a:pos x="1065" y="258"/>
                  </a:cxn>
                  <a:cxn ang="0">
                    <a:pos x="1093" y="279"/>
                  </a:cxn>
                  <a:cxn ang="0">
                    <a:pos x="1122" y="430"/>
                  </a:cxn>
                  <a:cxn ang="0">
                    <a:pos x="1150" y="594"/>
                  </a:cxn>
                  <a:cxn ang="0">
                    <a:pos x="1178" y="680"/>
                  </a:cxn>
                  <a:cxn ang="0">
                    <a:pos x="1206" y="766"/>
                  </a:cxn>
                  <a:cxn ang="0">
                    <a:pos x="1235" y="773"/>
                  </a:cxn>
                  <a:cxn ang="0">
                    <a:pos x="1263" y="773"/>
                  </a:cxn>
                  <a:cxn ang="0">
                    <a:pos x="1291" y="773"/>
                  </a:cxn>
                  <a:cxn ang="0">
                    <a:pos x="1320" y="773"/>
                  </a:cxn>
                  <a:cxn ang="0">
                    <a:pos x="1348" y="773"/>
                  </a:cxn>
                  <a:cxn ang="0">
                    <a:pos x="1376" y="773"/>
                  </a:cxn>
                  <a:cxn ang="0">
                    <a:pos x="1405" y="773"/>
                  </a:cxn>
                  <a:cxn ang="0">
                    <a:pos x="1433" y="773"/>
                  </a:cxn>
                </a:cxnLst>
                <a:rect l="0" t="0" r="r" b="b"/>
                <a:pathLst>
                  <a:path w="1450" h="773">
                    <a:moveTo>
                      <a:pt x="0" y="773"/>
                    </a:moveTo>
                    <a:lnTo>
                      <a:pt x="0" y="773"/>
                    </a:lnTo>
                    <a:lnTo>
                      <a:pt x="5" y="773"/>
                    </a:lnTo>
                    <a:lnTo>
                      <a:pt x="11" y="773"/>
                    </a:lnTo>
                    <a:lnTo>
                      <a:pt x="17" y="773"/>
                    </a:lnTo>
                    <a:lnTo>
                      <a:pt x="22" y="773"/>
                    </a:lnTo>
                    <a:lnTo>
                      <a:pt x="28" y="773"/>
                    </a:lnTo>
                    <a:lnTo>
                      <a:pt x="34" y="773"/>
                    </a:lnTo>
                    <a:lnTo>
                      <a:pt x="39" y="773"/>
                    </a:lnTo>
                    <a:lnTo>
                      <a:pt x="45" y="773"/>
                    </a:lnTo>
                    <a:lnTo>
                      <a:pt x="51" y="773"/>
                    </a:lnTo>
                    <a:lnTo>
                      <a:pt x="56" y="773"/>
                    </a:lnTo>
                    <a:lnTo>
                      <a:pt x="62" y="773"/>
                    </a:lnTo>
                    <a:lnTo>
                      <a:pt x="68" y="773"/>
                    </a:lnTo>
                    <a:lnTo>
                      <a:pt x="73" y="773"/>
                    </a:lnTo>
                    <a:lnTo>
                      <a:pt x="79" y="773"/>
                    </a:lnTo>
                    <a:lnTo>
                      <a:pt x="85" y="773"/>
                    </a:lnTo>
                    <a:lnTo>
                      <a:pt x="90" y="773"/>
                    </a:lnTo>
                    <a:lnTo>
                      <a:pt x="96" y="773"/>
                    </a:lnTo>
                    <a:lnTo>
                      <a:pt x="102" y="773"/>
                    </a:lnTo>
                    <a:lnTo>
                      <a:pt x="107" y="773"/>
                    </a:lnTo>
                    <a:lnTo>
                      <a:pt x="113" y="773"/>
                    </a:lnTo>
                    <a:lnTo>
                      <a:pt x="119" y="773"/>
                    </a:lnTo>
                    <a:lnTo>
                      <a:pt x="124" y="773"/>
                    </a:lnTo>
                    <a:lnTo>
                      <a:pt x="130" y="773"/>
                    </a:lnTo>
                    <a:lnTo>
                      <a:pt x="136" y="773"/>
                    </a:lnTo>
                    <a:lnTo>
                      <a:pt x="141" y="773"/>
                    </a:lnTo>
                    <a:lnTo>
                      <a:pt x="147" y="773"/>
                    </a:lnTo>
                    <a:lnTo>
                      <a:pt x="153" y="773"/>
                    </a:lnTo>
                    <a:lnTo>
                      <a:pt x="158" y="773"/>
                    </a:lnTo>
                    <a:lnTo>
                      <a:pt x="164" y="773"/>
                    </a:lnTo>
                    <a:lnTo>
                      <a:pt x="170" y="773"/>
                    </a:lnTo>
                    <a:lnTo>
                      <a:pt x="175" y="773"/>
                    </a:lnTo>
                    <a:lnTo>
                      <a:pt x="181" y="773"/>
                    </a:lnTo>
                    <a:lnTo>
                      <a:pt x="187" y="773"/>
                    </a:lnTo>
                    <a:lnTo>
                      <a:pt x="192" y="773"/>
                    </a:lnTo>
                    <a:lnTo>
                      <a:pt x="198" y="773"/>
                    </a:lnTo>
                    <a:lnTo>
                      <a:pt x="204" y="773"/>
                    </a:lnTo>
                    <a:lnTo>
                      <a:pt x="209" y="773"/>
                    </a:lnTo>
                    <a:lnTo>
                      <a:pt x="215" y="773"/>
                    </a:lnTo>
                    <a:lnTo>
                      <a:pt x="221" y="773"/>
                    </a:lnTo>
                    <a:lnTo>
                      <a:pt x="226" y="773"/>
                    </a:lnTo>
                    <a:lnTo>
                      <a:pt x="232" y="773"/>
                    </a:lnTo>
                    <a:lnTo>
                      <a:pt x="238" y="773"/>
                    </a:lnTo>
                    <a:lnTo>
                      <a:pt x="243" y="773"/>
                    </a:lnTo>
                    <a:lnTo>
                      <a:pt x="249" y="773"/>
                    </a:lnTo>
                    <a:lnTo>
                      <a:pt x="255" y="773"/>
                    </a:lnTo>
                    <a:lnTo>
                      <a:pt x="260" y="773"/>
                    </a:lnTo>
                    <a:lnTo>
                      <a:pt x="266" y="773"/>
                    </a:lnTo>
                    <a:lnTo>
                      <a:pt x="272" y="773"/>
                    </a:lnTo>
                    <a:lnTo>
                      <a:pt x="277" y="773"/>
                    </a:lnTo>
                    <a:lnTo>
                      <a:pt x="283" y="773"/>
                    </a:lnTo>
                    <a:lnTo>
                      <a:pt x="289" y="773"/>
                    </a:lnTo>
                    <a:lnTo>
                      <a:pt x="294" y="773"/>
                    </a:lnTo>
                    <a:lnTo>
                      <a:pt x="300" y="773"/>
                    </a:lnTo>
                    <a:lnTo>
                      <a:pt x="306" y="773"/>
                    </a:lnTo>
                    <a:lnTo>
                      <a:pt x="311" y="773"/>
                    </a:lnTo>
                    <a:lnTo>
                      <a:pt x="317" y="773"/>
                    </a:lnTo>
                    <a:lnTo>
                      <a:pt x="323" y="773"/>
                    </a:lnTo>
                    <a:lnTo>
                      <a:pt x="328" y="773"/>
                    </a:lnTo>
                    <a:lnTo>
                      <a:pt x="334" y="773"/>
                    </a:lnTo>
                    <a:lnTo>
                      <a:pt x="340" y="773"/>
                    </a:lnTo>
                    <a:lnTo>
                      <a:pt x="345" y="773"/>
                    </a:lnTo>
                    <a:lnTo>
                      <a:pt x="351" y="773"/>
                    </a:lnTo>
                    <a:lnTo>
                      <a:pt x="357" y="773"/>
                    </a:lnTo>
                    <a:lnTo>
                      <a:pt x="362" y="773"/>
                    </a:lnTo>
                    <a:lnTo>
                      <a:pt x="368" y="773"/>
                    </a:lnTo>
                    <a:lnTo>
                      <a:pt x="374" y="773"/>
                    </a:lnTo>
                    <a:lnTo>
                      <a:pt x="379" y="773"/>
                    </a:lnTo>
                    <a:lnTo>
                      <a:pt x="385" y="773"/>
                    </a:lnTo>
                    <a:lnTo>
                      <a:pt x="391" y="773"/>
                    </a:lnTo>
                    <a:lnTo>
                      <a:pt x="396" y="773"/>
                    </a:lnTo>
                    <a:lnTo>
                      <a:pt x="402" y="773"/>
                    </a:lnTo>
                    <a:lnTo>
                      <a:pt x="408" y="773"/>
                    </a:lnTo>
                    <a:lnTo>
                      <a:pt x="413" y="773"/>
                    </a:lnTo>
                    <a:lnTo>
                      <a:pt x="419" y="773"/>
                    </a:lnTo>
                    <a:lnTo>
                      <a:pt x="425" y="773"/>
                    </a:lnTo>
                    <a:lnTo>
                      <a:pt x="430" y="773"/>
                    </a:lnTo>
                    <a:lnTo>
                      <a:pt x="436" y="773"/>
                    </a:lnTo>
                    <a:lnTo>
                      <a:pt x="441" y="773"/>
                    </a:lnTo>
                    <a:lnTo>
                      <a:pt x="447" y="773"/>
                    </a:lnTo>
                    <a:lnTo>
                      <a:pt x="453" y="773"/>
                    </a:lnTo>
                    <a:lnTo>
                      <a:pt x="458" y="773"/>
                    </a:lnTo>
                    <a:lnTo>
                      <a:pt x="464" y="773"/>
                    </a:lnTo>
                    <a:lnTo>
                      <a:pt x="470" y="773"/>
                    </a:lnTo>
                    <a:lnTo>
                      <a:pt x="476" y="773"/>
                    </a:lnTo>
                    <a:lnTo>
                      <a:pt x="481" y="773"/>
                    </a:lnTo>
                    <a:lnTo>
                      <a:pt x="487" y="751"/>
                    </a:lnTo>
                    <a:lnTo>
                      <a:pt x="493" y="773"/>
                    </a:lnTo>
                    <a:lnTo>
                      <a:pt x="498" y="766"/>
                    </a:lnTo>
                    <a:lnTo>
                      <a:pt x="504" y="773"/>
                    </a:lnTo>
                    <a:lnTo>
                      <a:pt x="510" y="773"/>
                    </a:lnTo>
                    <a:lnTo>
                      <a:pt x="515" y="773"/>
                    </a:lnTo>
                    <a:lnTo>
                      <a:pt x="521" y="766"/>
                    </a:lnTo>
                    <a:lnTo>
                      <a:pt x="527" y="773"/>
                    </a:lnTo>
                    <a:lnTo>
                      <a:pt x="532" y="773"/>
                    </a:lnTo>
                    <a:lnTo>
                      <a:pt x="538" y="773"/>
                    </a:lnTo>
                    <a:lnTo>
                      <a:pt x="544" y="773"/>
                    </a:lnTo>
                    <a:lnTo>
                      <a:pt x="549" y="759"/>
                    </a:lnTo>
                    <a:lnTo>
                      <a:pt x="555" y="773"/>
                    </a:lnTo>
                    <a:lnTo>
                      <a:pt x="561" y="766"/>
                    </a:lnTo>
                    <a:lnTo>
                      <a:pt x="566" y="766"/>
                    </a:lnTo>
                    <a:lnTo>
                      <a:pt x="572" y="773"/>
                    </a:lnTo>
                    <a:lnTo>
                      <a:pt x="578" y="773"/>
                    </a:lnTo>
                    <a:lnTo>
                      <a:pt x="583" y="773"/>
                    </a:lnTo>
                    <a:lnTo>
                      <a:pt x="589" y="773"/>
                    </a:lnTo>
                    <a:lnTo>
                      <a:pt x="595" y="773"/>
                    </a:lnTo>
                    <a:lnTo>
                      <a:pt x="600" y="773"/>
                    </a:lnTo>
                    <a:lnTo>
                      <a:pt x="606" y="766"/>
                    </a:lnTo>
                    <a:lnTo>
                      <a:pt x="612" y="773"/>
                    </a:lnTo>
                    <a:lnTo>
                      <a:pt x="617" y="766"/>
                    </a:lnTo>
                    <a:lnTo>
                      <a:pt x="623" y="773"/>
                    </a:lnTo>
                    <a:lnTo>
                      <a:pt x="629" y="773"/>
                    </a:lnTo>
                    <a:lnTo>
                      <a:pt x="634" y="766"/>
                    </a:lnTo>
                    <a:lnTo>
                      <a:pt x="640" y="759"/>
                    </a:lnTo>
                    <a:lnTo>
                      <a:pt x="646" y="773"/>
                    </a:lnTo>
                    <a:lnTo>
                      <a:pt x="651" y="773"/>
                    </a:lnTo>
                    <a:lnTo>
                      <a:pt x="657" y="766"/>
                    </a:lnTo>
                    <a:lnTo>
                      <a:pt x="663" y="759"/>
                    </a:lnTo>
                    <a:lnTo>
                      <a:pt x="668" y="773"/>
                    </a:lnTo>
                    <a:lnTo>
                      <a:pt x="674" y="759"/>
                    </a:lnTo>
                    <a:lnTo>
                      <a:pt x="680" y="759"/>
                    </a:lnTo>
                    <a:lnTo>
                      <a:pt x="685" y="766"/>
                    </a:lnTo>
                    <a:lnTo>
                      <a:pt x="691" y="766"/>
                    </a:lnTo>
                    <a:lnTo>
                      <a:pt x="696" y="759"/>
                    </a:lnTo>
                    <a:lnTo>
                      <a:pt x="702" y="744"/>
                    </a:lnTo>
                    <a:lnTo>
                      <a:pt x="708" y="759"/>
                    </a:lnTo>
                    <a:lnTo>
                      <a:pt x="713" y="766"/>
                    </a:lnTo>
                    <a:lnTo>
                      <a:pt x="719" y="766"/>
                    </a:lnTo>
                    <a:lnTo>
                      <a:pt x="725" y="766"/>
                    </a:lnTo>
                    <a:lnTo>
                      <a:pt x="730" y="759"/>
                    </a:lnTo>
                    <a:lnTo>
                      <a:pt x="736" y="751"/>
                    </a:lnTo>
                    <a:lnTo>
                      <a:pt x="742" y="773"/>
                    </a:lnTo>
                    <a:lnTo>
                      <a:pt x="747" y="751"/>
                    </a:lnTo>
                    <a:lnTo>
                      <a:pt x="753" y="759"/>
                    </a:lnTo>
                    <a:lnTo>
                      <a:pt x="759" y="737"/>
                    </a:lnTo>
                    <a:lnTo>
                      <a:pt x="764" y="751"/>
                    </a:lnTo>
                    <a:lnTo>
                      <a:pt x="770" y="759"/>
                    </a:lnTo>
                    <a:lnTo>
                      <a:pt x="776" y="766"/>
                    </a:lnTo>
                    <a:lnTo>
                      <a:pt x="782" y="723"/>
                    </a:lnTo>
                    <a:lnTo>
                      <a:pt x="787" y="716"/>
                    </a:lnTo>
                    <a:lnTo>
                      <a:pt x="793" y="730"/>
                    </a:lnTo>
                    <a:lnTo>
                      <a:pt x="799" y="716"/>
                    </a:lnTo>
                    <a:lnTo>
                      <a:pt x="804" y="744"/>
                    </a:lnTo>
                    <a:lnTo>
                      <a:pt x="810" y="744"/>
                    </a:lnTo>
                    <a:lnTo>
                      <a:pt x="816" y="709"/>
                    </a:lnTo>
                    <a:lnTo>
                      <a:pt x="821" y="744"/>
                    </a:lnTo>
                    <a:lnTo>
                      <a:pt x="827" y="680"/>
                    </a:lnTo>
                    <a:lnTo>
                      <a:pt x="833" y="709"/>
                    </a:lnTo>
                    <a:lnTo>
                      <a:pt x="838" y="666"/>
                    </a:lnTo>
                    <a:lnTo>
                      <a:pt x="844" y="658"/>
                    </a:lnTo>
                    <a:lnTo>
                      <a:pt x="850" y="637"/>
                    </a:lnTo>
                    <a:lnTo>
                      <a:pt x="855" y="716"/>
                    </a:lnTo>
                    <a:lnTo>
                      <a:pt x="861" y="666"/>
                    </a:lnTo>
                    <a:lnTo>
                      <a:pt x="867" y="658"/>
                    </a:lnTo>
                    <a:lnTo>
                      <a:pt x="872" y="687"/>
                    </a:lnTo>
                    <a:lnTo>
                      <a:pt x="878" y="666"/>
                    </a:lnTo>
                    <a:lnTo>
                      <a:pt x="884" y="673"/>
                    </a:lnTo>
                    <a:lnTo>
                      <a:pt x="889" y="587"/>
                    </a:lnTo>
                    <a:lnTo>
                      <a:pt x="895" y="637"/>
                    </a:lnTo>
                    <a:lnTo>
                      <a:pt x="901" y="623"/>
                    </a:lnTo>
                    <a:lnTo>
                      <a:pt x="906" y="644"/>
                    </a:lnTo>
                    <a:lnTo>
                      <a:pt x="912" y="608"/>
                    </a:lnTo>
                    <a:lnTo>
                      <a:pt x="918" y="601"/>
                    </a:lnTo>
                    <a:lnTo>
                      <a:pt x="923" y="537"/>
                    </a:lnTo>
                    <a:lnTo>
                      <a:pt x="929" y="587"/>
                    </a:lnTo>
                    <a:lnTo>
                      <a:pt x="935" y="458"/>
                    </a:lnTo>
                    <a:lnTo>
                      <a:pt x="940" y="551"/>
                    </a:lnTo>
                    <a:lnTo>
                      <a:pt x="946" y="408"/>
                    </a:lnTo>
                    <a:lnTo>
                      <a:pt x="951" y="508"/>
                    </a:lnTo>
                    <a:lnTo>
                      <a:pt x="957" y="415"/>
                    </a:lnTo>
                    <a:lnTo>
                      <a:pt x="963" y="422"/>
                    </a:lnTo>
                    <a:lnTo>
                      <a:pt x="968" y="372"/>
                    </a:lnTo>
                    <a:lnTo>
                      <a:pt x="974" y="265"/>
                    </a:lnTo>
                    <a:lnTo>
                      <a:pt x="980" y="201"/>
                    </a:lnTo>
                    <a:lnTo>
                      <a:pt x="985" y="344"/>
                    </a:lnTo>
                    <a:lnTo>
                      <a:pt x="991" y="294"/>
                    </a:lnTo>
                    <a:lnTo>
                      <a:pt x="997" y="322"/>
                    </a:lnTo>
                    <a:lnTo>
                      <a:pt x="1002" y="229"/>
                    </a:lnTo>
                    <a:lnTo>
                      <a:pt x="1008" y="101"/>
                    </a:lnTo>
                    <a:lnTo>
                      <a:pt x="1014" y="43"/>
                    </a:lnTo>
                    <a:lnTo>
                      <a:pt x="1019" y="279"/>
                    </a:lnTo>
                    <a:lnTo>
                      <a:pt x="1025" y="79"/>
                    </a:lnTo>
                    <a:lnTo>
                      <a:pt x="1031" y="0"/>
                    </a:lnTo>
                    <a:lnTo>
                      <a:pt x="1036" y="115"/>
                    </a:lnTo>
                    <a:lnTo>
                      <a:pt x="1042" y="115"/>
                    </a:lnTo>
                    <a:lnTo>
                      <a:pt x="1048" y="65"/>
                    </a:lnTo>
                    <a:lnTo>
                      <a:pt x="1053" y="108"/>
                    </a:lnTo>
                    <a:lnTo>
                      <a:pt x="1059" y="165"/>
                    </a:lnTo>
                    <a:lnTo>
                      <a:pt x="1065" y="258"/>
                    </a:lnTo>
                    <a:lnTo>
                      <a:pt x="1070" y="51"/>
                    </a:lnTo>
                    <a:lnTo>
                      <a:pt x="1076" y="29"/>
                    </a:lnTo>
                    <a:lnTo>
                      <a:pt x="1082" y="86"/>
                    </a:lnTo>
                    <a:lnTo>
                      <a:pt x="1088" y="251"/>
                    </a:lnTo>
                    <a:lnTo>
                      <a:pt x="1093" y="279"/>
                    </a:lnTo>
                    <a:lnTo>
                      <a:pt x="1099" y="279"/>
                    </a:lnTo>
                    <a:lnTo>
                      <a:pt x="1105" y="372"/>
                    </a:lnTo>
                    <a:lnTo>
                      <a:pt x="1110" y="265"/>
                    </a:lnTo>
                    <a:lnTo>
                      <a:pt x="1116" y="444"/>
                    </a:lnTo>
                    <a:lnTo>
                      <a:pt x="1122" y="430"/>
                    </a:lnTo>
                    <a:lnTo>
                      <a:pt x="1127" y="544"/>
                    </a:lnTo>
                    <a:lnTo>
                      <a:pt x="1133" y="487"/>
                    </a:lnTo>
                    <a:lnTo>
                      <a:pt x="1139" y="544"/>
                    </a:lnTo>
                    <a:lnTo>
                      <a:pt x="1144" y="587"/>
                    </a:lnTo>
                    <a:lnTo>
                      <a:pt x="1150" y="594"/>
                    </a:lnTo>
                    <a:lnTo>
                      <a:pt x="1156" y="558"/>
                    </a:lnTo>
                    <a:lnTo>
                      <a:pt x="1161" y="623"/>
                    </a:lnTo>
                    <a:lnTo>
                      <a:pt x="1167" y="666"/>
                    </a:lnTo>
                    <a:lnTo>
                      <a:pt x="1173" y="673"/>
                    </a:lnTo>
                    <a:lnTo>
                      <a:pt x="1178" y="680"/>
                    </a:lnTo>
                    <a:lnTo>
                      <a:pt x="1184" y="701"/>
                    </a:lnTo>
                    <a:lnTo>
                      <a:pt x="1190" y="744"/>
                    </a:lnTo>
                    <a:lnTo>
                      <a:pt x="1195" y="716"/>
                    </a:lnTo>
                    <a:lnTo>
                      <a:pt x="1201" y="751"/>
                    </a:lnTo>
                    <a:lnTo>
                      <a:pt x="1206" y="766"/>
                    </a:lnTo>
                    <a:lnTo>
                      <a:pt x="1212" y="766"/>
                    </a:lnTo>
                    <a:lnTo>
                      <a:pt x="1218" y="773"/>
                    </a:lnTo>
                    <a:lnTo>
                      <a:pt x="1223" y="773"/>
                    </a:lnTo>
                    <a:lnTo>
                      <a:pt x="1229" y="773"/>
                    </a:lnTo>
                    <a:lnTo>
                      <a:pt x="1235" y="773"/>
                    </a:lnTo>
                    <a:lnTo>
                      <a:pt x="1240" y="773"/>
                    </a:lnTo>
                    <a:lnTo>
                      <a:pt x="1246" y="766"/>
                    </a:lnTo>
                    <a:lnTo>
                      <a:pt x="1252" y="773"/>
                    </a:lnTo>
                    <a:lnTo>
                      <a:pt x="1257" y="773"/>
                    </a:lnTo>
                    <a:lnTo>
                      <a:pt x="1263" y="773"/>
                    </a:lnTo>
                    <a:lnTo>
                      <a:pt x="1269" y="773"/>
                    </a:lnTo>
                    <a:lnTo>
                      <a:pt x="1274" y="766"/>
                    </a:lnTo>
                    <a:lnTo>
                      <a:pt x="1280" y="773"/>
                    </a:lnTo>
                    <a:lnTo>
                      <a:pt x="1286" y="773"/>
                    </a:lnTo>
                    <a:lnTo>
                      <a:pt x="1291" y="773"/>
                    </a:lnTo>
                    <a:lnTo>
                      <a:pt x="1297" y="773"/>
                    </a:lnTo>
                    <a:lnTo>
                      <a:pt x="1303" y="773"/>
                    </a:lnTo>
                    <a:lnTo>
                      <a:pt x="1308" y="773"/>
                    </a:lnTo>
                    <a:lnTo>
                      <a:pt x="1314" y="773"/>
                    </a:lnTo>
                    <a:lnTo>
                      <a:pt x="1320" y="773"/>
                    </a:lnTo>
                    <a:lnTo>
                      <a:pt x="1325" y="773"/>
                    </a:lnTo>
                    <a:lnTo>
                      <a:pt x="1331" y="773"/>
                    </a:lnTo>
                    <a:lnTo>
                      <a:pt x="1337" y="773"/>
                    </a:lnTo>
                    <a:lnTo>
                      <a:pt x="1342" y="773"/>
                    </a:lnTo>
                    <a:lnTo>
                      <a:pt x="1348" y="773"/>
                    </a:lnTo>
                    <a:lnTo>
                      <a:pt x="1354" y="773"/>
                    </a:lnTo>
                    <a:lnTo>
                      <a:pt x="1359" y="773"/>
                    </a:lnTo>
                    <a:lnTo>
                      <a:pt x="1365" y="773"/>
                    </a:lnTo>
                    <a:lnTo>
                      <a:pt x="1371" y="773"/>
                    </a:lnTo>
                    <a:lnTo>
                      <a:pt x="1376" y="773"/>
                    </a:lnTo>
                    <a:lnTo>
                      <a:pt x="1382" y="773"/>
                    </a:lnTo>
                    <a:lnTo>
                      <a:pt x="1388" y="773"/>
                    </a:lnTo>
                    <a:lnTo>
                      <a:pt x="1393" y="773"/>
                    </a:lnTo>
                    <a:lnTo>
                      <a:pt x="1399" y="773"/>
                    </a:lnTo>
                    <a:lnTo>
                      <a:pt x="1405" y="773"/>
                    </a:lnTo>
                    <a:lnTo>
                      <a:pt x="1411" y="773"/>
                    </a:lnTo>
                    <a:lnTo>
                      <a:pt x="1416" y="773"/>
                    </a:lnTo>
                    <a:lnTo>
                      <a:pt x="1422" y="766"/>
                    </a:lnTo>
                    <a:lnTo>
                      <a:pt x="1428" y="773"/>
                    </a:lnTo>
                    <a:lnTo>
                      <a:pt x="1433" y="773"/>
                    </a:lnTo>
                    <a:lnTo>
                      <a:pt x="1439" y="773"/>
                    </a:lnTo>
                    <a:lnTo>
                      <a:pt x="1445" y="773"/>
                    </a:lnTo>
                    <a:lnTo>
                      <a:pt x="1450" y="773"/>
                    </a:lnTo>
                    <a:lnTo>
                      <a:pt x="0" y="773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55" name="Freeform 287"/>
              <p:cNvSpPr>
                <a:spLocks/>
              </p:cNvSpPr>
              <p:nvPr/>
            </p:nvSpPr>
            <p:spPr bwMode="auto">
              <a:xfrm>
                <a:off x="5538788" y="9231313"/>
                <a:ext cx="2301875" cy="1227137"/>
              </a:xfrm>
              <a:custGeom>
                <a:avLst/>
                <a:gdLst/>
                <a:ahLst/>
                <a:cxnLst>
                  <a:cxn ang="0">
                    <a:pos x="17" y="773"/>
                  </a:cxn>
                  <a:cxn ang="0">
                    <a:pos x="45" y="773"/>
                  </a:cxn>
                  <a:cxn ang="0">
                    <a:pos x="73" y="773"/>
                  </a:cxn>
                  <a:cxn ang="0">
                    <a:pos x="102" y="773"/>
                  </a:cxn>
                  <a:cxn ang="0">
                    <a:pos x="130" y="773"/>
                  </a:cxn>
                  <a:cxn ang="0">
                    <a:pos x="158" y="773"/>
                  </a:cxn>
                  <a:cxn ang="0">
                    <a:pos x="187" y="773"/>
                  </a:cxn>
                  <a:cxn ang="0">
                    <a:pos x="215" y="773"/>
                  </a:cxn>
                  <a:cxn ang="0">
                    <a:pos x="243" y="773"/>
                  </a:cxn>
                  <a:cxn ang="0">
                    <a:pos x="272" y="773"/>
                  </a:cxn>
                  <a:cxn ang="0">
                    <a:pos x="300" y="773"/>
                  </a:cxn>
                  <a:cxn ang="0">
                    <a:pos x="328" y="773"/>
                  </a:cxn>
                  <a:cxn ang="0">
                    <a:pos x="357" y="773"/>
                  </a:cxn>
                  <a:cxn ang="0">
                    <a:pos x="385" y="773"/>
                  </a:cxn>
                  <a:cxn ang="0">
                    <a:pos x="413" y="773"/>
                  </a:cxn>
                  <a:cxn ang="0">
                    <a:pos x="441" y="773"/>
                  </a:cxn>
                  <a:cxn ang="0">
                    <a:pos x="470" y="773"/>
                  </a:cxn>
                  <a:cxn ang="0">
                    <a:pos x="498" y="766"/>
                  </a:cxn>
                  <a:cxn ang="0">
                    <a:pos x="527" y="773"/>
                  </a:cxn>
                  <a:cxn ang="0">
                    <a:pos x="555" y="773"/>
                  </a:cxn>
                  <a:cxn ang="0">
                    <a:pos x="583" y="773"/>
                  </a:cxn>
                  <a:cxn ang="0">
                    <a:pos x="612" y="773"/>
                  </a:cxn>
                  <a:cxn ang="0">
                    <a:pos x="640" y="759"/>
                  </a:cxn>
                  <a:cxn ang="0">
                    <a:pos x="668" y="773"/>
                  </a:cxn>
                  <a:cxn ang="0">
                    <a:pos x="696" y="759"/>
                  </a:cxn>
                  <a:cxn ang="0">
                    <a:pos x="725" y="766"/>
                  </a:cxn>
                  <a:cxn ang="0">
                    <a:pos x="753" y="759"/>
                  </a:cxn>
                  <a:cxn ang="0">
                    <a:pos x="782" y="723"/>
                  </a:cxn>
                  <a:cxn ang="0">
                    <a:pos x="810" y="744"/>
                  </a:cxn>
                  <a:cxn ang="0">
                    <a:pos x="838" y="666"/>
                  </a:cxn>
                  <a:cxn ang="0">
                    <a:pos x="867" y="658"/>
                  </a:cxn>
                  <a:cxn ang="0">
                    <a:pos x="895" y="637"/>
                  </a:cxn>
                  <a:cxn ang="0">
                    <a:pos x="923" y="537"/>
                  </a:cxn>
                  <a:cxn ang="0">
                    <a:pos x="951" y="508"/>
                  </a:cxn>
                  <a:cxn ang="0">
                    <a:pos x="980" y="201"/>
                  </a:cxn>
                  <a:cxn ang="0">
                    <a:pos x="1008" y="101"/>
                  </a:cxn>
                  <a:cxn ang="0">
                    <a:pos x="1036" y="115"/>
                  </a:cxn>
                  <a:cxn ang="0">
                    <a:pos x="1065" y="258"/>
                  </a:cxn>
                  <a:cxn ang="0">
                    <a:pos x="1093" y="279"/>
                  </a:cxn>
                  <a:cxn ang="0">
                    <a:pos x="1122" y="430"/>
                  </a:cxn>
                  <a:cxn ang="0">
                    <a:pos x="1150" y="594"/>
                  </a:cxn>
                  <a:cxn ang="0">
                    <a:pos x="1178" y="680"/>
                  </a:cxn>
                  <a:cxn ang="0">
                    <a:pos x="1206" y="766"/>
                  </a:cxn>
                  <a:cxn ang="0">
                    <a:pos x="1235" y="773"/>
                  </a:cxn>
                  <a:cxn ang="0">
                    <a:pos x="1263" y="773"/>
                  </a:cxn>
                  <a:cxn ang="0">
                    <a:pos x="1291" y="773"/>
                  </a:cxn>
                  <a:cxn ang="0">
                    <a:pos x="1320" y="773"/>
                  </a:cxn>
                  <a:cxn ang="0">
                    <a:pos x="1348" y="773"/>
                  </a:cxn>
                  <a:cxn ang="0">
                    <a:pos x="1376" y="773"/>
                  </a:cxn>
                  <a:cxn ang="0">
                    <a:pos x="1405" y="773"/>
                  </a:cxn>
                  <a:cxn ang="0">
                    <a:pos x="1433" y="773"/>
                  </a:cxn>
                </a:cxnLst>
                <a:rect l="0" t="0" r="r" b="b"/>
                <a:pathLst>
                  <a:path w="1450" h="773">
                    <a:moveTo>
                      <a:pt x="0" y="773"/>
                    </a:moveTo>
                    <a:lnTo>
                      <a:pt x="0" y="773"/>
                    </a:lnTo>
                    <a:lnTo>
                      <a:pt x="5" y="773"/>
                    </a:lnTo>
                    <a:lnTo>
                      <a:pt x="11" y="773"/>
                    </a:lnTo>
                    <a:lnTo>
                      <a:pt x="17" y="773"/>
                    </a:lnTo>
                    <a:lnTo>
                      <a:pt x="22" y="773"/>
                    </a:lnTo>
                    <a:lnTo>
                      <a:pt x="28" y="773"/>
                    </a:lnTo>
                    <a:lnTo>
                      <a:pt x="34" y="773"/>
                    </a:lnTo>
                    <a:lnTo>
                      <a:pt x="39" y="773"/>
                    </a:lnTo>
                    <a:lnTo>
                      <a:pt x="45" y="773"/>
                    </a:lnTo>
                    <a:lnTo>
                      <a:pt x="51" y="773"/>
                    </a:lnTo>
                    <a:lnTo>
                      <a:pt x="56" y="773"/>
                    </a:lnTo>
                    <a:lnTo>
                      <a:pt x="62" y="773"/>
                    </a:lnTo>
                    <a:lnTo>
                      <a:pt x="68" y="773"/>
                    </a:lnTo>
                    <a:lnTo>
                      <a:pt x="73" y="773"/>
                    </a:lnTo>
                    <a:lnTo>
                      <a:pt x="79" y="773"/>
                    </a:lnTo>
                    <a:lnTo>
                      <a:pt x="85" y="773"/>
                    </a:lnTo>
                    <a:lnTo>
                      <a:pt x="90" y="773"/>
                    </a:lnTo>
                    <a:lnTo>
                      <a:pt x="96" y="773"/>
                    </a:lnTo>
                    <a:lnTo>
                      <a:pt x="102" y="773"/>
                    </a:lnTo>
                    <a:lnTo>
                      <a:pt x="107" y="773"/>
                    </a:lnTo>
                    <a:lnTo>
                      <a:pt x="113" y="773"/>
                    </a:lnTo>
                    <a:lnTo>
                      <a:pt x="119" y="773"/>
                    </a:lnTo>
                    <a:lnTo>
                      <a:pt x="124" y="773"/>
                    </a:lnTo>
                    <a:lnTo>
                      <a:pt x="130" y="773"/>
                    </a:lnTo>
                    <a:lnTo>
                      <a:pt x="136" y="773"/>
                    </a:lnTo>
                    <a:lnTo>
                      <a:pt x="141" y="773"/>
                    </a:lnTo>
                    <a:lnTo>
                      <a:pt x="147" y="773"/>
                    </a:lnTo>
                    <a:lnTo>
                      <a:pt x="153" y="773"/>
                    </a:lnTo>
                    <a:lnTo>
                      <a:pt x="158" y="773"/>
                    </a:lnTo>
                    <a:lnTo>
                      <a:pt x="164" y="773"/>
                    </a:lnTo>
                    <a:lnTo>
                      <a:pt x="170" y="773"/>
                    </a:lnTo>
                    <a:lnTo>
                      <a:pt x="175" y="773"/>
                    </a:lnTo>
                    <a:lnTo>
                      <a:pt x="181" y="773"/>
                    </a:lnTo>
                    <a:lnTo>
                      <a:pt x="187" y="773"/>
                    </a:lnTo>
                    <a:lnTo>
                      <a:pt x="192" y="773"/>
                    </a:lnTo>
                    <a:lnTo>
                      <a:pt x="198" y="773"/>
                    </a:lnTo>
                    <a:lnTo>
                      <a:pt x="204" y="773"/>
                    </a:lnTo>
                    <a:lnTo>
                      <a:pt x="209" y="773"/>
                    </a:lnTo>
                    <a:lnTo>
                      <a:pt x="215" y="773"/>
                    </a:lnTo>
                    <a:lnTo>
                      <a:pt x="221" y="773"/>
                    </a:lnTo>
                    <a:lnTo>
                      <a:pt x="226" y="773"/>
                    </a:lnTo>
                    <a:lnTo>
                      <a:pt x="232" y="773"/>
                    </a:lnTo>
                    <a:lnTo>
                      <a:pt x="238" y="773"/>
                    </a:lnTo>
                    <a:lnTo>
                      <a:pt x="243" y="773"/>
                    </a:lnTo>
                    <a:lnTo>
                      <a:pt x="249" y="773"/>
                    </a:lnTo>
                    <a:lnTo>
                      <a:pt x="255" y="773"/>
                    </a:lnTo>
                    <a:lnTo>
                      <a:pt x="260" y="773"/>
                    </a:lnTo>
                    <a:lnTo>
                      <a:pt x="266" y="773"/>
                    </a:lnTo>
                    <a:lnTo>
                      <a:pt x="272" y="773"/>
                    </a:lnTo>
                    <a:lnTo>
                      <a:pt x="277" y="773"/>
                    </a:lnTo>
                    <a:lnTo>
                      <a:pt x="283" y="773"/>
                    </a:lnTo>
                    <a:lnTo>
                      <a:pt x="289" y="773"/>
                    </a:lnTo>
                    <a:lnTo>
                      <a:pt x="294" y="773"/>
                    </a:lnTo>
                    <a:lnTo>
                      <a:pt x="300" y="773"/>
                    </a:lnTo>
                    <a:lnTo>
                      <a:pt x="306" y="773"/>
                    </a:lnTo>
                    <a:lnTo>
                      <a:pt x="311" y="773"/>
                    </a:lnTo>
                    <a:lnTo>
                      <a:pt x="317" y="773"/>
                    </a:lnTo>
                    <a:lnTo>
                      <a:pt x="323" y="773"/>
                    </a:lnTo>
                    <a:lnTo>
                      <a:pt x="328" y="773"/>
                    </a:lnTo>
                    <a:lnTo>
                      <a:pt x="334" y="773"/>
                    </a:lnTo>
                    <a:lnTo>
                      <a:pt x="340" y="773"/>
                    </a:lnTo>
                    <a:lnTo>
                      <a:pt x="345" y="773"/>
                    </a:lnTo>
                    <a:lnTo>
                      <a:pt x="351" y="773"/>
                    </a:lnTo>
                    <a:lnTo>
                      <a:pt x="357" y="773"/>
                    </a:lnTo>
                    <a:lnTo>
                      <a:pt x="362" y="773"/>
                    </a:lnTo>
                    <a:lnTo>
                      <a:pt x="368" y="773"/>
                    </a:lnTo>
                    <a:lnTo>
                      <a:pt x="374" y="773"/>
                    </a:lnTo>
                    <a:lnTo>
                      <a:pt x="379" y="773"/>
                    </a:lnTo>
                    <a:lnTo>
                      <a:pt x="385" y="773"/>
                    </a:lnTo>
                    <a:lnTo>
                      <a:pt x="391" y="773"/>
                    </a:lnTo>
                    <a:lnTo>
                      <a:pt x="396" y="773"/>
                    </a:lnTo>
                    <a:lnTo>
                      <a:pt x="402" y="773"/>
                    </a:lnTo>
                    <a:lnTo>
                      <a:pt x="408" y="773"/>
                    </a:lnTo>
                    <a:lnTo>
                      <a:pt x="413" y="773"/>
                    </a:lnTo>
                    <a:lnTo>
                      <a:pt x="419" y="773"/>
                    </a:lnTo>
                    <a:lnTo>
                      <a:pt x="425" y="773"/>
                    </a:lnTo>
                    <a:lnTo>
                      <a:pt x="430" y="773"/>
                    </a:lnTo>
                    <a:lnTo>
                      <a:pt x="436" y="773"/>
                    </a:lnTo>
                    <a:lnTo>
                      <a:pt x="441" y="773"/>
                    </a:lnTo>
                    <a:lnTo>
                      <a:pt x="447" y="773"/>
                    </a:lnTo>
                    <a:lnTo>
                      <a:pt x="453" y="773"/>
                    </a:lnTo>
                    <a:lnTo>
                      <a:pt x="458" y="773"/>
                    </a:lnTo>
                    <a:lnTo>
                      <a:pt x="464" y="773"/>
                    </a:lnTo>
                    <a:lnTo>
                      <a:pt x="470" y="773"/>
                    </a:lnTo>
                    <a:lnTo>
                      <a:pt x="476" y="773"/>
                    </a:lnTo>
                    <a:lnTo>
                      <a:pt x="481" y="773"/>
                    </a:lnTo>
                    <a:lnTo>
                      <a:pt x="487" y="751"/>
                    </a:lnTo>
                    <a:lnTo>
                      <a:pt x="493" y="773"/>
                    </a:lnTo>
                    <a:lnTo>
                      <a:pt x="498" y="766"/>
                    </a:lnTo>
                    <a:lnTo>
                      <a:pt x="504" y="773"/>
                    </a:lnTo>
                    <a:lnTo>
                      <a:pt x="510" y="773"/>
                    </a:lnTo>
                    <a:lnTo>
                      <a:pt x="515" y="773"/>
                    </a:lnTo>
                    <a:lnTo>
                      <a:pt x="521" y="766"/>
                    </a:lnTo>
                    <a:lnTo>
                      <a:pt x="527" y="773"/>
                    </a:lnTo>
                    <a:lnTo>
                      <a:pt x="532" y="773"/>
                    </a:lnTo>
                    <a:lnTo>
                      <a:pt x="538" y="773"/>
                    </a:lnTo>
                    <a:lnTo>
                      <a:pt x="544" y="773"/>
                    </a:lnTo>
                    <a:lnTo>
                      <a:pt x="549" y="759"/>
                    </a:lnTo>
                    <a:lnTo>
                      <a:pt x="555" y="773"/>
                    </a:lnTo>
                    <a:lnTo>
                      <a:pt x="561" y="766"/>
                    </a:lnTo>
                    <a:lnTo>
                      <a:pt x="566" y="766"/>
                    </a:lnTo>
                    <a:lnTo>
                      <a:pt x="572" y="773"/>
                    </a:lnTo>
                    <a:lnTo>
                      <a:pt x="578" y="773"/>
                    </a:lnTo>
                    <a:lnTo>
                      <a:pt x="583" y="773"/>
                    </a:lnTo>
                    <a:lnTo>
                      <a:pt x="589" y="773"/>
                    </a:lnTo>
                    <a:lnTo>
                      <a:pt x="595" y="773"/>
                    </a:lnTo>
                    <a:lnTo>
                      <a:pt x="600" y="773"/>
                    </a:lnTo>
                    <a:lnTo>
                      <a:pt x="606" y="766"/>
                    </a:lnTo>
                    <a:lnTo>
                      <a:pt x="612" y="773"/>
                    </a:lnTo>
                    <a:lnTo>
                      <a:pt x="617" y="766"/>
                    </a:lnTo>
                    <a:lnTo>
                      <a:pt x="623" y="773"/>
                    </a:lnTo>
                    <a:lnTo>
                      <a:pt x="629" y="773"/>
                    </a:lnTo>
                    <a:lnTo>
                      <a:pt x="634" y="766"/>
                    </a:lnTo>
                    <a:lnTo>
                      <a:pt x="640" y="759"/>
                    </a:lnTo>
                    <a:lnTo>
                      <a:pt x="646" y="773"/>
                    </a:lnTo>
                    <a:lnTo>
                      <a:pt x="651" y="773"/>
                    </a:lnTo>
                    <a:lnTo>
                      <a:pt x="657" y="766"/>
                    </a:lnTo>
                    <a:lnTo>
                      <a:pt x="663" y="759"/>
                    </a:lnTo>
                    <a:lnTo>
                      <a:pt x="668" y="773"/>
                    </a:lnTo>
                    <a:lnTo>
                      <a:pt x="674" y="759"/>
                    </a:lnTo>
                    <a:lnTo>
                      <a:pt x="680" y="759"/>
                    </a:lnTo>
                    <a:lnTo>
                      <a:pt x="685" y="766"/>
                    </a:lnTo>
                    <a:lnTo>
                      <a:pt x="691" y="766"/>
                    </a:lnTo>
                    <a:lnTo>
                      <a:pt x="696" y="759"/>
                    </a:lnTo>
                    <a:lnTo>
                      <a:pt x="702" y="744"/>
                    </a:lnTo>
                    <a:lnTo>
                      <a:pt x="708" y="759"/>
                    </a:lnTo>
                    <a:lnTo>
                      <a:pt x="713" y="766"/>
                    </a:lnTo>
                    <a:lnTo>
                      <a:pt x="719" y="766"/>
                    </a:lnTo>
                    <a:lnTo>
                      <a:pt x="725" y="766"/>
                    </a:lnTo>
                    <a:lnTo>
                      <a:pt x="730" y="759"/>
                    </a:lnTo>
                    <a:lnTo>
                      <a:pt x="736" y="751"/>
                    </a:lnTo>
                    <a:lnTo>
                      <a:pt x="742" y="773"/>
                    </a:lnTo>
                    <a:lnTo>
                      <a:pt x="747" y="751"/>
                    </a:lnTo>
                    <a:lnTo>
                      <a:pt x="753" y="759"/>
                    </a:lnTo>
                    <a:lnTo>
                      <a:pt x="759" y="737"/>
                    </a:lnTo>
                    <a:lnTo>
                      <a:pt x="764" y="751"/>
                    </a:lnTo>
                    <a:lnTo>
                      <a:pt x="770" y="759"/>
                    </a:lnTo>
                    <a:lnTo>
                      <a:pt x="776" y="766"/>
                    </a:lnTo>
                    <a:lnTo>
                      <a:pt x="782" y="723"/>
                    </a:lnTo>
                    <a:lnTo>
                      <a:pt x="787" y="716"/>
                    </a:lnTo>
                    <a:lnTo>
                      <a:pt x="793" y="730"/>
                    </a:lnTo>
                    <a:lnTo>
                      <a:pt x="799" y="716"/>
                    </a:lnTo>
                    <a:lnTo>
                      <a:pt x="804" y="744"/>
                    </a:lnTo>
                    <a:lnTo>
                      <a:pt x="810" y="744"/>
                    </a:lnTo>
                    <a:lnTo>
                      <a:pt x="816" y="709"/>
                    </a:lnTo>
                    <a:lnTo>
                      <a:pt x="821" y="744"/>
                    </a:lnTo>
                    <a:lnTo>
                      <a:pt x="827" y="680"/>
                    </a:lnTo>
                    <a:lnTo>
                      <a:pt x="833" y="709"/>
                    </a:lnTo>
                    <a:lnTo>
                      <a:pt x="838" y="666"/>
                    </a:lnTo>
                    <a:lnTo>
                      <a:pt x="844" y="658"/>
                    </a:lnTo>
                    <a:lnTo>
                      <a:pt x="850" y="637"/>
                    </a:lnTo>
                    <a:lnTo>
                      <a:pt x="855" y="716"/>
                    </a:lnTo>
                    <a:lnTo>
                      <a:pt x="861" y="666"/>
                    </a:lnTo>
                    <a:lnTo>
                      <a:pt x="867" y="658"/>
                    </a:lnTo>
                    <a:lnTo>
                      <a:pt x="872" y="687"/>
                    </a:lnTo>
                    <a:lnTo>
                      <a:pt x="878" y="666"/>
                    </a:lnTo>
                    <a:lnTo>
                      <a:pt x="884" y="673"/>
                    </a:lnTo>
                    <a:lnTo>
                      <a:pt x="889" y="587"/>
                    </a:lnTo>
                    <a:lnTo>
                      <a:pt x="895" y="637"/>
                    </a:lnTo>
                    <a:lnTo>
                      <a:pt x="901" y="623"/>
                    </a:lnTo>
                    <a:lnTo>
                      <a:pt x="906" y="644"/>
                    </a:lnTo>
                    <a:lnTo>
                      <a:pt x="912" y="608"/>
                    </a:lnTo>
                    <a:lnTo>
                      <a:pt x="918" y="601"/>
                    </a:lnTo>
                    <a:lnTo>
                      <a:pt x="923" y="537"/>
                    </a:lnTo>
                    <a:lnTo>
                      <a:pt x="929" y="587"/>
                    </a:lnTo>
                    <a:lnTo>
                      <a:pt x="935" y="458"/>
                    </a:lnTo>
                    <a:lnTo>
                      <a:pt x="940" y="551"/>
                    </a:lnTo>
                    <a:lnTo>
                      <a:pt x="946" y="408"/>
                    </a:lnTo>
                    <a:lnTo>
                      <a:pt x="951" y="508"/>
                    </a:lnTo>
                    <a:lnTo>
                      <a:pt x="957" y="415"/>
                    </a:lnTo>
                    <a:lnTo>
                      <a:pt x="963" y="422"/>
                    </a:lnTo>
                    <a:lnTo>
                      <a:pt x="968" y="372"/>
                    </a:lnTo>
                    <a:lnTo>
                      <a:pt x="974" y="265"/>
                    </a:lnTo>
                    <a:lnTo>
                      <a:pt x="980" y="201"/>
                    </a:lnTo>
                    <a:lnTo>
                      <a:pt x="985" y="344"/>
                    </a:lnTo>
                    <a:lnTo>
                      <a:pt x="991" y="294"/>
                    </a:lnTo>
                    <a:lnTo>
                      <a:pt x="997" y="322"/>
                    </a:lnTo>
                    <a:lnTo>
                      <a:pt x="1002" y="229"/>
                    </a:lnTo>
                    <a:lnTo>
                      <a:pt x="1008" y="101"/>
                    </a:lnTo>
                    <a:lnTo>
                      <a:pt x="1014" y="43"/>
                    </a:lnTo>
                    <a:lnTo>
                      <a:pt x="1019" y="279"/>
                    </a:lnTo>
                    <a:lnTo>
                      <a:pt x="1025" y="79"/>
                    </a:lnTo>
                    <a:lnTo>
                      <a:pt x="1031" y="0"/>
                    </a:lnTo>
                    <a:lnTo>
                      <a:pt x="1036" y="115"/>
                    </a:lnTo>
                    <a:lnTo>
                      <a:pt x="1042" y="115"/>
                    </a:lnTo>
                    <a:lnTo>
                      <a:pt x="1048" y="65"/>
                    </a:lnTo>
                    <a:lnTo>
                      <a:pt x="1053" y="108"/>
                    </a:lnTo>
                    <a:lnTo>
                      <a:pt x="1059" y="165"/>
                    </a:lnTo>
                    <a:lnTo>
                      <a:pt x="1065" y="258"/>
                    </a:lnTo>
                    <a:lnTo>
                      <a:pt x="1070" y="51"/>
                    </a:lnTo>
                    <a:lnTo>
                      <a:pt x="1076" y="29"/>
                    </a:lnTo>
                    <a:lnTo>
                      <a:pt x="1082" y="86"/>
                    </a:lnTo>
                    <a:lnTo>
                      <a:pt x="1088" y="251"/>
                    </a:lnTo>
                    <a:lnTo>
                      <a:pt x="1093" y="279"/>
                    </a:lnTo>
                    <a:lnTo>
                      <a:pt x="1099" y="279"/>
                    </a:lnTo>
                    <a:lnTo>
                      <a:pt x="1105" y="372"/>
                    </a:lnTo>
                    <a:lnTo>
                      <a:pt x="1110" y="265"/>
                    </a:lnTo>
                    <a:lnTo>
                      <a:pt x="1116" y="444"/>
                    </a:lnTo>
                    <a:lnTo>
                      <a:pt x="1122" y="430"/>
                    </a:lnTo>
                    <a:lnTo>
                      <a:pt x="1127" y="544"/>
                    </a:lnTo>
                    <a:lnTo>
                      <a:pt x="1133" y="487"/>
                    </a:lnTo>
                    <a:lnTo>
                      <a:pt x="1139" y="544"/>
                    </a:lnTo>
                    <a:lnTo>
                      <a:pt x="1144" y="587"/>
                    </a:lnTo>
                    <a:lnTo>
                      <a:pt x="1150" y="594"/>
                    </a:lnTo>
                    <a:lnTo>
                      <a:pt x="1156" y="558"/>
                    </a:lnTo>
                    <a:lnTo>
                      <a:pt x="1161" y="623"/>
                    </a:lnTo>
                    <a:lnTo>
                      <a:pt x="1167" y="666"/>
                    </a:lnTo>
                    <a:lnTo>
                      <a:pt x="1173" y="673"/>
                    </a:lnTo>
                    <a:lnTo>
                      <a:pt x="1178" y="680"/>
                    </a:lnTo>
                    <a:lnTo>
                      <a:pt x="1184" y="701"/>
                    </a:lnTo>
                    <a:lnTo>
                      <a:pt x="1190" y="744"/>
                    </a:lnTo>
                    <a:lnTo>
                      <a:pt x="1195" y="716"/>
                    </a:lnTo>
                    <a:lnTo>
                      <a:pt x="1201" y="751"/>
                    </a:lnTo>
                    <a:lnTo>
                      <a:pt x="1206" y="766"/>
                    </a:lnTo>
                    <a:lnTo>
                      <a:pt x="1212" y="766"/>
                    </a:lnTo>
                    <a:lnTo>
                      <a:pt x="1218" y="773"/>
                    </a:lnTo>
                    <a:lnTo>
                      <a:pt x="1223" y="773"/>
                    </a:lnTo>
                    <a:lnTo>
                      <a:pt x="1229" y="773"/>
                    </a:lnTo>
                    <a:lnTo>
                      <a:pt x="1235" y="773"/>
                    </a:lnTo>
                    <a:lnTo>
                      <a:pt x="1240" y="773"/>
                    </a:lnTo>
                    <a:lnTo>
                      <a:pt x="1246" y="766"/>
                    </a:lnTo>
                    <a:lnTo>
                      <a:pt x="1252" y="773"/>
                    </a:lnTo>
                    <a:lnTo>
                      <a:pt x="1257" y="773"/>
                    </a:lnTo>
                    <a:lnTo>
                      <a:pt x="1263" y="773"/>
                    </a:lnTo>
                    <a:lnTo>
                      <a:pt x="1269" y="773"/>
                    </a:lnTo>
                    <a:lnTo>
                      <a:pt x="1274" y="766"/>
                    </a:lnTo>
                    <a:lnTo>
                      <a:pt x="1280" y="773"/>
                    </a:lnTo>
                    <a:lnTo>
                      <a:pt x="1286" y="773"/>
                    </a:lnTo>
                    <a:lnTo>
                      <a:pt x="1291" y="773"/>
                    </a:lnTo>
                    <a:lnTo>
                      <a:pt x="1297" y="773"/>
                    </a:lnTo>
                    <a:lnTo>
                      <a:pt x="1303" y="773"/>
                    </a:lnTo>
                    <a:lnTo>
                      <a:pt x="1308" y="773"/>
                    </a:lnTo>
                    <a:lnTo>
                      <a:pt x="1314" y="773"/>
                    </a:lnTo>
                    <a:lnTo>
                      <a:pt x="1320" y="773"/>
                    </a:lnTo>
                    <a:lnTo>
                      <a:pt x="1325" y="773"/>
                    </a:lnTo>
                    <a:lnTo>
                      <a:pt x="1331" y="773"/>
                    </a:lnTo>
                    <a:lnTo>
                      <a:pt x="1337" y="773"/>
                    </a:lnTo>
                    <a:lnTo>
                      <a:pt x="1342" y="773"/>
                    </a:lnTo>
                    <a:lnTo>
                      <a:pt x="1348" y="773"/>
                    </a:lnTo>
                    <a:lnTo>
                      <a:pt x="1354" y="773"/>
                    </a:lnTo>
                    <a:lnTo>
                      <a:pt x="1359" y="773"/>
                    </a:lnTo>
                    <a:lnTo>
                      <a:pt x="1365" y="773"/>
                    </a:lnTo>
                    <a:lnTo>
                      <a:pt x="1371" y="773"/>
                    </a:lnTo>
                    <a:lnTo>
                      <a:pt x="1376" y="773"/>
                    </a:lnTo>
                    <a:lnTo>
                      <a:pt x="1382" y="773"/>
                    </a:lnTo>
                    <a:lnTo>
                      <a:pt x="1388" y="773"/>
                    </a:lnTo>
                    <a:lnTo>
                      <a:pt x="1393" y="773"/>
                    </a:lnTo>
                    <a:lnTo>
                      <a:pt x="1399" y="773"/>
                    </a:lnTo>
                    <a:lnTo>
                      <a:pt x="1405" y="773"/>
                    </a:lnTo>
                    <a:lnTo>
                      <a:pt x="1411" y="773"/>
                    </a:lnTo>
                    <a:lnTo>
                      <a:pt x="1416" y="773"/>
                    </a:lnTo>
                    <a:lnTo>
                      <a:pt x="1422" y="766"/>
                    </a:lnTo>
                    <a:lnTo>
                      <a:pt x="1428" y="773"/>
                    </a:lnTo>
                    <a:lnTo>
                      <a:pt x="1433" y="773"/>
                    </a:lnTo>
                    <a:lnTo>
                      <a:pt x="1439" y="773"/>
                    </a:lnTo>
                    <a:lnTo>
                      <a:pt x="1445" y="773"/>
                    </a:lnTo>
                    <a:lnTo>
                      <a:pt x="1450" y="773"/>
                    </a:lnTo>
                    <a:lnTo>
                      <a:pt x="0" y="77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56" name="Rectangle 288"/>
              <p:cNvSpPr>
                <a:spLocks noChangeArrowheads="1"/>
              </p:cNvSpPr>
              <p:nvPr/>
            </p:nvSpPr>
            <p:spPr bwMode="auto">
              <a:xfrm>
                <a:off x="5538788" y="8618538"/>
                <a:ext cx="2301875" cy="1839912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grpSp>
          <p:nvGrpSpPr>
            <p:cNvPr id="407" name="Groep 406"/>
            <p:cNvGrpSpPr/>
            <p:nvPr/>
          </p:nvGrpSpPr>
          <p:grpSpPr>
            <a:xfrm>
              <a:off x="5123828" y="5910714"/>
              <a:ext cx="1163039" cy="1191023"/>
              <a:chOff x="8778875" y="6359525"/>
              <a:chExt cx="2301875" cy="1839913"/>
            </a:xfrm>
          </p:grpSpPr>
          <p:sp>
            <p:nvSpPr>
              <p:cNvPr id="58688" name="Freeform 320"/>
              <p:cNvSpPr>
                <a:spLocks/>
              </p:cNvSpPr>
              <p:nvPr/>
            </p:nvSpPr>
            <p:spPr bwMode="auto">
              <a:xfrm>
                <a:off x="8778875" y="6369050"/>
                <a:ext cx="2301875" cy="1830388"/>
              </a:xfrm>
              <a:custGeom>
                <a:avLst/>
                <a:gdLst/>
                <a:ahLst/>
                <a:cxnLst>
                  <a:cxn ang="0">
                    <a:pos x="17" y="1153"/>
                  </a:cxn>
                  <a:cxn ang="0">
                    <a:pos x="45" y="1153"/>
                  </a:cxn>
                  <a:cxn ang="0">
                    <a:pos x="73" y="1153"/>
                  </a:cxn>
                  <a:cxn ang="0">
                    <a:pos x="102" y="1153"/>
                  </a:cxn>
                  <a:cxn ang="0">
                    <a:pos x="130" y="1153"/>
                  </a:cxn>
                  <a:cxn ang="0">
                    <a:pos x="158" y="1153"/>
                  </a:cxn>
                  <a:cxn ang="0">
                    <a:pos x="187" y="1153"/>
                  </a:cxn>
                  <a:cxn ang="0">
                    <a:pos x="215" y="1153"/>
                  </a:cxn>
                  <a:cxn ang="0">
                    <a:pos x="243" y="1153"/>
                  </a:cxn>
                  <a:cxn ang="0">
                    <a:pos x="272" y="1153"/>
                  </a:cxn>
                  <a:cxn ang="0">
                    <a:pos x="300" y="1153"/>
                  </a:cxn>
                  <a:cxn ang="0">
                    <a:pos x="328" y="1153"/>
                  </a:cxn>
                  <a:cxn ang="0">
                    <a:pos x="357" y="1153"/>
                  </a:cxn>
                  <a:cxn ang="0">
                    <a:pos x="385" y="1153"/>
                  </a:cxn>
                  <a:cxn ang="0">
                    <a:pos x="413" y="1153"/>
                  </a:cxn>
                  <a:cxn ang="0">
                    <a:pos x="441" y="1153"/>
                  </a:cxn>
                  <a:cxn ang="0">
                    <a:pos x="470" y="1153"/>
                  </a:cxn>
                  <a:cxn ang="0">
                    <a:pos x="498" y="1153"/>
                  </a:cxn>
                  <a:cxn ang="0">
                    <a:pos x="527" y="1153"/>
                  </a:cxn>
                  <a:cxn ang="0">
                    <a:pos x="555" y="1153"/>
                  </a:cxn>
                  <a:cxn ang="0">
                    <a:pos x="583" y="1153"/>
                  </a:cxn>
                  <a:cxn ang="0">
                    <a:pos x="612" y="1153"/>
                  </a:cxn>
                  <a:cxn ang="0">
                    <a:pos x="640" y="1153"/>
                  </a:cxn>
                  <a:cxn ang="0">
                    <a:pos x="668" y="1153"/>
                  </a:cxn>
                  <a:cxn ang="0">
                    <a:pos x="696" y="1153"/>
                  </a:cxn>
                  <a:cxn ang="0">
                    <a:pos x="725" y="1153"/>
                  </a:cxn>
                  <a:cxn ang="0">
                    <a:pos x="753" y="1153"/>
                  </a:cxn>
                  <a:cxn ang="0">
                    <a:pos x="782" y="1153"/>
                  </a:cxn>
                  <a:cxn ang="0">
                    <a:pos x="810" y="1153"/>
                  </a:cxn>
                  <a:cxn ang="0">
                    <a:pos x="838" y="1153"/>
                  </a:cxn>
                  <a:cxn ang="0">
                    <a:pos x="867" y="1144"/>
                  </a:cxn>
                  <a:cxn ang="0">
                    <a:pos x="895" y="1153"/>
                  </a:cxn>
                  <a:cxn ang="0">
                    <a:pos x="923" y="1136"/>
                  </a:cxn>
                  <a:cxn ang="0">
                    <a:pos x="951" y="1153"/>
                  </a:cxn>
                  <a:cxn ang="0">
                    <a:pos x="980" y="1136"/>
                  </a:cxn>
                  <a:cxn ang="0">
                    <a:pos x="1008" y="1136"/>
                  </a:cxn>
                  <a:cxn ang="0">
                    <a:pos x="1036" y="1136"/>
                  </a:cxn>
                  <a:cxn ang="0">
                    <a:pos x="1065" y="1127"/>
                  </a:cxn>
                  <a:cxn ang="0">
                    <a:pos x="1093" y="1092"/>
                  </a:cxn>
                  <a:cxn ang="0">
                    <a:pos x="1122" y="1031"/>
                  </a:cxn>
                  <a:cxn ang="0">
                    <a:pos x="1150" y="970"/>
                  </a:cxn>
                  <a:cxn ang="0">
                    <a:pos x="1178" y="909"/>
                  </a:cxn>
                  <a:cxn ang="0">
                    <a:pos x="1206" y="891"/>
                  </a:cxn>
                  <a:cxn ang="0">
                    <a:pos x="1235" y="761"/>
                  </a:cxn>
                  <a:cxn ang="0">
                    <a:pos x="1263" y="665"/>
                  </a:cxn>
                  <a:cxn ang="0">
                    <a:pos x="1291" y="560"/>
                  </a:cxn>
                  <a:cxn ang="0">
                    <a:pos x="1320" y="473"/>
                  </a:cxn>
                  <a:cxn ang="0">
                    <a:pos x="1348" y="482"/>
                  </a:cxn>
                  <a:cxn ang="0">
                    <a:pos x="1376" y="595"/>
                  </a:cxn>
                  <a:cxn ang="0">
                    <a:pos x="1405" y="491"/>
                  </a:cxn>
                  <a:cxn ang="0">
                    <a:pos x="1433" y="142"/>
                  </a:cxn>
                </a:cxnLst>
                <a:rect l="0" t="0" r="r" b="b"/>
                <a:pathLst>
                  <a:path w="1450" h="1153">
                    <a:moveTo>
                      <a:pt x="0" y="1153"/>
                    </a:moveTo>
                    <a:lnTo>
                      <a:pt x="0" y="1153"/>
                    </a:lnTo>
                    <a:lnTo>
                      <a:pt x="5" y="1153"/>
                    </a:lnTo>
                    <a:lnTo>
                      <a:pt x="11" y="1153"/>
                    </a:lnTo>
                    <a:lnTo>
                      <a:pt x="17" y="1153"/>
                    </a:lnTo>
                    <a:lnTo>
                      <a:pt x="22" y="1153"/>
                    </a:lnTo>
                    <a:lnTo>
                      <a:pt x="28" y="1153"/>
                    </a:lnTo>
                    <a:lnTo>
                      <a:pt x="34" y="1153"/>
                    </a:lnTo>
                    <a:lnTo>
                      <a:pt x="39" y="1153"/>
                    </a:lnTo>
                    <a:lnTo>
                      <a:pt x="45" y="1153"/>
                    </a:lnTo>
                    <a:lnTo>
                      <a:pt x="51" y="1153"/>
                    </a:lnTo>
                    <a:lnTo>
                      <a:pt x="56" y="1153"/>
                    </a:lnTo>
                    <a:lnTo>
                      <a:pt x="62" y="1153"/>
                    </a:lnTo>
                    <a:lnTo>
                      <a:pt x="68" y="1153"/>
                    </a:lnTo>
                    <a:lnTo>
                      <a:pt x="73" y="1153"/>
                    </a:lnTo>
                    <a:lnTo>
                      <a:pt x="79" y="1153"/>
                    </a:lnTo>
                    <a:lnTo>
                      <a:pt x="85" y="1153"/>
                    </a:lnTo>
                    <a:lnTo>
                      <a:pt x="90" y="1153"/>
                    </a:lnTo>
                    <a:lnTo>
                      <a:pt x="96" y="1153"/>
                    </a:lnTo>
                    <a:lnTo>
                      <a:pt x="102" y="1153"/>
                    </a:lnTo>
                    <a:lnTo>
                      <a:pt x="107" y="1153"/>
                    </a:lnTo>
                    <a:lnTo>
                      <a:pt x="113" y="1153"/>
                    </a:lnTo>
                    <a:lnTo>
                      <a:pt x="119" y="1153"/>
                    </a:lnTo>
                    <a:lnTo>
                      <a:pt x="124" y="1153"/>
                    </a:lnTo>
                    <a:lnTo>
                      <a:pt x="130" y="1153"/>
                    </a:lnTo>
                    <a:lnTo>
                      <a:pt x="136" y="1153"/>
                    </a:lnTo>
                    <a:lnTo>
                      <a:pt x="141" y="1153"/>
                    </a:lnTo>
                    <a:lnTo>
                      <a:pt x="147" y="1153"/>
                    </a:lnTo>
                    <a:lnTo>
                      <a:pt x="153" y="1153"/>
                    </a:lnTo>
                    <a:lnTo>
                      <a:pt x="158" y="1153"/>
                    </a:lnTo>
                    <a:lnTo>
                      <a:pt x="164" y="1153"/>
                    </a:lnTo>
                    <a:lnTo>
                      <a:pt x="170" y="1153"/>
                    </a:lnTo>
                    <a:lnTo>
                      <a:pt x="175" y="1153"/>
                    </a:lnTo>
                    <a:lnTo>
                      <a:pt x="181" y="1153"/>
                    </a:lnTo>
                    <a:lnTo>
                      <a:pt x="187" y="1153"/>
                    </a:lnTo>
                    <a:lnTo>
                      <a:pt x="192" y="1153"/>
                    </a:lnTo>
                    <a:lnTo>
                      <a:pt x="198" y="1153"/>
                    </a:lnTo>
                    <a:lnTo>
                      <a:pt x="204" y="1153"/>
                    </a:lnTo>
                    <a:lnTo>
                      <a:pt x="209" y="1153"/>
                    </a:lnTo>
                    <a:lnTo>
                      <a:pt x="215" y="1153"/>
                    </a:lnTo>
                    <a:lnTo>
                      <a:pt x="221" y="1153"/>
                    </a:lnTo>
                    <a:lnTo>
                      <a:pt x="226" y="1153"/>
                    </a:lnTo>
                    <a:lnTo>
                      <a:pt x="232" y="1153"/>
                    </a:lnTo>
                    <a:lnTo>
                      <a:pt x="238" y="1153"/>
                    </a:lnTo>
                    <a:lnTo>
                      <a:pt x="243" y="1153"/>
                    </a:lnTo>
                    <a:lnTo>
                      <a:pt x="249" y="1153"/>
                    </a:lnTo>
                    <a:lnTo>
                      <a:pt x="255" y="1153"/>
                    </a:lnTo>
                    <a:lnTo>
                      <a:pt x="260" y="1153"/>
                    </a:lnTo>
                    <a:lnTo>
                      <a:pt x="266" y="1153"/>
                    </a:lnTo>
                    <a:lnTo>
                      <a:pt x="272" y="1153"/>
                    </a:lnTo>
                    <a:lnTo>
                      <a:pt x="277" y="1153"/>
                    </a:lnTo>
                    <a:lnTo>
                      <a:pt x="283" y="1153"/>
                    </a:lnTo>
                    <a:lnTo>
                      <a:pt x="289" y="1153"/>
                    </a:lnTo>
                    <a:lnTo>
                      <a:pt x="294" y="1153"/>
                    </a:lnTo>
                    <a:lnTo>
                      <a:pt x="300" y="1153"/>
                    </a:lnTo>
                    <a:lnTo>
                      <a:pt x="306" y="1153"/>
                    </a:lnTo>
                    <a:lnTo>
                      <a:pt x="311" y="1153"/>
                    </a:lnTo>
                    <a:lnTo>
                      <a:pt x="317" y="1153"/>
                    </a:lnTo>
                    <a:lnTo>
                      <a:pt x="323" y="1153"/>
                    </a:lnTo>
                    <a:lnTo>
                      <a:pt x="328" y="1153"/>
                    </a:lnTo>
                    <a:lnTo>
                      <a:pt x="334" y="1153"/>
                    </a:lnTo>
                    <a:lnTo>
                      <a:pt x="340" y="1153"/>
                    </a:lnTo>
                    <a:lnTo>
                      <a:pt x="345" y="1153"/>
                    </a:lnTo>
                    <a:lnTo>
                      <a:pt x="351" y="1153"/>
                    </a:lnTo>
                    <a:lnTo>
                      <a:pt x="357" y="1153"/>
                    </a:lnTo>
                    <a:lnTo>
                      <a:pt x="362" y="1153"/>
                    </a:lnTo>
                    <a:lnTo>
                      <a:pt x="368" y="1153"/>
                    </a:lnTo>
                    <a:lnTo>
                      <a:pt x="374" y="1153"/>
                    </a:lnTo>
                    <a:lnTo>
                      <a:pt x="379" y="1153"/>
                    </a:lnTo>
                    <a:lnTo>
                      <a:pt x="385" y="1153"/>
                    </a:lnTo>
                    <a:lnTo>
                      <a:pt x="391" y="1153"/>
                    </a:lnTo>
                    <a:lnTo>
                      <a:pt x="396" y="1144"/>
                    </a:lnTo>
                    <a:lnTo>
                      <a:pt x="402" y="1153"/>
                    </a:lnTo>
                    <a:lnTo>
                      <a:pt x="408" y="1153"/>
                    </a:lnTo>
                    <a:lnTo>
                      <a:pt x="413" y="1153"/>
                    </a:lnTo>
                    <a:lnTo>
                      <a:pt x="419" y="1153"/>
                    </a:lnTo>
                    <a:lnTo>
                      <a:pt x="425" y="1153"/>
                    </a:lnTo>
                    <a:lnTo>
                      <a:pt x="430" y="1153"/>
                    </a:lnTo>
                    <a:lnTo>
                      <a:pt x="436" y="1153"/>
                    </a:lnTo>
                    <a:lnTo>
                      <a:pt x="441" y="1153"/>
                    </a:lnTo>
                    <a:lnTo>
                      <a:pt x="447" y="1153"/>
                    </a:lnTo>
                    <a:lnTo>
                      <a:pt x="453" y="1153"/>
                    </a:lnTo>
                    <a:lnTo>
                      <a:pt x="458" y="1153"/>
                    </a:lnTo>
                    <a:lnTo>
                      <a:pt x="464" y="1153"/>
                    </a:lnTo>
                    <a:lnTo>
                      <a:pt x="470" y="1153"/>
                    </a:lnTo>
                    <a:lnTo>
                      <a:pt x="476" y="1153"/>
                    </a:lnTo>
                    <a:lnTo>
                      <a:pt x="481" y="1153"/>
                    </a:lnTo>
                    <a:lnTo>
                      <a:pt x="487" y="1153"/>
                    </a:lnTo>
                    <a:lnTo>
                      <a:pt x="493" y="1153"/>
                    </a:lnTo>
                    <a:lnTo>
                      <a:pt x="498" y="1153"/>
                    </a:lnTo>
                    <a:lnTo>
                      <a:pt x="504" y="1153"/>
                    </a:lnTo>
                    <a:lnTo>
                      <a:pt x="510" y="1153"/>
                    </a:lnTo>
                    <a:lnTo>
                      <a:pt x="515" y="1153"/>
                    </a:lnTo>
                    <a:lnTo>
                      <a:pt x="521" y="1153"/>
                    </a:lnTo>
                    <a:lnTo>
                      <a:pt x="527" y="1153"/>
                    </a:lnTo>
                    <a:lnTo>
                      <a:pt x="532" y="1153"/>
                    </a:lnTo>
                    <a:lnTo>
                      <a:pt x="538" y="1153"/>
                    </a:lnTo>
                    <a:lnTo>
                      <a:pt x="544" y="1153"/>
                    </a:lnTo>
                    <a:lnTo>
                      <a:pt x="549" y="1153"/>
                    </a:lnTo>
                    <a:lnTo>
                      <a:pt x="555" y="1153"/>
                    </a:lnTo>
                    <a:lnTo>
                      <a:pt x="561" y="1153"/>
                    </a:lnTo>
                    <a:lnTo>
                      <a:pt x="566" y="1153"/>
                    </a:lnTo>
                    <a:lnTo>
                      <a:pt x="572" y="1153"/>
                    </a:lnTo>
                    <a:lnTo>
                      <a:pt x="578" y="1153"/>
                    </a:lnTo>
                    <a:lnTo>
                      <a:pt x="583" y="1153"/>
                    </a:lnTo>
                    <a:lnTo>
                      <a:pt x="589" y="1153"/>
                    </a:lnTo>
                    <a:lnTo>
                      <a:pt x="595" y="1144"/>
                    </a:lnTo>
                    <a:lnTo>
                      <a:pt x="600" y="1153"/>
                    </a:lnTo>
                    <a:lnTo>
                      <a:pt x="606" y="1153"/>
                    </a:lnTo>
                    <a:lnTo>
                      <a:pt x="612" y="1153"/>
                    </a:lnTo>
                    <a:lnTo>
                      <a:pt x="617" y="1144"/>
                    </a:lnTo>
                    <a:lnTo>
                      <a:pt x="623" y="1153"/>
                    </a:lnTo>
                    <a:lnTo>
                      <a:pt x="629" y="1153"/>
                    </a:lnTo>
                    <a:lnTo>
                      <a:pt x="634" y="1153"/>
                    </a:lnTo>
                    <a:lnTo>
                      <a:pt x="640" y="1153"/>
                    </a:lnTo>
                    <a:lnTo>
                      <a:pt x="646" y="1153"/>
                    </a:lnTo>
                    <a:lnTo>
                      <a:pt x="651" y="1153"/>
                    </a:lnTo>
                    <a:lnTo>
                      <a:pt x="657" y="1144"/>
                    </a:lnTo>
                    <a:lnTo>
                      <a:pt x="663" y="1153"/>
                    </a:lnTo>
                    <a:lnTo>
                      <a:pt x="668" y="1153"/>
                    </a:lnTo>
                    <a:lnTo>
                      <a:pt x="674" y="1153"/>
                    </a:lnTo>
                    <a:lnTo>
                      <a:pt x="680" y="1153"/>
                    </a:lnTo>
                    <a:lnTo>
                      <a:pt x="685" y="1153"/>
                    </a:lnTo>
                    <a:lnTo>
                      <a:pt x="691" y="1144"/>
                    </a:lnTo>
                    <a:lnTo>
                      <a:pt x="696" y="1153"/>
                    </a:lnTo>
                    <a:lnTo>
                      <a:pt x="702" y="1144"/>
                    </a:lnTo>
                    <a:lnTo>
                      <a:pt x="708" y="1153"/>
                    </a:lnTo>
                    <a:lnTo>
                      <a:pt x="713" y="1153"/>
                    </a:lnTo>
                    <a:lnTo>
                      <a:pt x="719" y="1144"/>
                    </a:lnTo>
                    <a:lnTo>
                      <a:pt x="725" y="1153"/>
                    </a:lnTo>
                    <a:lnTo>
                      <a:pt x="730" y="1153"/>
                    </a:lnTo>
                    <a:lnTo>
                      <a:pt x="736" y="1144"/>
                    </a:lnTo>
                    <a:lnTo>
                      <a:pt x="742" y="1153"/>
                    </a:lnTo>
                    <a:lnTo>
                      <a:pt x="747" y="1153"/>
                    </a:lnTo>
                    <a:lnTo>
                      <a:pt x="753" y="1153"/>
                    </a:lnTo>
                    <a:lnTo>
                      <a:pt x="759" y="1153"/>
                    </a:lnTo>
                    <a:lnTo>
                      <a:pt x="764" y="1153"/>
                    </a:lnTo>
                    <a:lnTo>
                      <a:pt x="770" y="1144"/>
                    </a:lnTo>
                    <a:lnTo>
                      <a:pt x="776" y="1153"/>
                    </a:lnTo>
                    <a:lnTo>
                      <a:pt x="782" y="1153"/>
                    </a:lnTo>
                    <a:lnTo>
                      <a:pt x="787" y="1144"/>
                    </a:lnTo>
                    <a:lnTo>
                      <a:pt x="793" y="1153"/>
                    </a:lnTo>
                    <a:lnTo>
                      <a:pt x="799" y="1153"/>
                    </a:lnTo>
                    <a:lnTo>
                      <a:pt x="804" y="1153"/>
                    </a:lnTo>
                    <a:lnTo>
                      <a:pt x="810" y="1153"/>
                    </a:lnTo>
                    <a:lnTo>
                      <a:pt x="816" y="1153"/>
                    </a:lnTo>
                    <a:lnTo>
                      <a:pt x="821" y="1153"/>
                    </a:lnTo>
                    <a:lnTo>
                      <a:pt x="827" y="1144"/>
                    </a:lnTo>
                    <a:lnTo>
                      <a:pt x="833" y="1153"/>
                    </a:lnTo>
                    <a:lnTo>
                      <a:pt x="838" y="1153"/>
                    </a:lnTo>
                    <a:lnTo>
                      <a:pt x="844" y="1144"/>
                    </a:lnTo>
                    <a:lnTo>
                      <a:pt x="850" y="1153"/>
                    </a:lnTo>
                    <a:lnTo>
                      <a:pt x="855" y="1153"/>
                    </a:lnTo>
                    <a:lnTo>
                      <a:pt x="861" y="1144"/>
                    </a:lnTo>
                    <a:lnTo>
                      <a:pt x="867" y="1144"/>
                    </a:lnTo>
                    <a:lnTo>
                      <a:pt x="872" y="1144"/>
                    </a:lnTo>
                    <a:lnTo>
                      <a:pt x="878" y="1144"/>
                    </a:lnTo>
                    <a:lnTo>
                      <a:pt x="884" y="1153"/>
                    </a:lnTo>
                    <a:lnTo>
                      <a:pt x="889" y="1153"/>
                    </a:lnTo>
                    <a:lnTo>
                      <a:pt x="895" y="1153"/>
                    </a:lnTo>
                    <a:lnTo>
                      <a:pt x="901" y="1153"/>
                    </a:lnTo>
                    <a:lnTo>
                      <a:pt x="906" y="1153"/>
                    </a:lnTo>
                    <a:lnTo>
                      <a:pt x="912" y="1153"/>
                    </a:lnTo>
                    <a:lnTo>
                      <a:pt x="918" y="1153"/>
                    </a:lnTo>
                    <a:lnTo>
                      <a:pt x="923" y="1136"/>
                    </a:lnTo>
                    <a:lnTo>
                      <a:pt x="929" y="1144"/>
                    </a:lnTo>
                    <a:lnTo>
                      <a:pt x="935" y="1144"/>
                    </a:lnTo>
                    <a:lnTo>
                      <a:pt x="940" y="1144"/>
                    </a:lnTo>
                    <a:lnTo>
                      <a:pt x="946" y="1153"/>
                    </a:lnTo>
                    <a:lnTo>
                      <a:pt x="951" y="1153"/>
                    </a:lnTo>
                    <a:lnTo>
                      <a:pt x="957" y="1153"/>
                    </a:lnTo>
                    <a:lnTo>
                      <a:pt x="963" y="1136"/>
                    </a:lnTo>
                    <a:lnTo>
                      <a:pt x="968" y="1144"/>
                    </a:lnTo>
                    <a:lnTo>
                      <a:pt x="974" y="1153"/>
                    </a:lnTo>
                    <a:lnTo>
                      <a:pt x="980" y="1136"/>
                    </a:lnTo>
                    <a:lnTo>
                      <a:pt x="985" y="1127"/>
                    </a:lnTo>
                    <a:lnTo>
                      <a:pt x="991" y="1127"/>
                    </a:lnTo>
                    <a:lnTo>
                      <a:pt x="997" y="1127"/>
                    </a:lnTo>
                    <a:lnTo>
                      <a:pt x="1002" y="1153"/>
                    </a:lnTo>
                    <a:lnTo>
                      <a:pt x="1008" y="1136"/>
                    </a:lnTo>
                    <a:lnTo>
                      <a:pt x="1014" y="1127"/>
                    </a:lnTo>
                    <a:lnTo>
                      <a:pt x="1019" y="1136"/>
                    </a:lnTo>
                    <a:lnTo>
                      <a:pt x="1025" y="1144"/>
                    </a:lnTo>
                    <a:lnTo>
                      <a:pt x="1031" y="1136"/>
                    </a:lnTo>
                    <a:lnTo>
                      <a:pt x="1036" y="1136"/>
                    </a:lnTo>
                    <a:lnTo>
                      <a:pt x="1042" y="1127"/>
                    </a:lnTo>
                    <a:lnTo>
                      <a:pt x="1048" y="1118"/>
                    </a:lnTo>
                    <a:lnTo>
                      <a:pt x="1053" y="1127"/>
                    </a:lnTo>
                    <a:lnTo>
                      <a:pt x="1059" y="1136"/>
                    </a:lnTo>
                    <a:lnTo>
                      <a:pt x="1065" y="1127"/>
                    </a:lnTo>
                    <a:lnTo>
                      <a:pt x="1070" y="1083"/>
                    </a:lnTo>
                    <a:lnTo>
                      <a:pt x="1076" y="1136"/>
                    </a:lnTo>
                    <a:lnTo>
                      <a:pt x="1082" y="1118"/>
                    </a:lnTo>
                    <a:lnTo>
                      <a:pt x="1088" y="1118"/>
                    </a:lnTo>
                    <a:lnTo>
                      <a:pt x="1093" y="1092"/>
                    </a:lnTo>
                    <a:lnTo>
                      <a:pt x="1099" y="1048"/>
                    </a:lnTo>
                    <a:lnTo>
                      <a:pt x="1105" y="1066"/>
                    </a:lnTo>
                    <a:lnTo>
                      <a:pt x="1110" y="1022"/>
                    </a:lnTo>
                    <a:lnTo>
                      <a:pt x="1116" y="1048"/>
                    </a:lnTo>
                    <a:lnTo>
                      <a:pt x="1122" y="1031"/>
                    </a:lnTo>
                    <a:lnTo>
                      <a:pt x="1127" y="1048"/>
                    </a:lnTo>
                    <a:lnTo>
                      <a:pt x="1133" y="1074"/>
                    </a:lnTo>
                    <a:lnTo>
                      <a:pt x="1139" y="1048"/>
                    </a:lnTo>
                    <a:lnTo>
                      <a:pt x="1144" y="1022"/>
                    </a:lnTo>
                    <a:lnTo>
                      <a:pt x="1150" y="970"/>
                    </a:lnTo>
                    <a:lnTo>
                      <a:pt x="1156" y="1022"/>
                    </a:lnTo>
                    <a:lnTo>
                      <a:pt x="1161" y="1048"/>
                    </a:lnTo>
                    <a:lnTo>
                      <a:pt x="1167" y="1022"/>
                    </a:lnTo>
                    <a:lnTo>
                      <a:pt x="1173" y="987"/>
                    </a:lnTo>
                    <a:lnTo>
                      <a:pt x="1178" y="909"/>
                    </a:lnTo>
                    <a:lnTo>
                      <a:pt x="1184" y="979"/>
                    </a:lnTo>
                    <a:lnTo>
                      <a:pt x="1190" y="944"/>
                    </a:lnTo>
                    <a:lnTo>
                      <a:pt x="1195" y="987"/>
                    </a:lnTo>
                    <a:lnTo>
                      <a:pt x="1201" y="979"/>
                    </a:lnTo>
                    <a:lnTo>
                      <a:pt x="1206" y="891"/>
                    </a:lnTo>
                    <a:lnTo>
                      <a:pt x="1212" y="891"/>
                    </a:lnTo>
                    <a:lnTo>
                      <a:pt x="1218" y="935"/>
                    </a:lnTo>
                    <a:lnTo>
                      <a:pt x="1223" y="926"/>
                    </a:lnTo>
                    <a:lnTo>
                      <a:pt x="1229" y="848"/>
                    </a:lnTo>
                    <a:lnTo>
                      <a:pt x="1235" y="761"/>
                    </a:lnTo>
                    <a:lnTo>
                      <a:pt x="1240" y="918"/>
                    </a:lnTo>
                    <a:lnTo>
                      <a:pt x="1246" y="682"/>
                    </a:lnTo>
                    <a:lnTo>
                      <a:pt x="1252" y="865"/>
                    </a:lnTo>
                    <a:lnTo>
                      <a:pt x="1257" y="691"/>
                    </a:lnTo>
                    <a:lnTo>
                      <a:pt x="1263" y="665"/>
                    </a:lnTo>
                    <a:lnTo>
                      <a:pt x="1269" y="787"/>
                    </a:lnTo>
                    <a:lnTo>
                      <a:pt x="1274" y="656"/>
                    </a:lnTo>
                    <a:lnTo>
                      <a:pt x="1280" y="726"/>
                    </a:lnTo>
                    <a:lnTo>
                      <a:pt x="1286" y="691"/>
                    </a:lnTo>
                    <a:lnTo>
                      <a:pt x="1291" y="560"/>
                    </a:lnTo>
                    <a:lnTo>
                      <a:pt x="1297" y="569"/>
                    </a:lnTo>
                    <a:lnTo>
                      <a:pt x="1303" y="630"/>
                    </a:lnTo>
                    <a:lnTo>
                      <a:pt x="1308" y="578"/>
                    </a:lnTo>
                    <a:lnTo>
                      <a:pt x="1314" y="377"/>
                    </a:lnTo>
                    <a:lnTo>
                      <a:pt x="1320" y="473"/>
                    </a:lnTo>
                    <a:lnTo>
                      <a:pt x="1325" y="491"/>
                    </a:lnTo>
                    <a:lnTo>
                      <a:pt x="1331" y="552"/>
                    </a:lnTo>
                    <a:lnTo>
                      <a:pt x="1337" y="491"/>
                    </a:lnTo>
                    <a:lnTo>
                      <a:pt x="1342" y="447"/>
                    </a:lnTo>
                    <a:lnTo>
                      <a:pt x="1348" y="482"/>
                    </a:lnTo>
                    <a:lnTo>
                      <a:pt x="1354" y="526"/>
                    </a:lnTo>
                    <a:lnTo>
                      <a:pt x="1359" y="560"/>
                    </a:lnTo>
                    <a:lnTo>
                      <a:pt x="1365" y="526"/>
                    </a:lnTo>
                    <a:lnTo>
                      <a:pt x="1371" y="456"/>
                    </a:lnTo>
                    <a:lnTo>
                      <a:pt x="1376" y="595"/>
                    </a:lnTo>
                    <a:lnTo>
                      <a:pt x="1382" y="526"/>
                    </a:lnTo>
                    <a:lnTo>
                      <a:pt x="1388" y="491"/>
                    </a:lnTo>
                    <a:lnTo>
                      <a:pt x="1393" y="587"/>
                    </a:lnTo>
                    <a:lnTo>
                      <a:pt x="1399" y="473"/>
                    </a:lnTo>
                    <a:lnTo>
                      <a:pt x="1405" y="491"/>
                    </a:lnTo>
                    <a:lnTo>
                      <a:pt x="1411" y="439"/>
                    </a:lnTo>
                    <a:lnTo>
                      <a:pt x="1416" y="282"/>
                    </a:lnTo>
                    <a:lnTo>
                      <a:pt x="1422" y="134"/>
                    </a:lnTo>
                    <a:lnTo>
                      <a:pt x="1428" y="0"/>
                    </a:lnTo>
                    <a:lnTo>
                      <a:pt x="1433" y="142"/>
                    </a:lnTo>
                    <a:lnTo>
                      <a:pt x="1439" y="752"/>
                    </a:lnTo>
                    <a:lnTo>
                      <a:pt x="1445" y="1040"/>
                    </a:lnTo>
                    <a:lnTo>
                      <a:pt x="1450" y="1153"/>
                    </a:lnTo>
                    <a:lnTo>
                      <a:pt x="0" y="1153"/>
                    </a:lnTo>
                    <a:close/>
                  </a:path>
                </a:pathLst>
              </a:custGeom>
              <a:solidFill>
                <a:schemeClr val="bg1">
                  <a:lumMod val="75000"/>
                </a:schemeClr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89" name="Freeform 321"/>
              <p:cNvSpPr>
                <a:spLocks/>
              </p:cNvSpPr>
              <p:nvPr/>
            </p:nvSpPr>
            <p:spPr bwMode="auto">
              <a:xfrm>
                <a:off x="8778875" y="6369050"/>
                <a:ext cx="2301875" cy="1830388"/>
              </a:xfrm>
              <a:custGeom>
                <a:avLst/>
                <a:gdLst/>
                <a:ahLst/>
                <a:cxnLst>
                  <a:cxn ang="0">
                    <a:pos x="17" y="1153"/>
                  </a:cxn>
                  <a:cxn ang="0">
                    <a:pos x="45" y="1153"/>
                  </a:cxn>
                  <a:cxn ang="0">
                    <a:pos x="73" y="1153"/>
                  </a:cxn>
                  <a:cxn ang="0">
                    <a:pos x="102" y="1153"/>
                  </a:cxn>
                  <a:cxn ang="0">
                    <a:pos x="130" y="1153"/>
                  </a:cxn>
                  <a:cxn ang="0">
                    <a:pos x="158" y="1153"/>
                  </a:cxn>
                  <a:cxn ang="0">
                    <a:pos x="187" y="1153"/>
                  </a:cxn>
                  <a:cxn ang="0">
                    <a:pos x="215" y="1153"/>
                  </a:cxn>
                  <a:cxn ang="0">
                    <a:pos x="243" y="1153"/>
                  </a:cxn>
                  <a:cxn ang="0">
                    <a:pos x="272" y="1153"/>
                  </a:cxn>
                  <a:cxn ang="0">
                    <a:pos x="300" y="1153"/>
                  </a:cxn>
                  <a:cxn ang="0">
                    <a:pos x="328" y="1153"/>
                  </a:cxn>
                  <a:cxn ang="0">
                    <a:pos x="357" y="1153"/>
                  </a:cxn>
                  <a:cxn ang="0">
                    <a:pos x="385" y="1153"/>
                  </a:cxn>
                  <a:cxn ang="0">
                    <a:pos x="413" y="1153"/>
                  </a:cxn>
                  <a:cxn ang="0">
                    <a:pos x="441" y="1153"/>
                  </a:cxn>
                  <a:cxn ang="0">
                    <a:pos x="470" y="1153"/>
                  </a:cxn>
                  <a:cxn ang="0">
                    <a:pos x="498" y="1153"/>
                  </a:cxn>
                  <a:cxn ang="0">
                    <a:pos x="527" y="1153"/>
                  </a:cxn>
                  <a:cxn ang="0">
                    <a:pos x="555" y="1153"/>
                  </a:cxn>
                  <a:cxn ang="0">
                    <a:pos x="583" y="1153"/>
                  </a:cxn>
                  <a:cxn ang="0">
                    <a:pos x="612" y="1153"/>
                  </a:cxn>
                  <a:cxn ang="0">
                    <a:pos x="640" y="1153"/>
                  </a:cxn>
                  <a:cxn ang="0">
                    <a:pos x="668" y="1153"/>
                  </a:cxn>
                  <a:cxn ang="0">
                    <a:pos x="696" y="1153"/>
                  </a:cxn>
                  <a:cxn ang="0">
                    <a:pos x="725" y="1153"/>
                  </a:cxn>
                  <a:cxn ang="0">
                    <a:pos x="753" y="1153"/>
                  </a:cxn>
                  <a:cxn ang="0">
                    <a:pos x="782" y="1153"/>
                  </a:cxn>
                  <a:cxn ang="0">
                    <a:pos x="810" y="1153"/>
                  </a:cxn>
                  <a:cxn ang="0">
                    <a:pos x="838" y="1153"/>
                  </a:cxn>
                  <a:cxn ang="0">
                    <a:pos x="867" y="1144"/>
                  </a:cxn>
                  <a:cxn ang="0">
                    <a:pos x="895" y="1153"/>
                  </a:cxn>
                  <a:cxn ang="0">
                    <a:pos x="923" y="1136"/>
                  </a:cxn>
                  <a:cxn ang="0">
                    <a:pos x="951" y="1153"/>
                  </a:cxn>
                  <a:cxn ang="0">
                    <a:pos x="980" y="1136"/>
                  </a:cxn>
                  <a:cxn ang="0">
                    <a:pos x="1008" y="1136"/>
                  </a:cxn>
                  <a:cxn ang="0">
                    <a:pos x="1036" y="1136"/>
                  </a:cxn>
                  <a:cxn ang="0">
                    <a:pos x="1065" y="1127"/>
                  </a:cxn>
                  <a:cxn ang="0">
                    <a:pos x="1093" y="1092"/>
                  </a:cxn>
                  <a:cxn ang="0">
                    <a:pos x="1122" y="1031"/>
                  </a:cxn>
                  <a:cxn ang="0">
                    <a:pos x="1150" y="970"/>
                  </a:cxn>
                  <a:cxn ang="0">
                    <a:pos x="1178" y="909"/>
                  </a:cxn>
                  <a:cxn ang="0">
                    <a:pos x="1206" y="891"/>
                  </a:cxn>
                  <a:cxn ang="0">
                    <a:pos x="1235" y="761"/>
                  </a:cxn>
                  <a:cxn ang="0">
                    <a:pos x="1263" y="665"/>
                  </a:cxn>
                  <a:cxn ang="0">
                    <a:pos x="1291" y="560"/>
                  </a:cxn>
                  <a:cxn ang="0">
                    <a:pos x="1320" y="473"/>
                  </a:cxn>
                  <a:cxn ang="0">
                    <a:pos x="1348" y="482"/>
                  </a:cxn>
                  <a:cxn ang="0">
                    <a:pos x="1376" y="595"/>
                  </a:cxn>
                  <a:cxn ang="0">
                    <a:pos x="1405" y="491"/>
                  </a:cxn>
                  <a:cxn ang="0">
                    <a:pos x="1433" y="142"/>
                  </a:cxn>
                </a:cxnLst>
                <a:rect l="0" t="0" r="r" b="b"/>
                <a:pathLst>
                  <a:path w="1450" h="1153">
                    <a:moveTo>
                      <a:pt x="0" y="1153"/>
                    </a:moveTo>
                    <a:lnTo>
                      <a:pt x="0" y="1153"/>
                    </a:lnTo>
                    <a:lnTo>
                      <a:pt x="5" y="1153"/>
                    </a:lnTo>
                    <a:lnTo>
                      <a:pt x="11" y="1153"/>
                    </a:lnTo>
                    <a:lnTo>
                      <a:pt x="17" y="1153"/>
                    </a:lnTo>
                    <a:lnTo>
                      <a:pt x="22" y="1153"/>
                    </a:lnTo>
                    <a:lnTo>
                      <a:pt x="28" y="1153"/>
                    </a:lnTo>
                    <a:lnTo>
                      <a:pt x="34" y="1153"/>
                    </a:lnTo>
                    <a:lnTo>
                      <a:pt x="39" y="1153"/>
                    </a:lnTo>
                    <a:lnTo>
                      <a:pt x="45" y="1153"/>
                    </a:lnTo>
                    <a:lnTo>
                      <a:pt x="51" y="1153"/>
                    </a:lnTo>
                    <a:lnTo>
                      <a:pt x="56" y="1153"/>
                    </a:lnTo>
                    <a:lnTo>
                      <a:pt x="62" y="1153"/>
                    </a:lnTo>
                    <a:lnTo>
                      <a:pt x="68" y="1153"/>
                    </a:lnTo>
                    <a:lnTo>
                      <a:pt x="73" y="1153"/>
                    </a:lnTo>
                    <a:lnTo>
                      <a:pt x="79" y="1153"/>
                    </a:lnTo>
                    <a:lnTo>
                      <a:pt x="85" y="1153"/>
                    </a:lnTo>
                    <a:lnTo>
                      <a:pt x="90" y="1153"/>
                    </a:lnTo>
                    <a:lnTo>
                      <a:pt x="96" y="1153"/>
                    </a:lnTo>
                    <a:lnTo>
                      <a:pt x="102" y="1153"/>
                    </a:lnTo>
                    <a:lnTo>
                      <a:pt x="107" y="1153"/>
                    </a:lnTo>
                    <a:lnTo>
                      <a:pt x="113" y="1153"/>
                    </a:lnTo>
                    <a:lnTo>
                      <a:pt x="119" y="1153"/>
                    </a:lnTo>
                    <a:lnTo>
                      <a:pt x="124" y="1153"/>
                    </a:lnTo>
                    <a:lnTo>
                      <a:pt x="130" y="1153"/>
                    </a:lnTo>
                    <a:lnTo>
                      <a:pt x="136" y="1153"/>
                    </a:lnTo>
                    <a:lnTo>
                      <a:pt x="141" y="1153"/>
                    </a:lnTo>
                    <a:lnTo>
                      <a:pt x="147" y="1153"/>
                    </a:lnTo>
                    <a:lnTo>
                      <a:pt x="153" y="1153"/>
                    </a:lnTo>
                    <a:lnTo>
                      <a:pt x="158" y="1153"/>
                    </a:lnTo>
                    <a:lnTo>
                      <a:pt x="164" y="1153"/>
                    </a:lnTo>
                    <a:lnTo>
                      <a:pt x="170" y="1153"/>
                    </a:lnTo>
                    <a:lnTo>
                      <a:pt x="175" y="1153"/>
                    </a:lnTo>
                    <a:lnTo>
                      <a:pt x="181" y="1153"/>
                    </a:lnTo>
                    <a:lnTo>
                      <a:pt x="187" y="1153"/>
                    </a:lnTo>
                    <a:lnTo>
                      <a:pt x="192" y="1153"/>
                    </a:lnTo>
                    <a:lnTo>
                      <a:pt x="198" y="1153"/>
                    </a:lnTo>
                    <a:lnTo>
                      <a:pt x="204" y="1153"/>
                    </a:lnTo>
                    <a:lnTo>
                      <a:pt x="209" y="1153"/>
                    </a:lnTo>
                    <a:lnTo>
                      <a:pt x="215" y="1153"/>
                    </a:lnTo>
                    <a:lnTo>
                      <a:pt x="221" y="1153"/>
                    </a:lnTo>
                    <a:lnTo>
                      <a:pt x="226" y="1153"/>
                    </a:lnTo>
                    <a:lnTo>
                      <a:pt x="232" y="1153"/>
                    </a:lnTo>
                    <a:lnTo>
                      <a:pt x="238" y="1153"/>
                    </a:lnTo>
                    <a:lnTo>
                      <a:pt x="243" y="1153"/>
                    </a:lnTo>
                    <a:lnTo>
                      <a:pt x="249" y="1153"/>
                    </a:lnTo>
                    <a:lnTo>
                      <a:pt x="255" y="1153"/>
                    </a:lnTo>
                    <a:lnTo>
                      <a:pt x="260" y="1153"/>
                    </a:lnTo>
                    <a:lnTo>
                      <a:pt x="266" y="1153"/>
                    </a:lnTo>
                    <a:lnTo>
                      <a:pt x="272" y="1153"/>
                    </a:lnTo>
                    <a:lnTo>
                      <a:pt x="277" y="1153"/>
                    </a:lnTo>
                    <a:lnTo>
                      <a:pt x="283" y="1153"/>
                    </a:lnTo>
                    <a:lnTo>
                      <a:pt x="289" y="1153"/>
                    </a:lnTo>
                    <a:lnTo>
                      <a:pt x="294" y="1153"/>
                    </a:lnTo>
                    <a:lnTo>
                      <a:pt x="300" y="1153"/>
                    </a:lnTo>
                    <a:lnTo>
                      <a:pt x="306" y="1153"/>
                    </a:lnTo>
                    <a:lnTo>
                      <a:pt x="311" y="1153"/>
                    </a:lnTo>
                    <a:lnTo>
                      <a:pt x="317" y="1153"/>
                    </a:lnTo>
                    <a:lnTo>
                      <a:pt x="323" y="1153"/>
                    </a:lnTo>
                    <a:lnTo>
                      <a:pt x="328" y="1153"/>
                    </a:lnTo>
                    <a:lnTo>
                      <a:pt x="334" y="1153"/>
                    </a:lnTo>
                    <a:lnTo>
                      <a:pt x="340" y="1153"/>
                    </a:lnTo>
                    <a:lnTo>
                      <a:pt x="345" y="1153"/>
                    </a:lnTo>
                    <a:lnTo>
                      <a:pt x="351" y="1153"/>
                    </a:lnTo>
                    <a:lnTo>
                      <a:pt x="357" y="1153"/>
                    </a:lnTo>
                    <a:lnTo>
                      <a:pt x="362" y="1153"/>
                    </a:lnTo>
                    <a:lnTo>
                      <a:pt x="368" y="1153"/>
                    </a:lnTo>
                    <a:lnTo>
                      <a:pt x="374" y="1153"/>
                    </a:lnTo>
                    <a:lnTo>
                      <a:pt x="379" y="1153"/>
                    </a:lnTo>
                    <a:lnTo>
                      <a:pt x="385" y="1153"/>
                    </a:lnTo>
                    <a:lnTo>
                      <a:pt x="391" y="1153"/>
                    </a:lnTo>
                    <a:lnTo>
                      <a:pt x="396" y="1144"/>
                    </a:lnTo>
                    <a:lnTo>
                      <a:pt x="402" y="1153"/>
                    </a:lnTo>
                    <a:lnTo>
                      <a:pt x="408" y="1153"/>
                    </a:lnTo>
                    <a:lnTo>
                      <a:pt x="413" y="1153"/>
                    </a:lnTo>
                    <a:lnTo>
                      <a:pt x="419" y="1153"/>
                    </a:lnTo>
                    <a:lnTo>
                      <a:pt x="425" y="1153"/>
                    </a:lnTo>
                    <a:lnTo>
                      <a:pt x="430" y="1153"/>
                    </a:lnTo>
                    <a:lnTo>
                      <a:pt x="436" y="1153"/>
                    </a:lnTo>
                    <a:lnTo>
                      <a:pt x="441" y="1153"/>
                    </a:lnTo>
                    <a:lnTo>
                      <a:pt x="447" y="1153"/>
                    </a:lnTo>
                    <a:lnTo>
                      <a:pt x="453" y="1153"/>
                    </a:lnTo>
                    <a:lnTo>
                      <a:pt x="458" y="1153"/>
                    </a:lnTo>
                    <a:lnTo>
                      <a:pt x="464" y="1153"/>
                    </a:lnTo>
                    <a:lnTo>
                      <a:pt x="470" y="1153"/>
                    </a:lnTo>
                    <a:lnTo>
                      <a:pt x="476" y="1153"/>
                    </a:lnTo>
                    <a:lnTo>
                      <a:pt x="481" y="1153"/>
                    </a:lnTo>
                    <a:lnTo>
                      <a:pt x="487" y="1153"/>
                    </a:lnTo>
                    <a:lnTo>
                      <a:pt x="493" y="1153"/>
                    </a:lnTo>
                    <a:lnTo>
                      <a:pt x="498" y="1153"/>
                    </a:lnTo>
                    <a:lnTo>
                      <a:pt x="504" y="1153"/>
                    </a:lnTo>
                    <a:lnTo>
                      <a:pt x="510" y="1153"/>
                    </a:lnTo>
                    <a:lnTo>
                      <a:pt x="515" y="1153"/>
                    </a:lnTo>
                    <a:lnTo>
                      <a:pt x="521" y="1153"/>
                    </a:lnTo>
                    <a:lnTo>
                      <a:pt x="527" y="1153"/>
                    </a:lnTo>
                    <a:lnTo>
                      <a:pt x="532" y="1153"/>
                    </a:lnTo>
                    <a:lnTo>
                      <a:pt x="538" y="1153"/>
                    </a:lnTo>
                    <a:lnTo>
                      <a:pt x="544" y="1153"/>
                    </a:lnTo>
                    <a:lnTo>
                      <a:pt x="549" y="1153"/>
                    </a:lnTo>
                    <a:lnTo>
                      <a:pt x="555" y="1153"/>
                    </a:lnTo>
                    <a:lnTo>
                      <a:pt x="561" y="1153"/>
                    </a:lnTo>
                    <a:lnTo>
                      <a:pt x="566" y="1153"/>
                    </a:lnTo>
                    <a:lnTo>
                      <a:pt x="572" y="1153"/>
                    </a:lnTo>
                    <a:lnTo>
                      <a:pt x="578" y="1153"/>
                    </a:lnTo>
                    <a:lnTo>
                      <a:pt x="583" y="1153"/>
                    </a:lnTo>
                    <a:lnTo>
                      <a:pt x="589" y="1153"/>
                    </a:lnTo>
                    <a:lnTo>
                      <a:pt x="595" y="1144"/>
                    </a:lnTo>
                    <a:lnTo>
                      <a:pt x="600" y="1153"/>
                    </a:lnTo>
                    <a:lnTo>
                      <a:pt x="606" y="1153"/>
                    </a:lnTo>
                    <a:lnTo>
                      <a:pt x="612" y="1153"/>
                    </a:lnTo>
                    <a:lnTo>
                      <a:pt x="617" y="1144"/>
                    </a:lnTo>
                    <a:lnTo>
                      <a:pt x="623" y="1153"/>
                    </a:lnTo>
                    <a:lnTo>
                      <a:pt x="629" y="1153"/>
                    </a:lnTo>
                    <a:lnTo>
                      <a:pt x="634" y="1153"/>
                    </a:lnTo>
                    <a:lnTo>
                      <a:pt x="640" y="1153"/>
                    </a:lnTo>
                    <a:lnTo>
                      <a:pt x="646" y="1153"/>
                    </a:lnTo>
                    <a:lnTo>
                      <a:pt x="651" y="1153"/>
                    </a:lnTo>
                    <a:lnTo>
                      <a:pt x="657" y="1144"/>
                    </a:lnTo>
                    <a:lnTo>
                      <a:pt x="663" y="1153"/>
                    </a:lnTo>
                    <a:lnTo>
                      <a:pt x="668" y="1153"/>
                    </a:lnTo>
                    <a:lnTo>
                      <a:pt x="674" y="1153"/>
                    </a:lnTo>
                    <a:lnTo>
                      <a:pt x="680" y="1153"/>
                    </a:lnTo>
                    <a:lnTo>
                      <a:pt x="685" y="1153"/>
                    </a:lnTo>
                    <a:lnTo>
                      <a:pt x="691" y="1144"/>
                    </a:lnTo>
                    <a:lnTo>
                      <a:pt x="696" y="1153"/>
                    </a:lnTo>
                    <a:lnTo>
                      <a:pt x="702" y="1144"/>
                    </a:lnTo>
                    <a:lnTo>
                      <a:pt x="708" y="1153"/>
                    </a:lnTo>
                    <a:lnTo>
                      <a:pt x="713" y="1153"/>
                    </a:lnTo>
                    <a:lnTo>
                      <a:pt x="719" y="1144"/>
                    </a:lnTo>
                    <a:lnTo>
                      <a:pt x="725" y="1153"/>
                    </a:lnTo>
                    <a:lnTo>
                      <a:pt x="730" y="1153"/>
                    </a:lnTo>
                    <a:lnTo>
                      <a:pt x="736" y="1144"/>
                    </a:lnTo>
                    <a:lnTo>
                      <a:pt x="742" y="1153"/>
                    </a:lnTo>
                    <a:lnTo>
                      <a:pt x="747" y="1153"/>
                    </a:lnTo>
                    <a:lnTo>
                      <a:pt x="753" y="1153"/>
                    </a:lnTo>
                    <a:lnTo>
                      <a:pt x="759" y="1153"/>
                    </a:lnTo>
                    <a:lnTo>
                      <a:pt x="764" y="1153"/>
                    </a:lnTo>
                    <a:lnTo>
                      <a:pt x="770" y="1144"/>
                    </a:lnTo>
                    <a:lnTo>
                      <a:pt x="776" y="1153"/>
                    </a:lnTo>
                    <a:lnTo>
                      <a:pt x="782" y="1153"/>
                    </a:lnTo>
                    <a:lnTo>
                      <a:pt x="787" y="1144"/>
                    </a:lnTo>
                    <a:lnTo>
                      <a:pt x="793" y="1153"/>
                    </a:lnTo>
                    <a:lnTo>
                      <a:pt x="799" y="1153"/>
                    </a:lnTo>
                    <a:lnTo>
                      <a:pt x="804" y="1153"/>
                    </a:lnTo>
                    <a:lnTo>
                      <a:pt x="810" y="1153"/>
                    </a:lnTo>
                    <a:lnTo>
                      <a:pt x="816" y="1153"/>
                    </a:lnTo>
                    <a:lnTo>
                      <a:pt x="821" y="1153"/>
                    </a:lnTo>
                    <a:lnTo>
                      <a:pt x="827" y="1144"/>
                    </a:lnTo>
                    <a:lnTo>
                      <a:pt x="833" y="1153"/>
                    </a:lnTo>
                    <a:lnTo>
                      <a:pt x="838" y="1153"/>
                    </a:lnTo>
                    <a:lnTo>
                      <a:pt x="844" y="1144"/>
                    </a:lnTo>
                    <a:lnTo>
                      <a:pt x="850" y="1153"/>
                    </a:lnTo>
                    <a:lnTo>
                      <a:pt x="855" y="1153"/>
                    </a:lnTo>
                    <a:lnTo>
                      <a:pt x="861" y="1144"/>
                    </a:lnTo>
                    <a:lnTo>
                      <a:pt x="867" y="1144"/>
                    </a:lnTo>
                    <a:lnTo>
                      <a:pt x="872" y="1144"/>
                    </a:lnTo>
                    <a:lnTo>
                      <a:pt x="878" y="1144"/>
                    </a:lnTo>
                    <a:lnTo>
                      <a:pt x="884" y="1153"/>
                    </a:lnTo>
                    <a:lnTo>
                      <a:pt x="889" y="1153"/>
                    </a:lnTo>
                    <a:lnTo>
                      <a:pt x="895" y="1153"/>
                    </a:lnTo>
                    <a:lnTo>
                      <a:pt x="901" y="1153"/>
                    </a:lnTo>
                    <a:lnTo>
                      <a:pt x="906" y="1153"/>
                    </a:lnTo>
                    <a:lnTo>
                      <a:pt x="912" y="1153"/>
                    </a:lnTo>
                    <a:lnTo>
                      <a:pt x="918" y="1153"/>
                    </a:lnTo>
                    <a:lnTo>
                      <a:pt x="923" y="1136"/>
                    </a:lnTo>
                    <a:lnTo>
                      <a:pt x="929" y="1144"/>
                    </a:lnTo>
                    <a:lnTo>
                      <a:pt x="935" y="1144"/>
                    </a:lnTo>
                    <a:lnTo>
                      <a:pt x="940" y="1144"/>
                    </a:lnTo>
                    <a:lnTo>
                      <a:pt x="946" y="1153"/>
                    </a:lnTo>
                    <a:lnTo>
                      <a:pt x="951" y="1153"/>
                    </a:lnTo>
                    <a:lnTo>
                      <a:pt x="957" y="1153"/>
                    </a:lnTo>
                    <a:lnTo>
                      <a:pt x="963" y="1136"/>
                    </a:lnTo>
                    <a:lnTo>
                      <a:pt x="968" y="1144"/>
                    </a:lnTo>
                    <a:lnTo>
                      <a:pt x="974" y="1153"/>
                    </a:lnTo>
                    <a:lnTo>
                      <a:pt x="980" y="1136"/>
                    </a:lnTo>
                    <a:lnTo>
                      <a:pt x="985" y="1127"/>
                    </a:lnTo>
                    <a:lnTo>
                      <a:pt x="991" y="1127"/>
                    </a:lnTo>
                    <a:lnTo>
                      <a:pt x="997" y="1127"/>
                    </a:lnTo>
                    <a:lnTo>
                      <a:pt x="1002" y="1153"/>
                    </a:lnTo>
                    <a:lnTo>
                      <a:pt x="1008" y="1136"/>
                    </a:lnTo>
                    <a:lnTo>
                      <a:pt x="1014" y="1127"/>
                    </a:lnTo>
                    <a:lnTo>
                      <a:pt x="1019" y="1136"/>
                    </a:lnTo>
                    <a:lnTo>
                      <a:pt x="1025" y="1144"/>
                    </a:lnTo>
                    <a:lnTo>
                      <a:pt x="1031" y="1136"/>
                    </a:lnTo>
                    <a:lnTo>
                      <a:pt x="1036" y="1136"/>
                    </a:lnTo>
                    <a:lnTo>
                      <a:pt x="1042" y="1127"/>
                    </a:lnTo>
                    <a:lnTo>
                      <a:pt x="1048" y="1118"/>
                    </a:lnTo>
                    <a:lnTo>
                      <a:pt x="1053" y="1127"/>
                    </a:lnTo>
                    <a:lnTo>
                      <a:pt x="1059" y="1136"/>
                    </a:lnTo>
                    <a:lnTo>
                      <a:pt x="1065" y="1127"/>
                    </a:lnTo>
                    <a:lnTo>
                      <a:pt x="1070" y="1083"/>
                    </a:lnTo>
                    <a:lnTo>
                      <a:pt x="1076" y="1136"/>
                    </a:lnTo>
                    <a:lnTo>
                      <a:pt x="1082" y="1118"/>
                    </a:lnTo>
                    <a:lnTo>
                      <a:pt x="1088" y="1118"/>
                    </a:lnTo>
                    <a:lnTo>
                      <a:pt x="1093" y="1092"/>
                    </a:lnTo>
                    <a:lnTo>
                      <a:pt x="1099" y="1048"/>
                    </a:lnTo>
                    <a:lnTo>
                      <a:pt x="1105" y="1066"/>
                    </a:lnTo>
                    <a:lnTo>
                      <a:pt x="1110" y="1022"/>
                    </a:lnTo>
                    <a:lnTo>
                      <a:pt x="1116" y="1048"/>
                    </a:lnTo>
                    <a:lnTo>
                      <a:pt x="1122" y="1031"/>
                    </a:lnTo>
                    <a:lnTo>
                      <a:pt x="1127" y="1048"/>
                    </a:lnTo>
                    <a:lnTo>
                      <a:pt x="1133" y="1074"/>
                    </a:lnTo>
                    <a:lnTo>
                      <a:pt x="1139" y="1048"/>
                    </a:lnTo>
                    <a:lnTo>
                      <a:pt x="1144" y="1022"/>
                    </a:lnTo>
                    <a:lnTo>
                      <a:pt x="1150" y="970"/>
                    </a:lnTo>
                    <a:lnTo>
                      <a:pt x="1156" y="1022"/>
                    </a:lnTo>
                    <a:lnTo>
                      <a:pt x="1161" y="1048"/>
                    </a:lnTo>
                    <a:lnTo>
                      <a:pt x="1167" y="1022"/>
                    </a:lnTo>
                    <a:lnTo>
                      <a:pt x="1173" y="987"/>
                    </a:lnTo>
                    <a:lnTo>
                      <a:pt x="1178" y="909"/>
                    </a:lnTo>
                    <a:lnTo>
                      <a:pt x="1184" y="979"/>
                    </a:lnTo>
                    <a:lnTo>
                      <a:pt x="1190" y="944"/>
                    </a:lnTo>
                    <a:lnTo>
                      <a:pt x="1195" y="987"/>
                    </a:lnTo>
                    <a:lnTo>
                      <a:pt x="1201" y="979"/>
                    </a:lnTo>
                    <a:lnTo>
                      <a:pt x="1206" y="891"/>
                    </a:lnTo>
                    <a:lnTo>
                      <a:pt x="1212" y="891"/>
                    </a:lnTo>
                    <a:lnTo>
                      <a:pt x="1218" y="935"/>
                    </a:lnTo>
                    <a:lnTo>
                      <a:pt x="1223" y="926"/>
                    </a:lnTo>
                    <a:lnTo>
                      <a:pt x="1229" y="848"/>
                    </a:lnTo>
                    <a:lnTo>
                      <a:pt x="1235" y="761"/>
                    </a:lnTo>
                    <a:lnTo>
                      <a:pt x="1240" y="918"/>
                    </a:lnTo>
                    <a:lnTo>
                      <a:pt x="1246" y="682"/>
                    </a:lnTo>
                    <a:lnTo>
                      <a:pt x="1252" y="865"/>
                    </a:lnTo>
                    <a:lnTo>
                      <a:pt x="1257" y="691"/>
                    </a:lnTo>
                    <a:lnTo>
                      <a:pt x="1263" y="665"/>
                    </a:lnTo>
                    <a:lnTo>
                      <a:pt x="1269" y="787"/>
                    </a:lnTo>
                    <a:lnTo>
                      <a:pt x="1274" y="656"/>
                    </a:lnTo>
                    <a:lnTo>
                      <a:pt x="1280" y="726"/>
                    </a:lnTo>
                    <a:lnTo>
                      <a:pt x="1286" y="691"/>
                    </a:lnTo>
                    <a:lnTo>
                      <a:pt x="1291" y="560"/>
                    </a:lnTo>
                    <a:lnTo>
                      <a:pt x="1297" y="569"/>
                    </a:lnTo>
                    <a:lnTo>
                      <a:pt x="1303" y="630"/>
                    </a:lnTo>
                    <a:lnTo>
                      <a:pt x="1308" y="578"/>
                    </a:lnTo>
                    <a:lnTo>
                      <a:pt x="1314" y="377"/>
                    </a:lnTo>
                    <a:lnTo>
                      <a:pt x="1320" y="473"/>
                    </a:lnTo>
                    <a:lnTo>
                      <a:pt x="1325" y="491"/>
                    </a:lnTo>
                    <a:lnTo>
                      <a:pt x="1331" y="552"/>
                    </a:lnTo>
                    <a:lnTo>
                      <a:pt x="1337" y="491"/>
                    </a:lnTo>
                    <a:lnTo>
                      <a:pt x="1342" y="447"/>
                    </a:lnTo>
                    <a:lnTo>
                      <a:pt x="1348" y="482"/>
                    </a:lnTo>
                    <a:lnTo>
                      <a:pt x="1354" y="526"/>
                    </a:lnTo>
                    <a:lnTo>
                      <a:pt x="1359" y="560"/>
                    </a:lnTo>
                    <a:lnTo>
                      <a:pt x="1365" y="526"/>
                    </a:lnTo>
                    <a:lnTo>
                      <a:pt x="1371" y="456"/>
                    </a:lnTo>
                    <a:lnTo>
                      <a:pt x="1376" y="595"/>
                    </a:lnTo>
                    <a:lnTo>
                      <a:pt x="1382" y="526"/>
                    </a:lnTo>
                    <a:lnTo>
                      <a:pt x="1388" y="491"/>
                    </a:lnTo>
                    <a:lnTo>
                      <a:pt x="1393" y="587"/>
                    </a:lnTo>
                    <a:lnTo>
                      <a:pt x="1399" y="473"/>
                    </a:lnTo>
                    <a:lnTo>
                      <a:pt x="1405" y="491"/>
                    </a:lnTo>
                    <a:lnTo>
                      <a:pt x="1411" y="439"/>
                    </a:lnTo>
                    <a:lnTo>
                      <a:pt x="1416" y="282"/>
                    </a:lnTo>
                    <a:lnTo>
                      <a:pt x="1422" y="134"/>
                    </a:lnTo>
                    <a:lnTo>
                      <a:pt x="1428" y="0"/>
                    </a:lnTo>
                    <a:lnTo>
                      <a:pt x="1433" y="142"/>
                    </a:lnTo>
                    <a:lnTo>
                      <a:pt x="1439" y="752"/>
                    </a:lnTo>
                    <a:lnTo>
                      <a:pt x="1445" y="1040"/>
                    </a:lnTo>
                    <a:lnTo>
                      <a:pt x="1450" y="1153"/>
                    </a:lnTo>
                    <a:lnTo>
                      <a:pt x="0" y="1153"/>
                    </a:lnTo>
                    <a:close/>
                  </a:path>
                </a:pathLst>
              </a:custGeom>
              <a:noFill/>
              <a:ln w="0">
                <a:solidFill>
                  <a:srgbClr val="000000"/>
                </a:solidFill>
                <a:prstDash val="sysDot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  <p:sp>
            <p:nvSpPr>
              <p:cNvPr id="58690" name="Rectangle 322"/>
              <p:cNvSpPr>
                <a:spLocks noChangeArrowheads="1"/>
              </p:cNvSpPr>
              <p:nvPr/>
            </p:nvSpPr>
            <p:spPr bwMode="auto">
              <a:xfrm>
                <a:off x="8778875" y="6359525"/>
                <a:ext cx="2301875" cy="1839913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nl-NL"/>
              </a:p>
            </p:txBody>
          </p:sp>
        </p:grpSp>
        <p:sp>
          <p:nvSpPr>
            <p:cNvPr id="408" name="Tekstvak 407"/>
            <p:cNvSpPr txBox="1"/>
            <p:nvPr/>
          </p:nvSpPr>
          <p:spPr>
            <a:xfrm>
              <a:off x="578565" y="5570995"/>
              <a:ext cx="148107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600" b="1" dirty="0" err="1" smtClean="0"/>
                <a:t>Vorinostat</a:t>
              </a:r>
              <a:endParaRPr lang="nl-NL" sz="1600" b="1" dirty="0"/>
            </a:p>
          </p:txBody>
        </p:sp>
        <p:sp>
          <p:nvSpPr>
            <p:cNvPr id="418" name="Tekstvak 417"/>
            <p:cNvSpPr txBox="1"/>
            <p:nvPr/>
          </p:nvSpPr>
          <p:spPr>
            <a:xfrm>
              <a:off x="2178474" y="5480076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4/80</a:t>
              </a:r>
              <a:endParaRPr lang="nl-NL" sz="1200" b="1" dirty="0"/>
            </a:p>
          </p:txBody>
        </p:sp>
        <p:cxnSp>
          <p:nvCxnSpPr>
            <p:cNvPr id="419" name="Rechte verbindingslijn met pijl 418"/>
            <p:cNvCxnSpPr/>
            <p:nvPr/>
          </p:nvCxnSpPr>
          <p:spPr>
            <a:xfrm>
              <a:off x="1882133" y="5519867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0" name="Tekstvak 419"/>
            <p:cNvSpPr txBox="1"/>
            <p:nvPr/>
          </p:nvSpPr>
          <p:spPr>
            <a:xfrm>
              <a:off x="3982766" y="5471717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</a:t>
              </a:r>
            </a:p>
          </p:txBody>
        </p:sp>
        <p:cxnSp>
          <p:nvCxnSpPr>
            <p:cNvPr id="421" name="Rechte verbindingslijn met pijl 420"/>
            <p:cNvCxnSpPr/>
            <p:nvPr/>
          </p:nvCxnSpPr>
          <p:spPr>
            <a:xfrm>
              <a:off x="3651639" y="5519365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Rechte verbindingslijn met pijl 421"/>
            <p:cNvCxnSpPr/>
            <p:nvPr/>
          </p:nvCxnSpPr>
          <p:spPr>
            <a:xfrm>
              <a:off x="5112539" y="5508578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3" name="Tekstvak 422"/>
            <p:cNvSpPr txBox="1"/>
            <p:nvPr/>
          </p:nvSpPr>
          <p:spPr>
            <a:xfrm>
              <a:off x="5356866" y="5454783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I/III</a:t>
              </a:r>
            </a:p>
          </p:txBody>
        </p:sp>
        <p:sp>
          <p:nvSpPr>
            <p:cNvPr id="424" name="Tekstvak 423"/>
            <p:cNvSpPr txBox="1"/>
            <p:nvPr/>
          </p:nvSpPr>
          <p:spPr>
            <a:xfrm>
              <a:off x="2194053" y="7158755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4/80</a:t>
              </a:r>
              <a:endParaRPr lang="nl-NL" sz="1200" b="1" dirty="0"/>
            </a:p>
          </p:txBody>
        </p:sp>
        <p:cxnSp>
          <p:nvCxnSpPr>
            <p:cNvPr id="425" name="Rechte verbindingslijn met pijl 424"/>
            <p:cNvCxnSpPr/>
            <p:nvPr/>
          </p:nvCxnSpPr>
          <p:spPr>
            <a:xfrm>
              <a:off x="1897712" y="7198543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6" name="Tekstvak 425"/>
            <p:cNvSpPr txBox="1"/>
            <p:nvPr/>
          </p:nvSpPr>
          <p:spPr>
            <a:xfrm>
              <a:off x="3978194" y="7122964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</a:t>
              </a:r>
            </a:p>
          </p:txBody>
        </p:sp>
        <p:cxnSp>
          <p:nvCxnSpPr>
            <p:cNvPr id="427" name="Rechte verbindingslijn met pijl 426"/>
            <p:cNvCxnSpPr/>
            <p:nvPr/>
          </p:nvCxnSpPr>
          <p:spPr>
            <a:xfrm>
              <a:off x="3647067" y="7170610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Rechte verbindingslijn met pijl 427"/>
            <p:cNvCxnSpPr/>
            <p:nvPr/>
          </p:nvCxnSpPr>
          <p:spPr>
            <a:xfrm>
              <a:off x="5141069" y="7171111"/>
              <a:ext cx="1163039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9" name="Tekstvak 428"/>
            <p:cNvSpPr txBox="1"/>
            <p:nvPr/>
          </p:nvSpPr>
          <p:spPr>
            <a:xfrm>
              <a:off x="5317514" y="7117316"/>
              <a:ext cx="1105010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smtClean="0"/>
                <a:t>FcR</a:t>
              </a:r>
              <a:r>
                <a:rPr lang="el-GR" sz="1200" b="1" dirty="0" smtClean="0"/>
                <a:t>γ</a:t>
              </a:r>
              <a:r>
                <a:rPr lang="nl-NL" sz="1200" b="1" dirty="0" smtClean="0"/>
                <a:t>II/III</a:t>
              </a:r>
            </a:p>
          </p:txBody>
        </p:sp>
        <p:sp>
          <p:nvSpPr>
            <p:cNvPr id="430" name="Tekstvak 429"/>
            <p:cNvSpPr txBox="1"/>
            <p:nvPr/>
          </p:nvSpPr>
          <p:spPr>
            <a:xfrm>
              <a:off x="3784790" y="4044172"/>
              <a:ext cx="2733446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F4/80-low</a:t>
              </a:r>
              <a:endParaRPr lang="nl-NL" sz="1200" b="1" dirty="0"/>
            </a:p>
          </p:txBody>
        </p:sp>
        <p:sp>
          <p:nvSpPr>
            <p:cNvPr id="431" name="Tekstvak 430"/>
            <p:cNvSpPr txBox="1"/>
            <p:nvPr/>
          </p:nvSpPr>
          <p:spPr>
            <a:xfrm>
              <a:off x="3781112" y="5692738"/>
              <a:ext cx="2733446" cy="21356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Gated</a:t>
              </a:r>
              <a:r>
                <a:rPr lang="nl-NL" sz="1200" b="1" dirty="0" smtClean="0"/>
                <a:t> CD45.2+CD11b+F4/80-high</a:t>
              </a:r>
              <a:endParaRPr lang="nl-NL" sz="1200" b="1" dirty="0"/>
            </a:p>
          </p:txBody>
        </p:sp>
        <p:cxnSp>
          <p:nvCxnSpPr>
            <p:cNvPr id="95" name="Rechte verbindingslijn 94"/>
            <p:cNvCxnSpPr/>
            <p:nvPr/>
          </p:nvCxnSpPr>
          <p:spPr>
            <a:xfrm>
              <a:off x="1648802" y="872274"/>
              <a:ext cx="0" cy="289953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Rechte verbindingslijn 95"/>
            <p:cNvCxnSpPr/>
            <p:nvPr/>
          </p:nvCxnSpPr>
          <p:spPr>
            <a:xfrm>
              <a:off x="1648802" y="4273501"/>
              <a:ext cx="0" cy="289953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kstvak 99"/>
            <p:cNvSpPr txBox="1"/>
            <p:nvPr/>
          </p:nvSpPr>
          <p:spPr>
            <a:xfrm rot="16200000">
              <a:off x="1434299" y="1359697"/>
              <a:ext cx="714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Counts</a:t>
              </a:r>
              <a:endParaRPr lang="nl-NL" sz="1200" b="1" dirty="0"/>
            </a:p>
          </p:txBody>
        </p:sp>
        <p:sp>
          <p:nvSpPr>
            <p:cNvPr id="101" name="Tekstvak 100"/>
            <p:cNvSpPr txBox="1"/>
            <p:nvPr/>
          </p:nvSpPr>
          <p:spPr>
            <a:xfrm rot="16200000">
              <a:off x="1418737" y="2998818"/>
              <a:ext cx="714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Counts</a:t>
              </a:r>
              <a:endParaRPr lang="nl-NL" sz="1200" b="1" dirty="0"/>
            </a:p>
          </p:txBody>
        </p:sp>
        <p:sp>
          <p:nvSpPr>
            <p:cNvPr id="102" name="Tekstvak 101"/>
            <p:cNvSpPr txBox="1"/>
            <p:nvPr/>
          </p:nvSpPr>
          <p:spPr>
            <a:xfrm rot="16200000">
              <a:off x="1407191" y="4734025"/>
              <a:ext cx="714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Counts</a:t>
              </a:r>
              <a:endParaRPr lang="nl-NL" sz="1200" b="1" dirty="0"/>
            </a:p>
          </p:txBody>
        </p:sp>
        <p:sp>
          <p:nvSpPr>
            <p:cNvPr id="103" name="Tekstvak 102"/>
            <p:cNvSpPr txBox="1"/>
            <p:nvPr/>
          </p:nvSpPr>
          <p:spPr>
            <a:xfrm rot="16200000">
              <a:off x="1384870" y="6390209"/>
              <a:ext cx="7145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NL" sz="1200" b="1" dirty="0" err="1" smtClean="0"/>
                <a:t>Counts</a:t>
              </a:r>
              <a:endParaRPr lang="nl-NL" sz="1200" b="1" dirty="0"/>
            </a:p>
          </p:txBody>
        </p:sp>
      </p:grpSp>
      <p:sp>
        <p:nvSpPr>
          <p:cNvPr id="97" name="Tekstvak 96"/>
          <p:cNvSpPr txBox="1"/>
          <p:nvPr/>
        </p:nvSpPr>
        <p:spPr>
          <a:xfrm>
            <a:off x="683568" y="7704931"/>
            <a:ext cx="6336704" cy="187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2: CD45.2+CD11b+F4/80high macrophages express high levels of FcR in the tumor. </a:t>
            </a:r>
            <a:r>
              <a:rPr lang="en-US" sz="1400" dirty="0" smtClean="0"/>
              <a:t>Mice (6 mice / group) bearing 9464D tumors were treated with </a:t>
            </a:r>
            <a:r>
              <a:rPr lang="en-US" sz="1400" dirty="0" err="1" smtClean="0"/>
              <a:t>Vorinostat</a:t>
            </a:r>
            <a:r>
              <a:rPr lang="en-US" sz="1400" dirty="0" smtClean="0"/>
              <a:t> (150 mg/kg) for 3 consecutive days. One day after the last injection tumors were excised and single cell suspensions were made. CD45.2+CD11b+F4/80low and CD45.2+CD11b+F4/80</a:t>
            </a:r>
            <a:r>
              <a:rPr lang="en-US" sz="1400" baseline="30000" dirty="0" smtClean="0"/>
              <a:t>high</a:t>
            </a:r>
            <a:r>
              <a:rPr lang="en-US" sz="1400" dirty="0" smtClean="0"/>
              <a:t> cells were gated and analyzed for the expression of FcRγ1 and FcRγ2/3. Representative data from 3 independent experiments are shown.</a:t>
            </a:r>
            <a:endParaRPr lang="nl-NL" sz="1400" dirty="0" smtClean="0"/>
          </a:p>
          <a:p>
            <a:endParaRPr lang="nl-NL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75</TotalTime>
  <Words>124</Words>
  <Application>Microsoft Office PowerPoint</Application>
  <PresentationFormat>Aangepast</PresentationFormat>
  <Paragraphs>24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ichiel</dc:creator>
  <cp:lastModifiedBy>michiel</cp:lastModifiedBy>
  <cp:revision>359</cp:revision>
  <dcterms:created xsi:type="dcterms:W3CDTF">2010-10-14T15:06:18Z</dcterms:created>
  <dcterms:modified xsi:type="dcterms:W3CDTF">2015-11-12T09:45:27Z</dcterms:modified>
</cp:coreProperties>
</file>